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87425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>
        <p:scale>
          <a:sx n="60" d="100"/>
          <a:sy n="60" d="100"/>
        </p:scale>
        <p:origin x="840" y="-1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A51220A-F9C2-F82E-172A-DBFEBB88167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8402E76F-3217-6891-015C-2CDAA60853E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BED44E6-C457-3B54-7A15-7D793DBAC6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075D9-0791-460D-A1ED-E096D0911BDF}" type="datetimeFigureOut">
              <a:rPr kumimoji="1" lang="ja-JP" altLang="en-US" smtClean="0"/>
              <a:t>2025/7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1625E3D-6F2C-3EF4-2D48-1D616E568A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E3846ED-2350-2BB9-8F8A-F1808AC15F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AC9D84-486B-4AA8-BA72-3485D54456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297213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34F9CC3-202E-9F37-859C-589C684103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B509937A-41B5-D4EA-41CC-EE662BDE40A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DDD6B2D-578F-6398-0B29-806FF1606E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075D9-0791-460D-A1ED-E096D0911BDF}" type="datetimeFigureOut">
              <a:rPr kumimoji="1" lang="ja-JP" altLang="en-US" smtClean="0"/>
              <a:t>2025/7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45FD8B4-54BA-68FC-D73A-EB1CFE9F73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11B5915-17AA-6D42-8163-13ECC4EF59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AC9D84-486B-4AA8-BA72-3485D54456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803115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83A0B5F5-3CAF-CB17-1B96-CD947ED4E5F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E99A8E0A-01B3-9662-87C7-53EF0851953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F4074E3-5B0F-1C93-5E1D-6985FFF385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075D9-0791-460D-A1ED-E096D0911BDF}" type="datetimeFigureOut">
              <a:rPr kumimoji="1" lang="ja-JP" altLang="en-US" smtClean="0"/>
              <a:t>2025/7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BD54446-7463-C002-32DC-03E9DC9FAD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C60CACF-A102-CCF9-C065-FBCA85F2F6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AC9D84-486B-4AA8-BA72-3485D54456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112386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9B0341F-2D24-C409-0CF6-18F9FA84E77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CBB597EC-D174-47A2-CEE9-9586FD71A4E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00EF16C-B520-C48C-BCBD-7D0637CFBC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075D9-0791-460D-A1ED-E096D0911BDF}" type="datetimeFigureOut">
              <a:rPr kumimoji="1" lang="ja-JP" altLang="en-US" smtClean="0"/>
              <a:t>2025/7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F243548-7860-547B-EC80-78DF621B33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C1EAE51-19E5-D50B-1200-27701D0A6B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AC9D84-486B-4AA8-BA72-3485D54456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768210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D4B0172-E592-B488-9588-6CE68B008C1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06D3D74E-43C4-B719-D34D-A36EC8F3BA6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C47FEC8-5A76-1CAF-B22C-2FA4EBE593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075D9-0791-460D-A1ED-E096D0911BDF}" type="datetimeFigureOut">
              <a:rPr kumimoji="1" lang="ja-JP" altLang="en-US" smtClean="0"/>
              <a:t>2025/7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D60480F-60DE-10D4-D5F9-4DC2F6E605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329B249-0818-3498-4B63-6099F0AECC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AC9D84-486B-4AA8-BA72-3485D54456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191176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DCE340E-33BA-19E2-A2FC-51041D57077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FFF7BD03-0EB6-752C-30CF-0573460E104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5DE84220-E23A-3CD8-E7A5-582B709BF12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B4BABA6F-F768-5E1E-667F-8B41B8227C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075D9-0791-460D-A1ED-E096D0911BDF}" type="datetimeFigureOut">
              <a:rPr kumimoji="1" lang="ja-JP" altLang="en-US" smtClean="0"/>
              <a:t>2025/7/2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39191AA-D64E-72D7-1B73-379EB30938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9B2D6755-3E05-A1A0-4348-8451A5AF0B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AC9D84-486B-4AA8-BA72-3485D54456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637018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4290330-D0FE-9A34-1B98-1338A32495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B06E18E2-D4E8-B385-5A7F-E2B10E2B984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1B311F74-F6D4-0666-0E5C-70B86545F61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175C7154-7EF8-9F2C-4D1B-FDC1D518C4B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6C90687F-5090-07D6-17D9-04D9DB83D5B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D9851CF9-F67B-6744-867A-F781816213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075D9-0791-460D-A1ED-E096D0911BDF}" type="datetimeFigureOut">
              <a:rPr kumimoji="1" lang="ja-JP" altLang="en-US" smtClean="0"/>
              <a:t>2025/7/29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EB1C253C-FD52-639A-DD9F-9EFC90C232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608AB8C5-AFAC-41CB-0377-6096BE0A7F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AC9D84-486B-4AA8-BA72-3485D54456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849307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0282E58-0436-1918-CA11-E12212BC1F9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2C56DC54-B9A8-2913-B4A3-B9E69EFDCA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075D9-0791-460D-A1ED-E096D0911BDF}" type="datetimeFigureOut">
              <a:rPr kumimoji="1" lang="ja-JP" altLang="en-US" smtClean="0"/>
              <a:t>2025/7/29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D88C828C-A019-5E56-1343-B304E96611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C8C3517B-37AD-C0F5-D2BB-7C001B68E5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AC9D84-486B-4AA8-BA72-3485D54456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446222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95C08D7A-FBAA-0BE9-6DC6-81F553DB6B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075D9-0791-460D-A1ED-E096D0911BDF}" type="datetimeFigureOut">
              <a:rPr kumimoji="1" lang="ja-JP" altLang="en-US" smtClean="0"/>
              <a:t>2025/7/29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671FDF77-8D65-7462-7F00-93AA8C63F8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ED17ACC3-1A97-4FA8-9A14-625BECA905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AC9D84-486B-4AA8-BA72-3485D54456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69792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A35BEC0-D6A7-7C8E-5BF1-DAA6B356F22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D3066A40-B8B1-F0D8-77B9-8E5D90A803C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E1492C0F-C97E-3926-C6CE-9A74C2A6592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9A2B8C65-17DC-8A8B-A836-47238FF20C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075D9-0791-460D-A1ED-E096D0911BDF}" type="datetimeFigureOut">
              <a:rPr kumimoji="1" lang="ja-JP" altLang="en-US" smtClean="0"/>
              <a:t>2025/7/2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09D11F70-B5E7-5F01-109F-9B2326C31D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DB4C6EF2-97DC-18E8-49A4-444B47735E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AC9D84-486B-4AA8-BA72-3485D54456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612623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A5F4D9C-F2EA-3F84-46D8-41D29E9446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4B6D621E-5CD2-47FA-C537-AC770FAB98A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5113B1DC-8DB8-AF00-81C3-7E981784727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3CE69055-661F-D889-3EAE-B4213C0331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075D9-0791-460D-A1ED-E096D0911BDF}" type="datetimeFigureOut">
              <a:rPr kumimoji="1" lang="ja-JP" altLang="en-US" smtClean="0"/>
              <a:t>2025/7/2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07EC0FF4-82E6-FD31-D449-B689FCC3E8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DA255F88-E198-F784-83AF-60A3532835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AC9D84-486B-4AA8-BA72-3485D54456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265511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40A06FC7-65DD-8169-4E50-C4F75095C1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1DF6922B-0497-71A6-DBAE-1722AEF36B3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2A2D0F2-D360-C3B4-709E-56E5EEBC26A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D075D9-0791-460D-A1ED-E096D0911BDF}" type="datetimeFigureOut">
              <a:rPr kumimoji="1" lang="ja-JP" altLang="en-US" smtClean="0"/>
              <a:t>2025/7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7D9DFE4-F8A5-28D7-8D96-2947415EA2F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7E96013-BA3F-5EE6-F4D7-706E03ADBCD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AC9D84-486B-4AA8-BA72-3485D54456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873572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9" name="テキスト ボックス 248">
            <a:extLst>
              <a:ext uri="{FF2B5EF4-FFF2-40B4-BE49-F238E27FC236}">
                <a16:creationId xmlns:a16="http://schemas.microsoft.com/office/drawing/2014/main" id="{9E55D609-EC06-47FF-C173-AD1CDA954CBE}"/>
              </a:ext>
            </a:extLst>
          </p:cNvPr>
          <p:cNvSpPr txBox="1"/>
          <p:nvPr/>
        </p:nvSpPr>
        <p:spPr>
          <a:xfrm>
            <a:off x="773488" y="1262992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altLang="ja-JP" sz="1200" dirty="0">
                <a:ln/>
                <a:solidFill>
                  <a:srgbClr val="000000"/>
                </a:solidFill>
                <a:latin typeface="Palatino Linotype" panose="02040502050505030304" pitchFamily="18" charset="0"/>
                <a:ea typeface="ＭＳ ゴシック"/>
                <a:cs typeface="Times New Roman" panose="02020603050405020304" pitchFamily="18" charset="0"/>
                <a:sym typeface="ＭＳ ゴシック"/>
                <a:rtl val="0"/>
              </a:rPr>
              <a:t>P</a:t>
            </a:r>
          </a:p>
        </p:txBody>
      </p:sp>
      <p:sp>
        <p:nvSpPr>
          <p:cNvPr id="250" name="テキスト ボックス 249">
            <a:extLst>
              <a:ext uri="{FF2B5EF4-FFF2-40B4-BE49-F238E27FC236}">
                <a16:creationId xmlns:a16="http://schemas.microsoft.com/office/drawing/2014/main" id="{964B4571-846C-8045-DC0E-577717B77FC3}"/>
              </a:ext>
            </a:extLst>
          </p:cNvPr>
          <p:cNvSpPr txBox="1"/>
          <p:nvPr/>
        </p:nvSpPr>
        <p:spPr>
          <a:xfrm>
            <a:off x="7228113" y="962461"/>
            <a:ext cx="35862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>
                <a:latin typeface="Palatino Linotype" panose="02040502050505030304" pitchFamily="18" charset="0"/>
              </a:rPr>
              <a:t>(b) Contrast-enhanced CT and ultrasound</a:t>
            </a:r>
            <a:endParaRPr lang="ja-JP" altLang="en-US" sz="1400" b="1" spc="0" baseline="0" dirty="0">
              <a:ln/>
              <a:solidFill>
                <a:srgbClr val="000000"/>
              </a:solidFill>
              <a:latin typeface="Palatino Linotype" panose="02040502050505030304" pitchFamily="18" charset="0"/>
              <a:ea typeface="ＭＳ ゴシック"/>
              <a:cs typeface="Times New Roman" panose="02020603050405020304" pitchFamily="18" charset="0"/>
              <a:sym typeface="ＭＳ ゴシック"/>
              <a:rtl val="0"/>
            </a:endParaRPr>
          </a:p>
        </p:txBody>
      </p:sp>
      <p:sp>
        <p:nvSpPr>
          <p:cNvPr id="251" name="テキスト ボックス 250">
            <a:extLst>
              <a:ext uri="{FF2B5EF4-FFF2-40B4-BE49-F238E27FC236}">
                <a16:creationId xmlns:a16="http://schemas.microsoft.com/office/drawing/2014/main" id="{31145656-9C23-2B3A-5227-EEBB4ED5C8CC}"/>
              </a:ext>
            </a:extLst>
          </p:cNvPr>
          <p:cNvSpPr txBox="1"/>
          <p:nvPr/>
        </p:nvSpPr>
        <p:spPr>
          <a:xfrm>
            <a:off x="1717387" y="4957464"/>
            <a:ext cx="121700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400" dirty="0">
                <a:ln/>
                <a:solidFill>
                  <a:srgbClr val="000000"/>
                </a:solidFill>
                <a:latin typeface="Palatino Linotype" panose="02040502050505030304" pitchFamily="18" charset="0"/>
                <a:cs typeface="Times New Roman" panose="02020603050405020304" pitchFamily="18" charset="0"/>
                <a:sym typeface="Arial"/>
                <a:rtl val="0"/>
              </a:rPr>
              <a:t>Transient</a:t>
            </a:r>
          </a:p>
          <a:p>
            <a:pPr algn="ctr"/>
            <a:r>
              <a:rPr lang="en-US" altLang="ja-JP" sz="1400" spc="0" baseline="0" dirty="0">
                <a:ln/>
                <a:solidFill>
                  <a:srgbClr val="000000"/>
                </a:solidFill>
                <a:latin typeface="Palatino Linotype" panose="02040502050505030304" pitchFamily="18" charset="0"/>
                <a:cs typeface="Times New Roman" panose="02020603050405020304" pitchFamily="18" charset="0"/>
                <a:sym typeface="Arial"/>
                <a:rtl val="0"/>
              </a:rPr>
              <a:t>galactosemia</a:t>
            </a:r>
            <a:endParaRPr lang="ja-JP" altLang="en-US" sz="1400" spc="0" baseline="0" dirty="0">
              <a:ln/>
              <a:solidFill>
                <a:srgbClr val="000000"/>
              </a:solidFill>
              <a:latin typeface="Palatino Linotype" panose="02040502050505030304" pitchFamily="18" charset="0"/>
              <a:cs typeface="Times New Roman" panose="02020603050405020304" pitchFamily="18" charset="0"/>
              <a:sym typeface="Arial"/>
              <a:rtl val="0"/>
            </a:endParaRPr>
          </a:p>
        </p:txBody>
      </p:sp>
      <p:sp>
        <p:nvSpPr>
          <p:cNvPr id="252" name="テキスト ボックス 251">
            <a:extLst>
              <a:ext uri="{FF2B5EF4-FFF2-40B4-BE49-F238E27FC236}">
                <a16:creationId xmlns:a16="http://schemas.microsoft.com/office/drawing/2014/main" id="{79ACD956-D62B-0557-4664-C88286C96C44}"/>
              </a:ext>
            </a:extLst>
          </p:cNvPr>
          <p:cNvSpPr txBox="1"/>
          <p:nvPr/>
        </p:nvSpPr>
        <p:spPr>
          <a:xfrm>
            <a:off x="7383219" y="4951526"/>
            <a:ext cx="121700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400" dirty="0">
                <a:ln/>
                <a:solidFill>
                  <a:srgbClr val="000000"/>
                </a:solidFill>
                <a:latin typeface="Palatino Linotype" panose="02040502050505030304" pitchFamily="18" charset="0"/>
                <a:cs typeface="Times New Roman" panose="02020603050405020304" pitchFamily="18" charset="0"/>
                <a:sym typeface="Arial"/>
                <a:rtl val="0"/>
              </a:rPr>
              <a:t>Transient</a:t>
            </a:r>
          </a:p>
          <a:p>
            <a:pPr algn="ctr"/>
            <a:r>
              <a:rPr lang="en-US" altLang="ja-JP" sz="1400" spc="0" baseline="0" dirty="0">
                <a:ln/>
                <a:solidFill>
                  <a:srgbClr val="000000"/>
                </a:solidFill>
                <a:latin typeface="Palatino Linotype" panose="02040502050505030304" pitchFamily="18" charset="0"/>
                <a:cs typeface="Times New Roman" panose="02020603050405020304" pitchFamily="18" charset="0"/>
                <a:sym typeface="Arial"/>
                <a:rtl val="0"/>
              </a:rPr>
              <a:t>galactosemia</a:t>
            </a:r>
            <a:endParaRPr lang="ja-JP" altLang="en-US" sz="1400" spc="0" baseline="0" dirty="0">
              <a:ln/>
              <a:solidFill>
                <a:srgbClr val="000000"/>
              </a:solidFill>
              <a:latin typeface="Palatino Linotype" panose="02040502050505030304" pitchFamily="18" charset="0"/>
              <a:cs typeface="Times New Roman" panose="02020603050405020304" pitchFamily="18" charset="0"/>
              <a:sym typeface="Arial"/>
              <a:rtl val="0"/>
            </a:endParaRPr>
          </a:p>
        </p:txBody>
      </p:sp>
      <p:sp>
        <p:nvSpPr>
          <p:cNvPr id="253" name="テキスト ボックス 252">
            <a:extLst>
              <a:ext uri="{FF2B5EF4-FFF2-40B4-BE49-F238E27FC236}">
                <a16:creationId xmlns:a16="http://schemas.microsoft.com/office/drawing/2014/main" id="{F9DE5832-9C1B-EA8B-270A-F874370DA331}"/>
              </a:ext>
            </a:extLst>
          </p:cNvPr>
          <p:cNvSpPr txBox="1"/>
          <p:nvPr/>
        </p:nvSpPr>
        <p:spPr>
          <a:xfrm>
            <a:off x="3907891" y="4978041"/>
            <a:ext cx="6094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altLang="ja-JP" sz="1400" dirty="0">
                <a:ln/>
                <a:solidFill>
                  <a:srgbClr val="000000"/>
                </a:solidFill>
                <a:latin typeface="Palatino Linotype" panose="02040502050505030304" pitchFamily="18" charset="0"/>
                <a:cs typeface="Times New Roman" panose="02020603050405020304" pitchFamily="18" charset="0"/>
                <a:sym typeface="Arial"/>
                <a:rtl val="0"/>
              </a:rPr>
              <a:t>CPSS</a:t>
            </a:r>
            <a:endParaRPr lang="ja-JP" altLang="en-US" sz="1400" spc="0" baseline="0" dirty="0">
              <a:ln/>
              <a:solidFill>
                <a:srgbClr val="000000"/>
              </a:solidFill>
              <a:latin typeface="Palatino Linotype" panose="02040502050505030304" pitchFamily="18" charset="0"/>
              <a:cs typeface="Times New Roman" panose="02020603050405020304" pitchFamily="18" charset="0"/>
              <a:sym typeface="Arial"/>
              <a:rtl val="0"/>
            </a:endParaRPr>
          </a:p>
        </p:txBody>
      </p:sp>
      <p:sp>
        <p:nvSpPr>
          <p:cNvPr id="254" name="テキスト ボックス 253">
            <a:extLst>
              <a:ext uri="{FF2B5EF4-FFF2-40B4-BE49-F238E27FC236}">
                <a16:creationId xmlns:a16="http://schemas.microsoft.com/office/drawing/2014/main" id="{77E3599B-CBC6-E0C9-073A-2CDDD27521F2}"/>
              </a:ext>
            </a:extLst>
          </p:cNvPr>
          <p:cNvSpPr txBox="1"/>
          <p:nvPr/>
        </p:nvSpPr>
        <p:spPr>
          <a:xfrm>
            <a:off x="9480923" y="4948587"/>
            <a:ext cx="6094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altLang="ja-JP" sz="1400" dirty="0">
                <a:ln/>
                <a:solidFill>
                  <a:srgbClr val="000000"/>
                </a:solidFill>
                <a:latin typeface="Palatino Linotype" panose="02040502050505030304" pitchFamily="18" charset="0"/>
                <a:cs typeface="Times New Roman" panose="02020603050405020304" pitchFamily="18" charset="0"/>
                <a:sym typeface="Arial"/>
                <a:rtl val="0"/>
              </a:rPr>
              <a:t>CPSS</a:t>
            </a:r>
            <a:endParaRPr lang="ja-JP" altLang="en-US" sz="1400" spc="0" baseline="0" dirty="0">
              <a:ln/>
              <a:solidFill>
                <a:srgbClr val="000000"/>
              </a:solidFill>
              <a:latin typeface="Palatino Linotype" panose="02040502050505030304" pitchFamily="18" charset="0"/>
              <a:cs typeface="Times New Roman" panose="02020603050405020304" pitchFamily="18" charset="0"/>
              <a:sym typeface="Arial"/>
              <a:rtl val="0"/>
            </a:endParaRPr>
          </a:p>
        </p:txBody>
      </p:sp>
      <p:sp>
        <p:nvSpPr>
          <p:cNvPr id="256" name="テキスト ボックス 255">
            <a:extLst>
              <a:ext uri="{FF2B5EF4-FFF2-40B4-BE49-F238E27FC236}">
                <a16:creationId xmlns:a16="http://schemas.microsoft.com/office/drawing/2014/main" id="{8CECEBC6-88CE-B127-3972-B7F0153BC9CE}"/>
              </a:ext>
            </a:extLst>
          </p:cNvPr>
          <p:cNvSpPr txBox="1"/>
          <p:nvPr/>
        </p:nvSpPr>
        <p:spPr>
          <a:xfrm>
            <a:off x="2252950" y="962460"/>
            <a:ext cx="136287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altLang="ja-JP" sz="1400" b="1" dirty="0">
                <a:ln/>
                <a:solidFill>
                  <a:srgbClr val="000000"/>
                </a:solidFill>
                <a:latin typeface="Palatino Linotype" panose="02040502050505030304" pitchFamily="18" charset="0"/>
                <a:ea typeface="ＭＳ ゴシック"/>
                <a:cs typeface="Times New Roman" panose="02020603050405020304" pitchFamily="18" charset="0"/>
                <a:sym typeface="ＭＳ ゴシック"/>
                <a:rtl val="0"/>
              </a:rPr>
              <a:t>(a) Ultrasound</a:t>
            </a:r>
            <a:endParaRPr lang="ja-JP" altLang="en-US" sz="1400" b="1" spc="0" baseline="0" dirty="0">
              <a:ln/>
              <a:solidFill>
                <a:srgbClr val="000000"/>
              </a:solidFill>
              <a:latin typeface="Palatino Linotype" panose="02040502050505030304" pitchFamily="18" charset="0"/>
              <a:ea typeface="ＭＳ ゴシック"/>
              <a:cs typeface="Times New Roman" panose="02020603050405020304" pitchFamily="18" charset="0"/>
              <a:sym typeface="ＭＳ ゴシック"/>
              <a:rtl val="0"/>
            </a:endParaRPr>
          </a:p>
        </p:txBody>
      </p:sp>
      <p:sp>
        <p:nvSpPr>
          <p:cNvPr id="262" name="テキスト ボックス 261">
            <a:extLst>
              <a:ext uri="{FF2B5EF4-FFF2-40B4-BE49-F238E27FC236}">
                <a16:creationId xmlns:a16="http://schemas.microsoft.com/office/drawing/2014/main" id="{A05579EA-3F7F-73A3-A2BA-AF03D3A2B266}"/>
              </a:ext>
            </a:extLst>
          </p:cNvPr>
          <p:cNvSpPr txBox="1"/>
          <p:nvPr/>
        </p:nvSpPr>
        <p:spPr>
          <a:xfrm>
            <a:off x="6329036" y="1262991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altLang="ja-JP" sz="1200" dirty="0">
                <a:ln/>
                <a:solidFill>
                  <a:srgbClr val="000000"/>
                </a:solidFill>
                <a:latin typeface="Palatino Linotype" panose="02040502050505030304" pitchFamily="18" charset="0"/>
                <a:ea typeface="ＭＳ ゴシック"/>
                <a:cs typeface="Times New Roman" panose="02020603050405020304" pitchFamily="18" charset="0"/>
                <a:sym typeface="ＭＳ ゴシック"/>
                <a:rtl val="0"/>
              </a:rPr>
              <a:t>P</a:t>
            </a:r>
          </a:p>
        </p:txBody>
      </p:sp>
      <p:sp>
        <p:nvSpPr>
          <p:cNvPr id="266" name="Rectangle 6">
            <a:extLst>
              <a:ext uri="{FF2B5EF4-FFF2-40B4-BE49-F238E27FC236}">
                <a16:creationId xmlns:a16="http://schemas.microsoft.com/office/drawing/2014/main" id="{994E4FC4-0D13-A3F7-74C7-376406DB7BE4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79566" y="5664706"/>
            <a:ext cx="10192214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pitchFamily="18" charset="0"/>
              </a:rPr>
              <a:t>Figure S2. </a:t>
            </a:r>
            <a:r>
              <a:rPr kumimoji="0" lang="ja-JP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pitchFamily="18" charset="0"/>
              </a:rPr>
              <a:t>Predicted probability (P) for </a:t>
            </a:r>
            <a:r>
              <a:rPr kumimoji="0" lang="ja-JP" altLang="ja-JP" sz="1200" b="0" i="0" u="none" strike="noStrike" cap="none" normalizeH="0" baseline="0" dirty="0">
                <a:ln>
                  <a:noFill/>
                </a:ln>
                <a:effectLst/>
                <a:latin typeface="Palatino Linotype" panose="02040502050505030304" pitchFamily="18" charset="0"/>
              </a:rPr>
              <a:t>cases </a:t>
            </a:r>
            <a:r>
              <a:rPr kumimoji="0" lang="en-US" altLang="ja-JP" sz="1200" b="0" i="0" u="none" strike="noStrike" cap="none" normalizeH="0" baseline="0" dirty="0">
                <a:ln>
                  <a:noFill/>
                </a:ln>
                <a:effectLst/>
                <a:latin typeface="Palatino Linotype" panose="02040502050505030304" pitchFamily="18" charset="0"/>
              </a:rPr>
              <a:t>diagnosed with</a:t>
            </a:r>
            <a:r>
              <a:rPr kumimoji="0" lang="ja-JP" altLang="ja-JP" sz="1200" b="0" i="0" u="none" strike="noStrike" cap="none" normalizeH="0" baseline="0" dirty="0">
                <a:ln>
                  <a:noFill/>
                </a:ln>
                <a:effectLst/>
                <a:latin typeface="Palatino Linotype" panose="02040502050505030304" pitchFamily="18" charset="0"/>
              </a:rPr>
              <a:t> ultrasound alone (a), and </a:t>
            </a:r>
            <a:r>
              <a:rPr kumimoji="0" lang="en-US" altLang="ja-JP" sz="1200" dirty="0">
                <a:latin typeface="Palatino Linotype" panose="02040502050505030304" pitchFamily="18" charset="0"/>
              </a:rPr>
              <a:t>with</a:t>
            </a:r>
            <a:r>
              <a:rPr kumimoji="0" lang="en-US" altLang="ja-JP" sz="1200" b="0" i="0" u="none" strike="noStrike" cap="none" normalizeH="0" baseline="0" dirty="0">
                <a:ln>
                  <a:noFill/>
                </a:ln>
                <a:effectLst/>
                <a:latin typeface="Palatino Linotype" panose="02040502050505030304" pitchFamily="18" charset="0"/>
              </a:rPr>
              <a:t> both</a:t>
            </a:r>
            <a:r>
              <a:rPr kumimoji="0" lang="ja-JP" altLang="ja-JP" sz="1200" b="0" i="0" u="none" strike="noStrike" cap="none" normalizeH="0" baseline="0" dirty="0">
                <a:ln>
                  <a:noFill/>
                </a:ln>
                <a:effectLst/>
                <a:latin typeface="Palatino Linotype" panose="02040502050505030304" pitchFamily="18" charset="0"/>
              </a:rPr>
              <a:t> </a:t>
            </a:r>
            <a:r>
              <a:rPr kumimoji="0" lang="en-US" altLang="ja-JP" sz="1200" b="0" i="0" u="none" strike="noStrike" cap="none" normalizeH="0" baseline="0" dirty="0">
                <a:ln>
                  <a:noFill/>
                </a:ln>
                <a:effectLst/>
                <a:latin typeface="Palatino Linotype" panose="02040502050505030304" pitchFamily="18" charset="0"/>
              </a:rPr>
              <a:t>of </a:t>
            </a:r>
            <a:r>
              <a:rPr kumimoji="0" lang="en-US" altLang="ja-JP" sz="1200" dirty="0">
                <a:latin typeface="Palatino Linotype" panose="02040502050505030304" pitchFamily="18" charset="0"/>
              </a:rPr>
              <a:t>contrast-enhanced </a:t>
            </a:r>
            <a:r>
              <a:rPr kumimoji="0" lang="en-US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pitchFamily="18" charset="0"/>
              </a:rPr>
              <a:t>CT</a:t>
            </a:r>
            <a:r>
              <a:rPr kumimoji="0" lang="ja-JP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pitchFamily="18" charset="0"/>
              </a:rPr>
              <a:t> and ultrasound (b).</a:t>
            </a:r>
            <a:endParaRPr kumimoji="0" lang="en-US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Palatino Linotype" panose="0204050205050503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pitchFamily="18" charset="0"/>
              </a:rPr>
              <a:t>In the CPSS group, the number of cases with false negatives was reduced when CT was used for diagnosis (orange filled circles).</a:t>
            </a:r>
            <a:endParaRPr kumimoji="0" lang="ja-JP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Palatino Linotype" panose="02040502050505030304" pitchFamily="18" charset="0"/>
            </a:endParaRPr>
          </a:p>
        </p:txBody>
      </p:sp>
      <p:grpSp>
        <p:nvGrpSpPr>
          <p:cNvPr id="57" name="グラフィックス 3">
            <a:extLst>
              <a:ext uri="{FF2B5EF4-FFF2-40B4-BE49-F238E27FC236}">
                <a16:creationId xmlns:a16="http://schemas.microsoft.com/office/drawing/2014/main" id="{91DDC7F1-846F-C3DD-7EC3-24327FC9213D}"/>
              </a:ext>
            </a:extLst>
          </p:cNvPr>
          <p:cNvGrpSpPr/>
          <p:nvPr/>
        </p:nvGrpSpPr>
        <p:grpSpPr>
          <a:xfrm>
            <a:off x="557600" y="1535625"/>
            <a:ext cx="4992806" cy="3445221"/>
            <a:chOff x="724331" y="1510081"/>
            <a:chExt cx="4834561" cy="3457952"/>
          </a:xfrm>
        </p:grpSpPr>
        <p:grpSp>
          <p:nvGrpSpPr>
            <p:cNvPr id="199" name="グラフィックス 3">
              <a:extLst>
                <a:ext uri="{FF2B5EF4-FFF2-40B4-BE49-F238E27FC236}">
                  <a16:creationId xmlns:a16="http://schemas.microsoft.com/office/drawing/2014/main" id="{0C00824A-7920-C0A1-7B8D-FFBD58D51B29}"/>
                </a:ext>
              </a:extLst>
            </p:cNvPr>
            <p:cNvGrpSpPr/>
            <p:nvPr/>
          </p:nvGrpSpPr>
          <p:grpSpPr>
            <a:xfrm>
              <a:off x="724331" y="1510081"/>
              <a:ext cx="377026" cy="3457952"/>
              <a:chOff x="724331" y="1510081"/>
              <a:chExt cx="377026" cy="3457952"/>
            </a:xfrm>
            <a:solidFill>
              <a:srgbClr val="000000"/>
            </a:solidFill>
          </p:grpSpPr>
          <p:sp>
            <p:nvSpPr>
              <p:cNvPr id="385" name="テキスト ボックス 384">
                <a:extLst>
                  <a:ext uri="{FF2B5EF4-FFF2-40B4-BE49-F238E27FC236}">
                    <a16:creationId xmlns:a16="http://schemas.microsoft.com/office/drawing/2014/main" id="{38D2F0A2-52F9-15B0-B49B-1DCF4B3812E6}"/>
                  </a:ext>
                </a:extLst>
              </p:cNvPr>
              <p:cNvSpPr txBox="1"/>
              <p:nvPr/>
            </p:nvSpPr>
            <p:spPr>
              <a:xfrm>
                <a:off x="724331" y="4691034"/>
                <a:ext cx="3770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ja-JP" altLang="en-US" sz="1200" spc="0" baseline="0">
                    <a:ln/>
                    <a:solidFill>
                      <a:srgbClr val="000000"/>
                    </a:solidFill>
                    <a:latin typeface="Palatino Linotype" panose="02040502050505030304" pitchFamily="18" charset="0"/>
                    <a:cs typeface="Arial"/>
                    <a:sym typeface="Arial"/>
                    <a:rtl val="0"/>
                  </a:rPr>
                  <a:t>0.0</a:t>
                </a:r>
              </a:p>
            </p:txBody>
          </p:sp>
          <p:sp>
            <p:nvSpPr>
              <p:cNvPr id="386" name="テキスト ボックス 385">
                <a:extLst>
                  <a:ext uri="{FF2B5EF4-FFF2-40B4-BE49-F238E27FC236}">
                    <a16:creationId xmlns:a16="http://schemas.microsoft.com/office/drawing/2014/main" id="{1E32D1A9-191D-7240-6994-9A546034693D}"/>
                  </a:ext>
                </a:extLst>
              </p:cNvPr>
              <p:cNvSpPr txBox="1"/>
              <p:nvPr/>
            </p:nvSpPr>
            <p:spPr>
              <a:xfrm>
                <a:off x="724331" y="4372040"/>
                <a:ext cx="3770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ja-JP" altLang="en-US" sz="1200" spc="0" baseline="0">
                    <a:ln/>
                    <a:solidFill>
                      <a:srgbClr val="000000"/>
                    </a:solidFill>
                    <a:latin typeface="Palatino Linotype" panose="02040502050505030304" pitchFamily="18" charset="0"/>
                    <a:cs typeface="Arial"/>
                    <a:sym typeface="Arial"/>
                    <a:rtl val="0"/>
                  </a:rPr>
                  <a:t>0.1</a:t>
                </a:r>
              </a:p>
            </p:txBody>
          </p:sp>
          <p:sp>
            <p:nvSpPr>
              <p:cNvPr id="387" name="テキスト ボックス 386">
                <a:extLst>
                  <a:ext uri="{FF2B5EF4-FFF2-40B4-BE49-F238E27FC236}">
                    <a16:creationId xmlns:a16="http://schemas.microsoft.com/office/drawing/2014/main" id="{20A0A5E1-1B38-F774-3574-F7D23DF21599}"/>
                  </a:ext>
                </a:extLst>
              </p:cNvPr>
              <p:cNvSpPr txBox="1"/>
              <p:nvPr/>
            </p:nvSpPr>
            <p:spPr>
              <a:xfrm>
                <a:off x="724331" y="4053046"/>
                <a:ext cx="3770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ja-JP" altLang="en-US" sz="1200" spc="0" baseline="0">
                    <a:ln/>
                    <a:solidFill>
                      <a:srgbClr val="000000"/>
                    </a:solidFill>
                    <a:latin typeface="Palatino Linotype" panose="02040502050505030304" pitchFamily="18" charset="0"/>
                    <a:cs typeface="Arial"/>
                    <a:sym typeface="Arial"/>
                    <a:rtl val="0"/>
                  </a:rPr>
                  <a:t>0.2</a:t>
                </a:r>
              </a:p>
            </p:txBody>
          </p:sp>
          <p:sp>
            <p:nvSpPr>
              <p:cNvPr id="388" name="テキスト ボックス 387">
                <a:extLst>
                  <a:ext uri="{FF2B5EF4-FFF2-40B4-BE49-F238E27FC236}">
                    <a16:creationId xmlns:a16="http://schemas.microsoft.com/office/drawing/2014/main" id="{02AC4A7D-9258-6C40-FC6E-E17B509C11E0}"/>
                  </a:ext>
                </a:extLst>
              </p:cNvPr>
              <p:cNvSpPr txBox="1"/>
              <p:nvPr/>
            </p:nvSpPr>
            <p:spPr>
              <a:xfrm>
                <a:off x="724331" y="3738545"/>
                <a:ext cx="3770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ja-JP" altLang="en-US" sz="1200" spc="0" baseline="0">
                    <a:ln/>
                    <a:solidFill>
                      <a:srgbClr val="000000"/>
                    </a:solidFill>
                    <a:latin typeface="Palatino Linotype" panose="02040502050505030304" pitchFamily="18" charset="0"/>
                    <a:cs typeface="Arial"/>
                    <a:sym typeface="Arial"/>
                    <a:rtl val="0"/>
                  </a:rPr>
                  <a:t>0.3</a:t>
                </a:r>
              </a:p>
            </p:txBody>
          </p:sp>
          <p:sp>
            <p:nvSpPr>
              <p:cNvPr id="389" name="テキスト ボックス 388">
                <a:extLst>
                  <a:ext uri="{FF2B5EF4-FFF2-40B4-BE49-F238E27FC236}">
                    <a16:creationId xmlns:a16="http://schemas.microsoft.com/office/drawing/2014/main" id="{D7081DC9-D190-4455-0345-7A80FFEB8739}"/>
                  </a:ext>
                </a:extLst>
              </p:cNvPr>
              <p:cNvSpPr txBox="1"/>
              <p:nvPr/>
            </p:nvSpPr>
            <p:spPr>
              <a:xfrm>
                <a:off x="724331" y="3419552"/>
                <a:ext cx="3770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ja-JP" altLang="en-US" sz="1200" spc="0" baseline="0">
                    <a:ln/>
                    <a:solidFill>
                      <a:srgbClr val="000000"/>
                    </a:solidFill>
                    <a:latin typeface="Palatino Linotype" panose="02040502050505030304" pitchFamily="18" charset="0"/>
                    <a:cs typeface="Arial"/>
                    <a:sym typeface="Arial"/>
                    <a:rtl val="0"/>
                  </a:rPr>
                  <a:t>0.4</a:t>
                </a:r>
              </a:p>
            </p:txBody>
          </p:sp>
          <p:sp>
            <p:nvSpPr>
              <p:cNvPr id="390" name="テキスト ボックス 389">
                <a:extLst>
                  <a:ext uri="{FF2B5EF4-FFF2-40B4-BE49-F238E27FC236}">
                    <a16:creationId xmlns:a16="http://schemas.microsoft.com/office/drawing/2014/main" id="{33EBC330-581C-C6C8-E87F-54FC1F07535E}"/>
                  </a:ext>
                </a:extLst>
              </p:cNvPr>
              <p:cNvSpPr txBox="1"/>
              <p:nvPr/>
            </p:nvSpPr>
            <p:spPr>
              <a:xfrm>
                <a:off x="724331" y="3100558"/>
                <a:ext cx="3770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ja-JP" altLang="en-US" sz="1200" spc="0" baseline="0">
                    <a:ln/>
                    <a:solidFill>
                      <a:srgbClr val="000000"/>
                    </a:solidFill>
                    <a:latin typeface="Palatino Linotype" panose="02040502050505030304" pitchFamily="18" charset="0"/>
                    <a:cs typeface="Arial"/>
                    <a:sym typeface="Arial"/>
                    <a:rtl val="0"/>
                  </a:rPr>
                  <a:t>0.5</a:t>
                </a:r>
              </a:p>
            </p:txBody>
          </p:sp>
          <p:sp>
            <p:nvSpPr>
              <p:cNvPr id="391" name="テキスト ボックス 390">
                <a:extLst>
                  <a:ext uri="{FF2B5EF4-FFF2-40B4-BE49-F238E27FC236}">
                    <a16:creationId xmlns:a16="http://schemas.microsoft.com/office/drawing/2014/main" id="{D1671066-FC77-139B-A36D-01E316ACF979}"/>
                  </a:ext>
                </a:extLst>
              </p:cNvPr>
              <p:cNvSpPr txBox="1"/>
              <p:nvPr/>
            </p:nvSpPr>
            <p:spPr>
              <a:xfrm>
                <a:off x="724331" y="2781564"/>
                <a:ext cx="3770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ja-JP" altLang="en-US" sz="1200" spc="0" baseline="0">
                    <a:ln/>
                    <a:solidFill>
                      <a:srgbClr val="000000"/>
                    </a:solidFill>
                    <a:latin typeface="Palatino Linotype" panose="02040502050505030304" pitchFamily="18" charset="0"/>
                    <a:cs typeface="Arial"/>
                    <a:sym typeface="Arial"/>
                    <a:rtl val="0"/>
                  </a:rPr>
                  <a:t>0.6</a:t>
                </a:r>
              </a:p>
            </p:txBody>
          </p:sp>
          <p:sp>
            <p:nvSpPr>
              <p:cNvPr id="392" name="テキスト ボックス 391">
                <a:extLst>
                  <a:ext uri="{FF2B5EF4-FFF2-40B4-BE49-F238E27FC236}">
                    <a16:creationId xmlns:a16="http://schemas.microsoft.com/office/drawing/2014/main" id="{690FE505-957A-EB9D-F401-31853DA82D96}"/>
                  </a:ext>
                </a:extLst>
              </p:cNvPr>
              <p:cNvSpPr txBox="1"/>
              <p:nvPr/>
            </p:nvSpPr>
            <p:spPr>
              <a:xfrm>
                <a:off x="724331" y="2462570"/>
                <a:ext cx="3770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ja-JP" altLang="en-US" sz="1200" spc="0" baseline="0">
                    <a:ln/>
                    <a:solidFill>
                      <a:srgbClr val="000000"/>
                    </a:solidFill>
                    <a:latin typeface="Palatino Linotype" panose="02040502050505030304" pitchFamily="18" charset="0"/>
                    <a:cs typeface="Arial"/>
                    <a:sym typeface="Arial"/>
                    <a:rtl val="0"/>
                  </a:rPr>
                  <a:t>0.7</a:t>
                </a:r>
              </a:p>
            </p:txBody>
          </p:sp>
          <p:sp>
            <p:nvSpPr>
              <p:cNvPr id="393" name="テキスト ボックス 392">
                <a:extLst>
                  <a:ext uri="{FF2B5EF4-FFF2-40B4-BE49-F238E27FC236}">
                    <a16:creationId xmlns:a16="http://schemas.microsoft.com/office/drawing/2014/main" id="{16880DFF-2C77-1AD7-DBE2-276F0C9895CE}"/>
                  </a:ext>
                </a:extLst>
              </p:cNvPr>
              <p:cNvSpPr txBox="1"/>
              <p:nvPr/>
            </p:nvSpPr>
            <p:spPr>
              <a:xfrm>
                <a:off x="724331" y="2148069"/>
                <a:ext cx="3770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ja-JP" altLang="en-US" sz="1200" spc="0" baseline="0">
                    <a:ln/>
                    <a:solidFill>
                      <a:srgbClr val="000000"/>
                    </a:solidFill>
                    <a:latin typeface="Palatino Linotype" panose="02040502050505030304" pitchFamily="18" charset="0"/>
                    <a:cs typeface="Arial"/>
                    <a:sym typeface="Arial"/>
                    <a:rtl val="0"/>
                  </a:rPr>
                  <a:t>0.8</a:t>
                </a:r>
              </a:p>
            </p:txBody>
          </p:sp>
          <p:sp>
            <p:nvSpPr>
              <p:cNvPr id="394" name="テキスト ボックス 393">
                <a:extLst>
                  <a:ext uri="{FF2B5EF4-FFF2-40B4-BE49-F238E27FC236}">
                    <a16:creationId xmlns:a16="http://schemas.microsoft.com/office/drawing/2014/main" id="{4DC9F737-104C-95B0-BDA5-559F72743A54}"/>
                  </a:ext>
                </a:extLst>
              </p:cNvPr>
              <p:cNvSpPr txBox="1"/>
              <p:nvPr/>
            </p:nvSpPr>
            <p:spPr>
              <a:xfrm>
                <a:off x="724331" y="1829075"/>
                <a:ext cx="3770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ja-JP" altLang="en-US" sz="1200" spc="0" baseline="0">
                    <a:ln/>
                    <a:solidFill>
                      <a:srgbClr val="000000"/>
                    </a:solidFill>
                    <a:latin typeface="Palatino Linotype" panose="02040502050505030304" pitchFamily="18" charset="0"/>
                    <a:cs typeface="Arial"/>
                    <a:sym typeface="Arial"/>
                    <a:rtl val="0"/>
                  </a:rPr>
                  <a:t>0.9</a:t>
                </a:r>
              </a:p>
            </p:txBody>
          </p:sp>
          <p:sp>
            <p:nvSpPr>
              <p:cNvPr id="395" name="テキスト ボックス 394">
                <a:extLst>
                  <a:ext uri="{FF2B5EF4-FFF2-40B4-BE49-F238E27FC236}">
                    <a16:creationId xmlns:a16="http://schemas.microsoft.com/office/drawing/2014/main" id="{A9422E52-DA9A-A102-87FD-132AE94B4B99}"/>
                  </a:ext>
                </a:extLst>
              </p:cNvPr>
              <p:cNvSpPr txBox="1"/>
              <p:nvPr/>
            </p:nvSpPr>
            <p:spPr>
              <a:xfrm>
                <a:off x="724331" y="1510081"/>
                <a:ext cx="3770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ja-JP" altLang="en-US" sz="1200" spc="0" baseline="0">
                    <a:ln/>
                    <a:solidFill>
                      <a:srgbClr val="000000"/>
                    </a:solidFill>
                    <a:latin typeface="Palatino Linotype" panose="02040502050505030304" pitchFamily="18" charset="0"/>
                    <a:cs typeface="Arial"/>
                    <a:sym typeface="Arial"/>
                    <a:rtl val="0"/>
                  </a:rPr>
                  <a:t>1.0</a:t>
                </a:r>
              </a:p>
            </p:txBody>
          </p:sp>
        </p:grpSp>
        <p:grpSp>
          <p:nvGrpSpPr>
            <p:cNvPr id="255" name="グラフィックス 3">
              <a:extLst>
                <a:ext uri="{FF2B5EF4-FFF2-40B4-BE49-F238E27FC236}">
                  <a16:creationId xmlns:a16="http://schemas.microsoft.com/office/drawing/2014/main" id="{025D0D7B-6ACF-03E2-37E7-ED3E648D2739}"/>
                </a:ext>
              </a:extLst>
            </p:cNvPr>
            <p:cNvGrpSpPr/>
            <p:nvPr/>
          </p:nvGrpSpPr>
          <p:grpSpPr>
            <a:xfrm>
              <a:off x="1228078" y="1663301"/>
              <a:ext cx="4317336" cy="3180952"/>
              <a:chOff x="1228078" y="1663301"/>
              <a:chExt cx="4317336" cy="3180952"/>
            </a:xfrm>
            <a:noFill/>
          </p:grpSpPr>
          <p:sp>
            <p:nvSpPr>
              <p:cNvPr id="374" name="フリーフォーム: 図形 373">
                <a:extLst>
                  <a:ext uri="{FF2B5EF4-FFF2-40B4-BE49-F238E27FC236}">
                    <a16:creationId xmlns:a16="http://schemas.microsoft.com/office/drawing/2014/main" id="{76D57FCA-47BE-1FA5-B4C2-33301733D49B}"/>
                  </a:ext>
                </a:extLst>
              </p:cNvPr>
              <p:cNvSpPr/>
              <p:nvPr/>
            </p:nvSpPr>
            <p:spPr>
              <a:xfrm>
                <a:off x="1228078" y="1663301"/>
                <a:ext cx="4317336" cy="4492"/>
              </a:xfrm>
              <a:custGeom>
                <a:avLst/>
                <a:gdLst>
                  <a:gd name="connsiteX0" fmla="*/ 0 w 4317336"/>
                  <a:gd name="connsiteY0" fmla="*/ 0 h 4492"/>
                  <a:gd name="connsiteX1" fmla="*/ 4317337 w 4317336"/>
                  <a:gd name="connsiteY1" fmla="*/ 0 h 449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4317336" h="4492">
                    <a:moveTo>
                      <a:pt x="0" y="0"/>
                    </a:moveTo>
                    <a:lnTo>
                      <a:pt x="4317337" y="0"/>
                    </a:lnTo>
                  </a:path>
                </a:pathLst>
              </a:custGeom>
              <a:noFill/>
              <a:ln w="4485" cap="flat">
                <a:solidFill>
                  <a:srgbClr val="A0A0A0"/>
                </a:solidFill>
                <a:custDash>
                  <a:ds d="75000" sp="75000"/>
                </a:custDash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75" name="フリーフォーム: 図形 374">
                <a:extLst>
                  <a:ext uri="{FF2B5EF4-FFF2-40B4-BE49-F238E27FC236}">
                    <a16:creationId xmlns:a16="http://schemas.microsoft.com/office/drawing/2014/main" id="{53091893-6991-D92A-FDC9-EA73BDFA92E2}"/>
                  </a:ext>
                </a:extLst>
              </p:cNvPr>
              <p:cNvSpPr/>
              <p:nvPr/>
            </p:nvSpPr>
            <p:spPr>
              <a:xfrm>
                <a:off x="1228078" y="1982295"/>
                <a:ext cx="4317336" cy="4492"/>
              </a:xfrm>
              <a:custGeom>
                <a:avLst/>
                <a:gdLst>
                  <a:gd name="connsiteX0" fmla="*/ 0 w 4317336"/>
                  <a:gd name="connsiteY0" fmla="*/ 0 h 4492"/>
                  <a:gd name="connsiteX1" fmla="*/ 4317337 w 4317336"/>
                  <a:gd name="connsiteY1" fmla="*/ 0 h 449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4317336" h="4492">
                    <a:moveTo>
                      <a:pt x="0" y="0"/>
                    </a:moveTo>
                    <a:lnTo>
                      <a:pt x="4317337" y="0"/>
                    </a:lnTo>
                  </a:path>
                </a:pathLst>
              </a:custGeom>
              <a:noFill/>
              <a:ln w="4485" cap="flat">
                <a:solidFill>
                  <a:srgbClr val="A0A0A0"/>
                </a:solidFill>
                <a:custDash>
                  <a:ds d="75000" sp="75000"/>
                </a:custDash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76" name="フリーフォーム: 図形 375">
                <a:extLst>
                  <a:ext uri="{FF2B5EF4-FFF2-40B4-BE49-F238E27FC236}">
                    <a16:creationId xmlns:a16="http://schemas.microsoft.com/office/drawing/2014/main" id="{621B1BBF-9583-15CB-EF7F-0D5448567CBB}"/>
                  </a:ext>
                </a:extLst>
              </p:cNvPr>
              <p:cNvSpPr/>
              <p:nvPr/>
            </p:nvSpPr>
            <p:spPr>
              <a:xfrm>
                <a:off x="1228078" y="2301289"/>
                <a:ext cx="4317336" cy="4492"/>
              </a:xfrm>
              <a:custGeom>
                <a:avLst/>
                <a:gdLst>
                  <a:gd name="connsiteX0" fmla="*/ 0 w 4317336"/>
                  <a:gd name="connsiteY0" fmla="*/ 0 h 4492"/>
                  <a:gd name="connsiteX1" fmla="*/ 4317337 w 4317336"/>
                  <a:gd name="connsiteY1" fmla="*/ 0 h 449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4317336" h="4492">
                    <a:moveTo>
                      <a:pt x="0" y="0"/>
                    </a:moveTo>
                    <a:lnTo>
                      <a:pt x="4317337" y="0"/>
                    </a:lnTo>
                  </a:path>
                </a:pathLst>
              </a:custGeom>
              <a:noFill/>
              <a:ln w="4485" cap="flat">
                <a:solidFill>
                  <a:srgbClr val="A0A0A0"/>
                </a:solidFill>
                <a:custDash>
                  <a:ds d="75000" sp="75000"/>
                </a:custDash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77" name="フリーフォーム: 図形 376">
                <a:extLst>
                  <a:ext uri="{FF2B5EF4-FFF2-40B4-BE49-F238E27FC236}">
                    <a16:creationId xmlns:a16="http://schemas.microsoft.com/office/drawing/2014/main" id="{8C85BCA3-6FFF-D361-8F1A-7078FEAEA95F}"/>
                  </a:ext>
                </a:extLst>
              </p:cNvPr>
              <p:cNvSpPr/>
              <p:nvPr/>
            </p:nvSpPr>
            <p:spPr>
              <a:xfrm>
                <a:off x="1228078" y="2615790"/>
                <a:ext cx="4317336" cy="4492"/>
              </a:xfrm>
              <a:custGeom>
                <a:avLst/>
                <a:gdLst>
                  <a:gd name="connsiteX0" fmla="*/ 0 w 4317336"/>
                  <a:gd name="connsiteY0" fmla="*/ 0 h 4492"/>
                  <a:gd name="connsiteX1" fmla="*/ 4317337 w 4317336"/>
                  <a:gd name="connsiteY1" fmla="*/ 0 h 449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4317336" h="4492">
                    <a:moveTo>
                      <a:pt x="0" y="0"/>
                    </a:moveTo>
                    <a:lnTo>
                      <a:pt x="4317337" y="0"/>
                    </a:lnTo>
                  </a:path>
                </a:pathLst>
              </a:custGeom>
              <a:noFill/>
              <a:ln w="4485" cap="flat">
                <a:solidFill>
                  <a:srgbClr val="A0A0A0"/>
                </a:solidFill>
                <a:custDash>
                  <a:ds d="75000" sp="75000"/>
                </a:custDash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78" name="フリーフォーム: 図形 377">
                <a:extLst>
                  <a:ext uri="{FF2B5EF4-FFF2-40B4-BE49-F238E27FC236}">
                    <a16:creationId xmlns:a16="http://schemas.microsoft.com/office/drawing/2014/main" id="{C4B7337A-33D0-F1AB-7BDC-2521002F62DD}"/>
                  </a:ext>
                </a:extLst>
              </p:cNvPr>
              <p:cNvSpPr/>
              <p:nvPr/>
            </p:nvSpPr>
            <p:spPr>
              <a:xfrm>
                <a:off x="1228078" y="2934784"/>
                <a:ext cx="4317336" cy="4492"/>
              </a:xfrm>
              <a:custGeom>
                <a:avLst/>
                <a:gdLst>
                  <a:gd name="connsiteX0" fmla="*/ 0 w 4317336"/>
                  <a:gd name="connsiteY0" fmla="*/ 0 h 4492"/>
                  <a:gd name="connsiteX1" fmla="*/ 4317337 w 4317336"/>
                  <a:gd name="connsiteY1" fmla="*/ 0 h 449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4317336" h="4492">
                    <a:moveTo>
                      <a:pt x="0" y="0"/>
                    </a:moveTo>
                    <a:lnTo>
                      <a:pt x="4317337" y="0"/>
                    </a:lnTo>
                  </a:path>
                </a:pathLst>
              </a:custGeom>
              <a:noFill/>
              <a:ln w="4485" cap="flat">
                <a:solidFill>
                  <a:srgbClr val="A0A0A0"/>
                </a:solidFill>
                <a:custDash>
                  <a:ds d="75000" sp="75000"/>
                </a:custDash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79" name="フリーフォーム: 図形 378">
                <a:extLst>
                  <a:ext uri="{FF2B5EF4-FFF2-40B4-BE49-F238E27FC236}">
                    <a16:creationId xmlns:a16="http://schemas.microsoft.com/office/drawing/2014/main" id="{6A1D82BB-EC4F-9F80-E79F-BF7397955C87}"/>
                  </a:ext>
                </a:extLst>
              </p:cNvPr>
              <p:cNvSpPr/>
              <p:nvPr/>
            </p:nvSpPr>
            <p:spPr>
              <a:xfrm>
                <a:off x="1228078" y="3253778"/>
                <a:ext cx="4317336" cy="4492"/>
              </a:xfrm>
              <a:custGeom>
                <a:avLst/>
                <a:gdLst>
                  <a:gd name="connsiteX0" fmla="*/ 0 w 4317336"/>
                  <a:gd name="connsiteY0" fmla="*/ 0 h 4492"/>
                  <a:gd name="connsiteX1" fmla="*/ 4317337 w 4317336"/>
                  <a:gd name="connsiteY1" fmla="*/ 0 h 449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4317336" h="4492">
                    <a:moveTo>
                      <a:pt x="0" y="0"/>
                    </a:moveTo>
                    <a:lnTo>
                      <a:pt x="4317337" y="0"/>
                    </a:lnTo>
                  </a:path>
                </a:pathLst>
              </a:custGeom>
              <a:noFill/>
              <a:ln w="4485" cap="flat">
                <a:solidFill>
                  <a:srgbClr val="A0A0A0"/>
                </a:solidFill>
                <a:custDash>
                  <a:ds d="75000" sp="75000"/>
                </a:custDash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80" name="フリーフォーム: 図形 379">
                <a:extLst>
                  <a:ext uri="{FF2B5EF4-FFF2-40B4-BE49-F238E27FC236}">
                    <a16:creationId xmlns:a16="http://schemas.microsoft.com/office/drawing/2014/main" id="{5EF33886-166D-A89B-8A7E-D455A90C4FA4}"/>
                  </a:ext>
                </a:extLst>
              </p:cNvPr>
              <p:cNvSpPr/>
              <p:nvPr/>
            </p:nvSpPr>
            <p:spPr>
              <a:xfrm>
                <a:off x="1228078" y="3572771"/>
                <a:ext cx="4317336" cy="4492"/>
              </a:xfrm>
              <a:custGeom>
                <a:avLst/>
                <a:gdLst>
                  <a:gd name="connsiteX0" fmla="*/ 0 w 4317336"/>
                  <a:gd name="connsiteY0" fmla="*/ 0 h 4492"/>
                  <a:gd name="connsiteX1" fmla="*/ 4317337 w 4317336"/>
                  <a:gd name="connsiteY1" fmla="*/ 0 h 449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4317336" h="4492">
                    <a:moveTo>
                      <a:pt x="0" y="0"/>
                    </a:moveTo>
                    <a:lnTo>
                      <a:pt x="4317337" y="0"/>
                    </a:lnTo>
                  </a:path>
                </a:pathLst>
              </a:custGeom>
              <a:noFill/>
              <a:ln w="4485" cap="flat">
                <a:solidFill>
                  <a:srgbClr val="A0A0A0"/>
                </a:solidFill>
                <a:custDash>
                  <a:ds d="75000" sp="75000"/>
                </a:custDash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81" name="フリーフォーム: 図形 380">
                <a:extLst>
                  <a:ext uri="{FF2B5EF4-FFF2-40B4-BE49-F238E27FC236}">
                    <a16:creationId xmlns:a16="http://schemas.microsoft.com/office/drawing/2014/main" id="{D9D64378-5320-9030-B52E-4D651211D3BC}"/>
                  </a:ext>
                </a:extLst>
              </p:cNvPr>
              <p:cNvSpPr/>
              <p:nvPr/>
            </p:nvSpPr>
            <p:spPr>
              <a:xfrm>
                <a:off x="1228078" y="3891765"/>
                <a:ext cx="4317336" cy="4492"/>
              </a:xfrm>
              <a:custGeom>
                <a:avLst/>
                <a:gdLst>
                  <a:gd name="connsiteX0" fmla="*/ 0 w 4317336"/>
                  <a:gd name="connsiteY0" fmla="*/ 0 h 4492"/>
                  <a:gd name="connsiteX1" fmla="*/ 4317337 w 4317336"/>
                  <a:gd name="connsiteY1" fmla="*/ 0 h 449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4317336" h="4492">
                    <a:moveTo>
                      <a:pt x="0" y="0"/>
                    </a:moveTo>
                    <a:lnTo>
                      <a:pt x="4317337" y="0"/>
                    </a:lnTo>
                  </a:path>
                </a:pathLst>
              </a:custGeom>
              <a:noFill/>
              <a:ln w="4485" cap="flat">
                <a:solidFill>
                  <a:srgbClr val="A0A0A0"/>
                </a:solidFill>
                <a:custDash>
                  <a:ds d="75000" sp="75000"/>
                </a:custDash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82" name="フリーフォーム: 図形 381">
                <a:extLst>
                  <a:ext uri="{FF2B5EF4-FFF2-40B4-BE49-F238E27FC236}">
                    <a16:creationId xmlns:a16="http://schemas.microsoft.com/office/drawing/2014/main" id="{BCA5FE87-B563-43D3-BB0E-CA906AB307B4}"/>
                  </a:ext>
                </a:extLst>
              </p:cNvPr>
              <p:cNvSpPr/>
              <p:nvPr/>
            </p:nvSpPr>
            <p:spPr>
              <a:xfrm>
                <a:off x="1228078" y="4206266"/>
                <a:ext cx="4317336" cy="4492"/>
              </a:xfrm>
              <a:custGeom>
                <a:avLst/>
                <a:gdLst>
                  <a:gd name="connsiteX0" fmla="*/ 0 w 4317336"/>
                  <a:gd name="connsiteY0" fmla="*/ 0 h 4492"/>
                  <a:gd name="connsiteX1" fmla="*/ 4317337 w 4317336"/>
                  <a:gd name="connsiteY1" fmla="*/ 0 h 449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4317336" h="4492">
                    <a:moveTo>
                      <a:pt x="0" y="0"/>
                    </a:moveTo>
                    <a:lnTo>
                      <a:pt x="4317337" y="0"/>
                    </a:lnTo>
                  </a:path>
                </a:pathLst>
              </a:custGeom>
              <a:noFill/>
              <a:ln w="4485" cap="flat">
                <a:solidFill>
                  <a:srgbClr val="A0A0A0"/>
                </a:solidFill>
                <a:custDash>
                  <a:ds d="75000" sp="75000"/>
                </a:custDash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83" name="フリーフォーム: 図形 382">
                <a:extLst>
                  <a:ext uri="{FF2B5EF4-FFF2-40B4-BE49-F238E27FC236}">
                    <a16:creationId xmlns:a16="http://schemas.microsoft.com/office/drawing/2014/main" id="{9D432C90-208C-FB01-49F4-641BBB8D4E7B}"/>
                  </a:ext>
                </a:extLst>
              </p:cNvPr>
              <p:cNvSpPr/>
              <p:nvPr/>
            </p:nvSpPr>
            <p:spPr>
              <a:xfrm>
                <a:off x="1228078" y="4525260"/>
                <a:ext cx="4317336" cy="4492"/>
              </a:xfrm>
              <a:custGeom>
                <a:avLst/>
                <a:gdLst>
                  <a:gd name="connsiteX0" fmla="*/ 0 w 4317336"/>
                  <a:gd name="connsiteY0" fmla="*/ 0 h 4492"/>
                  <a:gd name="connsiteX1" fmla="*/ 4317337 w 4317336"/>
                  <a:gd name="connsiteY1" fmla="*/ 0 h 449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4317336" h="4492">
                    <a:moveTo>
                      <a:pt x="0" y="0"/>
                    </a:moveTo>
                    <a:lnTo>
                      <a:pt x="4317337" y="0"/>
                    </a:lnTo>
                  </a:path>
                </a:pathLst>
              </a:custGeom>
              <a:noFill/>
              <a:ln w="4485" cap="flat">
                <a:solidFill>
                  <a:srgbClr val="A0A0A0"/>
                </a:solidFill>
                <a:custDash>
                  <a:ds d="75000" sp="75000"/>
                </a:custDash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84" name="フリーフォーム: 図形 383">
                <a:extLst>
                  <a:ext uri="{FF2B5EF4-FFF2-40B4-BE49-F238E27FC236}">
                    <a16:creationId xmlns:a16="http://schemas.microsoft.com/office/drawing/2014/main" id="{3099469E-A072-D472-B108-C1C55C8DDC58}"/>
                  </a:ext>
                </a:extLst>
              </p:cNvPr>
              <p:cNvSpPr/>
              <p:nvPr/>
            </p:nvSpPr>
            <p:spPr>
              <a:xfrm>
                <a:off x="1228078" y="4844254"/>
                <a:ext cx="4317336" cy="4492"/>
              </a:xfrm>
              <a:custGeom>
                <a:avLst/>
                <a:gdLst>
                  <a:gd name="connsiteX0" fmla="*/ 0 w 4317336"/>
                  <a:gd name="connsiteY0" fmla="*/ 0 h 4492"/>
                  <a:gd name="connsiteX1" fmla="*/ 4317337 w 4317336"/>
                  <a:gd name="connsiteY1" fmla="*/ 0 h 449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4317336" h="4492">
                    <a:moveTo>
                      <a:pt x="0" y="0"/>
                    </a:moveTo>
                    <a:lnTo>
                      <a:pt x="4317337" y="0"/>
                    </a:lnTo>
                  </a:path>
                </a:pathLst>
              </a:custGeom>
              <a:noFill/>
              <a:ln w="4485" cap="flat">
                <a:solidFill>
                  <a:srgbClr val="A0A0A0"/>
                </a:solidFill>
                <a:custDash>
                  <a:ds d="75000" sp="75000"/>
                </a:custDash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</p:grpSp>
        <p:grpSp>
          <p:nvGrpSpPr>
            <p:cNvPr id="257" name="グラフィックス 3">
              <a:extLst>
                <a:ext uri="{FF2B5EF4-FFF2-40B4-BE49-F238E27FC236}">
                  <a16:creationId xmlns:a16="http://schemas.microsoft.com/office/drawing/2014/main" id="{21CA9164-2780-30DA-1922-37CBC9778B61}"/>
                </a:ext>
              </a:extLst>
            </p:cNvPr>
            <p:cNvGrpSpPr/>
            <p:nvPr/>
          </p:nvGrpSpPr>
          <p:grpSpPr>
            <a:xfrm>
              <a:off x="1133735" y="1663301"/>
              <a:ext cx="94343" cy="3180952"/>
              <a:chOff x="1133735" y="1663301"/>
              <a:chExt cx="94343" cy="3180952"/>
            </a:xfrm>
            <a:noFill/>
          </p:grpSpPr>
          <p:sp>
            <p:nvSpPr>
              <p:cNvPr id="363" name="フリーフォーム: 図形 362">
                <a:extLst>
                  <a:ext uri="{FF2B5EF4-FFF2-40B4-BE49-F238E27FC236}">
                    <a16:creationId xmlns:a16="http://schemas.microsoft.com/office/drawing/2014/main" id="{109249F2-33B7-4D98-0BCA-EC4051A3DB4E}"/>
                  </a:ext>
                </a:extLst>
              </p:cNvPr>
              <p:cNvSpPr/>
              <p:nvPr/>
            </p:nvSpPr>
            <p:spPr>
              <a:xfrm>
                <a:off x="1133735" y="1663301"/>
                <a:ext cx="94343" cy="4492"/>
              </a:xfrm>
              <a:custGeom>
                <a:avLst/>
                <a:gdLst>
                  <a:gd name="connsiteX0" fmla="*/ 0 w 94343"/>
                  <a:gd name="connsiteY0" fmla="*/ 0 h 4492"/>
                  <a:gd name="connsiteX1" fmla="*/ 94343 w 94343"/>
                  <a:gd name="connsiteY1" fmla="*/ 0 h 449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94343" h="4492">
                    <a:moveTo>
                      <a:pt x="0" y="0"/>
                    </a:moveTo>
                    <a:lnTo>
                      <a:pt x="94343" y="0"/>
                    </a:lnTo>
                  </a:path>
                </a:pathLst>
              </a:custGeom>
              <a:noFill/>
              <a:ln w="12227" cap="flat">
                <a:solidFill>
                  <a:srgbClr val="40404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64" name="フリーフォーム: 図形 363">
                <a:extLst>
                  <a:ext uri="{FF2B5EF4-FFF2-40B4-BE49-F238E27FC236}">
                    <a16:creationId xmlns:a16="http://schemas.microsoft.com/office/drawing/2014/main" id="{D566D1B5-FA68-6182-AD95-A8C246D3E048}"/>
                  </a:ext>
                </a:extLst>
              </p:cNvPr>
              <p:cNvSpPr/>
              <p:nvPr/>
            </p:nvSpPr>
            <p:spPr>
              <a:xfrm>
                <a:off x="1133735" y="1982295"/>
                <a:ext cx="94343" cy="4492"/>
              </a:xfrm>
              <a:custGeom>
                <a:avLst/>
                <a:gdLst>
                  <a:gd name="connsiteX0" fmla="*/ 0 w 94343"/>
                  <a:gd name="connsiteY0" fmla="*/ 0 h 4492"/>
                  <a:gd name="connsiteX1" fmla="*/ 94343 w 94343"/>
                  <a:gd name="connsiteY1" fmla="*/ 0 h 449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94343" h="4492">
                    <a:moveTo>
                      <a:pt x="0" y="0"/>
                    </a:moveTo>
                    <a:lnTo>
                      <a:pt x="94343" y="0"/>
                    </a:lnTo>
                  </a:path>
                </a:pathLst>
              </a:custGeom>
              <a:noFill/>
              <a:ln w="12227" cap="flat">
                <a:solidFill>
                  <a:srgbClr val="40404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65" name="フリーフォーム: 図形 364">
                <a:extLst>
                  <a:ext uri="{FF2B5EF4-FFF2-40B4-BE49-F238E27FC236}">
                    <a16:creationId xmlns:a16="http://schemas.microsoft.com/office/drawing/2014/main" id="{B7F76BC1-681C-1F2B-B13A-D9A69B2CDF00}"/>
                  </a:ext>
                </a:extLst>
              </p:cNvPr>
              <p:cNvSpPr/>
              <p:nvPr/>
            </p:nvSpPr>
            <p:spPr>
              <a:xfrm>
                <a:off x="1133735" y="2301289"/>
                <a:ext cx="94343" cy="4492"/>
              </a:xfrm>
              <a:custGeom>
                <a:avLst/>
                <a:gdLst>
                  <a:gd name="connsiteX0" fmla="*/ 0 w 94343"/>
                  <a:gd name="connsiteY0" fmla="*/ 0 h 4492"/>
                  <a:gd name="connsiteX1" fmla="*/ 94343 w 94343"/>
                  <a:gd name="connsiteY1" fmla="*/ 0 h 449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94343" h="4492">
                    <a:moveTo>
                      <a:pt x="0" y="0"/>
                    </a:moveTo>
                    <a:lnTo>
                      <a:pt x="94343" y="0"/>
                    </a:lnTo>
                  </a:path>
                </a:pathLst>
              </a:custGeom>
              <a:noFill/>
              <a:ln w="12227" cap="flat">
                <a:solidFill>
                  <a:srgbClr val="40404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66" name="フリーフォーム: 図形 365">
                <a:extLst>
                  <a:ext uri="{FF2B5EF4-FFF2-40B4-BE49-F238E27FC236}">
                    <a16:creationId xmlns:a16="http://schemas.microsoft.com/office/drawing/2014/main" id="{EA4FA784-B041-6521-F438-B169091468D3}"/>
                  </a:ext>
                </a:extLst>
              </p:cNvPr>
              <p:cNvSpPr/>
              <p:nvPr/>
            </p:nvSpPr>
            <p:spPr>
              <a:xfrm>
                <a:off x="1133735" y="2615790"/>
                <a:ext cx="94343" cy="4492"/>
              </a:xfrm>
              <a:custGeom>
                <a:avLst/>
                <a:gdLst>
                  <a:gd name="connsiteX0" fmla="*/ 0 w 94343"/>
                  <a:gd name="connsiteY0" fmla="*/ 0 h 4492"/>
                  <a:gd name="connsiteX1" fmla="*/ 94343 w 94343"/>
                  <a:gd name="connsiteY1" fmla="*/ 0 h 449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94343" h="4492">
                    <a:moveTo>
                      <a:pt x="0" y="0"/>
                    </a:moveTo>
                    <a:lnTo>
                      <a:pt x="94343" y="0"/>
                    </a:lnTo>
                  </a:path>
                </a:pathLst>
              </a:custGeom>
              <a:noFill/>
              <a:ln w="12227" cap="flat">
                <a:solidFill>
                  <a:srgbClr val="40404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67" name="フリーフォーム: 図形 366">
                <a:extLst>
                  <a:ext uri="{FF2B5EF4-FFF2-40B4-BE49-F238E27FC236}">
                    <a16:creationId xmlns:a16="http://schemas.microsoft.com/office/drawing/2014/main" id="{6346520B-78ED-0BF7-49D5-56465107E800}"/>
                  </a:ext>
                </a:extLst>
              </p:cNvPr>
              <p:cNvSpPr/>
              <p:nvPr/>
            </p:nvSpPr>
            <p:spPr>
              <a:xfrm>
                <a:off x="1133735" y="2934784"/>
                <a:ext cx="94343" cy="4492"/>
              </a:xfrm>
              <a:custGeom>
                <a:avLst/>
                <a:gdLst>
                  <a:gd name="connsiteX0" fmla="*/ 0 w 94343"/>
                  <a:gd name="connsiteY0" fmla="*/ 0 h 4492"/>
                  <a:gd name="connsiteX1" fmla="*/ 94343 w 94343"/>
                  <a:gd name="connsiteY1" fmla="*/ 0 h 449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94343" h="4492">
                    <a:moveTo>
                      <a:pt x="0" y="0"/>
                    </a:moveTo>
                    <a:lnTo>
                      <a:pt x="94343" y="0"/>
                    </a:lnTo>
                  </a:path>
                </a:pathLst>
              </a:custGeom>
              <a:noFill/>
              <a:ln w="12227" cap="flat">
                <a:solidFill>
                  <a:srgbClr val="40404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68" name="フリーフォーム: 図形 367">
                <a:extLst>
                  <a:ext uri="{FF2B5EF4-FFF2-40B4-BE49-F238E27FC236}">
                    <a16:creationId xmlns:a16="http://schemas.microsoft.com/office/drawing/2014/main" id="{4838A847-7F0B-C7EE-9CDC-A8B7C3A526BE}"/>
                  </a:ext>
                </a:extLst>
              </p:cNvPr>
              <p:cNvSpPr/>
              <p:nvPr/>
            </p:nvSpPr>
            <p:spPr>
              <a:xfrm>
                <a:off x="1133735" y="3253778"/>
                <a:ext cx="94343" cy="4492"/>
              </a:xfrm>
              <a:custGeom>
                <a:avLst/>
                <a:gdLst>
                  <a:gd name="connsiteX0" fmla="*/ 0 w 94343"/>
                  <a:gd name="connsiteY0" fmla="*/ 0 h 4492"/>
                  <a:gd name="connsiteX1" fmla="*/ 94343 w 94343"/>
                  <a:gd name="connsiteY1" fmla="*/ 0 h 449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94343" h="4492">
                    <a:moveTo>
                      <a:pt x="0" y="0"/>
                    </a:moveTo>
                    <a:lnTo>
                      <a:pt x="94343" y="0"/>
                    </a:lnTo>
                  </a:path>
                </a:pathLst>
              </a:custGeom>
              <a:noFill/>
              <a:ln w="12227" cap="flat">
                <a:solidFill>
                  <a:srgbClr val="40404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69" name="フリーフォーム: 図形 368">
                <a:extLst>
                  <a:ext uri="{FF2B5EF4-FFF2-40B4-BE49-F238E27FC236}">
                    <a16:creationId xmlns:a16="http://schemas.microsoft.com/office/drawing/2014/main" id="{9E952DD2-9EC0-D9CE-642F-B36228C6A02B}"/>
                  </a:ext>
                </a:extLst>
              </p:cNvPr>
              <p:cNvSpPr/>
              <p:nvPr/>
            </p:nvSpPr>
            <p:spPr>
              <a:xfrm>
                <a:off x="1133735" y="3572771"/>
                <a:ext cx="94343" cy="4492"/>
              </a:xfrm>
              <a:custGeom>
                <a:avLst/>
                <a:gdLst>
                  <a:gd name="connsiteX0" fmla="*/ 0 w 94343"/>
                  <a:gd name="connsiteY0" fmla="*/ 0 h 4492"/>
                  <a:gd name="connsiteX1" fmla="*/ 94343 w 94343"/>
                  <a:gd name="connsiteY1" fmla="*/ 0 h 449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94343" h="4492">
                    <a:moveTo>
                      <a:pt x="0" y="0"/>
                    </a:moveTo>
                    <a:lnTo>
                      <a:pt x="94343" y="0"/>
                    </a:lnTo>
                  </a:path>
                </a:pathLst>
              </a:custGeom>
              <a:noFill/>
              <a:ln w="12227" cap="flat">
                <a:solidFill>
                  <a:srgbClr val="40404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70" name="フリーフォーム: 図形 369">
                <a:extLst>
                  <a:ext uri="{FF2B5EF4-FFF2-40B4-BE49-F238E27FC236}">
                    <a16:creationId xmlns:a16="http://schemas.microsoft.com/office/drawing/2014/main" id="{B0F026E9-6C3B-F724-45DC-1327F536CA3C}"/>
                  </a:ext>
                </a:extLst>
              </p:cNvPr>
              <p:cNvSpPr/>
              <p:nvPr/>
            </p:nvSpPr>
            <p:spPr>
              <a:xfrm>
                <a:off x="1133735" y="3891765"/>
                <a:ext cx="94343" cy="4492"/>
              </a:xfrm>
              <a:custGeom>
                <a:avLst/>
                <a:gdLst>
                  <a:gd name="connsiteX0" fmla="*/ 0 w 94343"/>
                  <a:gd name="connsiteY0" fmla="*/ 0 h 4492"/>
                  <a:gd name="connsiteX1" fmla="*/ 94343 w 94343"/>
                  <a:gd name="connsiteY1" fmla="*/ 0 h 449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94343" h="4492">
                    <a:moveTo>
                      <a:pt x="0" y="0"/>
                    </a:moveTo>
                    <a:lnTo>
                      <a:pt x="94343" y="0"/>
                    </a:lnTo>
                  </a:path>
                </a:pathLst>
              </a:custGeom>
              <a:noFill/>
              <a:ln w="12227" cap="flat">
                <a:solidFill>
                  <a:srgbClr val="40404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71" name="フリーフォーム: 図形 370">
                <a:extLst>
                  <a:ext uri="{FF2B5EF4-FFF2-40B4-BE49-F238E27FC236}">
                    <a16:creationId xmlns:a16="http://schemas.microsoft.com/office/drawing/2014/main" id="{0735D108-73E7-7CA4-C143-B60C1C790900}"/>
                  </a:ext>
                </a:extLst>
              </p:cNvPr>
              <p:cNvSpPr/>
              <p:nvPr/>
            </p:nvSpPr>
            <p:spPr>
              <a:xfrm>
                <a:off x="1133735" y="4206266"/>
                <a:ext cx="94343" cy="4492"/>
              </a:xfrm>
              <a:custGeom>
                <a:avLst/>
                <a:gdLst>
                  <a:gd name="connsiteX0" fmla="*/ 0 w 94343"/>
                  <a:gd name="connsiteY0" fmla="*/ 0 h 4492"/>
                  <a:gd name="connsiteX1" fmla="*/ 94343 w 94343"/>
                  <a:gd name="connsiteY1" fmla="*/ 0 h 449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94343" h="4492">
                    <a:moveTo>
                      <a:pt x="0" y="0"/>
                    </a:moveTo>
                    <a:lnTo>
                      <a:pt x="94343" y="0"/>
                    </a:lnTo>
                  </a:path>
                </a:pathLst>
              </a:custGeom>
              <a:noFill/>
              <a:ln w="12227" cap="flat">
                <a:solidFill>
                  <a:srgbClr val="40404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72" name="フリーフォーム: 図形 371">
                <a:extLst>
                  <a:ext uri="{FF2B5EF4-FFF2-40B4-BE49-F238E27FC236}">
                    <a16:creationId xmlns:a16="http://schemas.microsoft.com/office/drawing/2014/main" id="{DC6D095F-E4D2-93C7-E4F6-4538BDAA190D}"/>
                  </a:ext>
                </a:extLst>
              </p:cNvPr>
              <p:cNvSpPr/>
              <p:nvPr/>
            </p:nvSpPr>
            <p:spPr>
              <a:xfrm>
                <a:off x="1133735" y="4525260"/>
                <a:ext cx="94343" cy="4492"/>
              </a:xfrm>
              <a:custGeom>
                <a:avLst/>
                <a:gdLst>
                  <a:gd name="connsiteX0" fmla="*/ 0 w 94343"/>
                  <a:gd name="connsiteY0" fmla="*/ 0 h 4492"/>
                  <a:gd name="connsiteX1" fmla="*/ 94343 w 94343"/>
                  <a:gd name="connsiteY1" fmla="*/ 0 h 449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94343" h="4492">
                    <a:moveTo>
                      <a:pt x="0" y="0"/>
                    </a:moveTo>
                    <a:lnTo>
                      <a:pt x="94343" y="0"/>
                    </a:lnTo>
                  </a:path>
                </a:pathLst>
              </a:custGeom>
              <a:noFill/>
              <a:ln w="12227" cap="flat">
                <a:solidFill>
                  <a:srgbClr val="40404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73" name="フリーフォーム: 図形 372">
                <a:extLst>
                  <a:ext uri="{FF2B5EF4-FFF2-40B4-BE49-F238E27FC236}">
                    <a16:creationId xmlns:a16="http://schemas.microsoft.com/office/drawing/2014/main" id="{A6BAB9E1-CB20-427A-B5F3-1C24F8F41E67}"/>
                  </a:ext>
                </a:extLst>
              </p:cNvPr>
              <p:cNvSpPr/>
              <p:nvPr/>
            </p:nvSpPr>
            <p:spPr>
              <a:xfrm>
                <a:off x="1133735" y="4844254"/>
                <a:ext cx="94343" cy="4492"/>
              </a:xfrm>
              <a:custGeom>
                <a:avLst/>
                <a:gdLst>
                  <a:gd name="connsiteX0" fmla="*/ 0 w 94343"/>
                  <a:gd name="connsiteY0" fmla="*/ 0 h 4492"/>
                  <a:gd name="connsiteX1" fmla="*/ 94343 w 94343"/>
                  <a:gd name="connsiteY1" fmla="*/ 0 h 449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94343" h="4492">
                    <a:moveTo>
                      <a:pt x="0" y="0"/>
                    </a:moveTo>
                    <a:lnTo>
                      <a:pt x="94343" y="0"/>
                    </a:lnTo>
                  </a:path>
                </a:pathLst>
              </a:custGeom>
              <a:noFill/>
              <a:ln w="12227" cap="flat">
                <a:solidFill>
                  <a:srgbClr val="40404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</p:grpSp>
        <p:grpSp>
          <p:nvGrpSpPr>
            <p:cNvPr id="258" name="グラフィックス 3">
              <a:extLst>
                <a:ext uri="{FF2B5EF4-FFF2-40B4-BE49-F238E27FC236}">
                  <a16:creationId xmlns:a16="http://schemas.microsoft.com/office/drawing/2014/main" id="{54395728-F25E-2AA1-5626-D61079D42BC9}"/>
                </a:ext>
              </a:extLst>
            </p:cNvPr>
            <p:cNvGrpSpPr/>
            <p:nvPr/>
          </p:nvGrpSpPr>
          <p:grpSpPr>
            <a:xfrm>
              <a:off x="1133735" y="1820552"/>
              <a:ext cx="49418" cy="2866451"/>
              <a:chOff x="1133735" y="1820552"/>
              <a:chExt cx="49418" cy="2866451"/>
            </a:xfrm>
            <a:noFill/>
          </p:grpSpPr>
          <p:sp>
            <p:nvSpPr>
              <p:cNvPr id="353" name="フリーフォーム: 図形 352">
                <a:extLst>
                  <a:ext uri="{FF2B5EF4-FFF2-40B4-BE49-F238E27FC236}">
                    <a16:creationId xmlns:a16="http://schemas.microsoft.com/office/drawing/2014/main" id="{488F91BA-3BBD-520E-D5A8-10E521E4F0A5}"/>
                  </a:ext>
                </a:extLst>
              </p:cNvPr>
              <p:cNvSpPr/>
              <p:nvPr/>
            </p:nvSpPr>
            <p:spPr>
              <a:xfrm>
                <a:off x="1133735" y="1820552"/>
                <a:ext cx="49418" cy="4492"/>
              </a:xfrm>
              <a:custGeom>
                <a:avLst/>
                <a:gdLst>
                  <a:gd name="connsiteX0" fmla="*/ 0 w 49418"/>
                  <a:gd name="connsiteY0" fmla="*/ 0 h 4492"/>
                  <a:gd name="connsiteX1" fmla="*/ 49418 w 49418"/>
                  <a:gd name="connsiteY1" fmla="*/ 0 h 449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49418" h="4492">
                    <a:moveTo>
                      <a:pt x="0" y="0"/>
                    </a:moveTo>
                    <a:lnTo>
                      <a:pt x="49418" y="0"/>
                    </a:lnTo>
                  </a:path>
                </a:pathLst>
              </a:custGeom>
              <a:noFill/>
              <a:ln w="8151" cap="flat">
                <a:solidFill>
                  <a:srgbClr val="40404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54" name="フリーフォーム: 図形 353">
                <a:extLst>
                  <a:ext uri="{FF2B5EF4-FFF2-40B4-BE49-F238E27FC236}">
                    <a16:creationId xmlns:a16="http://schemas.microsoft.com/office/drawing/2014/main" id="{109267BD-6F47-8BFA-3F5F-4FA5F32A943E}"/>
                  </a:ext>
                </a:extLst>
              </p:cNvPr>
              <p:cNvSpPr/>
              <p:nvPr/>
            </p:nvSpPr>
            <p:spPr>
              <a:xfrm>
                <a:off x="1133735" y="2139545"/>
                <a:ext cx="49418" cy="4492"/>
              </a:xfrm>
              <a:custGeom>
                <a:avLst/>
                <a:gdLst>
                  <a:gd name="connsiteX0" fmla="*/ 0 w 49418"/>
                  <a:gd name="connsiteY0" fmla="*/ 0 h 4492"/>
                  <a:gd name="connsiteX1" fmla="*/ 49418 w 49418"/>
                  <a:gd name="connsiteY1" fmla="*/ 0 h 449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49418" h="4492">
                    <a:moveTo>
                      <a:pt x="0" y="0"/>
                    </a:moveTo>
                    <a:lnTo>
                      <a:pt x="49418" y="0"/>
                    </a:lnTo>
                  </a:path>
                </a:pathLst>
              </a:custGeom>
              <a:noFill/>
              <a:ln w="8151" cap="flat">
                <a:solidFill>
                  <a:srgbClr val="40404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55" name="フリーフォーム: 図形 354">
                <a:extLst>
                  <a:ext uri="{FF2B5EF4-FFF2-40B4-BE49-F238E27FC236}">
                    <a16:creationId xmlns:a16="http://schemas.microsoft.com/office/drawing/2014/main" id="{78645B83-72FC-37E9-3683-6C411F5645D6}"/>
                  </a:ext>
                </a:extLst>
              </p:cNvPr>
              <p:cNvSpPr/>
              <p:nvPr/>
            </p:nvSpPr>
            <p:spPr>
              <a:xfrm>
                <a:off x="1133735" y="2458539"/>
                <a:ext cx="49418" cy="4492"/>
              </a:xfrm>
              <a:custGeom>
                <a:avLst/>
                <a:gdLst>
                  <a:gd name="connsiteX0" fmla="*/ 0 w 49418"/>
                  <a:gd name="connsiteY0" fmla="*/ 0 h 4492"/>
                  <a:gd name="connsiteX1" fmla="*/ 49418 w 49418"/>
                  <a:gd name="connsiteY1" fmla="*/ 0 h 449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49418" h="4492">
                    <a:moveTo>
                      <a:pt x="0" y="0"/>
                    </a:moveTo>
                    <a:lnTo>
                      <a:pt x="49418" y="0"/>
                    </a:lnTo>
                  </a:path>
                </a:pathLst>
              </a:custGeom>
              <a:noFill/>
              <a:ln w="8151" cap="flat">
                <a:solidFill>
                  <a:srgbClr val="40404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56" name="フリーフォーム: 図形 355">
                <a:extLst>
                  <a:ext uri="{FF2B5EF4-FFF2-40B4-BE49-F238E27FC236}">
                    <a16:creationId xmlns:a16="http://schemas.microsoft.com/office/drawing/2014/main" id="{12A1298B-DD15-68D5-12B5-F27A5B8FA30F}"/>
                  </a:ext>
                </a:extLst>
              </p:cNvPr>
              <p:cNvSpPr/>
              <p:nvPr/>
            </p:nvSpPr>
            <p:spPr>
              <a:xfrm>
                <a:off x="1133735" y="2777533"/>
                <a:ext cx="49418" cy="4492"/>
              </a:xfrm>
              <a:custGeom>
                <a:avLst/>
                <a:gdLst>
                  <a:gd name="connsiteX0" fmla="*/ 0 w 49418"/>
                  <a:gd name="connsiteY0" fmla="*/ 0 h 4492"/>
                  <a:gd name="connsiteX1" fmla="*/ 49418 w 49418"/>
                  <a:gd name="connsiteY1" fmla="*/ 0 h 449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49418" h="4492">
                    <a:moveTo>
                      <a:pt x="0" y="0"/>
                    </a:moveTo>
                    <a:lnTo>
                      <a:pt x="49418" y="0"/>
                    </a:lnTo>
                  </a:path>
                </a:pathLst>
              </a:custGeom>
              <a:noFill/>
              <a:ln w="8151" cap="flat">
                <a:solidFill>
                  <a:srgbClr val="40404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57" name="フリーフォーム: 図形 356">
                <a:extLst>
                  <a:ext uri="{FF2B5EF4-FFF2-40B4-BE49-F238E27FC236}">
                    <a16:creationId xmlns:a16="http://schemas.microsoft.com/office/drawing/2014/main" id="{B6F365D9-7C39-D365-8F95-204995C1582B}"/>
                  </a:ext>
                </a:extLst>
              </p:cNvPr>
              <p:cNvSpPr/>
              <p:nvPr/>
            </p:nvSpPr>
            <p:spPr>
              <a:xfrm>
                <a:off x="1133735" y="3096527"/>
                <a:ext cx="49418" cy="4492"/>
              </a:xfrm>
              <a:custGeom>
                <a:avLst/>
                <a:gdLst>
                  <a:gd name="connsiteX0" fmla="*/ 0 w 49418"/>
                  <a:gd name="connsiteY0" fmla="*/ 0 h 4492"/>
                  <a:gd name="connsiteX1" fmla="*/ 49418 w 49418"/>
                  <a:gd name="connsiteY1" fmla="*/ 0 h 449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49418" h="4492">
                    <a:moveTo>
                      <a:pt x="0" y="0"/>
                    </a:moveTo>
                    <a:lnTo>
                      <a:pt x="49418" y="0"/>
                    </a:lnTo>
                  </a:path>
                </a:pathLst>
              </a:custGeom>
              <a:noFill/>
              <a:ln w="8151" cap="flat">
                <a:solidFill>
                  <a:srgbClr val="40404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58" name="フリーフォーム: 図形 357">
                <a:extLst>
                  <a:ext uri="{FF2B5EF4-FFF2-40B4-BE49-F238E27FC236}">
                    <a16:creationId xmlns:a16="http://schemas.microsoft.com/office/drawing/2014/main" id="{686B8D5C-A92E-FAFB-1B8C-1CDF340283CC}"/>
                  </a:ext>
                </a:extLst>
              </p:cNvPr>
              <p:cNvSpPr/>
              <p:nvPr/>
            </p:nvSpPr>
            <p:spPr>
              <a:xfrm>
                <a:off x="1133735" y="3411028"/>
                <a:ext cx="49418" cy="4492"/>
              </a:xfrm>
              <a:custGeom>
                <a:avLst/>
                <a:gdLst>
                  <a:gd name="connsiteX0" fmla="*/ 0 w 49418"/>
                  <a:gd name="connsiteY0" fmla="*/ 0 h 4492"/>
                  <a:gd name="connsiteX1" fmla="*/ 49418 w 49418"/>
                  <a:gd name="connsiteY1" fmla="*/ 0 h 449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49418" h="4492">
                    <a:moveTo>
                      <a:pt x="0" y="0"/>
                    </a:moveTo>
                    <a:lnTo>
                      <a:pt x="49418" y="0"/>
                    </a:lnTo>
                  </a:path>
                </a:pathLst>
              </a:custGeom>
              <a:noFill/>
              <a:ln w="8151" cap="flat">
                <a:solidFill>
                  <a:srgbClr val="40404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59" name="フリーフォーム: 図形 358">
                <a:extLst>
                  <a:ext uri="{FF2B5EF4-FFF2-40B4-BE49-F238E27FC236}">
                    <a16:creationId xmlns:a16="http://schemas.microsoft.com/office/drawing/2014/main" id="{657927C1-F2FD-5AD0-FF3B-AA75AA2B40FC}"/>
                  </a:ext>
                </a:extLst>
              </p:cNvPr>
              <p:cNvSpPr/>
              <p:nvPr/>
            </p:nvSpPr>
            <p:spPr>
              <a:xfrm>
                <a:off x="1133735" y="3730022"/>
                <a:ext cx="49418" cy="4492"/>
              </a:xfrm>
              <a:custGeom>
                <a:avLst/>
                <a:gdLst>
                  <a:gd name="connsiteX0" fmla="*/ 0 w 49418"/>
                  <a:gd name="connsiteY0" fmla="*/ 0 h 4492"/>
                  <a:gd name="connsiteX1" fmla="*/ 49418 w 49418"/>
                  <a:gd name="connsiteY1" fmla="*/ 0 h 449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49418" h="4492">
                    <a:moveTo>
                      <a:pt x="0" y="0"/>
                    </a:moveTo>
                    <a:lnTo>
                      <a:pt x="49418" y="0"/>
                    </a:lnTo>
                  </a:path>
                </a:pathLst>
              </a:custGeom>
              <a:noFill/>
              <a:ln w="8151" cap="flat">
                <a:solidFill>
                  <a:srgbClr val="40404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60" name="フリーフォーム: 図形 359">
                <a:extLst>
                  <a:ext uri="{FF2B5EF4-FFF2-40B4-BE49-F238E27FC236}">
                    <a16:creationId xmlns:a16="http://schemas.microsoft.com/office/drawing/2014/main" id="{68C02724-73A8-860B-812E-0272FB759ECD}"/>
                  </a:ext>
                </a:extLst>
              </p:cNvPr>
              <p:cNvSpPr/>
              <p:nvPr/>
            </p:nvSpPr>
            <p:spPr>
              <a:xfrm>
                <a:off x="1133735" y="4049016"/>
                <a:ext cx="49418" cy="4492"/>
              </a:xfrm>
              <a:custGeom>
                <a:avLst/>
                <a:gdLst>
                  <a:gd name="connsiteX0" fmla="*/ 0 w 49418"/>
                  <a:gd name="connsiteY0" fmla="*/ 0 h 4492"/>
                  <a:gd name="connsiteX1" fmla="*/ 49418 w 49418"/>
                  <a:gd name="connsiteY1" fmla="*/ 0 h 449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49418" h="4492">
                    <a:moveTo>
                      <a:pt x="0" y="0"/>
                    </a:moveTo>
                    <a:lnTo>
                      <a:pt x="49418" y="0"/>
                    </a:lnTo>
                  </a:path>
                </a:pathLst>
              </a:custGeom>
              <a:noFill/>
              <a:ln w="8151" cap="flat">
                <a:solidFill>
                  <a:srgbClr val="40404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61" name="フリーフォーム: 図形 360">
                <a:extLst>
                  <a:ext uri="{FF2B5EF4-FFF2-40B4-BE49-F238E27FC236}">
                    <a16:creationId xmlns:a16="http://schemas.microsoft.com/office/drawing/2014/main" id="{DB302BE9-66AE-6B4F-CE79-01377D50F15F}"/>
                  </a:ext>
                </a:extLst>
              </p:cNvPr>
              <p:cNvSpPr/>
              <p:nvPr/>
            </p:nvSpPr>
            <p:spPr>
              <a:xfrm>
                <a:off x="1133735" y="4368010"/>
                <a:ext cx="49418" cy="4492"/>
              </a:xfrm>
              <a:custGeom>
                <a:avLst/>
                <a:gdLst>
                  <a:gd name="connsiteX0" fmla="*/ 0 w 49418"/>
                  <a:gd name="connsiteY0" fmla="*/ 0 h 4492"/>
                  <a:gd name="connsiteX1" fmla="*/ 49418 w 49418"/>
                  <a:gd name="connsiteY1" fmla="*/ 0 h 449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49418" h="4492">
                    <a:moveTo>
                      <a:pt x="0" y="0"/>
                    </a:moveTo>
                    <a:lnTo>
                      <a:pt x="49418" y="0"/>
                    </a:lnTo>
                  </a:path>
                </a:pathLst>
              </a:custGeom>
              <a:noFill/>
              <a:ln w="8151" cap="flat">
                <a:solidFill>
                  <a:srgbClr val="40404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62" name="フリーフォーム: 図形 361">
                <a:extLst>
                  <a:ext uri="{FF2B5EF4-FFF2-40B4-BE49-F238E27FC236}">
                    <a16:creationId xmlns:a16="http://schemas.microsoft.com/office/drawing/2014/main" id="{3C82E33E-C3FD-D41B-85EE-5BB35DF7A8AF}"/>
                  </a:ext>
                </a:extLst>
              </p:cNvPr>
              <p:cNvSpPr/>
              <p:nvPr/>
            </p:nvSpPr>
            <p:spPr>
              <a:xfrm>
                <a:off x="1133735" y="4687003"/>
                <a:ext cx="49418" cy="4492"/>
              </a:xfrm>
              <a:custGeom>
                <a:avLst/>
                <a:gdLst>
                  <a:gd name="connsiteX0" fmla="*/ 0 w 49418"/>
                  <a:gd name="connsiteY0" fmla="*/ 0 h 4492"/>
                  <a:gd name="connsiteX1" fmla="*/ 49418 w 49418"/>
                  <a:gd name="connsiteY1" fmla="*/ 0 h 449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49418" h="4492">
                    <a:moveTo>
                      <a:pt x="0" y="0"/>
                    </a:moveTo>
                    <a:lnTo>
                      <a:pt x="49418" y="0"/>
                    </a:lnTo>
                  </a:path>
                </a:pathLst>
              </a:custGeom>
              <a:noFill/>
              <a:ln w="8151" cap="flat">
                <a:solidFill>
                  <a:srgbClr val="40404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</p:grpSp>
        <p:grpSp>
          <p:nvGrpSpPr>
            <p:cNvPr id="259" name="グラフィックス 3">
              <a:extLst>
                <a:ext uri="{FF2B5EF4-FFF2-40B4-BE49-F238E27FC236}">
                  <a16:creationId xmlns:a16="http://schemas.microsoft.com/office/drawing/2014/main" id="{4B62C835-814C-1B33-48F1-8DD097E5735F}"/>
                </a:ext>
              </a:extLst>
            </p:cNvPr>
            <p:cNvGrpSpPr/>
            <p:nvPr/>
          </p:nvGrpSpPr>
          <p:grpSpPr>
            <a:xfrm>
              <a:off x="1124750" y="1564458"/>
              <a:ext cx="4434142" cy="3374146"/>
              <a:chOff x="1124750" y="1564458"/>
              <a:chExt cx="4434142" cy="3374146"/>
            </a:xfrm>
            <a:noFill/>
          </p:grpSpPr>
          <p:sp>
            <p:nvSpPr>
              <p:cNvPr id="351" name="フリーフォーム: 図形 350">
                <a:extLst>
                  <a:ext uri="{FF2B5EF4-FFF2-40B4-BE49-F238E27FC236}">
                    <a16:creationId xmlns:a16="http://schemas.microsoft.com/office/drawing/2014/main" id="{35475964-E74A-AA5D-642E-7158770FFC5A}"/>
                  </a:ext>
                </a:extLst>
              </p:cNvPr>
              <p:cNvSpPr/>
              <p:nvPr/>
            </p:nvSpPr>
            <p:spPr>
              <a:xfrm>
                <a:off x="1133735" y="1564458"/>
                <a:ext cx="4492" cy="3374146"/>
              </a:xfrm>
              <a:custGeom>
                <a:avLst/>
                <a:gdLst>
                  <a:gd name="connsiteX0" fmla="*/ 0 w 4492"/>
                  <a:gd name="connsiteY0" fmla="*/ 0 h 3374146"/>
                  <a:gd name="connsiteX1" fmla="*/ 0 w 4492"/>
                  <a:gd name="connsiteY1" fmla="*/ 3374147 h 337414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4492" h="3374146">
                    <a:moveTo>
                      <a:pt x="0" y="0"/>
                    </a:moveTo>
                    <a:lnTo>
                      <a:pt x="0" y="3374147"/>
                    </a:lnTo>
                  </a:path>
                </a:pathLst>
              </a:custGeom>
              <a:noFill/>
              <a:ln w="16302" cap="flat">
                <a:solidFill>
                  <a:srgbClr val="00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52" name="フリーフォーム: 図形 351">
                <a:extLst>
                  <a:ext uri="{FF2B5EF4-FFF2-40B4-BE49-F238E27FC236}">
                    <a16:creationId xmlns:a16="http://schemas.microsoft.com/office/drawing/2014/main" id="{4D5B680C-C9D2-C429-DD02-A45072533824}"/>
                  </a:ext>
                </a:extLst>
              </p:cNvPr>
              <p:cNvSpPr/>
              <p:nvPr/>
            </p:nvSpPr>
            <p:spPr>
              <a:xfrm>
                <a:off x="1124750" y="4938604"/>
                <a:ext cx="4434142" cy="4492"/>
              </a:xfrm>
              <a:custGeom>
                <a:avLst/>
                <a:gdLst>
                  <a:gd name="connsiteX0" fmla="*/ 0 w 4434142"/>
                  <a:gd name="connsiteY0" fmla="*/ 0 h 4492"/>
                  <a:gd name="connsiteX1" fmla="*/ 4434143 w 4434142"/>
                  <a:gd name="connsiteY1" fmla="*/ 0 h 449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4434142" h="4492">
                    <a:moveTo>
                      <a:pt x="0" y="0"/>
                    </a:moveTo>
                    <a:lnTo>
                      <a:pt x="4434143" y="0"/>
                    </a:lnTo>
                  </a:path>
                </a:pathLst>
              </a:custGeom>
              <a:noFill/>
              <a:ln w="16302" cap="flat">
                <a:solidFill>
                  <a:srgbClr val="00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</p:grpSp>
        <p:sp>
          <p:nvSpPr>
            <p:cNvPr id="260" name="フリーフォーム: 図形 259">
              <a:extLst>
                <a:ext uri="{FF2B5EF4-FFF2-40B4-BE49-F238E27FC236}">
                  <a16:creationId xmlns:a16="http://schemas.microsoft.com/office/drawing/2014/main" id="{F86D438A-978E-8520-BD36-4E9D8EA8A052}"/>
                </a:ext>
              </a:extLst>
            </p:cNvPr>
            <p:cNvSpPr/>
            <p:nvPr/>
          </p:nvSpPr>
          <p:spPr>
            <a:xfrm>
              <a:off x="2436573" y="4853240"/>
              <a:ext cx="4492" cy="85364"/>
            </a:xfrm>
            <a:custGeom>
              <a:avLst/>
              <a:gdLst>
                <a:gd name="connsiteX0" fmla="*/ 0 w 4492"/>
                <a:gd name="connsiteY0" fmla="*/ 85365 h 85364"/>
                <a:gd name="connsiteX1" fmla="*/ 0 w 4492"/>
                <a:gd name="connsiteY1" fmla="*/ 0 h 8536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4492" h="85364">
                  <a:moveTo>
                    <a:pt x="0" y="85365"/>
                  </a:moveTo>
                  <a:lnTo>
                    <a:pt x="0" y="0"/>
                  </a:lnTo>
                </a:path>
              </a:pathLst>
            </a:custGeom>
            <a:noFill/>
            <a:ln w="12227" cap="flat">
              <a:solidFill>
                <a:srgbClr val="40404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>
                <a:latin typeface="Palatino Linotype" panose="02040502050505030304" pitchFamily="18" charset="0"/>
              </a:endParaRPr>
            </a:p>
          </p:txBody>
        </p:sp>
        <p:sp>
          <p:nvSpPr>
            <p:cNvPr id="261" name="フリーフォーム: 図形 260">
              <a:extLst>
                <a:ext uri="{FF2B5EF4-FFF2-40B4-BE49-F238E27FC236}">
                  <a16:creationId xmlns:a16="http://schemas.microsoft.com/office/drawing/2014/main" id="{30867C82-9687-7EA1-6A21-8500234EBF71}"/>
                </a:ext>
              </a:extLst>
            </p:cNvPr>
            <p:cNvSpPr/>
            <p:nvPr/>
          </p:nvSpPr>
          <p:spPr>
            <a:xfrm>
              <a:off x="4247069" y="4853240"/>
              <a:ext cx="4492" cy="85364"/>
            </a:xfrm>
            <a:custGeom>
              <a:avLst/>
              <a:gdLst>
                <a:gd name="connsiteX0" fmla="*/ 0 w 4492"/>
                <a:gd name="connsiteY0" fmla="*/ 85365 h 85364"/>
                <a:gd name="connsiteX1" fmla="*/ 0 w 4492"/>
                <a:gd name="connsiteY1" fmla="*/ 0 h 8536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4492" h="85364">
                  <a:moveTo>
                    <a:pt x="0" y="85365"/>
                  </a:moveTo>
                  <a:lnTo>
                    <a:pt x="0" y="0"/>
                  </a:lnTo>
                </a:path>
              </a:pathLst>
            </a:custGeom>
            <a:noFill/>
            <a:ln w="12227" cap="flat">
              <a:solidFill>
                <a:srgbClr val="40404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>
                <a:latin typeface="Palatino Linotype" panose="02040502050505030304" pitchFamily="18" charset="0"/>
              </a:endParaRPr>
            </a:p>
          </p:txBody>
        </p:sp>
        <p:grpSp>
          <p:nvGrpSpPr>
            <p:cNvPr id="263" name="グラフィックス 3">
              <a:extLst>
                <a:ext uri="{FF2B5EF4-FFF2-40B4-BE49-F238E27FC236}">
                  <a16:creationId xmlns:a16="http://schemas.microsoft.com/office/drawing/2014/main" id="{75A26D25-A4C6-1CC9-C718-E28AFF099BAD}"/>
                </a:ext>
              </a:extLst>
            </p:cNvPr>
            <p:cNvGrpSpPr/>
            <p:nvPr/>
          </p:nvGrpSpPr>
          <p:grpSpPr>
            <a:xfrm>
              <a:off x="2436573" y="1667794"/>
              <a:ext cx="1810495" cy="3171967"/>
              <a:chOff x="2436573" y="1667794"/>
              <a:chExt cx="1810495" cy="3171967"/>
            </a:xfrm>
            <a:noFill/>
          </p:grpSpPr>
          <p:sp>
            <p:nvSpPr>
              <p:cNvPr id="349" name="フリーフォーム: 図形 348">
                <a:extLst>
                  <a:ext uri="{FF2B5EF4-FFF2-40B4-BE49-F238E27FC236}">
                    <a16:creationId xmlns:a16="http://schemas.microsoft.com/office/drawing/2014/main" id="{745C01FC-8830-07AE-007C-81762095E315}"/>
                  </a:ext>
                </a:extLst>
              </p:cNvPr>
              <p:cNvSpPr/>
              <p:nvPr/>
            </p:nvSpPr>
            <p:spPr>
              <a:xfrm>
                <a:off x="2436573" y="1667794"/>
                <a:ext cx="4492" cy="3171967"/>
              </a:xfrm>
              <a:custGeom>
                <a:avLst/>
                <a:gdLst>
                  <a:gd name="connsiteX0" fmla="*/ 0 w 4492"/>
                  <a:gd name="connsiteY0" fmla="*/ 3171967 h 3171967"/>
                  <a:gd name="connsiteX1" fmla="*/ 0 w 4492"/>
                  <a:gd name="connsiteY1" fmla="*/ 0 h 317196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4492" h="3171967">
                    <a:moveTo>
                      <a:pt x="0" y="3171967"/>
                    </a:moveTo>
                    <a:lnTo>
                      <a:pt x="0" y="0"/>
                    </a:lnTo>
                  </a:path>
                </a:pathLst>
              </a:custGeom>
              <a:noFill/>
              <a:ln w="4485" cap="flat">
                <a:solidFill>
                  <a:srgbClr val="A0A0A0"/>
                </a:solidFill>
                <a:custDash>
                  <a:ds d="75000" sp="75000"/>
                </a:custDash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50" name="フリーフォーム: 図形 349">
                <a:extLst>
                  <a:ext uri="{FF2B5EF4-FFF2-40B4-BE49-F238E27FC236}">
                    <a16:creationId xmlns:a16="http://schemas.microsoft.com/office/drawing/2014/main" id="{D3635306-EFF6-CCFF-DCE2-59638B75474E}"/>
                  </a:ext>
                </a:extLst>
              </p:cNvPr>
              <p:cNvSpPr/>
              <p:nvPr/>
            </p:nvSpPr>
            <p:spPr>
              <a:xfrm>
                <a:off x="4247069" y="1667794"/>
                <a:ext cx="4492" cy="3171967"/>
              </a:xfrm>
              <a:custGeom>
                <a:avLst/>
                <a:gdLst>
                  <a:gd name="connsiteX0" fmla="*/ 0 w 4492"/>
                  <a:gd name="connsiteY0" fmla="*/ 3171967 h 3171967"/>
                  <a:gd name="connsiteX1" fmla="*/ 0 w 4492"/>
                  <a:gd name="connsiteY1" fmla="*/ 0 h 317196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4492" h="3171967">
                    <a:moveTo>
                      <a:pt x="0" y="3171967"/>
                    </a:moveTo>
                    <a:lnTo>
                      <a:pt x="0" y="0"/>
                    </a:lnTo>
                  </a:path>
                </a:pathLst>
              </a:custGeom>
              <a:noFill/>
              <a:ln w="4485" cap="flat">
                <a:solidFill>
                  <a:srgbClr val="A0A0A0"/>
                </a:solidFill>
                <a:custDash>
                  <a:ds d="75000" sp="75000"/>
                </a:custDash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</p:grpSp>
        <p:grpSp>
          <p:nvGrpSpPr>
            <p:cNvPr id="264" name="グラフィックス 3">
              <a:extLst>
                <a:ext uri="{FF2B5EF4-FFF2-40B4-BE49-F238E27FC236}">
                  <a16:creationId xmlns:a16="http://schemas.microsoft.com/office/drawing/2014/main" id="{A55AABCF-F583-5D99-9D88-633135527004}"/>
                </a:ext>
              </a:extLst>
            </p:cNvPr>
            <p:cNvGrpSpPr/>
            <p:nvPr/>
          </p:nvGrpSpPr>
          <p:grpSpPr>
            <a:xfrm>
              <a:off x="2292812" y="2058674"/>
              <a:ext cx="2062078" cy="2817030"/>
              <a:chOff x="2292812" y="2058674"/>
              <a:chExt cx="2062078" cy="2817030"/>
            </a:xfrm>
            <a:solidFill>
              <a:srgbClr val="FFFFFF"/>
            </a:solidFill>
          </p:grpSpPr>
          <p:sp>
            <p:nvSpPr>
              <p:cNvPr id="265" name="フリーフォーム: 図形 264">
                <a:extLst>
                  <a:ext uri="{FF2B5EF4-FFF2-40B4-BE49-F238E27FC236}">
                    <a16:creationId xmlns:a16="http://schemas.microsoft.com/office/drawing/2014/main" id="{DFE4D68D-41FA-FEC5-8846-B27F5D3B405B}"/>
                  </a:ext>
                </a:extLst>
              </p:cNvPr>
              <p:cNvSpPr/>
              <p:nvPr/>
            </p:nvSpPr>
            <p:spPr>
              <a:xfrm>
                <a:off x="2328752" y="4812804"/>
                <a:ext cx="62895" cy="62900"/>
              </a:xfrm>
              <a:custGeom>
                <a:avLst/>
                <a:gdLst>
                  <a:gd name="connsiteX0" fmla="*/ 62896 w 62895"/>
                  <a:gd name="connsiteY0" fmla="*/ 31450 h 62900"/>
                  <a:gd name="connsiteX1" fmla="*/ 31448 w 62895"/>
                  <a:gd name="connsiteY1" fmla="*/ 62900 h 62900"/>
                  <a:gd name="connsiteX2" fmla="*/ 0 w 62895"/>
                  <a:gd name="connsiteY2" fmla="*/ 31450 h 62900"/>
                  <a:gd name="connsiteX3" fmla="*/ 31448 w 62895"/>
                  <a:gd name="connsiteY3" fmla="*/ 0 h 62900"/>
                  <a:gd name="connsiteX4" fmla="*/ 62896 w 62895"/>
                  <a:gd name="connsiteY4" fmla="*/ 31450 h 629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62895" h="62900">
                    <a:moveTo>
                      <a:pt x="62896" y="31450"/>
                    </a:moveTo>
                    <a:cubicBezTo>
                      <a:pt x="62896" y="48819"/>
                      <a:pt x="48816" y="62900"/>
                      <a:pt x="31448" y="62900"/>
                    </a:cubicBezTo>
                    <a:cubicBezTo>
                      <a:pt x="14080" y="62900"/>
                      <a:pt x="0" y="48819"/>
                      <a:pt x="0" y="31450"/>
                    </a:cubicBezTo>
                    <a:cubicBezTo>
                      <a:pt x="0" y="14081"/>
                      <a:pt x="14080" y="0"/>
                      <a:pt x="31448" y="0"/>
                    </a:cubicBezTo>
                    <a:cubicBezTo>
                      <a:pt x="48816" y="0"/>
                      <a:pt x="62896" y="14081"/>
                      <a:pt x="62896" y="31450"/>
                    </a:cubicBezTo>
                    <a:close/>
                  </a:path>
                </a:pathLst>
              </a:custGeom>
              <a:solidFill>
                <a:srgbClr val="FFFFFF"/>
              </a:solidFill>
              <a:ln w="5706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67" name="フリーフォーム: 図形 266">
                <a:extLst>
                  <a:ext uri="{FF2B5EF4-FFF2-40B4-BE49-F238E27FC236}">
                    <a16:creationId xmlns:a16="http://schemas.microsoft.com/office/drawing/2014/main" id="{711C8E46-D7C2-6C34-1B4E-D52C01D549D5}"/>
                  </a:ext>
                </a:extLst>
              </p:cNvPr>
              <p:cNvSpPr/>
              <p:nvPr/>
            </p:nvSpPr>
            <p:spPr>
              <a:xfrm>
                <a:off x="2405125" y="4808311"/>
                <a:ext cx="62895" cy="62900"/>
              </a:xfrm>
              <a:custGeom>
                <a:avLst/>
                <a:gdLst>
                  <a:gd name="connsiteX0" fmla="*/ 62896 w 62895"/>
                  <a:gd name="connsiteY0" fmla="*/ 31450 h 62900"/>
                  <a:gd name="connsiteX1" fmla="*/ 31448 w 62895"/>
                  <a:gd name="connsiteY1" fmla="*/ 62900 h 62900"/>
                  <a:gd name="connsiteX2" fmla="*/ 0 w 62895"/>
                  <a:gd name="connsiteY2" fmla="*/ 31450 h 62900"/>
                  <a:gd name="connsiteX3" fmla="*/ 31448 w 62895"/>
                  <a:gd name="connsiteY3" fmla="*/ 0 h 62900"/>
                  <a:gd name="connsiteX4" fmla="*/ 62896 w 62895"/>
                  <a:gd name="connsiteY4" fmla="*/ 31450 h 629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62895" h="62900">
                    <a:moveTo>
                      <a:pt x="62896" y="31450"/>
                    </a:moveTo>
                    <a:cubicBezTo>
                      <a:pt x="62896" y="48819"/>
                      <a:pt x="48816" y="62900"/>
                      <a:pt x="31448" y="62900"/>
                    </a:cubicBezTo>
                    <a:cubicBezTo>
                      <a:pt x="14080" y="62900"/>
                      <a:pt x="0" y="48819"/>
                      <a:pt x="0" y="31450"/>
                    </a:cubicBezTo>
                    <a:cubicBezTo>
                      <a:pt x="0" y="14081"/>
                      <a:pt x="14080" y="0"/>
                      <a:pt x="31448" y="0"/>
                    </a:cubicBezTo>
                    <a:cubicBezTo>
                      <a:pt x="48816" y="0"/>
                      <a:pt x="62896" y="14081"/>
                      <a:pt x="62896" y="31450"/>
                    </a:cubicBezTo>
                    <a:close/>
                  </a:path>
                </a:pathLst>
              </a:custGeom>
              <a:solidFill>
                <a:srgbClr val="FFFFFF"/>
              </a:solidFill>
              <a:ln w="5706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68" name="フリーフォーム: 図形 267">
                <a:extLst>
                  <a:ext uri="{FF2B5EF4-FFF2-40B4-BE49-F238E27FC236}">
                    <a16:creationId xmlns:a16="http://schemas.microsoft.com/office/drawing/2014/main" id="{3406D38E-B229-86C3-58CF-2C8900B1D6FB}"/>
                  </a:ext>
                </a:extLst>
              </p:cNvPr>
              <p:cNvSpPr/>
              <p:nvPr/>
            </p:nvSpPr>
            <p:spPr>
              <a:xfrm>
                <a:off x="2481499" y="4781354"/>
                <a:ext cx="62895" cy="62900"/>
              </a:xfrm>
              <a:custGeom>
                <a:avLst/>
                <a:gdLst>
                  <a:gd name="connsiteX0" fmla="*/ 62896 w 62895"/>
                  <a:gd name="connsiteY0" fmla="*/ 31450 h 62900"/>
                  <a:gd name="connsiteX1" fmla="*/ 31448 w 62895"/>
                  <a:gd name="connsiteY1" fmla="*/ 62900 h 62900"/>
                  <a:gd name="connsiteX2" fmla="*/ 0 w 62895"/>
                  <a:gd name="connsiteY2" fmla="*/ 31450 h 62900"/>
                  <a:gd name="connsiteX3" fmla="*/ 31448 w 62895"/>
                  <a:gd name="connsiteY3" fmla="*/ 0 h 62900"/>
                  <a:gd name="connsiteX4" fmla="*/ 62896 w 62895"/>
                  <a:gd name="connsiteY4" fmla="*/ 31450 h 629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62895" h="62900">
                    <a:moveTo>
                      <a:pt x="62896" y="31450"/>
                    </a:moveTo>
                    <a:cubicBezTo>
                      <a:pt x="62896" y="48819"/>
                      <a:pt x="48816" y="62900"/>
                      <a:pt x="31448" y="62900"/>
                    </a:cubicBezTo>
                    <a:cubicBezTo>
                      <a:pt x="14080" y="62900"/>
                      <a:pt x="0" y="48819"/>
                      <a:pt x="0" y="31450"/>
                    </a:cubicBezTo>
                    <a:cubicBezTo>
                      <a:pt x="0" y="14081"/>
                      <a:pt x="14080" y="0"/>
                      <a:pt x="31448" y="0"/>
                    </a:cubicBezTo>
                    <a:cubicBezTo>
                      <a:pt x="48816" y="0"/>
                      <a:pt x="62896" y="14081"/>
                      <a:pt x="62896" y="31450"/>
                    </a:cubicBezTo>
                    <a:close/>
                  </a:path>
                </a:pathLst>
              </a:custGeom>
              <a:solidFill>
                <a:srgbClr val="FFFFFF"/>
              </a:solidFill>
              <a:ln w="5706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69" name="フリーフォーム: 図形 268">
                <a:extLst>
                  <a:ext uri="{FF2B5EF4-FFF2-40B4-BE49-F238E27FC236}">
                    <a16:creationId xmlns:a16="http://schemas.microsoft.com/office/drawing/2014/main" id="{1FB6BDC5-A0B8-4296-23B6-6FA2C60267CC}"/>
                  </a:ext>
                </a:extLst>
              </p:cNvPr>
              <p:cNvSpPr/>
              <p:nvPr/>
            </p:nvSpPr>
            <p:spPr>
              <a:xfrm>
                <a:off x="2328752" y="4767875"/>
                <a:ext cx="62895" cy="62900"/>
              </a:xfrm>
              <a:custGeom>
                <a:avLst/>
                <a:gdLst>
                  <a:gd name="connsiteX0" fmla="*/ 62896 w 62895"/>
                  <a:gd name="connsiteY0" fmla="*/ 31450 h 62900"/>
                  <a:gd name="connsiteX1" fmla="*/ 31448 w 62895"/>
                  <a:gd name="connsiteY1" fmla="*/ 62900 h 62900"/>
                  <a:gd name="connsiteX2" fmla="*/ 0 w 62895"/>
                  <a:gd name="connsiteY2" fmla="*/ 31450 h 62900"/>
                  <a:gd name="connsiteX3" fmla="*/ 31448 w 62895"/>
                  <a:gd name="connsiteY3" fmla="*/ 0 h 62900"/>
                  <a:gd name="connsiteX4" fmla="*/ 62896 w 62895"/>
                  <a:gd name="connsiteY4" fmla="*/ 31450 h 629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62895" h="62900">
                    <a:moveTo>
                      <a:pt x="62896" y="31450"/>
                    </a:moveTo>
                    <a:cubicBezTo>
                      <a:pt x="62896" y="48819"/>
                      <a:pt x="48816" y="62900"/>
                      <a:pt x="31448" y="62900"/>
                    </a:cubicBezTo>
                    <a:cubicBezTo>
                      <a:pt x="14080" y="62900"/>
                      <a:pt x="0" y="48819"/>
                      <a:pt x="0" y="31450"/>
                    </a:cubicBezTo>
                    <a:cubicBezTo>
                      <a:pt x="0" y="14081"/>
                      <a:pt x="14080" y="0"/>
                      <a:pt x="31448" y="0"/>
                    </a:cubicBezTo>
                    <a:cubicBezTo>
                      <a:pt x="48816" y="0"/>
                      <a:pt x="62896" y="14081"/>
                      <a:pt x="62896" y="31450"/>
                    </a:cubicBezTo>
                    <a:close/>
                  </a:path>
                </a:pathLst>
              </a:custGeom>
              <a:solidFill>
                <a:srgbClr val="FFFFFF"/>
              </a:solidFill>
              <a:ln w="5706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70" name="フリーフォーム: 図形 269">
                <a:extLst>
                  <a:ext uri="{FF2B5EF4-FFF2-40B4-BE49-F238E27FC236}">
                    <a16:creationId xmlns:a16="http://schemas.microsoft.com/office/drawing/2014/main" id="{02B9FE18-7513-1D68-E069-FF33B1C8940F}"/>
                  </a:ext>
                </a:extLst>
              </p:cNvPr>
              <p:cNvSpPr/>
              <p:nvPr/>
            </p:nvSpPr>
            <p:spPr>
              <a:xfrm>
                <a:off x="2405125" y="4745411"/>
                <a:ext cx="62895" cy="62900"/>
              </a:xfrm>
              <a:custGeom>
                <a:avLst/>
                <a:gdLst>
                  <a:gd name="connsiteX0" fmla="*/ 62896 w 62895"/>
                  <a:gd name="connsiteY0" fmla="*/ 31450 h 62900"/>
                  <a:gd name="connsiteX1" fmla="*/ 31448 w 62895"/>
                  <a:gd name="connsiteY1" fmla="*/ 62900 h 62900"/>
                  <a:gd name="connsiteX2" fmla="*/ 0 w 62895"/>
                  <a:gd name="connsiteY2" fmla="*/ 31450 h 62900"/>
                  <a:gd name="connsiteX3" fmla="*/ 31448 w 62895"/>
                  <a:gd name="connsiteY3" fmla="*/ 0 h 62900"/>
                  <a:gd name="connsiteX4" fmla="*/ 62896 w 62895"/>
                  <a:gd name="connsiteY4" fmla="*/ 31450 h 629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62895" h="62900">
                    <a:moveTo>
                      <a:pt x="62896" y="31450"/>
                    </a:moveTo>
                    <a:cubicBezTo>
                      <a:pt x="62896" y="48819"/>
                      <a:pt x="48816" y="62900"/>
                      <a:pt x="31448" y="62900"/>
                    </a:cubicBezTo>
                    <a:cubicBezTo>
                      <a:pt x="14080" y="62900"/>
                      <a:pt x="0" y="48819"/>
                      <a:pt x="0" y="31450"/>
                    </a:cubicBezTo>
                    <a:cubicBezTo>
                      <a:pt x="0" y="14081"/>
                      <a:pt x="14080" y="0"/>
                      <a:pt x="31448" y="0"/>
                    </a:cubicBezTo>
                    <a:cubicBezTo>
                      <a:pt x="48816" y="0"/>
                      <a:pt x="62896" y="14081"/>
                      <a:pt x="62896" y="31450"/>
                    </a:cubicBezTo>
                    <a:close/>
                  </a:path>
                </a:pathLst>
              </a:custGeom>
              <a:solidFill>
                <a:srgbClr val="FFFFFF"/>
              </a:solidFill>
              <a:ln w="5706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71" name="フリーフォーム: 図形 270">
                <a:extLst>
                  <a:ext uri="{FF2B5EF4-FFF2-40B4-BE49-F238E27FC236}">
                    <a16:creationId xmlns:a16="http://schemas.microsoft.com/office/drawing/2014/main" id="{CB4E2173-7FF9-30B5-0A2C-F6382C556EA5}"/>
                  </a:ext>
                </a:extLst>
              </p:cNvPr>
              <p:cNvSpPr/>
              <p:nvPr/>
            </p:nvSpPr>
            <p:spPr>
              <a:xfrm>
                <a:off x="2481499" y="4736425"/>
                <a:ext cx="62895" cy="62900"/>
              </a:xfrm>
              <a:custGeom>
                <a:avLst/>
                <a:gdLst>
                  <a:gd name="connsiteX0" fmla="*/ 62896 w 62895"/>
                  <a:gd name="connsiteY0" fmla="*/ 31450 h 62900"/>
                  <a:gd name="connsiteX1" fmla="*/ 31448 w 62895"/>
                  <a:gd name="connsiteY1" fmla="*/ 62900 h 62900"/>
                  <a:gd name="connsiteX2" fmla="*/ 0 w 62895"/>
                  <a:gd name="connsiteY2" fmla="*/ 31450 h 62900"/>
                  <a:gd name="connsiteX3" fmla="*/ 31448 w 62895"/>
                  <a:gd name="connsiteY3" fmla="*/ 0 h 62900"/>
                  <a:gd name="connsiteX4" fmla="*/ 62896 w 62895"/>
                  <a:gd name="connsiteY4" fmla="*/ 31450 h 629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62895" h="62900">
                    <a:moveTo>
                      <a:pt x="62896" y="31450"/>
                    </a:moveTo>
                    <a:cubicBezTo>
                      <a:pt x="62896" y="48819"/>
                      <a:pt x="48816" y="62900"/>
                      <a:pt x="31448" y="62900"/>
                    </a:cubicBezTo>
                    <a:cubicBezTo>
                      <a:pt x="14080" y="62900"/>
                      <a:pt x="0" y="48819"/>
                      <a:pt x="0" y="31450"/>
                    </a:cubicBezTo>
                    <a:cubicBezTo>
                      <a:pt x="0" y="14081"/>
                      <a:pt x="14080" y="0"/>
                      <a:pt x="31448" y="0"/>
                    </a:cubicBezTo>
                    <a:cubicBezTo>
                      <a:pt x="48816" y="0"/>
                      <a:pt x="62896" y="14081"/>
                      <a:pt x="62896" y="31450"/>
                    </a:cubicBezTo>
                    <a:close/>
                  </a:path>
                </a:pathLst>
              </a:custGeom>
              <a:solidFill>
                <a:srgbClr val="FFFFFF"/>
              </a:solidFill>
              <a:ln w="5706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72" name="フリーフォーム: 図形 271">
                <a:extLst>
                  <a:ext uri="{FF2B5EF4-FFF2-40B4-BE49-F238E27FC236}">
                    <a16:creationId xmlns:a16="http://schemas.microsoft.com/office/drawing/2014/main" id="{8E2CD19D-CD7D-E7CE-BE16-729863A38200}"/>
                  </a:ext>
                </a:extLst>
              </p:cNvPr>
              <p:cNvSpPr/>
              <p:nvPr/>
            </p:nvSpPr>
            <p:spPr>
              <a:xfrm>
                <a:off x="2292812" y="4709468"/>
                <a:ext cx="62895" cy="62900"/>
              </a:xfrm>
              <a:custGeom>
                <a:avLst/>
                <a:gdLst>
                  <a:gd name="connsiteX0" fmla="*/ 62896 w 62895"/>
                  <a:gd name="connsiteY0" fmla="*/ 31450 h 62900"/>
                  <a:gd name="connsiteX1" fmla="*/ 31448 w 62895"/>
                  <a:gd name="connsiteY1" fmla="*/ 62900 h 62900"/>
                  <a:gd name="connsiteX2" fmla="*/ 0 w 62895"/>
                  <a:gd name="connsiteY2" fmla="*/ 31450 h 62900"/>
                  <a:gd name="connsiteX3" fmla="*/ 31448 w 62895"/>
                  <a:gd name="connsiteY3" fmla="*/ 0 h 62900"/>
                  <a:gd name="connsiteX4" fmla="*/ 62896 w 62895"/>
                  <a:gd name="connsiteY4" fmla="*/ 31450 h 629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62895" h="62900">
                    <a:moveTo>
                      <a:pt x="62896" y="31450"/>
                    </a:moveTo>
                    <a:cubicBezTo>
                      <a:pt x="62896" y="48819"/>
                      <a:pt x="48816" y="62900"/>
                      <a:pt x="31448" y="62900"/>
                    </a:cubicBezTo>
                    <a:cubicBezTo>
                      <a:pt x="14080" y="62900"/>
                      <a:pt x="0" y="48819"/>
                      <a:pt x="0" y="31450"/>
                    </a:cubicBezTo>
                    <a:cubicBezTo>
                      <a:pt x="0" y="14081"/>
                      <a:pt x="14080" y="0"/>
                      <a:pt x="31448" y="0"/>
                    </a:cubicBezTo>
                    <a:cubicBezTo>
                      <a:pt x="48816" y="0"/>
                      <a:pt x="62896" y="14081"/>
                      <a:pt x="62896" y="31450"/>
                    </a:cubicBezTo>
                    <a:close/>
                  </a:path>
                </a:pathLst>
              </a:custGeom>
              <a:solidFill>
                <a:srgbClr val="FFFFFF"/>
              </a:solidFill>
              <a:ln w="5706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73" name="フリーフォーム: 図形 272">
                <a:extLst>
                  <a:ext uri="{FF2B5EF4-FFF2-40B4-BE49-F238E27FC236}">
                    <a16:creationId xmlns:a16="http://schemas.microsoft.com/office/drawing/2014/main" id="{EFD4DCDD-B40D-F95E-4071-E69F78DEA078}"/>
                  </a:ext>
                </a:extLst>
              </p:cNvPr>
              <p:cNvSpPr/>
              <p:nvPr/>
            </p:nvSpPr>
            <p:spPr>
              <a:xfrm>
                <a:off x="2369185" y="4700482"/>
                <a:ext cx="62895" cy="62900"/>
              </a:xfrm>
              <a:custGeom>
                <a:avLst/>
                <a:gdLst>
                  <a:gd name="connsiteX0" fmla="*/ 62896 w 62895"/>
                  <a:gd name="connsiteY0" fmla="*/ 31450 h 62900"/>
                  <a:gd name="connsiteX1" fmla="*/ 31448 w 62895"/>
                  <a:gd name="connsiteY1" fmla="*/ 62900 h 62900"/>
                  <a:gd name="connsiteX2" fmla="*/ 0 w 62895"/>
                  <a:gd name="connsiteY2" fmla="*/ 31450 h 62900"/>
                  <a:gd name="connsiteX3" fmla="*/ 31448 w 62895"/>
                  <a:gd name="connsiteY3" fmla="*/ 0 h 62900"/>
                  <a:gd name="connsiteX4" fmla="*/ 62896 w 62895"/>
                  <a:gd name="connsiteY4" fmla="*/ 31450 h 629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62895" h="62900">
                    <a:moveTo>
                      <a:pt x="62896" y="31450"/>
                    </a:moveTo>
                    <a:cubicBezTo>
                      <a:pt x="62896" y="48819"/>
                      <a:pt x="48816" y="62900"/>
                      <a:pt x="31448" y="62900"/>
                    </a:cubicBezTo>
                    <a:cubicBezTo>
                      <a:pt x="14080" y="62900"/>
                      <a:pt x="0" y="48819"/>
                      <a:pt x="0" y="31450"/>
                    </a:cubicBezTo>
                    <a:cubicBezTo>
                      <a:pt x="0" y="14081"/>
                      <a:pt x="14080" y="0"/>
                      <a:pt x="31448" y="0"/>
                    </a:cubicBezTo>
                    <a:cubicBezTo>
                      <a:pt x="48816" y="0"/>
                      <a:pt x="62896" y="14081"/>
                      <a:pt x="62896" y="31450"/>
                    </a:cubicBezTo>
                    <a:close/>
                  </a:path>
                </a:pathLst>
              </a:custGeom>
              <a:solidFill>
                <a:srgbClr val="FFFFFF"/>
              </a:solidFill>
              <a:ln w="5706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74" name="フリーフォーム: 図形 273">
                <a:extLst>
                  <a:ext uri="{FF2B5EF4-FFF2-40B4-BE49-F238E27FC236}">
                    <a16:creationId xmlns:a16="http://schemas.microsoft.com/office/drawing/2014/main" id="{62AD8FC0-4FA5-825C-35C4-4AEB7688ED1B}"/>
                  </a:ext>
                </a:extLst>
              </p:cNvPr>
              <p:cNvSpPr/>
              <p:nvPr/>
            </p:nvSpPr>
            <p:spPr>
              <a:xfrm>
                <a:off x="2445558" y="4682511"/>
                <a:ext cx="62895" cy="62900"/>
              </a:xfrm>
              <a:custGeom>
                <a:avLst/>
                <a:gdLst>
                  <a:gd name="connsiteX0" fmla="*/ 62896 w 62895"/>
                  <a:gd name="connsiteY0" fmla="*/ 31450 h 62900"/>
                  <a:gd name="connsiteX1" fmla="*/ 31448 w 62895"/>
                  <a:gd name="connsiteY1" fmla="*/ 62900 h 62900"/>
                  <a:gd name="connsiteX2" fmla="*/ 0 w 62895"/>
                  <a:gd name="connsiteY2" fmla="*/ 31450 h 62900"/>
                  <a:gd name="connsiteX3" fmla="*/ 31448 w 62895"/>
                  <a:gd name="connsiteY3" fmla="*/ 0 h 62900"/>
                  <a:gd name="connsiteX4" fmla="*/ 62896 w 62895"/>
                  <a:gd name="connsiteY4" fmla="*/ 31450 h 629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62895" h="62900">
                    <a:moveTo>
                      <a:pt x="62896" y="31450"/>
                    </a:moveTo>
                    <a:cubicBezTo>
                      <a:pt x="62896" y="48819"/>
                      <a:pt x="48816" y="62900"/>
                      <a:pt x="31448" y="62900"/>
                    </a:cubicBezTo>
                    <a:cubicBezTo>
                      <a:pt x="14080" y="62900"/>
                      <a:pt x="0" y="48819"/>
                      <a:pt x="0" y="31450"/>
                    </a:cubicBezTo>
                    <a:cubicBezTo>
                      <a:pt x="0" y="14081"/>
                      <a:pt x="14080" y="0"/>
                      <a:pt x="31448" y="0"/>
                    </a:cubicBezTo>
                    <a:cubicBezTo>
                      <a:pt x="48816" y="0"/>
                      <a:pt x="62896" y="14081"/>
                      <a:pt x="62896" y="31450"/>
                    </a:cubicBezTo>
                    <a:close/>
                  </a:path>
                </a:pathLst>
              </a:custGeom>
              <a:solidFill>
                <a:srgbClr val="FFFFFF"/>
              </a:solidFill>
              <a:ln w="5706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75" name="フリーフォーム: 図形 274">
                <a:extLst>
                  <a:ext uri="{FF2B5EF4-FFF2-40B4-BE49-F238E27FC236}">
                    <a16:creationId xmlns:a16="http://schemas.microsoft.com/office/drawing/2014/main" id="{EE1072C0-DBDD-EB30-0324-15C4A685E1A2}"/>
                  </a:ext>
                </a:extLst>
              </p:cNvPr>
              <p:cNvSpPr/>
              <p:nvPr/>
            </p:nvSpPr>
            <p:spPr>
              <a:xfrm>
                <a:off x="2521932" y="4678018"/>
                <a:ext cx="62895" cy="62900"/>
              </a:xfrm>
              <a:custGeom>
                <a:avLst/>
                <a:gdLst>
                  <a:gd name="connsiteX0" fmla="*/ 62896 w 62895"/>
                  <a:gd name="connsiteY0" fmla="*/ 31450 h 62900"/>
                  <a:gd name="connsiteX1" fmla="*/ 31448 w 62895"/>
                  <a:gd name="connsiteY1" fmla="*/ 62900 h 62900"/>
                  <a:gd name="connsiteX2" fmla="*/ 0 w 62895"/>
                  <a:gd name="connsiteY2" fmla="*/ 31450 h 62900"/>
                  <a:gd name="connsiteX3" fmla="*/ 31448 w 62895"/>
                  <a:gd name="connsiteY3" fmla="*/ 0 h 62900"/>
                  <a:gd name="connsiteX4" fmla="*/ 62896 w 62895"/>
                  <a:gd name="connsiteY4" fmla="*/ 31450 h 629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62895" h="62900">
                    <a:moveTo>
                      <a:pt x="62896" y="31450"/>
                    </a:moveTo>
                    <a:cubicBezTo>
                      <a:pt x="62896" y="48819"/>
                      <a:pt x="48816" y="62900"/>
                      <a:pt x="31448" y="62900"/>
                    </a:cubicBezTo>
                    <a:cubicBezTo>
                      <a:pt x="14080" y="62900"/>
                      <a:pt x="0" y="48819"/>
                      <a:pt x="0" y="31450"/>
                    </a:cubicBezTo>
                    <a:cubicBezTo>
                      <a:pt x="0" y="14081"/>
                      <a:pt x="14080" y="0"/>
                      <a:pt x="31448" y="0"/>
                    </a:cubicBezTo>
                    <a:cubicBezTo>
                      <a:pt x="48816" y="0"/>
                      <a:pt x="62896" y="14081"/>
                      <a:pt x="62896" y="31450"/>
                    </a:cubicBezTo>
                    <a:close/>
                  </a:path>
                </a:pathLst>
              </a:custGeom>
              <a:solidFill>
                <a:srgbClr val="FFFFFF"/>
              </a:solidFill>
              <a:ln w="5706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76" name="フリーフォーム: 図形 275">
                <a:extLst>
                  <a:ext uri="{FF2B5EF4-FFF2-40B4-BE49-F238E27FC236}">
                    <a16:creationId xmlns:a16="http://schemas.microsoft.com/office/drawing/2014/main" id="{B513A3D3-03D3-2DB1-E822-31CC056F0788}"/>
                  </a:ext>
                </a:extLst>
              </p:cNvPr>
              <p:cNvSpPr/>
              <p:nvPr/>
            </p:nvSpPr>
            <p:spPr>
              <a:xfrm>
                <a:off x="2328752" y="4660046"/>
                <a:ext cx="62895" cy="62900"/>
              </a:xfrm>
              <a:custGeom>
                <a:avLst/>
                <a:gdLst>
                  <a:gd name="connsiteX0" fmla="*/ 62896 w 62895"/>
                  <a:gd name="connsiteY0" fmla="*/ 31450 h 62900"/>
                  <a:gd name="connsiteX1" fmla="*/ 31448 w 62895"/>
                  <a:gd name="connsiteY1" fmla="*/ 62900 h 62900"/>
                  <a:gd name="connsiteX2" fmla="*/ 0 w 62895"/>
                  <a:gd name="connsiteY2" fmla="*/ 31450 h 62900"/>
                  <a:gd name="connsiteX3" fmla="*/ 31448 w 62895"/>
                  <a:gd name="connsiteY3" fmla="*/ 0 h 62900"/>
                  <a:gd name="connsiteX4" fmla="*/ 62896 w 62895"/>
                  <a:gd name="connsiteY4" fmla="*/ 31450 h 629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62895" h="62900">
                    <a:moveTo>
                      <a:pt x="62896" y="31450"/>
                    </a:moveTo>
                    <a:cubicBezTo>
                      <a:pt x="62896" y="48819"/>
                      <a:pt x="48816" y="62900"/>
                      <a:pt x="31448" y="62900"/>
                    </a:cubicBezTo>
                    <a:cubicBezTo>
                      <a:pt x="14080" y="62900"/>
                      <a:pt x="0" y="48819"/>
                      <a:pt x="0" y="31450"/>
                    </a:cubicBezTo>
                    <a:cubicBezTo>
                      <a:pt x="0" y="14081"/>
                      <a:pt x="14080" y="0"/>
                      <a:pt x="31448" y="0"/>
                    </a:cubicBezTo>
                    <a:cubicBezTo>
                      <a:pt x="48816" y="0"/>
                      <a:pt x="62896" y="14081"/>
                      <a:pt x="62896" y="31450"/>
                    </a:cubicBezTo>
                    <a:close/>
                  </a:path>
                </a:pathLst>
              </a:custGeom>
              <a:solidFill>
                <a:srgbClr val="FFFFFF"/>
              </a:solidFill>
              <a:ln w="5706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77" name="フリーフォーム: 図形 276">
                <a:extLst>
                  <a:ext uri="{FF2B5EF4-FFF2-40B4-BE49-F238E27FC236}">
                    <a16:creationId xmlns:a16="http://schemas.microsoft.com/office/drawing/2014/main" id="{300CF0B4-87E5-6F46-3E2E-DEAAEA6B1198}"/>
                  </a:ext>
                </a:extLst>
              </p:cNvPr>
              <p:cNvSpPr/>
              <p:nvPr/>
            </p:nvSpPr>
            <p:spPr>
              <a:xfrm>
                <a:off x="2405125" y="4660046"/>
                <a:ext cx="62895" cy="62900"/>
              </a:xfrm>
              <a:custGeom>
                <a:avLst/>
                <a:gdLst>
                  <a:gd name="connsiteX0" fmla="*/ 62896 w 62895"/>
                  <a:gd name="connsiteY0" fmla="*/ 31450 h 62900"/>
                  <a:gd name="connsiteX1" fmla="*/ 31448 w 62895"/>
                  <a:gd name="connsiteY1" fmla="*/ 62900 h 62900"/>
                  <a:gd name="connsiteX2" fmla="*/ 0 w 62895"/>
                  <a:gd name="connsiteY2" fmla="*/ 31450 h 62900"/>
                  <a:gd name="connsiteX3" fmla="*/ 31448 w 62895"/>
                  <a:gd name="connsiteY3" fmla="*/ 0 h 62900"/>
                  <a:gd name="connsiteX4" fmla="*/ 62896 w 62895"/>
                  <a:gd name="connsiteY4" fmla="*/ 31450 h 629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62895" h="62900">
                    <a:moveTo>
                      <a:pt x="62896" y="31450"/>
                    </a:moveTo>
                    <a:cubicBezTo>
                      <a:pt x="62896" y="48819"/>
                      <a:pt x="48816" y="62900"/>
                      <a:pt x="31448" y="62900"/>
                    </a:cubicBezTo>
                    <a:cubicBezTo>
                      <a:pt x="14080" y="62900"/>
                      <a:pt x="0" y="48819"/>
                      <a:pt x="0" y="31450"/>
                    </a:cubicBezTo>
                    <a:cubicBezTo>
                      <a:pt x="0" y="14081"/>
                      <a:pt x="14080" y="0"/>
                      <a:pt x="31448" y="0"/>
                    </a:cubicBezTo>
                    <a:cubicBezTo>
                      <a:pt x="48816" y="0"/>
                      <a:pt x="62896" y="14081"/>
                      <a:pt x="62896" y="31450"/>
                    </a:cubicBezTo>
                    <a:close/>
                  </a:path>
                </a:pathLst>
              </a:custGeom>
              <a:solidFill>
                <a:srgbClr val="FFFFFF"/>
              </a:solidFill>
              <a:ln w="5706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78" name="フリーフォーム: 図形 277">
                <a:extLst>
                  <a:ext uri="{FF2B5EF4-FFF2-40B4-BE49-F238E27FC236}">
                    <a16:creationId xmlns:a16="http://schemas.microsoft.com/office/drawing/2014/main" id="{B98F0EDF-009C-85B1-4E3D-19D28684C993}"/>
                  </a:ext>
                </a:extLst>
              </p:cNvPr>
              <p:cNvSpPr/>
              <p:nvPr/>
            </p:nvSpPr>
            <p:spPr>
              <a:xfrm>
                <a:off x="2481499" y="4633089"/>
                <a:ext cx="62895" cy="62900"/>
              </a:xfrm>
              <a:custGeom>
                <a:avLst/>
                <a:gdLst>
                  <a:gd name="connsiteX0" fmla="*/ 62896 w 62895"/>
                  <a:gd name="connsiteY0" fmla="*/ 31450 h 62900"/>
                  <a:gd name="connsiteX1" fmla="*/ 31448 w 62895"/>
                  <a:gd name="connsiteY1" fmla="*/ 62900 h 62900"/>
                  <a:gd name="connsiteX2" fmla="*/ 0 w 62895"/>
                  <a:gd name="connsiteY2" fmla="*/ 31450 h 62900"/>
                  <a:gd name="connsiteX3" fmla="*/ 31448 w 62895"/>
                  <a:gd name="connsiteY3" fmla="*/ 0 h 62900"/>
                  <a:gd name="connsiteX4" fmla="*/ 62896 w 62895"/>
                  <a:gd name="connsiteY4" fmla="*/ 31450 h 629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62895" h="62900">
                    <a:moveTo>
                      <a:pt x="62896" y="31450"/>
                    </a:moveTo>
                    <a:cubicBezTo>
                      <a:pt x="62896" y="48819"/>
                      <a:pt x="48816" y="62900"/>
                      <a:pt x="31448" y="62900"/>
                    </a:cubicBezTo>
                    <a:cubicBezTo>
                      <a:pt x="14080" y="62900"/>
                      <a:pt x="0" y="48819"/>
                      <a:pt x="0" y="31450"/>
                    </a:cubicBezTo>
                    <a:cubicBezTo>
                      <a:pt x="0" y="14081"/>
                      <a:pt x="14080" y="0"/>
                      <a:pt x="31448" y="0"/>
                    </a:cubicBezTo>
                    <a:cubicBezTo>
                      <a:pt x="48816" y="0"/>
                      <a:pt x="62896" y="14081"/>
                      <a:pt x="62896" y="31450"/>
                    </a:cubicBezTo>
                    <a:close/>
                  </a:path>
                </a:pathLst>
              </a:custGeom>
              <a:solidFill>
                <a:srgbClr val="FFFFFF"/>
              </a:solidFill>
              <a:ln w="5706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79" name="フリーフォーム: 図形 278">
                <a:extLst>
                  <a:ext uri="{FF2B5EF4-FFF2-40B4-BE49-F238E27FC236}">
                    <a16:creationId xmlns:a16="http://schemas.microsoft.com/office/drawing/2014/main" id="{E38000D7-22D8-193E-898E-2B1486137E15}"/>
                  </a:ext>
                </a:extLst>
              </p:cNvPr>
              <p:cNvSpPr/>
              <p:nvPr/>
            </p:nvSpPr>
            <p:spPr>
              <a:xfrm>
                <a:off x="2328752" y="4610625"/>
                <a:ext cx="62895" cy="62900"/>
              </a:xfrm>
              <a:custGeom>
                <a:avLst/>
                <a:gdLst>
                  <a:gd name="connsiteX0" fmla="*/ 62896 w 62895"/>
                  <a:gd name="connsiteY0" fmla="*/ 31450 h 62900"/>
                  <a:gd name="connsiteX1" fmla="*/ 31448 w 62895"/>
                  <a:gd name="connsiteY1" fmla="*/ 62900 h 62900"/>
                  <a:gd name="connsiteX2" fmla="*/ 0 w 62895"/>
                  <a:gd name="connsiteY2" fmla="*/ 31450 h 62900"/>
                  <a:gd name="connsiteX3" fmla="*/ 31448 w 62895"/>
                  <a:gd name="connsiteY3" fmla="*/ 0 h 62900"/>
                  <a:gd name="connsiteX4" fmla="*/ 62896 w 62895"/>
                  <a:gd name="connsiteY4" fmla="*/ 31450 h 629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62895" h="62900">
                    <a:moveTo>
                      <a:pt x="62896" y="31450"/>
                    </a:moveTo>
                    <a:cubicBezTo>
                      <a:pt x="62896" y="48819"/>
                      <a:pt x="48816" y="62900"/>
                      <a:pt x="31448" y="62900"/>
                    </a:cubicBezTo>
                    <a:cubicBezTo>
                      <a:pt x="14080" y="62900"/>
                      <a:pt x="0" y="48819"/>
                      <a:pt x="0" y="31450"/>
                    </a:cubicBezTo>
                    <a:cubicBezTo>
                      <a:pt x="0" y="14081"/>
                      <a:pt x="14080" y="0"/>
                      <a:pt x="31448" y="0"/>
                    </a:cubicBezTo>
                    <a:cubicBezTo>
                      <a:pt x="48816" y="0"/>
                      <a:pt x="62896" y="14081"/>
                      <a:pt x="62896" y="31450"/>
                    </a:cubicBezTo>
                    <a:close/>
                  </a:path>
                </a:pathLst>
              </a:custGeom>
              <a:solidFill>
                <a:srgbClr val="FFFFFF"/>
              </a:solidFill>
              <a:ln w="5706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80" name="フリーフォーム: 図形 279">
                <a:extLst>
                  <a:ext uri="{FF2B5EF4-FFF2-40B4-BE49-F238E27FC236}">
                    <a16:creationId xmlns:a16="http://schemas.microsoft.com/office/drawing/2014/main" id="{D76AA2A2-8173-C4E6-8719-4C109C1F9ADA}"/>
                  </a:ext>
                </a:extLst>
              </p:cNvPr>
              <p:cNvSpPr/>
              <p:nvPr/>
            </p:nvSpPr>
            <p:spPr>
              <a:xfrm>
                <a:off x="2405125" y="4601639"/>
                <a:ext cx="62895" cy="62900"/>
              </a:xfrm>
              <a:custGeom>
                <a:avLst/>
                <a:gdLst>
                  <a:gd name="connsiteX0" fmla="*/ 62896 w 62895"/>
                  <a:gd name="connsiteY0" fmla="*/ 31450 h 62900"/>
                  <a:gd name="connsiteX1" fmla="*/ 31448 w 62895"/>
                  <a:gd name="connsiteY1" fmla="*/ 62900 h 62900"/>
                  <a:gd name="connsiteX2" fmla="*/ 0 w 62895"/>
                  <a:gd name="connsiteY2" fmla="*/ 31450 h 62900"/>
                  <a:gd name="connsiteX3" fmla="*/ 31448 w 62895"/>
                  <a:gd name="connsiteY3" fmla="*/ 0 h 62900"/>
                  <a:gd name="connsiteX4" fmla="*/ 62896 w 62895"/>
                  <a:gd name="connsiteY4" fmla="*/ 31450 h 629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62895" h="62900">
                    <a:moveTo>
                      <a:pt x="62896" y="31450"/>
                    </a:moveTo>
                    <a:cubicBezTo>
                      <a:pt x="62896" y="48819"/>
                      <a:pt x="48816" y="62900"/>
                      <a:pt x="31448" y="62900"/>
                    </a:cubicBezTo>
                    <a:cubicBezTo>
                      <a:pt x="14080" y="62900"/>
                      <a:pt x="0" y="48819"/>
                      <a:pt x="0" y="31450"/>
                    </a:cubicBezTo>
                    <a:cubicBezTo>
                      <a:pt x="0" y="14081"/>
                      <a:pt x="14080" y="0"/>
                      <a:pt x="31448" y="0"/>
                    </a:cubicBezTo>
                    <a:cubicBezTo>
                      <a:pt x="48816" y="0"/>
                      <a:pt x="62896" y="14081"/>
                      <a:pt x="62896" y="31450"/>
                    </a:cubicBezTo>
                    <a:close/>
                  </a:path>
                </a:pathLst>
              </a:custGeom>
              <a:solidFill>
                <a:srgbClr val="FFFFFF"/>
              </a:solidFill>
              <a:ln w="5706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81" name="フリーフォーム: 図形 280">
                <a:extLst>
                  <a:ext uri="{FF2B5EF4-FFF2-40B4-BE49-F238E27FC236}">
                    <a16:creationId xmlns:a16="http://schemas.microsoft.com/office/drawing/2014/main" id="{58A46E77-C087-393F-D4A5-7F1997AFB5F0}"/>
                  </a:ext>
                </a:extLst>
              </p:cNvPr>
              <p:cNvSpPr/>
              <p:nvPr/>
            </p:nvSpPr>
            <p:spPr>
              <a:xfrm>
                <a:off x="2481499" y="4597146"/>
                <a:ext cx="62895" cy="62900"/>
              </a:xfrm>
              <a:custGeom>
                <a:avLst/>
                <a:gdLst>
                  <a:gd name="connsiteX0" fmla="*/ 62896 w 62895"/>
                  <a:gd name="connsiteY0" fmla="*/ 31450 h 62900"/>
                  <a:gd name="connsiteX1" fmla="*/ 31448 w 62895"/>
                  <a:gd name="connsiteY1" fmla="*/ 62900 h 62900"/>
                  <a:gd name="connsiteX2" fmla="*/ 0 w 62895"/>
                  <a:gd name="connsiteY2" fmla="*/ 31450 h 62900"/>
                  <a:gd name="connsiteX3" fmla="*/ 31448 w 62895"/>
                  <a:gd name="connsiteY3" fmla="*/ 0 h 62900"/>
                  <a:gd name="connsiteX4" fmla="*/ 62896 w 62895"/>
                  <a:gd name="connsiteY4" fmla="*/ 31450 h 629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62895" h="62900">
                    <a:moveTo>
                      <a:pt x="62896" y="31450"/>
                    </a:moveTo>
                    <a:cubicBezTo>
                      <a:pt x="62896" y="48819"/>
                      <a:pt x="48816" y="62900"/>
                      <a:pt x="31448" y="62900"/>
                    </a:cubicBezTo>
                    <a:cubicBezTo>
                      <a:pt x="14080" y="62900"/>
                      <a:pt x="0" y="48819"/>
                      <a:pt x="0" y="31450"/>
                    </a:cubicBezTo>
                    <a:cubicBezTo>
                      <a:pt x="0" y="14081"/>
                      <a:pt x="14080" y="0"/>
                      <a:pt x="31448" y="0"/>
                    </a:cubicBezTo>
                    <a:cubicBezTo>
                      <a:pt x="48816" y="0"/>
                      <a:pt x="62896" y="14081"/>
                      <a:pt x="62896" y="31450"/>
                    </a:cubicBezTo>
                    <a:close/>
                  </a:path>
                </a:pathLst>
              </a:custGeom>
              <a:solidFill>
                <a:srgbClr val="FFFFFF"/>
              </a:solidFill>
              <a:ln w="5706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82" name="フリーフォーム: 図形 281">
                <a:extLst>
                  <a:ext uri="{FF2B5EF4-FFF2-40B4-BE49-F238E27FC236}">
                    <a16:creationId xmlns:a16="http://schemas.microsoft.com/office/drawing/2014/main" id="{1DFFE385-1C76-784B-355F-A0C79EAEEFDE}"/>
                  </a:ext>
                </a:extLst>
              </p:cNvPr>
              <p:cNvSpPr/>
              <p:nvPr/>
            </p:nvSpPr>
            <p:spPr>
              <a:xfrm>
                <a:off x="2369185" y="4561203"/>
                <a:ext cx="62895" cy="62900"/>
              </a:xfrm>
              <a:custGeom>
                <a:avLst/>
                <a:gdLst>
                  <a:gd name="connsiteX0" fmla="*/ 62896 w 62895"/>
                  <a:gd name="connsiteY0" fmla="*/ 31450 h 62900"/>
                  <a:gd name="connsiteX1" fmla="*/ 31448 w 62895"/>
                  <a:gd name="connsiteY1" fmla="*/ 62900 h 62900"/>
                  <a:gd name="connsiteX2" fmla="*/ 0 w 62895"/>
                  <a:gd name="connsiteY2" fmla="*/ 31450 h 62900"/>
                  <a:gd name="connsiteX3" fmla="*/ 31448 w 62895"/>
                  <a:gd name="connsiteY3" fmla="*/ 0 h 62900"/>
                  <a:gd name="connsiteX4" fmla="*/ 62896 w 62895"/>
                  <a:gd name="connsiteY4" fmla="*/ 31450 h 629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62895" h="62900">
                    <a:moveTo>
                      <a:pt x="62896" y="31450"/>
                    </a:moveTo>
                    <a:cubicBezTo>
                      <a:pt x="62896" y="48819"/>
                      <a:pt x="48816" y="62900"/>
                      <a:pt x="31448" y="62900"/>
                    </a:cubicBezTo>
                    <a:cubicBezTo>
                      <a:pt x="14080" y="62900"/>
                      <a:pt x="0" y="48819"/>
                      <a:pt x="0" y="31450"/>
                    </a:cubicBezTo>
                    <a:cubicBezTo>
                      <a:pt x="0" y="14081"/>
                      <a:pt x="14080" y="0"/>
                      <a:pt x="31448" y="0"/>
                    </a:cubicBezTo>
                    <a:cubicBezTo>
                      <a:pt x="48816" y="0"/>
                      <a:pt x="62896" y="14081"/>
                      <a:pt x="62896" y="31450"/>
                    </a:cubicBezTo>
                    <a:close/>
                  </a:path>
                </a:pathLst>
              </a:custGeom>
              <a:solidFill>
                <a:srgbClr val="FFFFFF"/>
              </a:solidFill>
              <a:ln w="5706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83" name="フリーフォーム: 図形 282">
                <a:extLst>
                  <a:ext uri="{FF2B5EF4-FFF2-40B4-BE49-F238E27FC236}">
                    <a16:creationId xmlns:a16="http://schemas.microsoft.com/office/drawing/2014/main" id="{74AC7687-0831-EE1C-F333-2216CAB658C6}"/>
                  </a:ext>
                </a:extLst>
              </p:cNvPr>
              <p:cNvSpPr/>
              <p:nvPr/>
            </p:nvSpPr>
            <p:spPr>
              <a:xfrm>
                <a:off x="2445558" y="4561203"/>
                <a:ext cx="62895" cy="62900"/>
              </a:xfrm>
              <a:custGeom>
                <a:avLst/>
                <a:gdLst>
                  <a:gd name="connsiteX0" fmla="*/ 62896 w 62895"/>
                  <a:gd name="connsiteY0" fmla="*/ 31450 h 62900"/>
                  <a:gd name="connsiteX1" fmla="*/ 31448 w 62895"/>
                  <a:gd name="connsiteY1" fmla="*/ 62900 h 62900"/>
                  <a:gd name="connsiteX2" fmla="*/ 0 w 62895"/>
                  <a:gd name="connsiteY2" fmla="*/ 31450 h 62900"/>
                  <a:gd name="connsiteX3" fmla="*/ 31448 w 62895"/>
                  <a:gd name="connsiteY3" fmla="*/ 0 h 62900"/>
                  <a:gd name="connsiteX4" fmla="*/ 62896 w 62895"/>
                  <a:gd name="connsiteY4" fmla="*/ 31450 h 629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62895" h="62900">
                    <a:moveTo>
                      <a:pt x="62896" y="31450"/>
                    </a:moveTo>
                    <a:cubicBezTo>
                      <a:pt x="62896" y="48819"/>
                      <a:pt x="48816" y="62900"/>
                      <a:pt x="31448" y="62900"/>
                    </a:cubicBezTo>
                    <a:cubicBezTo>
                      <a:pt x="14080" y="62900"/>
                      <a:pt x="0" y="48819"/>
                      <a:pt x="0" y="31450"/>
                    </a:cubicBezTo>
                    <a:cubicBezTo>
                      <a:pt x="0" y="14081"/>
                      <a:pt x="14080" y="0"/>
                      <a:pt x="31448" y="0"/>
                    </a:cubicBezTo>
                    <a:cubicBezTo>
                      <a:pt x="48816" y="0"/>
                      <a:pt x="62896" y="14081"/>
                      <a:pt x="62896" y="31450"/>
                    </a:cubicBezTo>
                    <a:close/>
                  </a:path>
                </a:pathLst>
              </a:custGeom>
              <a:solidFill>
                <a:srgbClr val="FFFFFF"/>
              </a:solidFill>
              <a:ln w="5706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84" name="フリーフォーム: 図形 283">
                <a:extLst>
                  <a:ext uri="{FF2B5EF4-FFF2-40B4-BE49-F238E27FC236}">
                    <a16:creationId xmlns:a16="http://schemas.microsoft.com/office/drawing/2014/main" id="{B1D4E081-556C-DD9C-3668-9DB6696BC518}"/>
                  </a:ext>
                </a:extLst>
              </p:cNvPr>
              <p:cNvSpPr/>
              <p:nvPr/>
            </p:nvSpPr>
            <p:spPr>
              <a:xfrm>
                <a:off x="2405125" y="4498303"/>
                <a:ext cx="62895" cy="62900"/>
              </a:xfrm>
              <a:custGeom>
                <a:avLst/>
                <a:gdLst>
                  <a:gd name="connsiteX0" fmla="*/ 62896 w 62895"/>
                  <a:gd name="connsiteY0" fmla="*/ 31450 h 62900"/>
                  <a:gd name="connsiteX1" fmla="*/ 31448 w 62895"/>
                  <a:gd name="connsiteY1" fmla="*/ 62900 h 62900"/>
                  <a:gd name="connsiteX2" fmla="*/ 0 w 62895"/>
                  <a:gd name="connsiteY2" fmla="*/ 31450 h 62900"/>
                  <a:gd name="connsiteX3" fmla="*/ 31448 w 62895"/>
                  <a:gd name="connsiteY3" fmla="*/ 0 h 62900"/>
                  <a:gd name="connsiteX4" fmla="*/ 62896 w 62895"/>
                  <a:gd name="connsiteY4" fmla="*/ 31450 h 629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62895" h="62900">
                    <a:moveTo>
                      <a:pt x="62896" y="31450"/>
                    </a:moveTo>
                    <a:cubicBezTo>
                      <a:pt x="62896" y="48819"/>
                      <a:pt x="48816" y="62900"/>
                      <a:pt x="31448" y="62900"/>
                    </a:cubicBezTo>
                    <a:cubicBezTo>
                      <a:pt x="14080" y="62900"/>
                      <a:pt x="0" y="48819"/>
                      <a:pt x="0" y="31450"/>
                    </a:cubicBezTo>
                    <a:cubicBezTo>
                      <a:pt x="0" y="14081"/>
                      <a:pt x="14080" y="0"/>
                      <a:pt x="31448" y="0"/>
                    </a:cubicBezTo>
                    <a:cubicBezTo>
                      <a:pt x="48816" y="0"/>
                      <a:pt x="62896" y="14081"/>
                      <a:pt x="62896" y="31450"/>
                    </a:cubicBezTo>
                    <a:close/>
                  </a:path>
                </a:pathLst>
              </a:custGeom>
              <a:solidFill>
                <a:srgbClr val="FFFFFF"/>
              </a:solidFill>
              <a:ln w="5706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85" name="フリーフォーム: 図形 284">
                <a:extLst>
                  <a:ext uri="{FF2B5EF4-FFF2-40B4-BE49-F238E27FC236}">
                    <a16:creationId xmlns:a16="http://schemas.microsoft.com/office/drawing/2014/main" id="{D00F2F87-9441-3673-C91A-CE8DA643E1C8}"/>
                  </a:ext>
                </a:extLst>
              </p:cNvPr>
              <p:cNvSpPr/>
              <p:nvPr/>
            </p:nvSpPr>
            <p:spPr>
              <a:xfrm>
                <a:off x="2405125" y="4453374"/>
                <a:ext cx="62895" cy="62900"/>
              </a:xfrm>
              <a:custGeom>
                <a:avLst/>
                <a:gdLst>
                  <a:gd name="connsiteX0" fmla="*/ 62896 w 62895"/>
                  <a:gd name="connsiteY0" fmla="*/ 31450 h 62900"/>
                  <a:gd name="connsiteX1" fmla="*/ 31448 w 62895"/>
                  <a:gd name="connsiteY1" fmla="*/ 62900 h 62900"/>
                  <a:gd name="connsiteX2" fmla="*/ 0 w 62895"/>
                  <a:gd name="connsiteY2" fmla="*/ 31450 h 62900"/>
                  <a:gd name="connsiteX3" fmla="*/ 31448 w 62895"/>
                  <a:gd name="connsiteY3" fmla="*/ 0 h 62900"/>
                  <a:gd name="connsiteX4" fmla="*/ 62896 w 62895"/>
                  <a:gd name="connsiteY4" fmla="*/ 31450 h 629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62895" h="62900">
                    <a:moveTo>
                      <a:pt x="62896" y="31450"/>
                    </a:moveTo>
                    <a:cubicBezTo>
                      <a:pt x="62896" y="48819"/>
                      <a:pt x="48816" y="62900"/>
                      <a:pt x="31448" y="62900"/>
                    </a:cubicBezTo>
                    <a:cubicBezTo>
                      <a:pt x="14080" y="62900"/>
                      <a:pt x="0" y="48819"/>
                      <a:pt x="0" y="31450"/>
                    </a:cubicBezTo>
                    <a:cubicBezTo>
                      <a:pt x="0" y="14081"/>
                      <a:pt x="14080" y="0"/>
                      <a:pt x="31448" y="0"/>
                    </a:cubicBezTo>
                    <a:cubicBezTo>
                      <a:pt x="48816" y="0"/>
                      <a:pt x="62896" y="14081"/>
                      <a:pt x="62896" y="31450"/>
                    </a:cubicBezTo>
                    <a:close/>
                  </a:path>
                </a:pathLst>
              </a:custGeom>
              <a:solidFill>
                <a:srgbClr val="FFFFFF"/>
              </a:solidFill>
              <a:ln w="5706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86" name="フリーフォーム: 図形 285">
                <a:extLst>
                  <a:ext uri="{FF2B5EF4-FFF2-40B4-BE49-F238E27FC236}">
                    <a16:creationId xmlns:a16="http://schemas.microsoft.com/office/drawing/2014/main" id="{D8A3C412-FDB9-9B56-1E22-902148AF6E2B}"/>
                  </a:ext>
                </a:extLst>
              </p:cNvPr>
              <p:cNvSpPr/>
              <p:nvPr/>
            </p:nvSpPr>
            <p:spPr>
              <a:xfrm>
                <a:off x="2328752" y="4260181"/>
                <a:ext cx="62895" cy="62900"/>
              </a:xfrm>
              <a:custGeom>
                <a:avLst/>
                <a:gdLst>
                  <a:gd name="connsiteX0" fmla="*/ 62896 w 62895"/>
                  <a:gd name="connsiteY0" fmla="*/ 31450 h 62900"/>
                  <a:gd name="connsiteX1" fmla="*/ 31448 w 62895"/>
                  <a:gd name="connsiteY1" fmla="*/ 62900 h 62900"/>
                  <a:gd name="connsiteX2" fmla="*/ 0 w 62895"/>
                  <a:gd name="connsiteY2" fmla="*/ 31450 h 62900"/>
                  <a:gd name="connsiteX3" fmla="*/ 31448 w 62895"/>
                  <a:gd name="connsiteY3" fmla="*/ 0 h 62900"/>
                  <a:gd name="connsiteX4" fmla="*/ 62896 w 62895"/>
                  <a:gd name="connsiteY4" fmla="*/ 31450 h 629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62895" h="62900">
                    <a:moveTo>
                      <a:pt x="62896" y="31450"/>
                    </a:moveTo>
                    <a:cubicBezTo>
                      <a:pt x="62896" y="48819"/>
                      <a:pt x="48816" y="62900"/>
                      <a:pt x="31448" y="62900"/>
                    </a:cubicBezTo>
                    <a:cubicBezTo>
                      <a:pt x="14080" y="62900"/>
                      <a:pt x="0" y="48819"/>
                      <a:pt x="0" y="31450"/>
                    </a:cubicBezTo>
                    <a:cubicBezTo>
                      <a:pt x="0" y="14081"/>
                      <a:pt x="14080" y="0"/>
                      <a:pt x="31448" y="0"/>
                    </a:cubicBezTo>
                    <a:cubicBezTo>
                      <a:pt x="48816" y="0"/>
                      <a:pt x="62896" y="14081"/>
                      <a:pt x="62896" y="31450"/>
                    </a:cubicBezTo>
                    <a:close/>
                  </a:path>
                </a:pathLst>
              </a:custGeom>
              <a:solidFill>
                <a:srgbClr val="FFFFFF"/>
              </a:solidFill>
              <a:ln w="5706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87" name="フリーフォーム: 図形 286">
                <a:extLst>
                  <a:ext uri="{FF2B5EF4-FFF2-40B4-BE49-F238E27FC236}">
                    <a16:creationId xmlns:a16="http://schemas.microsoft.com/office/drawing/2014/main" id="{AAD7890A-968D-F4FC-4D53-BF772D5B58F4}"/>
                  </a:ext>
                </a:extLst>
              </p:cNvPr>
              <p:cNvSpPr/>
              <p:nvPr/>
            </p:nvSpPr>
            <p:spPr>
              <a:xfrm>
                <a:off x="2405125" y="4237716"/>
                <a:ext cx="62895" cy="62900"/>
              </a:xfrm>
              <a:custGeom>
                <a:avLst/>
                <a:gdLst>
                  <a:gd name="connsiteX0" fmla="*/ 62896 w 62895"/>
                  <a:gd name="connsiteY0" fmla="*/ 31450 h 62900"/>
                  <a:gd name="connsiteX1" fmla="*/ 31448 w 62895"/>
                  <a:gd name="connsiteY1" fmla="*/ 62900 h 62900"/>
                  <a:gd name="connsiteX2" fmla="*/ 0 w 62895"/>
                  <a:gd name="connsiteY2" fmla="*/ 31450 h 62900"/>
                  <a:gd name="connsiteX3" fmla="*/ 31448 w 62895"/>
                  <a:gd name="connsiteY3" fmla="*/ 0 h 62900"/>
                  <a:gd name="connsiteX4" fmla="*/ 62896 w 62895"/>
                  <a:gd name="connsiteY4" fmla="*/ 31450 h 629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62895" h="62900">
                    <a:moveTo>
                      <a:pt x="62896" y="31450"/>
                    </a:moveTo>
                    <a:cubicBezTo>
                      <a:pt x="62896" y="48819"/>
                      <a:pt x="48816" y="62900"/>
                      <a:pt x="31448" y="62900"/>
                    </a:cubicBezTo>
                    <a:cubicBezTo>
                      <a:pt x="14080" y="62900"/>
                      <a:pt x="0" y="48819"/>
                      <a:pt x="0" y="31450"/>
                    </a:cubicBezTo>
                    <a:cubicBezTo>
                      <a:pt x="0" y="14081"/>
                      <a:pt x="14080" y="0"/>
                      <a:pt x="31448" y="0"/>
                    </a:cubicBezTo>
                    <a:cubicBezTo>
                      <a:pt x="48816" y="0"/>
                      <a:pt x="62896" y="14081"/>
                      <a:pt x="62896" y="31450"/>
                    </a:cubicBezTo>
                    <a:close/>
                  </a:path>
                </a:pathLst>
              </a:custGeom>
              <a:solidFill>
                <a:srgbClr val="FFFFFF"/>
              </a:solidFill>
              <a:ln w="5706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88" name="フリーフォーム: 図形 287">
                <a:extLst>
                  <a:ext uri="{FF2B5EF4-FFF2-40B4-BE49-F238E27FC236}">
                    <a16:creationId xmlns:a16="http://schemas.microsoft.com/office/drawing/2014/main" id="{B660A5C2-BFB2-38F4-DA6B-71ADDCCEE6AF}"/>
                  </a:ext>
                </a:extLst>
              </p:cNvPr>
              <p:cNvSpPr/>
              <p:nvPr/>
            </p:nvSpPr>
            <p:spPr>
              <a:xfrm>
                <a:off x="2481499" y="4228731"/>
                <a:ext cx="62895" cy="62900"/>
              </a:xfrm>
              <a:custGeom>
                <a:avLst/>
                <a:gdLst>
                  <a:gd name="connsiteX0" fmla="*/ 62896 w 62895"/>
                  <a:gd name="connsiteY0" fmla="*/ 31450 h 62900"/>
                  <a:gd name="connsiteX1" fmla="*/ 31448 w 62895"/>
                  <a:gd name="connsiteY1" fmla="*/ 62900 h 62900"/>
                  <a:gd name="connsiteX2" fmla="*/ 0 w 62895"/>
                  <a:gd name="connsiteY2" fmla="*/ 31450 h 62900"/>
                  <a:gd name="connsiteX3" fmla="*/ 31448 w 62895"/>
                  <a:gd name="connsiteY3" fmla="*/ 0 h 62900"/>
                  <a:gd name="connsiteX4" fmla="*/ 62896 w 62895"/>
                  <a:gd name="connsiteY4" fmla="*/ 31450 h 629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62895" h="62900">
                    <a:moveTo>
                      <a:pt x="62896" y="31450"/>
                    </a:moveTo>
                    <a:cubicBezTo>
                      <a:pt x="62896" y="48819"/>
                      <a:pt x="48816" y="62900"/>
                      <a:pt x="31448" y="62900"/>
                    </a:cubicBezTo>
                    <a:cubicBezTo>
                      <a:pt x="14080" y="62900"/>
                      <a:pt x="0" y="48819"/>
                      <a:pt x="0" y="31450"/>
                    </a:cubicBezTo>
                    <a:cubicBezTo>
                      <a:pt x="0" y="14081"/>
                      <a:pt x="14080" y="0"/>
                      <a:pt x="31448" y="0"/>
                    </a:cubicBezTo>
                    <a:cubicBezTo>
                      <a:pt x="48816" y="0"/>
                      <a:pt x="62896" y="14081"/>
                      <a:pt x="62896" y="31450"/>
                    </a:cubicBezTo>
                    <a:close/>
                  </a:path>
                </a:pathLst>
              </a:custGeom>
              <a:solidFill>
                <a:srgbClr val="FFFFFF"/>
              </a:solidFill>
              <a:ln w="5706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89" name="フリーフォーム: 図形 288">
                <a:extLst>
                  <a:ext uri="{FF2B5EF4-FFF2-40B4-BE49-F238E27FC236}">
                    <a16:creationId xmlns:a16="http://schemas.microsoft.com/office/drawing/2014/main" id="{6DA21996-7E87-B674-E5F4-93717E971F54}"/>
                  </a:ext>
                </a:extLst>
              </p:cNvPr>
              <p:cNvSpPr/>
              <p:nvPr/>
            </p:nvSpPr>
            <p:spPr>
              <a:xfrm>
                <a:off x="2405125" y="4174816"/>
                <a:ext cx="62895" cy="62900"/>
              </a:xfrm>
              <a:custGeom>
                <a:avLst/>
                <a:gdLst>
                  <a:gd name="connsiteX0" fmla="*/ 62896 w 62895"/>
                  <a:gd name="connsiteY0" fmla="*/ 31450 h 62900"/>
                  <a:gd name="connsiteX1" fmla="*/ 31448 w 62895"/>
                  <a:gd name="connsiteY1" fmla="*/ 62900 h 62900"/>
                  <a:gd name="connsiteX2" fmla="*/ 0 w 62895"/>
                  <a:gd name="connsiteY2" fmla="*/ 31450 h 62900"/>
                  <a:gd name="connsiteX3" fmla="*/ 31448 w 62895"/>
                  <a:gd name="connsiteY3" fmla="*/ 0 h 62900"/>
                  <a:gd name="connsiteX4" fmla="*/ 62896 w 62895"/>
                  <a:gd name="connsiteY4" fmla="*/ 31450 h 629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62895" h="62900">
                    <a:moveTo>
                      <a:pt x="62896" y="31450"/>
                    </a:moveTo>
                    <a:cubicBezTo>
                      <a:pt x="62896" y="48819"/>
                      <a:pt x="48816" y="62900"/>
                      <a:pt x="31448" y="62900"/>
                    </a:cubicBezTo>
                    <a:cubicBezTo>
                      <a:pt x="14080" y="62900"/>
                      <a:pt x="0" y="48819"/>
                      <a:pt x="0" y="31450"/>
                    </a:cubicBezTo>
                    <a:cubicBezTo>
                      <a:pt x="0" y="14081"/>
                      <a:pt x="14080" y="0"/>
                      <a:pt x="31448" y="0"/>
                    </a:cubicBezTo>
                    <a:cubicBezTo>
                      <a:pt x="48816" y="0"/>
                      <a:pt x="62896" y="14081"/>
                      <a:pt x="62896" y="31450"/>
                    </a:cubicBezTo>
                    <a:close/>
                  </a:path>
                </a:pathLst>
              </a:custGeom>
              <a:solidFill>
                <a:srgbClr val="FFFFFF"/>
              </a:solidFill>
              <a:ln w="5706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90" name="フリーフォーム: 図形 289">
                <a:extLst>
                  <a:ext uri="{FF2B5EF4-FFF2-40B4-BE49-F238E27FC236}">
                    <a16:creationId xmlns:a16="http://schemas.microsoft.com/office/drawing/2014/main" id="{E2510C2C-B26B-78B9-B760-A2FD6BAD7BC6}"/>
                  </a:ext>
                </a:extLst>
              </p:cNvPr>
              <p:cNvSpPr/>
              <p:nvPr/>
            </p:nvSpPr>
            <p:spPr>
              <a:xfrm>
                <a:off x="2292812" y="4129887"/>
                <a:ext cx="62895" cy="62900"/>
              </a:xfrm>
              <a:custGeom>
                <a:avLst/>
                <a:gdLst>
                  <a:gd name="connsiteX0" fmla="*/ 62896 w 62895"/>
                  <a:gd name="connsiteY0" fmla="*/ 31450 h 62900"/>
                  <a:gd name="connsiteX1" fmla="*/ 31448 w 62895"/>
                  <a:gd name="connsiteY1" fmla="*/ 62900 h 62900"/>
                  <a:gd name="connsiteX2" fmla="*/ 0 w 62895"/>
                  <a:gd name="connsiteY2" fmla="*/ 31450 h 62900"/>
                  <a:gd name="connsiteX3" fmla="*/ 31448 w 62895"/>
                  <a:gd name="connsiteY3" fmla="*/ 0 h 62900"/>
                  <a:gd name="connsiteX4" fmla="*/ 62896 w 62895"/>
                  <a:gd name="connsiteY4" fmla="*/ 31450 h 629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62895" h="62900">
                    <a:moveTo>
                      <a:pt x="62896" y="31450"/>
                    </a:moveTo>
                    <a:cubicBezTo>
                      <a:pt x="62896" y="48819"/>
                      <a:pt x="48816" y="62900"/>
                      <a:pt x="31448" y="62900"/>
                    </a:cubicBezTo>
                    <a:cubicBezTo>
                      <a:pt x="14080" y="62900"/>
                      <a:pt x="0" y="48819"/>
                      <a:pt x="0" y="31450"/>
                    </a:cubicBezTo>
                    <a:cubicBezTo>
                      <a:pt x="0" y="14081"/>
                      <a:pt x="14080" y="0"/>
                      <a:pt x="31448" y="0"/>
                    </a:cubicBezTo>
                    <a:cubicBezTo>
                      <a:pt x="48816" y="0"/>
                      <a:pt x="62896" y="14081"/>
                      <a:pt x="62896" y="31450"/>
                    </a:cubicBezTo>
                    <a:close/>
                  </a:path>
                </a:pathLst>
              </a:custGeom>
              <a:solidFill>
                <a:srgbClr val="FFFFFF"/>
              </a:solidFill>
              <a:ln w="5706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91" name="フリーフォーム: 図形 290">
                <a:extLst>
                  <a:ext uri="{FF2B5EF4-FFF2-40B4-BE49-F238E27FC236}">
                    <a16:creationId xmlns:a16="http://schemas.microsoft.com/office/drawing/2014/main" id="{7AAC595F-FD1A-0847-D752-6893E1A5857F}"/>
                  </a:ext>
                </a:extLst>
              </p:cNvPr>
              <p:cNvSpPr/>
              <p:nvPr/>
            </p:nvSpPr>
            <p:spPr>
              <a:xfrm>
                <a:off x="2369185" y="4116409"/>
                <a:ext cx="62895" cy="62900"/>
              </a:xfrm>
              <a:custGeom>
                <a:avLst/>
                <a:gdLst>
                  <a:gd name="connsiteX0" fmla="*/ 62896 w 62895"/>
                  <a:gd name="connsiteY0" fmla="*/ 31450 h 62900"/>
                  <a:gd name="connsiteX1" fmla="*/ 31448 w 62895"/>
                  <a:gd name="connsiteY1" fmla="*/ 62900 h 62900"/>
                  <a:gd name="connsiteX2" fmla="*/ 0 w 62895"/>
                  <a:gd name="connsiteY2" fmla="*/ 31450 h 62900"/>
                  <a:gd name="connsiteX3" fmla="*/ 31448 w 62895"/>
                  <a:gd name="connsiteY3" fmla="*/ 0 h 62900"/>
                  <a:gd name="connsiteX4" fmla="*/ 62896 w 62895"/>
                  <a:gd name="connsiteY4" fmla="*/ 31450 h 629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62895" h="62900">
                    <a:moveTo>
                      <a:pt x="62896" y="31450"/>
                    </a:moveTo>
                    <a:cubicBezTo>
                      <a:pt x="62896" y="48819"/>
                      <a:pt x="48816" y="62900"/>
                      <a:pt x="31448" y="62900"/>
                    </a:cubicBezTo>
                    <a:cubicBezTo>
                      <a:pt x="14080" y="62900"/>
                      <a:pt x="0" y="48819"/>
                      <a:pt x="0" y="31450"/>
                    </a:cubicBezTo>
                    <a:cubicBezTo>
                      <a:pt x="0" y="14081"/>
                      <a:pt x="14080" y="0"/>
                      <a:pt x="31448" y="0"/>
                    </a:cubicBezTo>
                    <a:cubicBezTo>
                      <a:pt x="48816" y="0"/>
                      <a:pt x="62896" y="14081"/>
                      <a:pt x="62896" y="31450"/>
                    </a:cubicBezTo>
                    <a:close/>
                  </a:path>
                </a:pathLst>
              </a:custGeom>
              <a:solidFill>
                <a:srgbClr val="FFFFFF"/>
              </a:solidFill>
              <a:ln w="5706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92" name="フリーフォーム: 図形 291">
                <a:extLst>
                  <a:ext uri="{FF2B5EF4-FFF2-40B4-BE49-F238E27FC236}">
                    <a16:creationId xmlns:a16="http://schemas.microsoft.com/office/drawing/2014/main" id="{BD858CAD-265B-E6D8-E230-F23C7E572C67}"/>
                  </a:ext>
                </a:extLst>
              </p:cNvPr>
              <p:cNvSpPr/>
              <p:nvPr/>
            </p:nvSpPr>
            <p:spPr>
              <a:xfrm>
                <a:off x="2445558" y="4111916"/>
                <a:ext cx="62895" cy="62900"/>
              </a:xfrm>
              <a:custGeom>
                <a:avLst/>
                <a:gdLst>
                  <a:gd name="connsiteX0" fmla="*/ 62896 w 62895"/>
                  <a:gd name="connsiteY0" fmla="*/ 31450 h 62900"/>
                  <a:gd name="connsiteX1" fmla="*/ 31448 w 62895"/>
                  <a:gd name="connsiteY1" fmla="*/ 62900 h 62900"/>
                  <a:gd name="connsiteX2" fmla="*/ 0 w 62895"/>
                  <a:gd name="connsiteY2" fmla="*/ 31450 h 62900"/>
                  <a:gd name="connsiteX3" fmla="*/ 31448 w 62895"/>
                  <a:gd name="connsiteY3" fmla="*/ 0 h 62900"/>
                  <a:gd name="connsiteX4" fmla="*/ 62896 w 62895"/>
                  <a:gd name="connsiteY4" fmla="*/ 31450 h 629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62895" h="62900">
                    <a:moveTo>
                      <a:pt x="62896" y="31450"/>
                    </a:moveTo>
                    <a:cubicBezTo>
                      <a:pt x="62896" y="48819"/>
                      <a:pt x="48816" y="62900"/>
                      <a:pt x="31448" y="62900"/>
                    </a:cubicBezTo>
                    <a:cubicBezTo>
                      <a:pt x="14080" y="62900"/>
                      <a:pt x="0" y="48819"/>
                      <a:pt x="0" y="31450"/>
                    </a:cubicBezTo>
                    <a:cubicBezTo>
                      <a:pt x="0" y="14081"/>
                      <a:pt x="14080" y="0"/>
                      <a:pt x="31448" y="0"/>
                    </a:cubicBezTo>
                    <a:cubicBezTo>
                      <a:pt x="48816" y="0"/>
                      <a:pt x="62896" y="14081"/>
                      <a:pt x="62896" y="31450"/>
                    </a:cubicBezTo>
                    <a:close/>
                  </a:path>
                </a:pathLst>
              </a:custGeom>
              <a:solidFill>
                <a:srgbClr val="FFFFFF"/>
              </a:solidFill>
              <a:ln w="5706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93" name="フリーフォーム: 図形 292">
                <a:extLst>
                  <a:ext uri="{FF2B5EF4-FFF2-40B4-BE49-F238E27FC236}">
                    <a16:creationId xmlns:a16="http://schemas.microsoft.com/office/drawing/2014/main" id="{5BACBEB7-275A-C963-6327-58BD4BDEB5BD}"/>
                  </a:ext>
                </a:extLst>
              </p:cNvPr>
              <p:cNvSpPr/>
              <p:nvPr/>
            </p:nvSpPr>
            <p:spPr>
              <a:xfrm>
                <a:off x="2521932" y="4102930"/>
                <a:ext cx="62895" cy="62900"/>
              </a:xfrm>
              <a:custGeom>
                <a:avLst/>
                <a:gdLst>
                  <a:gd name="connsiteX0" fmla="*/ 62896 w 62895"/>
                  <a:gd name="connsiteY0" fmla="*/ 31450 h 62900"/>
                  <a:gd name="connsiteX1" fmla="*/ 31448 w 62895"/>
                  <a:gd name="connsiteY1" fmla="*/ 62900 h 62900"/>
                  <a:gd name="connsiteX2" fmla="*/ 0 w 62895"/>
                  <a:gd name="connsiteY2" fmla="*/ 31450 h 62900"/>
                  <a:gd name="connsiteX3" fmla="*/ 31448 w 62895"/>
                  <a:gd name="connsiteY3" fmla="*/ 0 h 62900"/>
                  <a:gd name="connsiteX4" fmla="*/ 62896 w 62895"/>
                  <a:gd name="connsiteY4" fmla="*/ 31450 h 629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62895" h="62900">
                    <a:moveTo>
                      <a:pt x="62896" y="31450"/>
                    </a:moveTo>
                    <a:cubicBezTo>
                      <a:pt x="62896" y="48819"/>
                      <a:pt x="48816" y="62900"/>
                      <a:pt x="31448" y="62900"/>
                    </a:cubicBezTo>
                    <a:cubicBezTo>
                      <a:pt x="14080" y="62900"/>
                      <a:pt x="0" y="48819"/>
                      <a:pt x="0" y="31450"/>
                    </a:cubicBezTo>
                    <a:cubicBezTo>
                      <a:pt x="0" y="14081"/>
                      <a:pt x="14080" y="0"/>
                      <a:pt x="31448" y="0"/>
                    </a:cubicBezTo>
                    <a:cubicBezTo>
                      <a:pt x="48816" y="0"/>
                      <a:pt x="62896" y="14081"/>
                      <a:pt x="62896" y="31450"/>
                    </a:cubicBezTo>
                    <a:close/>
                  </a:path>
                </a:pathLst>
              </a:custGeom>
              <a:solidFill>
                <a:srgbClr val="FFFFFF"/>
              </a:solidFill>
              <a:ln w="5706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94" name="フリーフォーム: 図形 293">
                <a:extLst>
                  <a:ext uri="{FF2B5EF4-FFF2-40B4-BE49-F238E27FC236}">
                    <a16:creationId xmlns:a16="http://schemas.microsoft.com/office/drawing/2014/main" id="{DF51AC0C-37B5-6E36-5C22-EA8F335BC328}"/>
                  </a:ext>
                </a:extLst>
              </p:cNvPr>
              <p:cNvSpPr/>
              <p:nvPr/>
            </p:nvSpPr>
            <p:spPr>
              <a:xfrm>
                <a:off x="2328752" y="4031044"/>
                <a:ext cx="62895" cy="62900"/>
              </a:xfrm>
              <a:custGeom>
                <a:avLst/>
                <a:gdLst>
                  <a:gd name="connsiteX0" fmla="*/ 62896 w 62895"/>
                  <a:gd name="connsiteY0" fmla="*/ 31450 h 62900"/>
                  <a:gd name="connsiteX1" fmla="*/ 31448 w 62895"/>
                  <a:gd name="connsiteY1" fmla="*/ 62900 h 62900"/>
                  <a:gd name="connsiteX2" fmla="*/ 0 w 62895"/>
                  <a:gd name="connsiteY2" fmla="*/ 31450 h 62900"/>
                  <a:gd name="connsiteX3" fmla="*/ 31448 w 62895"/>
                  <a:gd name="connsiteY3" fmla="*/ 0 h 62900"/>
                  <a:gd name="connsiteX4" fmla="*/ 62896 w 62895"/>
                  <a:gd name="connsiteY4" fmla="*/ 31450 h 629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62895" h="62900">
                    <a:moveTo>
                      <a:pt x="62896" y="31450"/>
                    </a:moveTo>
                    <a:cubicBezTo>
                      <a:pt x="62896" y="48819"/>
                      <a:pt x="48816" y="62900"/>
                      <a:pt x="31448" y="62900"/>
                    </a:cubicBezTo>
                    <a:cubicBezTo>
                      <a:pt x="14080" y="62900"/>
                      <a:pt x="0" y="48819"/>
                      <a:pt x="0" y="31450"/>
                    </a:cubicBezTo>
                    <a:cubicBezTo>
                      <a:pt x="0" y="14081"/>
                      <a:pt x="14080" y="0"/>
                      <a:pt x="31448" y="0"/>
                    </a:cubicBezTo>
                    <a:cubicBezTo>
                      <a:pt x="48816" y="0"/>
                      <a:pt x="62896" y="14081"/>
                      <a:pt x="62896" y="31450"/>
                    </a:cubicBezTo>
                    <a:close/>
                  </a:path>
                </a:pathLst>
              </a:custGeom>
              <a:solidFill>
                <a:srgbClr val="FFFFFF"/>
              </a:solidFill>
              <a:ln w="5706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95" name="フリーフォーム: 図形 294">
                <a:extLst>
                  <a:ext uri="{FF2B5EF4-FFF2-40B4-BE49-F238E27FC236}">
                    <a16:creationId xmlns:a16="http://schemas.microsoft.com/office/drawing/2014/main" id="{0CB7E8FF-BDC3-C553-301C-A97DF64B3901}"/>
                  </a:ext>
                </a:extLst>
              </p:cNvPr>
              <p:cNvSpPr/>
              <p:nvPr/>
            </p:nvSpPr>
            <p:spPr>
              <a:xfrm>
                <a:off x="2405125" y="4022059"/>
                <a:ext cx="62895" cy="62900"/>
              </a:xfrm>
              <a:custGeom>
                <a:avLst/>
                <a:gdLst>
                  <a:gd name="connsiteX0" fmla="*/ 62896 w 62895"/>
                  <a:gd name="connsiteY0" fmla="*/ 31450 h 62900"/>
                  <a:gd name="connsiteX1" fmla="*/ 31448 w 62895"/>
                  <a:gd name="connsiteY1" fmla="*/ 62900 h 62900"/>
                  <a:gd name="connsiteX2" fmla="*/ 0 w 62895"/>
                  <a:gd name="connsiteY2" fmla="*/ 31450 h 62900"/>
                  <a:gd name="connsiteX3" fmla="*/ 31448 w 62895"/>
                  <a:gd name="connsiteY3" fmla="*/ 0 h 62900"/>
                  <a:gd name="connsiteX4" fmla="*/ 62896 w 62895"/>
                  <a:gd name="connsiteY4" fmla="*/ 31450 h 629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62895" h="62900">
                    <a:moveTo>
                      <a:pt x="62896" y="31450"/>
                    </a:moveTo>
                    <a:cubicBezTo>
                      <a:pt x="62896" y="48819"/>
                      <a:pt x="48816" y="62900"/>
                      <a:pt x="31448" y="62900"/>
                    </a:cubicBezTo>
                    <a:cubicBezTo>
                      <a:pt x="14080" y="62900"/>
                      <a:pt x="0" y="48819"/>
                      <a:pt x="0" y="31450"/>
                    </a:cubicBezTo>
                    <a:cubicBezTo>
                      <a:pt x="0" y="14081"/>
                      <a:pt x="14080" y="0"/>
                      <a:pt x="31448" y="0"/>
                    </a:cubicBezTo>
                    <a:cubicBezTo>
                      <a:pt x="48816" y="0"/>
                      <a:pt x="62896" y="14081"/>
                      <a:pt x="62896" y="31450"/>
                    </a:cubicBezTo>
                    <a:close/>
                  </a:path>
                </a:pathLst>
              </a:custGeom>
              <a:solidFill>
                <a:srgbClr val="FFFFFF"/>
              </a:solidFill>
              <a:ln w="5706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96" name="フリーフォーム: 図形 295">
                <a:extLst>
                  <a:ext uri="{FF2B5EF4-FFF2-40B4-BE49-F238E27FC236}">
                    <a16:creationId xmlns:a16="http://schemas.microsoft.com/office/drawing/2014/main" id="{14E6D1BB-A078-A922-9CBE-ABE038B8D08F}"/>
                  </a:ext>
                </a:extLst>
              </p:cNvPr>
              <p:cNvSpPr/>
              <p:nvPr/>
            </p:nvSpPr>
            <p:spPr>
              <a:xfrm>
                <a:off x="2481499" y="3990608"/>
                <a:ext cx="62895" cy="62900"/>
              </a:xfrm>
              <a:custGeom>
                <a:avLst/>
                <a:gdLst>
                  <a:gd name="connsiteX0" fmla="*/ 62896 w 62895"/>
                  <a:gd name="connsiteY0" fmla="*/ 31450 h 62900"/>
                  <a:gd name="connsiteX1" fmla="*/ 31448 w 62895"/>
                  <a:gd name="connsiteY1" fmla="*/ 62900 h 62900"/>
                  <a:gd name="connsiteX2" fmla="*/ 0 w 62895"/>
                  <a:gd name="connsiteY2" fmla="*/ 31450 h 62900"/>
                  <a:gd name="connsiteX3" fmla="*/ 31448 w 62895"/>
                  <a:gd name="connsiteY3" fmla="*/ 0 h 62900"/>
                  <a:gd name="connsiteX4" fmla="*/ 62896 w 62895"/>
                  <a:gd name="connsiteY4" fmla="*/ 31450 h 629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62895" h="62900">
                    <a:moveTo>
                      <a:pt x="62896" y="31450"/>
                    </a:moveTo>
                    <a:cubicBezTo>
                      <a:pt x="62896" y="48819"/>
                      <a:pt x="48816" y="62900"/>
                      <a:pt x="31448" y="62900"/>
                    </a:cubicBezTo>
                    <a:cubicBezTo>
                      <a:pt x="14080" y="62900"/>
                      <a:pt x="0" y="48819"/>
                      <a:pt x="0" y="31450"/>
                    </a:cubicBezTo>
                    <a:cubicBezTo>
                      <a:pt x="0" y="14081"/>
                      <a:pt x="14080" y="0"/>
                      <a:pt x="31448" y="0"/>
                    </a:cubicBezTo>
                    <a:cubicBezTo>
                      <a:pt x="48816" y="0"/>
                      <a:pt x="62896" y="14081"/>
                      <a:pt x="62896" y="31450"/>
                    </a:cubicBezTo>
                    <a:close/>
                  </a:path>
                </a:pathLst>
              </a:custGeom>
              <a:solidFill>
                <a:srgbClr val="FFFFFF"/>
              </a:solidFill>
              <a:ln w="5706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97" name="フリーフォーム: 図形 296">
                <a:extLst>
                  <a:ext uri="{FF2B5EF4-FFF2-40B4-BE49-F238E27FC236}">
                    <a16:creationId xmlns:a16="http://schemas.microsoft.com/office/drawing/2014/main" id="{30929376-958B-B00D-AA7B-38C84CAABB87}"/>
                  </a:ext>
                </a:extLst>
              </p:cNvPr>
              <p:cNvSpPr/>
              <p:nvPr/>
            </p:nvSpPr>
            <p:spPr>
              <a:xfrm>
                <a:off x="2369185" y="3972637"/>
                <a:ext cx="62895" cy="62900"/>
              </a:xfrm>
              <a:custGeom>
                <a:avLst/>
                <a:gdLst>
                  <a:gd name="connsiteX0" fmla="*/ 62896 w 62895"/>
                  <a:gd name="connsiteY0" fmla="*/ 31450 h 62900"/>
                  <a:gd name="connsiteX1" fmla="*/ 31448 w 62895"/>
                  <a:gd name="connsiteY1" fmla="*/ 62900 h 62900"/>
                  <a:gd name="connsiteX2" fmla="*/ 0 w 62895"/>
                  <a:gd name="connsiteY2" fmla="*/ 31450 h 62900"/>
                  <a:gd name="connsiteX3" fmla="*/ 31448 w 62895"/>
                  <a:gd name="connsiteY3" fmla="*/ 0 h 62900"/>
                  <a:gd name="connsiteX4" fmla="*/ 62896 w 62895"/>
                  <a:gd name="connsiteY4" fmla="*/ 31450 h 629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62895" h="62900">
                    <a:moveTo>
                      <a:pt x="62896" y="31450"/>
                    </a:moveTo>
                    <a:cubicBezTo>
                      <a:pt x="62896" y="48819"/>
                      <a:pt x="48816" y="62900"/>
                      <a:pt x="31448" y="62900"/>
                    </a:cubicBezTo>
                    <a:cubicBezTo>
                      <a:pt x="14080" y="62900"/>
                      <a:pt x="0" y="48819"/>
                      <a:pt x="0" y="31450"/>
                    </a:cubicBezTo>
                    <a:cubicBezTo>
                      <a:pt x="0" y="14081"/>
                      <a:pt x="14080" y="0"/>
                      <a:pt x="31448" y="0"/>
                    </a:cubicBezTo>
                    <a:cubicBezTo>
                      <a:pt x="48816" y="0"/>
                      <a:pt x="62896" y="14081"/>
                      <a:pt x="62896" y="31450"/>
                    </a:cubicBezTo>
                    <a:close/>
                  </a:path>
                </a:pathLst>
              </a:custGeom>
              <a:solidFill>
                <a:srgbClr val="FFFFFF"/>
              </a:solidFill>
              <a:ln w="5706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98" name="フリーフォーム: 図形 297">
                <a:extLst>
                  <a:ext uri="{FF2B5EF4-FFF2-40B4-BE49-F238E27FC236}">
                    <a16:creationId xmlns:a16="http://schemas.microsoft.com/office/drawing/2014/main" id="{A4C5012C-94D0-6F3A-0DAE-27FB465D4E70}"/>
                  </a:ext>
                </a:extLst>
              </p:cNvPr>
              <p:cNvSpPr/>
              <p:nvPr/>
            </p:nvSpPr>
            <p:spPr>
              <a:xfrm>
                <a:off x="2445558" y="3950173"/>
                <a:ext cx="62895" cy="62900"/>
              </a:xfrm>
              <a:custGeom>
                <a:avLst/>
                <a:gdLst>
                  <a:gd name="connsiteX0" fmla="*/ 62896 w 62895"/>
                  <a:gd name="connsiteY0" fmla="*/ 31450 h 62900"/>
                  <a:gd name="connsiteX1" fmla="*/ 31448 w 62895"/>
                  <a:gd name="connsiteY1" fmla="*/ 62900 h 62900"/>
                  <a:gd name="connsiteX2" fmla="*/ 0 w 62895"/>
                  <a:gd name="connsiteY2" fmla="*/ 31450 h 62900"/>
                  <a:gd name="connsiteX3" fmla="*/ 31448 w 62895"/>
                  <a:gd name="connsiteY3" fmla="*/ 0 h 62900"/>
                  <a:gd name="connsiteX4" fmla="*/ 62896 w 62895"/>
                  <a:gd name="connsiteY4" fmla="*/ 31450 h 629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62895" h="62900">
                    <a:moveTo>
                      <a:pt x="62896" y="31450"/>
                    </a:moveTo>
                    <a:cubicBezTo>
                      <a:pt x="62896" y="48819"/>
                      <a:pt x="48816" y="62900"/>
                      <a:pt x="31448" y="62900"/>
                    </a:cubicBezTo>
                    <a:cubicBezTo>
                      <a:pt x="14080" y="62900"/>
                      <a:pt x="0" y="48819"/>
                      <a:pt x="0" y="31450"/>
                    </a:cubicBezTo>
                    <a:cubicBezTo>
                      <a:pt x="0" y="14081"/>
                      <a:pt x="14080" y="0"/>
                      <a:pt x="31448" y="0"/>
                    </a:cubicBezTo>
                    <a:cubicBezTo>
                      <a:pt x="48816" y="0"/>
                      <a:pt x="62896" y="14081"/>
                      <a:pt x="62896" y="31450"/>
                    </a:cubicBezTo>
                    <a:close/>
                  </a:path>
                </a:pathLst>
              </a:custGeom>
              <a:solidFill>
                <a:srgbClr val="FFFFFF"/>
              </a:solidFill>
              <a:ln w="5706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99" name="フリーフォーム: 図形 298">
                <a:extLst>
                  <a:ext uri="{FF2B5EF4-FFF2-40B4-BE49-F238E27FC236}">
                    <a16:creationId xmlns:a16="http://schemas.microsoft.com/office/drawing/2014/main" id="{1751027C-7C20-5B0D-8654-A268FC6B7ED1}"/>
                  </a:ext>
                </a:extLst>
              </p:cNvPr>
              <p:cNvSpPr/>
              <p:nvPr/>
            </p:nvSpPr>
            <p:spPr>
              <a:xfrm>
                <a:off x="2292812" y="3878287"/>
                <a:ext cx="62895" cy="62900"/>
              </a:xfrm>
              <a:custGeom>
                <a:avLst/>
                <a:gdLst>
                  <a:gd name="connsiteX0" fmla="*/ 62896 w 62895"/>
                  <a:gd name="connsiteY0" fmla="*/ 31450 h 62900"/>
                  <a:gd name="connsiteX1" fmla="*/ 31448 w 62895"/>
                  <a:gd name="connsiteY1" fmla="*/ 62900 h 62900"/>
                  <a:gd name="connsiteX2" fmla="*/ 0 w 62895"/>
                  <a:gd name="connsiteY2" fmla="*/ 31450 h 62900"/>
                  <a:gd name="connsiteX3" fmla="*/ 31448 w 62895"/>
                  <a:gd name="connsiteY3" fmla="*/ 0 h 62900"/>
                  <a:gd name="connsiteX4" fmla="*/ 62896 w 62895"/>
                  <a:gd name="connsiteY4" fmla="*/ 31450 h 629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62895" h="62900">
                    <a:moveTo>
                      <a:pt x="62896" y="31450"/>
                    </a:moveTo>
                    <a:cubicBezTo>
                      <a:pt x="62896" y="48819"/>
                      <a:pt x="48816" y="62900"/>
                      <a:pt x="31448" y="62900"/>
                    </a:cubicBezTo>
                    <a:cubicBezTo>
                      <a:pt x="14080" y="62900"/>
                      <a:pt x="0" y="48819"/>
                      <a:pt x="0" y="31450"/>
                    </a:cubicBezTo>
                    <a:cubicBezTo>
                      <a:pt x="0" y="14081"/>
                      <a:pt x="14080" y="0"/>
                      <a:pt x="31448" y="0"/>
                    </a:cubicBezTo>
                    <a:cubicBezTo>
                      <a:pt x="48816" y="0"/>
                      <a:pt x="62896" y="14081"/>
                      <a:pt x="62896" y="31450"/>
                    </a:cubicBezTo>
                    <a:close/>
                  </a:path>
                </a:pathLst>
              </a:custGeom>
              <a:solidFill>
                <a:srgbClr val="FFFFFF"/>
              </a:solidFill>
              <a:ln w="5706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00" name="フリーフォーム: 図形 299">
                <a:extLst>
                  <a:ext uri="{FF2B5EF4-FFF2-40B4-BE49-F238E27FC236}">
                    <a16:creationId xmlns:a16="http://schemas.microsoft.com/office/drawing/2014/main" id="{232BBBF8-A166-3B6B-3778-36FBBA6B0585}"/>
                  </a:ext>
                </a:extLst>
              </p:cNvPr>
              <p:cNvSpPr/>
              <p:nvPr/>
            </p:nvSpPr>
            <p:spPr>
              <a:xfrm>
                <a:off x="2369185" y="3864808"/>
                <a:ext cx="62895" cy="62900"/>
              </a:xfrm>
              <a:custGeom>
                <a:avLst/>
                <a:gdLst>
                  <a:gd name="connsiteX0" fmla="*/ 62896 w 62895"/>
                  <a:gd name="connsiteY0" fmla="*/ 31450 h 62900"/>
                  <a:gd name="connsiteX1" fmla="*/ 31448 w 62895"/>
                  <a:gd name="connsiteY1" fmla="*/ 62900 h 62900"/>
                  <a:gd name="connsiteX2" fmla="*/ 0 w 62895"/>
                  <a:gd name="connsiteY2" fmla="*/ 31450 h 62900"/>
                  <a:gd name="connsiteX3" fmla="*/ 31448 w 62895"/>
                  <a:gd name="connsiteY3" fmla="*/ 0 h 62900"/>
                  <a:gd name="connsiteX4" fmla="*/ 62896 w 62895"/>
                  <a:gd name="connsiteY4" fmla="*/ 31450 h 629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62895" h="62900">
                    <a:moveTo>
                      <a:pt x="62896" y="31450"/>
                    </a:moveTo>
                    <a:cubicBezTo>
                      <a:pt x="62896" y="48819"/>
                      <a:pt x="48816" y="62900"/>
                      <a:pt x="31448" y="62900"/>
                    </a:cubicBezTo>
                    <a:cubicBezTo>
                      <a:pt x="14080" y="62900"/>
                      <a:pt x="0" y="48819"/>
                      <a:pt x="0" y="31450"/>
                    </a:cubicBezTo>
                    <a:cubicBezTo>
                      <a:pt x="0" y="14081"/>
                      <a:pt x="14080" y="0"/>
                      <a:pt x="31448" y="0"/>
                    </a:cubicBezTo>
                    <a:cubicBezTo>
                      <a:pt x="48816" y="0"/>
                      <a:pt x="62896" y="14081"/>
                      <a:pt x="62896" y="31450"/>
                    </a:cubicBezTo>
                    <a:close/>
                  </a:path>
                </a:pathLst>
              </a:custGeom>
              <a:solidFill>
                <a:srgbClr val="FFFFFF"/>
              </a:solidFill>
              <a:ln w="5706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01" name="フリーフォーム: 図形 300">
                <a:extLst>
                  <a:ext uri="{FF2B5EF4-FFF2-40B4-BE49-F238E27FC236}">
                    <a16:creationId xmlns:a16="http://schemas.microsoft.com/office/drawing/2014/main" id="{646384C1-2C40-67E5-9733-2B49F7161393}"/>
                  </a:ext>
                </a:extLst>
              </p:cNvPr>
              <p:cNvSpPr/>
              <p:nvPr/>
            </p:nvSpPr>
            <p:spPr>
              <a:xfrm>
                <a:off x="2445558" y="3851329"/>
                <a:ext cx="62895" cy="62900"/>
              </a:xfrm>
              <a:custGeom>
                <a:avLst/>
                <a:gdLst>
                  <a:gd name="connsiteX0" fmla="*/ 62896 w 62895"/>
                  <a:gd name="connsiteY0" fmla="*/ 31450 h 62900"/>
                  <a:gd name="connsiteX1" fmla="*/ 31448 w 62895"/>
                  <a:gd name="connsiteY1" fmla="*/ 62900 h 62900"/>
                  <a:gd name="connsiteX2" fmla="*/ 0 w 62895"/>
                  <a:gd name="connsiteY2" fmla="*/ 31450 h 62900"/>
                  <a:gd name="connsiteX3" fmla="*/ 31448 w 62895"/>
                  <a:gd name="connsiteY3" fmla="*/ 0 h 62900"/>
                  <a:gd name="connsiteX4" fmla="*/ 62896 w 62895"/>
                  <a:gd name="connsiteY4" fmla="*/ 31450 h 629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62895" h="62900">
                    <a:moveTo>
                      <a:pt x="62896" y="31450"/>
                    </a:moveTo>
                    <a:cubicBezTo>
                      <a:pt x="62896" y="48819"/>
                      <a:pt x="48816" y="62900"/>
                      <a:pt x="31448" y="62900"/>
                    </a:cubicBezTo>
                    <a:cubicBezTo>
                      <a:pt x="14080" y="62900"/>
                      <a:pt x="0" y="48819"/>
                      <a:pt x="0" y="31450"/>
                    </a:cubicBezTo>
                    <a:cubicBezTo>
                      <a:pt x="0" y="14081"/>
                      <a:pt x="14080" y="0"/>
                      <a:pt x="31448" y="0"/>
                    </a:cubicBezTo>
                    <a:cubicBezTo>
                      <a:pt x="48816" y="0"/>
                      <a:pt x="62896" y="14081"/>
                      <a:pt x="62896" y="31450"/>
                    </a:cubicBezTo>
                    <a:close/>
                  </a:path>
                </a:pathLst>
              </a:custGeom>
              <a:solidFill>
                <a:srgbClr val="FFFFFF"/>
              </a:solidFill>
              <a:ln w="5706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02" name="フリーフォーム: 図形 301">
                <a:extLst>
                  <a:ext uri="{FF2B5EF4-FFF2-40B4-BE49-F238E27FC236}">
                    <a16:creationId xmlns:a16="http://schemas.microsoft.com/office/drawing/2014/main" id="{2A7B6FDF-AC6D-9518-1E73-B052B94E5AE0}"/>
                  </a:ext>
                </a:extLst>
              </p:cNvPr>
              <p:cNvSpPr/>
              <p:nvPr/>
            </p:nvSpPr>
            <p:spPr>
              <a:xfrm>
                <a:off x="2521932" y="3842344"/>
                <a:ext cx="62895" cy="62900"/>
              </a:xfrm>
              <a:custGeom>
                <a:avLst/>
                <a:gdLst>
                  <a:gd name="connsiteX0" fmla="*/ 62896 w 62895"/>
                  <a:gd name="connsiteY0" fmla="*/ 31450 h 62900"/>
                  <a:gd name="connsiteX1" fmla="*/ 31448 w 62895"/>
                  <a:gd name="connsiteY1" fmla="*/ 62900 h 62900"/>
                  <a:gd name="connsiteX2" fmla="*/ 0 w 62895"/>
                  <a:gd name="connsiteY2" fmla="*/ 31450 h 62900"/>
                  <a:gd name="connsiteX3" fmla="*/ 31448 w 62895"/>
                  <a:gd name="connsiteY3" fmla="*/ 0 h 62900"/>
                  <a:gd name="connsiteX4" fmla="*/ 62896 w 62895"/>
                  <a:gd name="connsiteY4" fmla="*/ 31450 h 629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62895" h="62900">
                    <a:moveTo>
                      <a:pt x="62896" y="31450"/>
                    </a:moveTo>
                    <a:cubicBezTo>
                      <a:pt x="62896" y="48819"/>
                      <a:pt x="48816" y="62900"/>
                      <a:pt x="31448" y="62900"/>
                    </a:cubicBezTo>
                    <a:cubicBezTo>
                      <a:pt x="14080" y="62900"/>
                      <a:pt x="0" y="48819"/>
                      <a:pt x="0" y="31450"/>
                    </a:cubicBezTo>
                    <a:cubicBezTo>
                      <a:pt x="0" y="14081"/>
                      <a:pt x="14080" y="0"/>
                      <a:pt x="31448" y="0"/>
                    </a:cubicBezTo>
                    <a:cubicBezTo>
                      <a:pt x="48816" y="0"/>
                      <a:pt x="62896" y="14081"/>
                      <a:pt x="62896" y="31450"/>
                    </a:cubicBezTo>
                    <a:close/>
                  </a:path>
                </a:pathLst>
              </a:custGeom>
              <a:solidFill>
                <a:srgbClr val="FFFFFF"/>
              </a:solidFill>
              <a:ln w="5706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03" name="フリーフォーム: 図形 302">
                <a:extLst>
                  <a:ext uri="{FF2B5EF4-FFF2-40B4-BE49-F238E27FC236}">
                    <a16:creationId xmlns:a16="http://schemas.microsoft.com/office/drawing/2014/main" id="{68A4D4B8-1513-9383-4EAF-B41B2DC60055}"/>
                  </a:ext>
                </a:extLst>
              </p:cNvPr>
              <p:cNvSpPr/>
              <p:nvPr/>
            </p:nvSpPr>
            <p:spPr>
              <a:xfrm>
                <a:off x="2405125" y="3833358"/>
                <a:ext cx="62895" cy="62900"/>
              </a:xfrm>
              <a:custGeom>
                <a:avLst/>
                <a:gdLst>
                  <a:gd name="connsiteX0" fmla="*/ 62896 w 62895"/>
                  <a:gd name="connsiteY0" fmla="*/ 31450 h 62900"/>
                  <a:gd name="connsiteX1" fmla="*/ 31448 w 62895"/>
                  <a:gd name="connsiteY1" fmla="*/ 62900 h 62900"/>
                  <a:gd name="connsiteX2" fmla="*/ 0 w 62895"/>
                  <a:gd name="connsiteY2" fmla="*/ 31450 h 62900"/>
                  <a:gd name="connsiteX3" fmla="*/ 31448 w 62895"/>
                  <a:gd name="connsiteY3" fmla="*/ 0 h 62900"/>
                  <a:gd name="connsiteX4" fmla="*/ 62896 w 62895"/>
                  <a:gd name="connsiteY4" fmla="*/ 31450 h 629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62895" h="62900">
                    <a:moveTo>
                      <a:pt x="62896" y="31450"/>
                    </a:moveTo>
                    <a:cubicBezTo>
                      <a:pt x="62896" y="48819"/>
                      <a:pt x="48816" y="62900"/>
                      <a:pt x="31448" y="62900"/>
                    </a:cubicBezTo>
                    <a:cubicBezTo>
                      <a:pt x="14080" y="62900"/>
                      <a:pt x="0" y="48819"/>
                      <a:pt x="0" y="31450"/>
                    </a:cubicBezTo>
                    <a:cubicBezTo>
                      <a:pt x="0" y="14081"/>
                      <a:pt x="14080" y="0"/>
                      <a:pt x="31448" y="0"/>
                    </a:cubicBezTo>
                    <a:cubicBezTo>
                      <a:pt x="48816" y="0"/>
                      <a:pt x="62896" y="14081"/>
                      <a:pt x="62896" y="31450"/>
                    </a:cubicBezTo>
                    <a:close/>
                  </a:path>
                </a:pathLst>
              </a:custGeom>
              <a:solidFill>
                <a:srgbClr val="FFFFFF"/>
              </a:solidFill>
              <a:ln w="5706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04" name="フリーフォーム: 図形 303">
                <a:extLst>
                  <a:ext uri="{FF2B5EF4-FFF2-40B4-BE49-F238E27FC236}">
                    <a16:creationId xmlns:a16="http://schemas.microsoft.com/office/drawing/2014/main" id="{3CC91CBA-BD6D-AF4F-711E-CECEDF29E2E5}"/>
                  </a:ext>
                </a:extLst>
              </p:cNvPr>
              <p:cNvSpPr/>
              <p:nvPr/>
            </p:nvSpPr>
            <p:spPr>
              <a:xfrm>
                <a:off x="2405125" y="3761472"/>
                <a:ext cx="62895" cy="62900"/>
              </a:xfrm>
              <a:custGeom>
                <a:avLst/>
                <a:gdLst>
                  <a:gd name="connsiteX0" fmla="*/ 62896 w 62895"/>
                  <a:gd name="connsiteY0" fmla="*/ 31450 h 62900"/>
                  <a:gd name="connsiteX1" fmla="*/ 31448 w 62895"/>
                  <a:gd name="connsiteY1" fmla="*/ 62900 h 62900"/>
                  <a:gd name="connsiteX2" fmla="*/ 0 w 62895"/>
                  <a:gd name="connsiteY2" fmla="*/ 31450 h 62900"/>
                  <a:gd name="connsiteX3" fmla="*/ 31448 w 62895"/>
                  <a:gd name="connsiteY3" fmla="*/ 0 h 62900"/>
                  <a:gd name="connsiteX4" fmla="*/ 62896 w 62895"/>
                  <a:gd name="connsiteY4" fmla="*/ 31450 h 629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62895" h="62900">
                    <a:moveTo>
                      <a:pt x="62896" y="31450"/>
                    </a:moveTo>
                    <a:cubicBezTo>
                      <a:pt x="62896" y="48819"/>
                      <a:pt x="48816" y="62900"/>
                      <a:pt x="31448" y="62900"/>
                    </a:cubicBezTo>
                    <a:cubicBezTo>
                      <a:pt x="14080" y="62900"/>
                      <a:pt x="0" y="48819"/>
                      <a:pt x="0" y="31450"/>
                    </a:cubicBezTo>
                    <a:cubicBezTo>
                      <a:pt x="0" y="14081"/>
                      <a:pt x="14080" y="0"/>
                      <a:pt x="31448" y="0"/>
                    </a:cubicBezTo>
                    <a:cubicBezTo>
                      <a:pt x="48816" y="0"/>
                      <a:pt x="62896" y="14081"/>
                      <a:pt x="62896" y="31450"/>
                    </a:cubicBezTo>
                    <a:close/>
                  </a:path>
                </a:pathLst>
              </a:custGeom>
              <a:solidFill>
                <a:srgbClr val="FFFFFF"/>
              </a:solidFill>
              <a:ln w="5706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05" name="フリーフォーム: 図形 304">
                <a:extLst>
                  <a:ext uri="{FF2B5EF4-FFF2-40B4-BE49-F238E27FC236}">
                    <a16:creationId xmlns:a16="http://schemas.microsoft.com/office/drawing/2014/main" id="{4D86B3FB-B390-2A69-2190-C7E30214821A}"/>
                  </a:ext>
                </a:extLst>
              </p:cNvPr>
              <p:cNvSpPr/>
              <p:nvPr/>
            </p:nvSpPr>
            <p:spPr>
              <a:xfrm>
                <a:off x="2328752" y="3712050"/>
                <a:ext cx="62895" cy="62900"/>
              </a:xfrm>
              <a:custGeom>
                <a:avLst/>
                <a:gdLst>
                  <a:gd name="connsiteX0" fmla="*/ 62896 w 62895"/>
                  <a:gd name="connsiteY0" fmla="*/ 31450 h 62900"/>
                  <a:gd name="connsiteX1" fmla="*/ 31448 w 62895"/>
                  <a:gd name="connsiteY1" fmla="*/ 62900 h 62900"/>
                  <a:gd name="connsiteX2" fmla="*/ 0 w 62895"/>
                  <a:gd name="connsiteY2" fmla="*/ 31450 h 62900"/>
                  <a:gd name="connsiteX3" fmla="*/ 31448 w 62895"/>
                  <a:gd name="connsiteY3" fmla="*/ 0 h 62900"/>
                  <a:gd name="connsiteX4" fmla="*/ 62896 w 62895"/>
                  <a:gd name="connsiteY4" fmla="*/ 31450 h 629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62895" h="62900">
                    <a:moveTo>
                      <a:pt x="62896" y="31450"/>
                    </a:moveTo>
                    <a:cubicBezTo>
                      <a:pt x="62896" y="48819"/>
                      <a:pt x="48816" y="62900"/>
                      <a:pt x="31448" y="62900"/>
                    </a:cubicBezTo>
                    <a:cubicBezTo>
                      <a:pt x="14080" y="62900"/>
                      <a:pt x="0" y="48819"/>
                      <a:pt x="0" y="31450"/>
                    </a:cubicBezTo>
                    <a:cubicBezTo>
                      <a:pt x="0" y="14081"/>
                      <a:pt x="14080" y="0"/>
                      <a:pt x="31448" y="0"/>
                    </a:cubicBezTo>
                    <a:cubicBezTo>
                      <a:pt x="48816" y="0"/>
                      <a:pt x="62896" y="14081"/>
                      <a:pt x="62896" y="31450"/>
                    </a:cubicBezTo>
                    <a:close/>
                  </a:path>
                </a:pathLst>
              </a:custGeom>
              <a:solidFill>
                <a:srgbClr val="FFFFFF"/>
              </a:solidFill>
              <a:ln w="5706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06" name="フリーフォーム: 図形 305">
                <a:extLst>
                  <a:ext uri="{FF2B5EF4-FFF2-40B4-BE49-F238E27FC236}">
                    <a16:creationId xmlns:a16="http://schemas.microsoft.com/office/drawing/2014/main" id="{0DEAB899-E244-EE53-7B9D-B4923597A8E6}"/>
                  </a:ext>
                </a:extLst>
              </p:cNvPr>
              <p:cNvSpPr/>
              <p:nvPr/>
            </p:nvSpPr>
            <p:spPr>
              <a:xfrm>
                <a:off x="2405125" y="3680600"/>
                <a:ext cx="62895" cy="62900"/>
              </a:xfrm>
              <a:custGeom>
                <a:avLst/>
                <a:gdLst>
                  <a:gd name="connsiteX0" fmla="*/ 62896 w 62895"/>
                  <a:gd name="connsiteY0" fmla="*/ 31450 h 62900"/>
                  <a:gd name="connsiteX1" fmla="*/ 31448 w 62895"/>
                  <a:gd name="connsiteY1" fmla="*/ 62900 h 62900"/>
                  <a:gd name="connsiteX2" fmla="*/ 0 w 62895"/>
                  <a:gd name="connsiteY2" fmla="*/ 31450 h 62900"/>
                  <a:gd name="connsiteX3" fmla="*/ 31448 w 62895"/>
                  <a:gd name="connsiteY3" fmla="*/ 0 h 62900"/>
                  <a:gd name="connsiteX4" fmla="*/ 62896 w 62895"/>
                  <a:gd name="connsiteY4" fmla="*/ 31450 h 629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62895" h="62900">
                    <a:moveTo>
                      <a:pt x="62896" y="31450"/>
                    </a:moveTo>
                    <a:cubicBezTo>
                      <a:pt x="62896" y="48819"/>
                      <a:pt x="48816" y="62900"/>
                      <a:pt x="31448" y="62900"/>
                    </a:cubicBezTo>
                    <a:cubicBezTo>
                      <a:pt x="14080" y="62900"/>
                      <a:pt x="0" y="48819"/>
                      <a:pt x="0" y="31450"/>
                    </a:cubicBezTo>
                    <a:cubicBezTo>
                      <a:pt x="0" y="14081"/>
                      <a:pt x="14080" y="0"/>
                      <a:pt x="31448" y="0"/>
                    </a:cubicBezTo>
                    <a:cubicBezTo>
                      <a:pt x="48816" y="0"/>
                      <a:pt x="62896" y="14081"/>
                      <a:pt x="62896" y="31450"/>
                    </a:cubicBezTo>
                    <a:close/>
                  </a:path>
                </a:pathLst>
              </a:custGeom>
              <a:solidFill>
                <a:srgbClr val="FFFFFF"/>
              </a:solidFill>
              <a:ln w="5706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07" name="フリーフォーム: 図形 306">
                <a:extLst>
                  <a:ext uri="{FF2B5EF4-FFF2-40B4-BE49-F238E27FC236}">
                    <a16:creationId xmlns:a16="http://schemas.microsoft.com/office/drawing/2014/main" id="{F4847A0B-476B-F152-7CC4-CA2660C8DD1D}"/>
                  </a:ext>
                </a:extLst>
              </p:cNvPr>
              <p:cNvSpPr/>
              <p:nvPr/>
            </p:nvSpPr>
            <p:spPr>
              <a:xfrm>
                <a:off x="2481499" y="3676107"/>
                <a:ext cx="62895" cy="62900"/>
              </a:xfrm>
              <a:custGeom>
                <a:avLst/>
                <a:gdLst>
                  <a:gd name="connsiteX0" fmla="*/ 62896 w 62895"/>
                  <a:gd name="connsiteY0" fmla="*/ 31450 h 62900"/>
                  <a:gd name="connsiteX1" fmla="*/ 31448 w 62895"/>
                  <a:gd name="connsiteY1" fmla="*/ 62900 h 62900"/>
                  <a:gd name="connsiteX2" fmla="*/ 0 w 62895"/>
                  <a:gd name="connsiteY2" fmla="*/ 31450 h 62900"/>
                  <a:gd name="connsiteX3" fmla="*/ 31448 w 62895"/>
                  <a:gd name="connsiteY3" fmla="*/ 0 h 62900"/>
                  <a:gd name="connsiteX4" fmla="*/ 62896 w 62895"/>
                  <a:gd name="connsiteY4" fmla="*/ 31450 h 629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62895" h="62900">
                    <a:moveTo>
                      <a:pt x="62896" y="31450"/>
                    </a:moveTo>
                    <a:cubicBezTo>
                      <a:pt x="62896" y="48819"/>
                      <a:pt x="48816" y="62900"/>
                      <a:pt x="31448" y="62900"/>
                    </a:cubicBezTo>
                    <a:cubicBezTo>
                      <a:pt x="14080" y="62900"/>
                      <a:pt x="0" y="48819"/>
                      <a:pt x="0" y="31450"/>
                    </a:cubicBezTo>
                    <a:cubicBezTo>
                      <a:pt x="0" y="14081"/>
                      <a:pt x="14080" y="0"/>
                      <a:pt x="31448" y="0"/>
                    </a:cubicBezTo>
                    <a:cubicBezTo>
                      <a:pt x="48816" y="0"/>
                      <a:pt x="62896" y="14081"/>
                      <a:pt x="62896" y="31450"/>
                    </a:cubicBezTo>
                    <a:close/>
                  </a:path>
                </a:pathLst>
              </a:custGeom>
              <a:solidFill>
                <a:srgbClr val="FFFFFF"/>
              </a:solidFill>
              <a:ln w="5706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08" name="フリーフォーム: 図形 307">
                <a:extLst>
                  <a:ext uri="{FF2B5EF4-FFF2-40B4-BE49-F238E27FC236}">
                    <a16:creationId xmlns:a16="http://schemas.microsoft.com/office/drawing/2014/main" id="{CBFC4441-1663-9B8A-4863-C63B34B79CF1}"/>
                  </a:ext>
                </a:extLst>
              </p:cNvPr>
              <p:cNvSpPr/>
              <p:nvPr/>
            </p:nvSpPr>
            <p:spPr>
              <a:xfrm>
                <a:off x="2405125" y="3590743"/>
                <a:ext cx="62895" cy="62900"/>
              </a:xfrm>
              <a:custGeom>
                <a:avLst/>
                <a:gdLst>
                  <a:gd name="connsiteX0" fmla="*/ 62896 w 62895"/>
                  <a:gd name="connsiteY0" fmla="*/ 31450 h 62900"/>
                  <a:gd name="connsiteX1" fmla="*/ 31448 w 62895"/>
                  <a:gd name="connsiteY1" fmla="*/ 62900 h 62900"/>
                  <a:gd name="connsiteX2" fmla="*/ 0 w 62895"/>
                  <a:gd name="connsiteY2" fmla="*/ 31450 h 62900"/>
                  <a:gd name="connsiteX3" fmla="*/ 31448 w 62895"/>
                  <a:gd name="connsiteY3" fmla="*/ 0 h 62900"/>
                  <a:gd name="connsiteX4" fmla="*/ 62896 w 62895"/>
                  <a:gd name="connsiteY4" fmla="*/ 31450 h 629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62895" h="62900">
                    <a:moveTo>
                      <a:pt x="62896" y="31450"/>
                    </a:moveTo>
                    <a:cubicBezTo>
                      <a:pt x="62896" y="48820"/>
                      <a:pt x="48816" y="62900"/>
                      <a:pt x="31448" y="62900"/>
                    </a:cubicBezTo>
                    <a:cubicBezTo>
                      <a:pt x="14080" y="62900"/>
                      <a:pt x="0" y="48820"/>
                      <a:pt x="0" y="31450"/>
                    </a:cubicBezTo>
                    <a:cubicBezTo>
                      <a:pt x="0" y="14081"/>
                      <a:pt x="14080" y="0"/>
                      <a:pt x="31448" y="0"/>
                    </a:cubicBezTo>
                    <a:cubicBezTo>
                      <a:pt x="48816" y="0"/>
                      <a:pt x="62896" y="14081"/>
                      <a:pt x="62896" y="31450"/>
                    </a:cubicBezTo>
                    <a:close/>
                  </a:path>
                </a:pathLst>
              </a:custGeom>
              <a:solidFill>
                <a:srgbClr val="FFFFFF"/>
              </a:solidFill>
              <a:ln w="5706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09" name="フリーフォーム: 図形 308">
                <a:extLst>
                  <a:ext uri="{FF2B5EF4-FFF2-40B4-BE49-F238E27FC236}">
                    <a16:creationId xmlns:a16="http://schemas.microsoft.com/office/drawing/2014/main" id="{F704BF82-554A-DA9D-D227-8958659972E5}"/>
                  </a:ext>
                </a:extLst>
              </p:cNvPr>
              <p:cNvSpPr/>
              <p:nvPr/>
            </p:nvSpPr>
            <p:spPr>
              <a:xfrm>
                <a:off x="2405125" y="3460450"/>
                <a:ext cx="62895" cy="62900"/>
              </a:xfrm>
              <a:custGeom>
                <a:avLst/>
                <a:gdLst>
                  <a:gd name="connsiteX0" fmla="*/ 62896 w 62895"/>
                  <a:gd name="connsiteY0" fmla="*/ 31450 h 62900"/>
                  <a:gd name="connsiteX1" fmla="*/ 31448 w 62895"/>
                  <a:gd name="connsiteY1" fmla="*/ 62900 h 62900"/>
                  <a:gd name="connsiteX2" fmla="*/ 0 w 62895"/>
                  <a:gd name="connsiteY2" fmla="*/ 31450 h 62900"/>
                  <a:gd name="connsiteX3" fmla="*/ 31448 w 62895"/>
                  <a:gd name="connsiteY3" fmla="*/ 0 h 62900"/>
                  <a:gd name="connsiteX4" fmla="*/ 62896 w 62895"/>
                  <a:gd name="connsiteY4" fmla="*/ 31450 h 629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62895" h="62900">
                    <a:moveTo>
                      <a:pt x="62896" y="31450"/>
                    </a:moveTo>
                    <a:cubicBezTo>
                      <a:pt x="62896" y="48820"/>
                      <a:pt x="48816" y="62900"/>
                      <a:pt x="31448" y="62900"/>
                    </a:cubicBezTo>
                    <a:cubicBezTo>
                      <a:pt x="14080" y="62900"/>
                      <a:pt x="0" y="48820"/>
                      <a:pt x="0" y="31450"/>
                    </a:cubicBezTo>
                    <a:cubicBezTo>
                      <a:pt x="0" y="14081"/>
                      <a:pt x="14080" y="0"/>
                      <a:pt x="31448" y="0"/>
                    </a:cubicBezTo>
                    <a:cubicBezTo>
                      <a:pt x="48816" y="0"/>
                      <a:pt x="62896" y="14081"/>
                      <a:pt x="62896" y="31450"/>
                    </a:cubicBezTo>
                    <a:close/>
                  </a:path>
                </a:pathLst>
              </a:custGeom>
              <a:solidFill>
                <a:srgbClr val="FFFFFF"/>
              </a:solidFill>
              <a:ln w="5706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10" name="フリーフォーム: 図形 309">
                <a:extLst>
                  <a:ext uri="{FF2B5EF4-FFF2-40B4-BE49-F238E27FC236}">
                    <a16:creationId xmlns:a16="http://schemas.microsoft.com/office/drawing/2014/main" id="{67B84DF3-E432-9C13-913C-EFA0FC37503B}"/>
                  </a:ext>
                </a:extLst>
              </p:cNvPr>
              <p:cNvSpPr/>
              <p:nvPr/>
            </p:nvSpPr>
            <p:spPr>
              <a:xfrm>
                <a:off x="2405125" y="3231313"/>
                <a:ext cx="62895" cy="62900"/>
              </a:xfrm>
              <a:custGeom>
                <a:avLst/>
                <a:gdLst>
                  <a:gd name="connsiteX0" fmla="*/ 62896 w 62895"/>
                  <a:gd name="connsiteY0" fmla="*/ 31450 h 62900"/>
                  <a:gd name="connsiteX1" fmla="*/ 31448 w 62895"/>
                  <a:gd name="connsiteY1" fmla="*/ 62900 h 62900"/>
                  <a:gd name="connsiteX2" fmla="*/ 0 w 62895"/>
                  <a:gd name="connsiteY2" fmla="*/ 31450 h 62900"/>
                  <a:gd name="connsiteX3" fmla="*/ 31448 w 62895"/>
                  <a:gd name="connsiteY3" fmla="*/ 0 h 62900"/>
                  <a:gd name="connsiteX4" fmla="*/ 62896 w 62895"/>
                  <a:gd name="connsiteY4" fmla="*/ 31450 h 629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62895" h="62900">
                    <a:moveTo>
                      <a:pt x="62896" y="31450"/>
                    </a:moveTo>
                    <a:cubicBezTo>
                      <a:pt x="62896" y="48820"/>
                      <a:pt x="48816" y="62900"/>
                      <a:pt x="31448" y="62900"/>
                    </a:cubicBezTo>
                    <a:cubicBezTo>
                      <a:pt x="14080" y="62900"/>
                      <a:pt x="0" y="48820"/>
                      <a:pt x="0" y="31450"/>
                    </a:cubicBezTo>
                    <a:cubicBezTo>
                      <a:pt x="0" y="14081"/>
                      <a:pt x="14080" y="0"/>
                      <a:pt x="31448" y="0"/>
                    </a:cubicBezTo>
                    <a:cubicBezTo>
                      <a:pt x="48816" y="0"/>
                      <a:pt x="62896" y="14081"/>
                      <a:pt x="62896" y="31450"/>
                    </a:cubicBezTo>
                    <a:close/>
                  </a:path>
                </a:pathLst>
              </a:custGeom>
              <a:solidFill>
                <a:srgbClr val="FFFFFF"/>
              </a:solidFill>
              <a:ln w="5706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11" name="フリーフォーム: 図形 310">
                <a:extLst>
                  <a:ext uri="{FF2B5EF4-FFF2-40B4-BE49-F238E27FC236}">
                    <a16:creationId xmlns:a16="http://schemas.microsoft.com/office/drawing/2014/main" id="{22532473-1FDA-0C5B-6385-474A8489F419}"/>
                  </a:ext>
                </a:extLst>
              </p:cNvPr>
              <p:cNvSpPr/>
              <p:nvPr/>
            </p:nvSpPr>
            <p:spPr>
              <a:xfrm>
                <a:off x="2405125" y="3083048"/>
                <a:ext cx="62895" cy="62900"/>
              </a:xfrm>
              <a:custGeom>
                <a:avLst/>
                <a:gdLst>
                  <a:gd name="connsiteX0" fmla="*/ 62896 w 62895"/>
                  <a:gd name="connsiteY0" fmla="*/ 31450 h 62900"/>
                  <a:gd name="connsiteX1" fmla="*/ 31448 w 62895"/>
                  <a:gd name="connsiteY1" fmla="*/ 62900 h 62900"/>
                  <a:gd name="connsiteX2" fmla="*/ 0 w 62895"/>
                  <a:gd name="connsiteY2" fmla="*/ 31450 h 62900"/>
                  <a:gd name="connsiteX3" fmla="*/ 31448 w 62895"/>
                  <a:gd name="connsiteY3" fmla="*/ 0 h 62900"/>
                  <a:gd name="connsiteX4" fmla="*/ 62896 w 62895"/>
                  <a:gd name="connsiteY4" fmla="*/ 31450 h 629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62895" h="62900">
                    <a:moveTo>
                      <a:pt x="62896" y="31450"/>
                    </a:moveTo>
                    <a:cubicBezTo>
                      <a:pt x="62896" y="48820"/>
                      <a:pt x="48816" y="62900"/>
                      <a:pt x="31448" y="62900"/>
                    </a:cubicBezTo>
                    <a:cubicBezTo>
                      <a:pt x="14080" y="62900"/>
                      <a:pt x="0" y="48820"/>
                      <a:pt x="0" y="31450"/>
                    </a:cubicBezTo>
                    <a:cubicBezTo>
                      <a:pt x="0" y="14081"/>
                      <a:pt x="14080" y="0"/>
                      <a:pt x="31448" y="0"/>
                    </a:cubicBezTo>
                    <a:cubicBezTo>
                      <a:pt x="48816" y="0"/>
                      <a:pt x="62896" y="14081"/>
                      <a:pt x="62896" y="31450"/>
                    </a:cubicBezTo>
                    <a:close/>
                  </a:path>
                </a:pathLst>
              </a:custGeom>
              <a:solidFill>
                <a:srgbClr val="FFFFFF"/>
              </a:solidFill>
              <a:ln w="5706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12" name="フリーフォーム: 図形 311">
                <a:extLst>
                  <a:ext uri="{FF2B5EF4-FFF2-40B4-BE49-F238E27FC236}">
                    <a16:creationId xmlns:a16="http://schemas.microsoft.com/office/drawing/2014/main" id="{9ADC3915-1ECA-992B-822B-B05344452590}"/>
                  </a:ext>
                </a:extLst>
              </p:cNvPr>
              <p:cNvSpPr/>
              <p:nvPr/>
            </p:nvSpPr>
            <p:spPr>
              <a:xfrm>
                <a:off x="2405125" y="2782026"/>
                <a:ext cx="62895" cy="62900"/>
              </a:xfrm>
              <a:custGeom>
                <a:avLst/>
                <a:gdLst>
                  <a:gd name="connsiteX0" fmla="*/ 62896 w 62895"/>
                  <a:gd name="connsiteY0" fmla="*/ 31450 h 62900"/>
                  <a:gd name="connsiteX1" fmla="*/ 31448 w 62895"/>
                  <a:gd name="connsiteY1" fmla="*/ 62900 h 62900"/>
                  <a:gd name="connsiteX2" fmla="*/ 0 w 62895"/>
                  <a:gd name="connsiteY2" fmla="*/ 31450 h 62900"/>
                  <a:gd name="connsiteX3" fmla="*/ 31448 w 62895"/>
                  <a:gd name="connsiteY3" fmla="*/ 0 h 62900"/>
                  <a:gd name="connsiteX4" fmla="*/ 62896 w 62895"/>
                  <a:gd name="connsiteY4" fmla="*/ 31450 h 629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62895" h="62900">
                    <a:moveTo>
                      <a:pt x="62896" y="31450"/>
                    </a:moveTo>
                    <a:cubicBezTo>
                      <a:pt x="62896" y="48820"/>
                      <a:pt x="48816" y="62900"/>
                      <a:pt x="31448" y="62900"/>
                    </a:cubicBezTo>
                    <a:cubicBezTo>
                      <a:pt x="14080" y="62900"/>
                      <a:pt x="0" y="48820"/>
                      <a:pt x="0" y="31450"/>
                    </a:cubicBezTo>
                    <a:cubicBezTo>
                      <a:pt x="0" y="14081"/>
                      <a:pt x="14080" y="0"/>
                      <a:pt x="31448" y="0"/>
                    </a:cubicBezTo>
                    <a:cubicBezTo>
                      <a:pt x="48816" y="0"/>
                      <a:pt x="62896" y="14081"/>
                      <a:pt x="62896" y="31450"/>
                    </a:cubicBezTo>
                    <a:close/>
                  </a:path>
                </a:pathLst>
              </a:custGeom>
              <a:solidFill>
                <a:srgbClr val="FFFFFF"/>
              </a:solidFill>
              <a:ln w="5706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13" name="フリーフォーム: 図形 312">
                <a:extLst>
                  <a:ext uri="{FF2B5EF4-FFF2-40B4-BE49-F238E27FC236}">
                    <a16:creationId xmlns:a16="http://schemas.microsoft.com/office/drawing/2014/main" id="{B1054548-B711-06C3-6EB4-041DA4278030}"/>
                  </a:ext>
                </a:extLst>
              </p:cNvPr>
              <p:cNvSpPr/>
              <p:nvPr/>
            </p:nvSpPr>
            <p:spPr>
              <a:xfrm>
                <a:off x="2369185" y="2651733"/>
                <a:ext cx="62895" cy="62900"/>
              </a:xfrm>
              <a:custGeom>
                <a:avLst/>
                <a:gdLst>
                  <a:gd name="connsiteX0" fmla="*/ 62896 w 62895"/>
                  <a:gd name="connsiteY0" fmla="*/ 31450 h 62900"/>
                  <a:gd name="connsiteX1" fmla="*/ 31448 w 62895"/>
                  <a:gd name="connsiteY1" fmla="*/ 62900 h 62900"/>
                  <a:gd name="connsiteX2" fmla="*/ 0 w 62895"/>
                  <a:gd name="connsiteY2" fmla="*/ 31450 h 62900"/>
                  <a:gd name="connsiteX3" fmla="*/ 31448 w 62895"/>
                  <a:gd name="connsiteY3" fmla="*/ 0 h 62900"/>
                  <a:gd name="connsiteX4" fmla="*/ 62896 w 62895"/>
                  <a:gd name="connsiteY4" fmla="*/ 31450 h 629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62895" h="62900">
                    <a:moveTo>
                      <a:pt x="62896" y="31450"/>
                    </a:moveTo>
                    <a:cubicBezTo>
                      <a:pt x="62896" y="48820"/>
                      <a:pt x="48816" y="62900"/>
                      <a:pt x="31448" y="62900"/>
                    </a:cubicBezTo>
                    <a:cubicBezTo>
                      <a:pt x="14080" y="62900"/>
                      <a:pt x="0" y="48820"/>
                      <a:pt x="0" y="31450"/>
                    </a:cubicBezTo>
                    <a:cubicBezTo>
                      <a:pt x="0" y="14081"/>
                      <a:pt x="14080" y="0"/>
                      <a:pt x="31448" y="0"/>
                    </a:cubicBezTo>
                    <a:cubicBezTo>
                      <a:pt x="48816" y="0"/>
                      <a:pt x="62896" y="14081"/>
                      <a:pt x="62896" y="31450"/>
                    </a:cubicBezTo>
                    <a:close/>
                  </a:path>
                </a:pathLst>
              </a:custGeom>
              <a:solidFill>
                <a:srgbClr val="FFFFFF"/>
              </a:solidFill>
              <a:ln w="5706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14" name="フリーフォーム: 図形 313">
                <a:extLst>
                  <a:ext uri="{FF2B5EF4-FFF2-40B4-BE49-F238E27FC236}">
                    <a16:creationId xmlns:a16="http://schemas.microsoft.com/office/drawing/2014/main" id="{1900D159-26FB-2A85-1DD5-A8D2AF348114}"/>
                  </a:ext>
                </a:extLst>
              </p:cNvPr>
              <p:cNvSpPr/>
              <p:nvPr/>
            </p:nvSpPr>
            <p:spPr>
              <a:xfrm>
                <a:off x="2445558" y="2629268"/>
                <a:ext cx="62895" cy="62900"/>
              </a:xfrm>
              <a:custGeom>
                <a:avLst/>
                <a:gdLst>
                  <a:gd name="connsiteX0" fmla="*/ 62896 w 62895"/>
                  <a:gd name="connsiteY0" fmla="*/ 31450 h 62900"/>
                  <a:gd name="connsiteX1" fmla="*/ 31448 w 62895"/>
                  <a:gd name="connsiteY1" fmla="*/ 62900 h 62900"/>
                  <a:gd name="connsiteX2" fmla="*/ 0 w 62895"/>
                  <a:gd name="connsiteY2" fmla="*/ 31450 h 62900"/>
                  <a:gd name="connsiteX3" fmla="*/ 31448 w 62895"/>
                  <a:gd name="connsiteY3" fmla="*/ 0 h 62900"/>
                  <a:gd name="connsiteX4" fmla="*/ 62896 w 62895"/>
                  <a:gd name="connsiteY4" fmla="*/ 31450 h 629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62895" h="62900">
                    <a:moveTo>
                      <a:pt x="62896" y="31450"/>
                    </a:moveTo>
                    <a:cubicBezTo>
                      <a:pt x="62896" y="48820"/>
                      <a:pt x="48816" y="62900"/>
                      <a:pt x="31448" y="62900"/>
                    </a:cubicBezTo>
                    <a:cubicBezTo>
                      <a:pt x="14080" y="62900"/>
                      <a:pt x="0" y="48820"/>
                      <a:pt x="0" y="31450"/>
                    </a:cubicBezTo>
                    <a:cubicBezTo>
                      <a:pt x="0" y="14081"/>
                      <a:pt x="14080" y="0"/>
                      <a:pt x="31448" y="0"/>
                    </a:cubicBezTo>
                    <a:cubicBezTo>
                      <a:pt x="48816" y="0"/>
                      <a:pt x="62896" y="14081"/>
                      <a:pt x="62896" y="31450"/>
                    </a:cubicBezTo>
                    <a:close/>
                  </a:path>
                </a:pathLst>
              </a:custGeom>
              <a:solidFill>
                <a:srgbClr val="FFFFFF"/>
              </a:solidFill>
              <a:ln w="5706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15" name="フリーフォーム: 図形 314">
                <a:extLst>
                  <a:ext uri="{FF2B5EF4-FFF2-40B4-BE49-F238E27FC236}">
                    <a16:creationId xmlns:a16="http://schemas.microsoft.com/office/drawing/2014/main" id="{AEF509AD-9FCF-ABF2-64D6-73FC467550B1}"/>
                  </a:ext>
                </a:extLst>
              </p:cNvPr>
              <p:cNvSpPr/>
              <p:nvPr/>
            </p:nvSpPr>
            <p:spPr>
              <a:xfrm>
                <a:off x="2405125" y="2539411"/>
                <a:ext cx="62895" cy="62900"/>
              </a:xfrm>
              <a:custGeom>
                <a:avLst/>
                <a:gdLst>
                  <a:gd name="connsiteX0" fmla="*/ 62896 w 62895"/>
                  <a:gd name="connsiteY0" fmla="*/ 31450 h 62900"/>
                  <a:gd name="connsiteX1" fmla="*/ 31448 w 62895"/>
                  <a:gd name="connsiteY1" fmla="*/ 62900 h 62900"/>
                  <a:gd name="connsiteX2" fmla="*/ 0 w 62895"/>
                  <a:gd name="connsiteY2" fmla="*/ 31450 h 62900"/>
                  <a:gd name="connsiteX3" fmla="*/ 31448 w 62895"/>
                  <a:gd name="connsiteY3" fmla="*/ 0 h 62900"/>
                  <a:gd name="connsiteX4" fmla="*/ 62896 w 62895"/>
                  <a:gd name="connsiteY4" fmla="*/ 31450 h 629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62895" h="62900">
                    <a:moveTo>
                      <a:pt x="62896" y="31450"/>
                    </a:moveTo>
                    <a:cubicBezTo>
                      <a:pt x="62896" y="48820"/>
                      <a:pt x="48816" y="62900"/>
                      <a:pt x="31448" y="62900"/>
                    </a:cubicBezTo>
                    <a:cubicBezTo>
                      <a:pt x="14080" y="62900"/>
                      <a:pt x="0" y="48820"/>
                      <a:pt x="0" y="31450"/>
                    </a:cubicBezTo>
                    <a:cubicBezTo>
                      <a:pt x="0" y="14081"/>
                      <a:pt x="14080" y="0"/>
                      <a:pt x="31448" y="0"/>
                    </a:cubicBezTo>
                    <a:cubicBezTo>
                      <a:pt x="48816" y="0"/>
                      <a:pt x="62896" y="14081"/>
                      <a:pt x="62896" y="31450"/>
                    </a:cubicBezTo>
                    <a:close/>
                  </a:path>
                </a:pathLst>
              </a:custGeom>
              <a:solidFill>
                <a:srgbClr val="FFFFFF"/>
              </a:solidFill>
              <a:ln w="5706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16" name="フリーフォーム: 図形 315">
                <a:extLst>
                  <a:ext uri="{FF2B5EF4-FFF2-40B4-BE49-F238E27FC236}">
                    <a16:creationId xmlns:a16="http://schemas.microsoft.com/office/drawing/2014/main" id="{797608F0-9A04-7FDB-F42A-CB4FA573F983}"/>
                  </a:ext>
                </a:extLst>
              </p:cNvPr>
              <p:cNvSpPr/>
              <p:nvPr/>
            </p:nvSpPr>
            <p:spPr>
              <a:xfrm>
                <a:off x="2405125" y="2449554"/>
                <a:ext cx="62895" cy="62900"/>
              </a:xfrm>
              <a:custGeom>
                <a:avLst/>
                <a:gdLst>
                  <a:gd name="connsiteX0" fmla="*/ 62896 w 62895"/>
                  <a:gd name="connsiteY0" fmla="*/ 31450 h 62900"/>
                  <a:gd name="connsiteX1" fmla="*/ 31448 w 62895"/>
                  <a:gd name="connsiteY1" fmla="*/ 62900 h 62900"/>
                  <a:gd name="connsiteX2" fmla="*/ 0 w 62895"/>
                  <a:gd name="connsiteY2" fmla="*/ 31450 h 62900"/>
                  <a:gd name="connsiteX3" fmla="*/ 31448 w 62895"/>
                  <a:gd name="connsiteY3" fmla="*/ 0 h 62900"/>
                  <a:gd name="connsiteX4" fmla="*/ 62896 w 62895"/>
                  <a:gd name="connsiteY4" fmla="*/ 31450 h 629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62895" h="62900">
                    <a:moveTo>
                      <a:pt x="62896" y="31450"/>
                    </a:moveTo>
                    <a:cubicBezTo>
                      <a:pt x="62896" y="48820"/>
                      <a:pt x="48816" y="62900"/>
                      <a:pt x="31448" y="62900"/>
                    </a:cubicBezTo>
                    <a:cubicBezTo>
                      <a:pt x="14080" y="62900"/>
                      <a:pt x="0" y="48820"/>
                      <a:pt x="0" y="31450"/>
                    </a:cubicBezTo>
                    <a:cubicBezTo>
                      <a:pt x="0" y="14081"/>
                      <a:pt x="14080" y="0"/>
                      <a:pt x="31448" y="0"/>
                    </a:cubicBezTo>
                    <a:cubicBezTo>
                      <a:pt x="48816" y="0"/>
                      <a:pt x="62896" y="14081"/>
                      <a:pt x="62896" y="31450"/>
                    </a:cubicBezTo>
                    <a:close/>
                  </a:path>
                </a:pathLst>
              </a:custGeom>
              <a:solidFill>
                <a:srgbClr val="FFFFFF"/>
              </a:solidFill>
              <a:ln w="5706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17" name="フリーフォーム: 図形 316">
                <a:extLst>
                  <a:ext uri="{FF2B5EF4-FFF2-40B4-BE49-F238E27FC236}">
                    <a16:creationId xmlns:a16="http://schemas.microsoft.com/office/drawing/2014/main" id="{2AB2EF98-68E9-E763-3F8E-AFF1AD7D5124}"/>
                  </a:ext>
                </a:extLst>
              </p:cNvPr>
              <p:cNvSpPr/>
              <p:nvPr/>
            </p:nvSpPr>
            <p:spPr>
              <a:xfrm>
                <a:off x="2405125" y="2391146"/>
                <a:ext cx="62895" cy="62900"/>
              </a:xfrm>
              <a:custGeom>
                <a:avLst/>
                <a:gdLst>
                  <a:gd name="connsiteX0" fmla="*/ 62896 w 62895"/>
                  <a:gd name="connsiteY0" fmla="*/ 31450 h 62900"/>
                  <a:gd name="connsiteX1" fmla="*/ 31448 w 62895"/>
                  <a:gd name="connsiteY1" fmla="*/ 62900 h 62900"/>
                  <a:gd name="connsiteX2" fmla="*/ 0 w 62895"/>
                  <a:gd name="connsiteY2" fmla="*/ 31450 h 62900"/>
                  <a:gd name="connsiteX3" fmla="*/ 31448 w 62895"/>
                  <a:gd name="connsiteY3" fmla="*/ 0 h 62900"/>
                  <a:gd name="connsiteX4" fmla="*/ 62896 w 62895"/>
                  <a:gd name="connsiteY4" fmla="*/ 31450 h 629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62895" h="62900">
                    <a:moveTo>
                      <a:pt x="62896" y="31450"/>
                    </a:moveTo>
                    <a:cubicBezTo>
                      <a:pt x="62896" y="48820"/>
                      <a:pt x="48816" y="62900"/>
                      <a:pt x="31448" y="62900"/>
                    </a:cubicBezTo>
                    <a:cubicBezTo>
                      <a:pt x="14080" y="62900"/>
                      <a:pt x="0" y="48820"/>
                      <a:pt x="0" y="31450"/>
                    </a:cubicBezTo>
                    <a:cubicBezTo>
                      <a:pt x="0" y="14081"/>
                      <a:pt x="14080" y="0"/>
                      <a:pt x="31448" y="0"/>
                    </a:cubicBezTo>
                    <a:cubicBezTo>
                      <a:pt x="48816" y="0"/>
                      <a:pt x="62896" y="14081"/>
                      <a:pt x="62896" y="31450"/>
                    </a:cubicBezTo>
                    <a:close/>
                  </a:path>
                </a:pathLst>
              </a:custGeom>
              <a:solidFill>
                <a:srgbClr val="FFFFFF"/>
              </a:solidFill>
              <a:ln w="5706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18" name="フリーフォーム: 図形 317">
                <a:extLst>
                  <a:ext uri="{FF2B5EF4-FFF2-40B4-BE49-F238E27FC236}">
                    <a16:creationId xmlns:a16="http://schemas.microsoft.com/office/drawing/2014/main" id="{BAB9DF28-37EB-D35D-CDEA-1011A073488D}"/>
                  </a:ext>
                </a:extLst>
              </p:cNvPr>
              <p:cNvSpPr/>
              <p:nvPr/>
            </p:nvSpPr>
            <p:spPr>
              <a:xfrm>
                <a:off x="2405125" y="2251867"/>
                <a:ext cx="62895" cy="62900"/>
              </a:xfrm>
              <a:custGeom>
                <a:avLst/>
                <a:gdLst>
                  <a:gd name="connsiteX0" fmla="*/ 62896 w 62895"/>
                  <a:gd name="connsiteY0" fmla="*/ 31450 h 62900"/>
                  <a:gd name="connsiteX1" fmla="*/ 31448 w 62895"/>
                  <a:gd name="connsiteY1" fmla="*/ 62900 h 62900"/>
                  <a:gd name="connsiteX2" fmla="*/ 0 w 62895"/>
                  <a:gd name="connsiteY2" fmla="*/ 31450 h 62900"/>
                  <a:gd name="connsiteX3" fmla="*/ 31448 w 62895"/>
                  <a:gd name="connsiteY3" fmla="*/ 0 h 62900"/>
                  <a:gd name="connsiteX4" fmla="*/ 62896 w 62895"/>
                  <a:gd name="connsiteY4" fmla="*/ 31450 h 629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62895" h="62900">
                    <a:moveTo>
                      <a:pt x="62896" y="31450"/>
                    </a:moveTo>
                    <a:cubicBezTo>
                      <a:pt x="62896" y="48820"/>
                      <a:pt x="48816" y="62900"/>
                      <a:pt x="31448" y="62900"/>
                    </a:cubicBezTo>
                    <a:cubicBezTo>
                      <a:pt x="14080" y="62900"/>
                      <a:pt x="0" y="48820"/>
                      <a:pt x="0" y="31450"/>
                    </a:cubicBezTo>
                    <a:cubicBezTo>
                      <a:pt x="0" y="14081"/>
                      <a:pt x="14080" y="0"/>
                      <a:pt x="31448" y="0"/>
                    </a:cubicBezTo>
                    <a:cubicBezTo>
                      <a:pt x="48816" y="0"/>
                      <a:pt x="62896" y="14081"/>
                      <a:pt x="62896" y="31450"/>
                    </a:cubicBezTo>
                    <a:close/>
                  </a:path>
                </a:pathLst>
              </a:custGeom>
              <a:solidFill>
                <a:srgbClr val="FFFFFF"/>
              </a:solidFill>
              <a:ln w="5706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19" name="フリーフォーム: 図形 318">
                <a:extLst>
                  <a:ext uri="{FF2B5EF4-FFF2-40B4-BE49-F238E27FC236}">
                    <a16:creationId xmlns:a16="http://schemas.microsoft.com/office/drawing/2014/main" id="{B2A7FAF9-26B0-77DB-4F30-D503C828E0BA}"/>
                  </a:ext>
                </a:extLst>
              </p:cNvPr>
              <p:cNvSpPr/>
              <p:nvPr/>
            </p:nvSpPr>
            <p:spPr>
              <a:xfrm>
                <a:off x="2405125" y="2193460"/>
                <a:ext cx="62895" cy="62900"/>
              </a:xfrm>
              <a:custGeom>
                <a:avLst/>
                <a:gdLst>
                  <a:gd name="connsiteX0" fmla="*/ 62896 w 62895"/>
                  <a:gd name="connsiteY0" fmla="*/ 31450 h 62900"/>
                  <a:gd name="connsiteX1" fmla="*/ 31448 w 62895"/>
                  <a:gd name="connsiteY1" fmla="*/ 62900 h 62900"/>
                  <a:gd name="connsiteX2" fmla="*/ 0 w 62895"/>
                  <a:gd name="connsiteY2" fmla="*/ 31450 h 62900"/>
                  <a:gd name="connsiteX3" fmla="*/ 31448 w 62895"/>
                  <a:gd name="connsiteY3" fmla="*/ 0 h 62900"/>
                  <a:gd name="connsiteX4" fmla="*/ 62896 w 62895"/>
                  <a:gd name="connsiteY4" fmla="*/ 31450 h 629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62895" h="62900">
                    <a:moveTo>
                      <a:pt x="62896" y="31450"/>
                    </a:moveTo>
                    <a:cubicBezTo>
                      <a:pt x="62896" y="48820"/>
                      <a:pt x="48816" y="62900"/>
                      <a:pt x="31448" y="62900"/>
                    </a:cubicBezTo>
                    <a:cubicBezTo>
                      <a:pt x="14080" y="62900"/>
                      <a:pt x="0" y="48820"/>
                      <a:pt x="0" y="31450"/>
                    </a:cubicBezTo>
                    <a:cubicBezTo>
                      <a:pt x="0" y="14081"/>
                      <a:pt x="14080" y="0"/>
                      <a:pt x="31448" y="0"/>
                    </a:cubicBezTo>
                    <a:cubicBezTo>
                      <a:pt x="48816" y="0"/>
                      <a:pt x="62896" y="14081"/>
                      <a:pt x="62896" y="31450"/>
                    </a:cubicBezTo>
                    <a:close/>
                  </a:path>
                </a:pathLst>
              </a:custGeom>
              <a:solidFill>
                <a:srgbClr val="FFFFFF"/>
              </a:solidFill>
              <a:ln w="5706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20" name="フリーフォーム: 図形 319">
                <a:extLst>
                  <a:ext uri="{FF2B5EF4-FFF2-40B4-BE49-F238E27FC236}">
                    <a16:creationId xmlns:a16="http://schemas.microsoft.com/office/drawing/2014/main" id="{40ADC2A7-4BA4-7E2E-64A8-D6A6367248B9}"/>
                  </a:ext>
                </a:extLst>
              </p:cNvPr>
              <p:cNvSpPr/>
              <p:nvPr/>
            </p:nvSpPr>
            <p:spPr>
              <a:xfrm>
                <a:off x="4215621" y="4758889"/>
                <a:ext cx="62895" cy="62900"/>
              </a:xfrm>
              <a:custGeom>
                <a:avLst/>
                <a:gdLst>
                  <a:gd name="connsiteX0" fmla="*/ 62896 w 62895"/>
                  <a:gd name="connsiteY0" fmla="*/ 31450 h 62900"/>
                  <a:gd name="connsiteX1" fmla="*/ 31448 w 62895"/>
                  <a:gd name="connsiteY1" fmla="*/ 62900 h 62900"/>
                  <a:gd name="connsiteX2" fmla="*/ 0 w 62895"/>
                  <a:gd name="connsiteY2" fmla="*/ 31450 h 62900"/>
                  <a:gd name="connsiteX3" fmla="*/ 31448 w 62895"/>
                  <a:gd name="connsiteY3" fmla="*/ 0 h 62900"/>
                  <a:gd name="connsiteX4" fmla="*/ 62896 w 62895"/>
                  <a:gd name="connsiteY4" fmla="*/ 31450 h 629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62895" h="62900">
                    <a:moveTo>
                      <a:pt x="62896" y="31450"/>
                    </a:moveTo>
                    <a:cubicBezTo>
                      <a:pt x="62896" y="48819"/>
                      <a:pt x="48816" y="62900"/>
                      <a:pt x="31448" y="62900"/>
                    </a:cubicBezTo>
                    <a:cubicBezTo>
                      <a:pt x="14080" y="62900"/>
                      <a:pt x="0" y="48819"/>
                      <a:pt x="0" y="31450"/>
                    </a:cubicBezTo>
                    <a:cubicBezTo>
                      <a:pt x="0" y="14081"/>
                      <a:pt x="14080" y="0"/>
                      <a:pt x="31448" y="0"/>
                    </a:cubicBezTo>
                    <a:cubicBezTo>
                      <a:pt x="48816" y="0"/>
                      <a:pt x="62896" y="14081"/>
                      <a:pt x="62896" y="31450"/>
                    </a:cubicBezTo>
                    <a:close/>
                  </a:path>
                </a:pathLst>
              </a:custGeom>
              <a:solidFill>
                <a:schemeClr val="accent2"/>
              </a:solidFill>
              <a:ln w="5706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21" name="フリーフォーム: 図形 320">
                <a:extLst>
                  <a:ext uri="{FF2B5EF4-FFF2-40B4-BE49-F238E27FC236}">
                    <a16:creationId xmlns:a16="http://schemas.microsoft.com/office/drawing/2014/main" id="{BEDA3366-B0D6-0AF4-DD16-A0F9E42AEBCC}"/>
                  </a:ext>
                </a:extLst>
              </p:cNvPr>
              <p:cNvSpPr/>
              <p:nvPr/>
            </p:nvSpPr>
            <p:spPr>
              <a:xfrm>
                <a:off x="4215621" y="4588160"/>
                <a:ext cx="62895" cy="62900"/>
              </a:xfrm>
              <a:custGeom>
                <a:avLst/>
                <a:gdLst>
                  <a:gd name="connsiteX0" fmla="*/ 62896 w 62895"/>
                  <a:gd name="connsiteY0" fmla="*/ 31450 h 62900"/>
                  <a:gd name="connsiteX1" fmla="*/ 31448 w 62895"/>
                  <a:gd name="connsiteY1" fmla="*/ 62900 h 62900"/>
                  <a:gd name="connsiteX2" fmla="*/ 0 w 62895"/>
                  <a:gd name="connsiteY2" fmla="*/ 31450 h 62900"/>
                  <a:gd name="connsiteX3" fmla="*/ 31448 w 62895"/>
                  <a:gd name="connsiteY3" fmla="*/ 0 h 62900"/>
                  <a:gd name="connsiteX4" fmla="*/ 62896 w 62895"/>
                  <a:gd name="connsiteY4" fmla="*/ 31450 h 629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62895" h="62900">
                    <a:moveTo>
                      <a:pt x="62896" y="31450"/>
                    </a:moveTo>
                    <a:cubicBezTo>
                      <a:pt x="62896" y="48819"/>
                      <a:pt x="48816" y="62900"/>
                      <a:pt x="31448" y="62900"/>
                    </a:cubicBezTo>
                    <a:cubicBezTo>
                      <a:pt x="14080" y="62900"/>
                      <a:pt x="0" y="48819"/>
                      <a:pt x="0" y="31450"/>
                    </a:cubicBezTo>
                    <a:cubicBezTo>
                      <a:pt x="0" y="14081"/>
                      <a:pt x="14080" y="0"/>
                      <a:pt x="31448" y="0"/>
                    </a:cubicBezTo>
                    <a:cubicBezTo>
                      <a:pt x="48816" y="0"/>
                      <a:pt x="62896" y="14081"/>
                      <a:pt x="62896" y="31450"/>
                    </a:cubicBezTo>
                    <a:close/>
                  </a:path>
                </a:pathLst>
              </a:custGeom>
              <a:solidFill>
                <a:schemeClr val="accent2"/>
              </a:solidFill>
              <a:ln w="5706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22" name="フリーフォーム: 図形 321">
                <a:extLst>
                  <a:ext uri="{FF2B5EF4-FFF2-40B4-BE49-F238E27FC236}">
                    <a16:creationId xmlns:a16="http://schemas.microsoft.com/office/drawing/2014/main" id="{7772D077-1615-64C5-7197-3ADEB2416AD8}"/>
                  </a:ext>
                </a:extLst>
              </p:cNvPr>
              <p:cNvSpPr/>
              <p:nvPr/>
            </p:nvSpPr>
            <p:spPr>
              <a:xfrm>
                <a:off x="4215621" y="4466853"/>
                <a:ext cx="62895" cy="62900"/>
              </a:xfrm>
              <a:custGeom>
                <a:avLst/>
                <a:gdLst>
                  <a:gd name="connsiteX0" fmla="*/ 62896 w 62895"/>
                  <a:gd name="connsiteY0" fmla="*/ 31450 h 62900"/>
                  <a:gd name="connsiteX1" fmla="*/ 31448 w 62895"/>
                  <a:gd name="connsiteY1" fmla="*/ 62900 h 62900"/>
                  <a:gd name="connsiteX2" fmla="*/ 0 w 62895"/>
                  <a:gd name="connsiteY2" fmla="*/ 31450 h 62900"/>
                  <a:gd name="connsiteX3" fmla="*/ 31448 w 62895"/>
                  <a:gd name="connsiteY3" fmla="*/ 0 h 62900"/>
                  <a:gd name="connsiteX4" fmla="*/ 62896 w 62895"/>
                  <a:gd name="connsiteY4" fmla="*/ 31450 h 629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62895" h="62900">
                    <a:moveTo>
                      <a:pt x="62896" y="31450"/>
                    </a:moveTo>
                    <a:cubicBezTo>
                      <a:pt x="62896" y="48819"/>
                      <a:pt x="48816" y="62900"/>
                      <a:pt x="31448" y="62900"/>
                    </a:cubicBezTo>
                    <a:cubicBezTo>
                      <a:pt x="14080" y="62900"/>
                      <a:pt x="0" y="48819"/>
                      <a:pt x="0" y="31450"/>
                    </a:cubicBezTo>
                    <a:cubicBezTo>
                      <a:pt x="0" y="14081"/>
                      <a:pt x="14080" y="0"/>
                      <a:pt x="31448" y="0"/>
                    </a:cubicBezTo>
                    <a:cubicBezTo>
                      <a:pt x="48816" y="0"/>
                      <a:pt x="62896" y="14081"/>
                      <a:pt x="62896" y="31450"/>
                    </a:cubicBezTo>
                    <a:close/>
                  </a:path>
                </a:pathLst>
              </a:custGeom>
              <a:solidFill>
                <a:schemeClr val="accent2"/>
              </a:solidFill>
              <a:ln w="5706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23" name="フリーフォーム: 図形 322">
                <a:extLst>
                  <a:ext uri="{FF2B5EF4-FFF2-40B4-BE49-F238E27FC236}">
                    <a16:creationId xmlns:a16="http://schemas.microsoft.com/office/drawing/2014/main" id="{37D48FC5-C9B1-82BD-FCB6-7D380E78FBBB}"/>
                  </a:ext>
                </a:extLst>
              </p:cNvPr>
              <p:cNvSpPr/>
              <p:nvPr/>
            </p:nvSpPr>
            <p:spPr>
              <a:xfrm>
                <a:off x="4215621" y="4179309"/>
                <a:ext cx="62895" cy="62900"/>
              </a:xfrm>
              <a:custGeom>
                <a:avLst/>
                <a:gdLst>
                  <a:gd name="connsiteX0" fmla="*/ 62896 w 62895"/>
                  <a:gd name="connsiteY0" fmla="*/ 31450 h 62900"/>
                  <a:gd name="connsiteX1" fmla="*/ 31448 w 62895"/>
                  <a:gd name="connsiteY1" fmla="*/ 62900 h 62900"/>
                  <a:gd name="connsiteX2" fmla="*/ 0 w 62895"/>
                  <a:gd name="connsiteY2" fmla="*/ 31450 h 62900"/>
                  <a:gd name="connsiteX3" fmla="*/ 31448 w 62895"/>
                  <a:gd name="connsiteY3" fmla="*/ 0 h 62900"/>
                  <a:gd name="connsiteX4" fmla="*/ 62896 w 62895"/>
                  <a:gd name="connsiteY4" fmla="*/ 31450 h 629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62895" h="62900">
                    <a:moveTo>
                      <a:pt x="62896" y="31450"/>
                    </a:moveTo>
                    <a:cubicBezTo>
                      <a:pt x="62896" y="48819"/>
                      <a:pt x="48816" y="62900"/>
                      <a:pt x="31448" y="62900"/>
                    </a:cubicBezTo>
                    <a:cubicBezTo>
                      <a:pt x="14080" y="62900"/>
                      <a:pt x="0" y="48819"/>
                      <a:pt x="0" y="31450"/>
                    </a:cubicBezTo>
                    <a:cubicBezTo>
                      <a:pt x="0" y="14081"/>
                      <a:pt x="14080" y="0"/>
                      <a:pt x="31448" y="0"/>
                    </a:cubicBezTo>
                    <a:cubicBezTo>
                      <a:pt x="48816" y="0"/>
                      <a:pt x="62896" y="14081"/>
                      <a:pt x="62896" y="31450"/>
                    </a:cubicBezTo>
                    <a:close/>
                  </a:path>
                </a:pathLst>
              </a:custGeom>
              <a:solidFill>
                <a:schemeClr val="accent2"/>
              </a:solidFill>
              <a:ln w="5706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24" name="フリーフォーム: 図形 323">
                <a:extLst>
                  <a:ext uri="{FF2B5EF4-FFF2-40B4-BE49-F238E27FC236}">
                    <a16:creationId xmlns:a16="http://schemas.microsoft.com/office/drawing/2014/main" id="{3566B00E-9441-3841-90B9-68F9E63A78CA}"/>
                  </a:ext>
                </a:extLst>
              </p:cNvPr>
              <p:cNvSpPr/>
              <p:nvPr/>
            </p:nvSpPr>
            <p:spPr>
              <a:xfrm>
                <a:off x="4215621" y="3869301"/>
                <a:ext cx="62895" cy="62900"/>
              </a:xfrm>
              <a:custGeom>
                <a:avLst/>
                <a:gdLst>
                  <a:gd name="connsiteX0" fmla="*/ 62896 w 62895"/>
                  <a:gd name="connsiteY0" fmla="*/ 31450 h 62900"/>
                  <a:gd name="connsiteX1" fmla="*/ 31448 w 62895"/>
                  <a:gd name="connsiteY1" fmla="*/ 62900 h 62900"/>
                  <a:gd name="connsiteX2" fmla="*/ 0 w 62895"/>
                  <a:gd name="connsiteY2" fmla="*/ 31450 h 62900"/>
                  <a:gd name="connsiteX3" fmla="*/ 31448 w 62895"/>
                  <a:gd name="connsiteY3" fmla="*/ 0 h 62900"/>
                  <a:gd name="connsiteX4" fmla="*/ 62896 w 62895"/>
                  <a:gd name="connsiteY4" fmla="*/ 31450 h 629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62895" h="62900">
                    <a:moveTo>
                      <a:pt x="62896" y="31450"/>
                    </a:moveTo>
                    <a:cubicBezTo>
                      <a:pt x="62896" y="48819"/>
                      <a:pt x="48816" y="62900"/>
                      <a:pt x="31448" y="62900"/>
                    </a:cubicBezTo>
                    <a:cubicBezTo>
                      <a:pt x="14080" y="62900"/>
                      <a:pt x="0" y="48819"/>
                      <a:pt x="0" y="31450"/>
                    </a:cubicBezTo>
                    <a:cubicBezTo>
                      <a:pt x="0" y="14081"/>
                      <a:pt x="14080" y="0"/>
                      <a:pt x="31448" y="0"/>
                    </a:cubicBezTo>
                    <a:cubicBezTo>
                      <a:pt x="48816" y="0"/>
                      <a:pt x="62896" y="14081"/>
                      <a:pt x="62896" y="31450"/>
                    </a:cubicBezTo>
                    <a:close/>
                  </a:path>
                </a:pathLst>
              </a:custGeom>
              <a:solidFill>
                <a:schemeClr val="accent2"/>
              </a:solidFill>
              <a:ln w="5706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 dirty="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25" name="フリーフォーム: 図形 324">
                <a:extLst>
                  <a:ext uri="{FF2B5EF4-FFF2-40B4-BE49-F238E27FC236}">
                    <a16:creationId xmlns:a16="http://schemas.microsoft.com/office/drawing/2014/main" id="{535C5DCE-5E27-2738-9497-782163B2CB08}"/>
                  </a:ext>
                </a:extLst>
              </p:cNvPr>
              <p:cNvSpPr/>
              <p:nvPr/>
            </p:nvSpPr>
            <p:spPr>
              <a:xfrm>
                <a:off x="4179681" y="3446971"/>
                <a:ext cx="62895" cy="62900"/>
              </a:xfrm>
              <a:custGeom>
                <a:avLst/>
                <a:gdLst>
                  <a:gd name="connsiteX0" fmla="*/ 62896 w 62895"/>
                  <a:gd name="connsiteY0" fmla="*/ 31450 h 62900"/>
                  <a:gd name="connsiteX1" fmla="*/ 31448 w 62895"/>
                  <a:gd name="connsiteY1" fmla="*/ 62900 h 62900"/>
                  <a:gd name="connsiteX2" fmla="*/ 0 w 62895"/>
                  <a:gd name="connsiteY2" fmla="*/ 31450 h 62900"/>
                  <a:gd name="connsiteX3" fmla="*/ 31448 w 62895"/>
                  <a:gd name="connsiteY3" fmla="*/ 0 h 62900"/>
                  <a:gd name="connsiteX4" fmla="*/ 62896 w 62895"/>
                  <a:gd name="connsiteY4" fmla="*/ 31450 h 629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62895" h="62900">
                    <a:moveTo>
                      <a:pt x="62896" y="31450"/>
                    </a:moveTo>
                    <a:cubicBezTo>
                      <a:pt x="62896" y="48820"/>
                      <a:pt x="48816" y="62900"/>
                      <a:pt x="31448" y="62900"/>
                    </a:cubicBezTo>
                    <a:cubicBezTo>
                      <a:pt x="14080" y="62900"/>
                      <a:pt x="0" y="48820"/>
                      <a:pt x="0" y="31450"/>
                    </a:cubicBezTo>
                    <a:cubicBezTo>
                      <a:pt x="0" y="14081"/>
                      <a:pt x="14080" y="0"/>
                      <a:pt x="31448" y="0"/>
                    </a:cubicBezTo>
                    <a:cubicBezTo>
                      <a:pt x="48816" y="0"/>
                      <a:pt x="62896" y="14081"/>
                      <a:pt x="62896" y="31450"/>
                    </a:cubicBezTo>
                    <a:close/>
                  </a:path>
                </a:pathLst>
              </a:custGeom>
              <a:solidFill>
                <a:srgbClr val="FFFFFF"/>
              </a:solidFill>
              <a:ln w="5706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26" name="フリーフォーム: 図形 325">
                <a:extLst>
                  <a:ext uri="{FF2B5EF4-FFF2-40B4-BE49-F238E27FC236}">
                    <a16:creationId xmlns:a16="http://schemas.microsoft.com/office/drawing/2014/main" id="{4ACCD5CC-D005-AE7F-BC71-E62184320B7A}"/>
                  </a:ext>
                </a:extLst>
              </p:cNvPr>
              <p:cNvSpPr/>
              <p:nvPr/>
            </p:nvSpPr>
            <p:spPr>
              <a:xfrm>
                <a:off x="4256054" y="3424507"/>
                <a:ext cx="62895" cy="62900"/>
              </a:xfrm>
              <a:custGeom>
                <a:avLst/>
                <a:gdLst>
                  <a:gd name="connsiteX0" fmla="*/ 62896 w 62895"/>
                  <a:gd name="connsiteY0" fmla="*/ 31450 h 62900"/>
                  <a:gd name="connsiteX1" fmla="*/ 31448 w 62895"/>
                  <a:gd name="connsiteY1" fmla="*/ 62900 h 62900"/>
                  <a:gd name="connsiteX2" fmla="*/ 0 w 62895"/>
                  <a:gd name="connsiteY2" fmla="*/ 31450 h 62900"/>
                  <a:gd name="connsiteX3" fmla="*/ 31448 w 62895"/>
                  <a:gd name="connsiteY3" fmla="*/ 0 h 62900"/>
                  <a:gd name="connsiteX4" fmla="*/ 62896 w 62895"/>
                  <a:gd name="connsiteY4" fmla="*/ 31450 h 629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62895" h="62900">
                    <a:moveTo>
                      <a:pt x="62896" y="31450"/>
                    </a:moveTo>
                    <a:cubicBezTo>
                      <a:pt x="62896" y="48820"/>
                      <a:pt x="48816" y="62900"/>
                      <a:pt x="31448" y="62900"/>
                    </a:cubicBezTo>
                    <a:cubicBezTo>
                      <a:pt x="14080" y="62900"/>
                      <a:pt x="0" y="48820"/>
                      <a:pt x="0" y="31450"/>
                    </a:cubicBezTo>
                    <a:cubicBezTo>
                      <a:pt x="0" y="14081"/>
                      <a:pt x="14080" y="0"/>
                      <a:pt x="31448" y="0"/>
                    </a:cubicBezTo>
                    <a:cubicBezTo>
                      <a:pt x="48816" y="0"/>
                      <a:pt x="62896" y="14081"/>
                      <a:pt x="62896" y="31450"/>
                    </a:cubicBezTo>
                    <a:close/>
                  </a:path>
                </a:pathLst>
              </a:custGeom>
              <a:solidFill>
                <a:srgbClr val="FFFFFF"/>
              </a:solidFill>
              <a:ln w="5706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27" name="フリーフォーム: 図形 326">
                <a:extLst>
                  <a:ext uri="{FF2B5EF4-FFF2-40B4-BE49-F238E27FC236}">
                    <a16:creationId xmlns:a16="http://schemas.microsoft.com/office/drawing/2014/main" id="{0EA1A3E1-2E1F-B00C-5920-FFF21B1CB068}"/>
                  </a:ext>
                </a:extLst>
              </p:cNvPr>
              <p:cNvSpPr/>
              <p:nvPr/>
            </p:nvSpPr>
            <p:spPr>
              <a:xfrm>
                <a:off x="4139248" y="3393057"/>
                <a:ext cx="62895" cy="62900"/>
              </a:xfrm>
              <a:custGeom>
                <a:avLst/>
                <a:gdLst>
                  <a:gd name="connsiteX0" fmla="*/ 62896 w 62895"/>
                  <a:gd name="connsiteY0" fmla="*/ 31450 h 62900"/>
                  <a:gd name="connsiteX1" fmla="*/ 31448 w 62895"/>
                  <a:gd name="connsiteY1" fmla="*/ 62900 h 62900"/>
                  <a:gd name="connsiteX2" fmla="*/ 0 w 62895"/>
                  <a:gd name="connsiteY2" fmla="*/ 31450 h 62900"/>
                  <a:gd name="connsiteX3" fmla="*/ 31448 w 62895"/>
                  <a:gd name="connsiteY3" fmla="*/ 0 h 62900"/>
                  <a:gd name="connsiteX4" fmla="*/ 62896 w 62895"/>
                  <a:gd name="connsiteY4" fmla="*/ 31450 h 629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62895" h="62900">
                    <a:moveTo>
                      <a:pt x="62896" y="31450"/>
                    </a:moveTo>
                    <a:cubicBezTo>
                      <a:pt x="62896" y="48820"/>
                      <a:pt x="48816" y="62900"/>
                      <a:pt x="31448" y="62900"/>
                    </a:cubicBezTo>
                    <a:cubicBezTo>
                      <a:pt x="14080" y="62900"/>
                      <a:pt x="0" y="48820"/>
                      <a:pt x="0" y="31450"/>
                    </a:cubicBezTo>
                    <a:cubicBezTo>
                      <a:pt x="0" y="14081"/>
                      <a:pt x="14080" y="0"/>
                      <a:pt x="31448" y="0"/>
                    </a:cubicBezTo>
                    <a:cubicBezTo>
                      <a:pt x="48816" y="0"/>
                      <a:pt x="62896" y="14081"/>
                      <a:pt x="62896" y="31450"/>
                    </a:cubicBezTo>
                    <a:close/>
                  </a:path>
                </a:pathLst>
              </a:custGeom>
              <a:solidFill>
                <a:srgbClr val="FFFFFF"/>
              </a:solidFill>
              <a:ln w="5706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28" name="フリーフォーム: 図形 327">
                <a:extLst>
                  <a:ext uri="{FF2B5EF4-FFF2-40B4-BE49-F238E27FC236}">
                    <a16:creationId xmlns:a16="http://schemas.microsoft.com/office/drawing/2014/main" id="{6355D0A8-A06D-3BE2-01AD-B8CB8697D83E}"/>
                  </a:ext>
                </a:extLst>
              </p:cNvPr>
              <p:cNvSpPr/>
              <p:nvPr/>
            </p:nvSpPr>
            <p:spPr>
              <a:xfrm>
                <a:off x="4215621" y="3393057"/>
                <a:ext cx="62895" cy="62900"/>
              </a:xfrm>
              <a:custGeom>
                <a:avLst/>
                <a:gdLst>
                  <a:gd name="connsiteX0" fmla="*/ 62896 w 62895"/>
                  <a:gd name="connsiteY0" fmla="*/ 31450 h 62900"/>
                  <a:gd name="connsiteX1" fmla="*/ 31448 w 62895"/>
                  <a:gd name="connsiteY1" fmla="*/ 62900 h 62900"/>
                  <a:gd name="connsiteX2" fmla="*/ 0 w 62895"/>
                  <a:gd name="connsiteY2" fmla="*/ 31450 h 62900"/>
                  <a:gd name="connsiteX3" fmla="*/ 31448 w 62895"/>
                  <a:gd name="connsiteY3" fmla="*/ 0 h 62900"/>
                  <a:gd name="connsiteX4" fmla="*/ 62896 w 62895"/>
                  <a:gd name="connsiteY4" fmla="*/ 31450 h 629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62895" h="62900">
                    <a:moveTo>
                      <a:pt x="62896" y="31450"/>
                    </a:moveTo>
                    <a:cubicBezTo>
                      <a:pt x="62896" y="48820"/>
                      <a:pt x="48816" y="62900"/>
                      <a:pt x="31448" y="62900"/>
                    </a:cubicBezTo>
                    <a:cubicBezTo>
                      <a:pt x="14080" y="62900"/>
                      <a:pt x="0" y="48820"/>
                      <a:pt x="0" y="31450"/>
                    </a:cubicBezTo>
                    <a:cubicBezTo>
                      <a:pt x="0" y="14081"/>
                      <a:pt x="14080" y="0"/>
                      <a:pt x="31448" y="0"/>
                    </a:cubicBezTo>
                    <a:cubicBezTo>
                      <a:pt x="48816" y="0"/>
                      <a:pt x="62896" y="14081"/>
                      <a:pt x="62896" y="31450"/>
                    </a:cubicBezTo>
                    <a:close/>
                  </a:path>
                </a:pathLst>
              </a:custGeom>
              <a:solidFill>
                <a:srgbClr val="FFFFFF"/>
              </a:solidFill>
              <a:ln w="5706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29" name="フリーフォーム: 図形 328">
                <a:extLst>
                  <a:ext uri="{FF2B5EF4-FFF2-40B4-BE49-F238E27FC236}">
                    <a16:creationId xmlns:a16="http://schemas.microsoft.com/office/drawing/2014/main" id="{4485BD27-DD18-BF1B-5523-9D8D08C73B61}"/>
                  </a:ext>
                </a:extLst>
              </p:cNvPr>
              <p:cNvSpPr/>
              <p:nvPr/>
            </p:nvSpPr>
            <p:spPr>
              <a:xfrm>
                <a:off x="4291995" y="3370592"/>
                <a:ext cx="62895" cy="62900"/>
              </a:xfrm>
              <a:custGeom>
                <a:avLst/>
                <a:gdLst>
                  <a:gd name="connsiteX0" fmla="*/ 62896 w 62895"/>
                  <a:gd name="connsiteY0" fmla="*/ 31450 h 62900"/>
                  <a:gd name="connsiteX1" fmla="*/ 31448 w 62895"/>
                  <a:gd name="connsiteY1" fmla="*/ 62900 h 62900"/>
                  <a:gd name="connsiteX2" fmla="*/ 0 w 62895"/>
                  <a:gd name="connsiteY2" fmla="*/ 31450 h 62900"/>
                  <a:gd name="connsiteX3" fmla="*/ 31448 w 62895"/>
                  <a:gd name="connsiteY3" fmla="*/ 0 h 62900"/>
                  <a:gd name="connsiteX4" fmla="*/ 62896 w 62895"/>
                  <a:gd name="connsiteY4" fmla="*/ 31450 h 629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62895" h="62900">
                    <a:moveTo>
                      <a:pt x="62896" y="31450"/>
                    </a:moveTo>
                    <a:cubicBezTo>
                      <a:pt x="62896" y="48820"/>
                      <a:pt x="48816" y="62900"/>
                      <a:pt x="31448" y="62900"/>
                    </a:cubicBezTo>
                    <a:cubicBezTo>
                      <a:pt x="14080" y="62900"/>
                      <a:pt x="0" y="48820"/>
                      <a:pt x="0" y="31450"/>
                    </a:cubicBezTo>
                    <a:cubicBezTo>
                      <a:pt x="0" y="14081"/>
                      <a:pt x="14080" y="0"/>
                      <a:pt x="31448" y="0"/>
                    </a:cubicBezTo>
                    <a:cubicBezTo>
                      <a:pt x="48816" y="0"/>
                      <a:pt x="62896" y="14081"/>
                      <a:pt x="62896" y="31450"/>
                    </a:cubicBezTo>
                    <a:close/>
                  </a:path>
                </a:pathLst>
              </a:custGeom>
              <a:solidFill>
                <a:srgbClr val="FFFFFF"/>
              </a:solidFill>
              <a:ln w="5706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30" name="フリーフォーム: 図形 329">
                <a:extLst>
                  <a:ext uri="{FF2B5EF4-FFF2-40B4-BE49-F238E27FC236}">
                    <a16:creationId xmlns:a16="http://schemas.microsoft.com/office/drawing/2014/main" id="{3226398C-C3A1-0300-4862-A43C062678DE}"/>
                  </a:ext>
                </a:extLst>
              </p:cNvPr>
              <p:cNvSpPr/>
              <p:nvPr/>
            </p:nvSpPr>
            <p:spPr>
              <a:xfrm>
                <a:off x="4215621" y="3285228"/>
                <a:ext cx="62895" cy="62900"/>
              </a:xfrm>
              <a:custGeom>
                <a:avLst/>
                <a:gdLst>
                  <a:gd name="connsiteX0" fmla="*/ 62896 w 62895"/>
                  <a:gd name="connsiteY0" fmla="*/ 31450 h 62900"/>
                  <a:gd name="connsiteX1" fmla="*/ 31448 w 62895"/>
                  <a:gd name="connsiteY1" fmla="*/ 62900 h 62900"/>
                  <a:gd name="connsiteX2" fmla="*/ 0 w 62895"/>
                  <a:gd name="connsiteY2" fmla="*/ 31450 h 62900"/>
                  <a:gd name="connsiteX3" fmla="*/ 31448 w 62895"/>
                  <a:gd name="connsiteY3" fmla="*/ 0 h 62900"/>
                  <a:gd name="connsiteX4" fmla="*/ 62896 w 62895"/>
                  <a:gd name="connsiteY4" fmla="*/ 31450 h 629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62895" h="62900">
                    <a:moveTo>
                      <a:pt x="62896" y="31450"/>
                    </a:moveTo>
                    <a:cubicBezTo>
                      <a:pt x="62896" y="48820"/>
                      <a:pt x="48816" y="62900"/>
                      <a:pt x="31448" y="62900"/>
                    </a:cubicBezTo>
                    <a:cubicBezTo>
                      <a:pt x="14080" y="62900"/>
                      <a:pt x="0" y="48820"/>
                      <a:pt x="0" y="31450"/>
                    </a:cubicBezTo>
                    <a:cubicBezTo>
                      <a:pt x="0" y="14081"/>
                      <a:pt x="14080" y="0"/>
                      <a:pt x="31448" y="0"/>
                    </a:cubicBezTo>
                    <a:cubicBezTo>
                      <a:pt x="48816" y="0"/>
                      <a:pt x="62896" y="14081"/>
                      <a:pt x="62896" y="31450"/>
                    </a:cubicBezTo>
                    <a:close/>
                  </a:path>
                </a:pathLst>
              </a:custGeom>
              <a:solidFill>
                <a:srgbClr val="FFFFFF"/>
              </a:solidFill>
              <a:ln w="5706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31" name="フリーフォーム: 図形 330">
                <a:extLst>
                  <a:ext uri="{FF2B5EF4-FFF2-40B4-BE49-F238E27FC236}">
                    <a16:creationId xmlns:a16="http://schemas.microsoft.com/office/drawing/2014/main" id="{F0F62FEF-2443-2E9B-7A3F-3FA6ADE08AA4}"/>
                  </a:ext>
                </a:extLst>
              </p:cNvPr>
              <p:cNvSpPr/>
              <p:nvPr/>
            </p:nvSpPr>
            <p:spPr>
              <a:xfrm>
                <a:off x="4215621" y="3132470"/>
                <a:ext cx="62895" cy="62900"/>
              </a:xfrm>
              <a:custGeom>
                <a:avLst/>
                <a:gdLst>
                  <a:gd name="connsiteX0" fmla="*/ 62896 w 62895"/>
                  <a:gd name="connsiteY0" fmla="*/ 31450 h 62900"/>
                  <a:gd name="connsiteX1" fmla="*/ 31448 w 62895"/>
                  <a:gd name="connsiteY1" fmla="*/ 62900 h 62900"/>
                  <a:gd name="connsiteX2" fmla="*/ 0 w 62895"/>
                  <a:gd name="connsiteY2" fmla="*/ 31450 h 62900"/>
                  <a:gd name="connsiteX3" fmla="*/ 31448 w 62895"/>
                  <a:gd name="connsiteY3" fmla="*/ 0 h 62900"/>
                  <a:gd name="connsiteX4" fmla="*/ 62896 w 62895"/>
                  <a:gd name="connsiteY4" fmla="*/ 31450 h 629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62895" h="62900">
                    <a:moveTo>
                      <a:pt x="62896" y="31450"/>
                    </a:moveTo>
                    <a:cubicBezTo>
                      <a:pt x="62896" y="48820"/>
                      <a:pt x="48816" y="62900"/>
                      <a:pt x="31448" y="62900"/>
                    </a:cubicBezTo>
                    <a:cubicBezTo>
                      <a:pt x="14080" y="62900"/>
                      <a:pt x="0" y="48820"/>
                      <a:pt x="0" y="31450"/>
                    </a:cubicBezTo>
                    <a:cubicBezTo>
                      <a:pt x="0" y="14081"/>
                      <a:pt x="14080" y="0"/>
                      <a:pt x="31448" y="0"/>
                    </a:cubicBezTo>
                    <a:cubicBezTo>
                      <a:pt x="48816" y="0"/>
                      <a:pt x="62896" y="14081"/>
                      <a:pt x="62896" y="31450"/>
                    </a:cubicBezTo>
                    <a:close/>
                  </a:path>
                </a:pathLst>
              </a:custGeom>
              <a:solidFill>
                <a:srgbClr val="FFFFFF"/>
              </a:solidFill>
              <a:ln w="5706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32" name="フリーフォーム: 図形 331">
                <a:extLst>
                  <a:ext uri="{FF2B5EF4-FFF2-40B4-BE49-F238E27FC236}">
                    <a16:creationId xmlns:a16="http://schemas.microsoft.com/office/drawing/2014/main" id="{0C2EAAD5-FD87-1B3B-EF27-C621B689732D}"/>
                  </a:ext>
                </a:extLst>
              </p:cNvPr>
              <p:cNvSpPr/>
              <p:nvPr/>
            </p:nvSpPr>
            <p:spPr>
              <a:xfrm>
                <a:off x="4215621" y="3087541"/>
                <a:ext cx="62895" cy="62900"/>
              </a:xfrm>
              <a:custGeom>
                <a:avLst/>
                <a:gdLst>
                  <a:gd name="connsiteX0" fmla="*/ 62896 w 62895"/>
                  <a:gd name="connsiteY0" fmla="*/ 31450 h 62900"/>
                  <a:gd name="connsiteX1" fmla="*/ 31448 w 62895"/>
                  <a:gd name="connsiteY1" fmla="*/ 62900 h 62900"/>
                  <a:gd name="connsiteX2" fmla="*/ 0 w 62895"/>
                  <a:gd name="connsiteY2" fmla="*/ 31450 h 62900"/>
                  <a:gd name="connsiteX3" fmla="*/ 31448 w 62895"/>
                  <a:gd name="connsiteY3" fmla="*/ 0 h 62900"/>
                  <a:gd name="connsiteX4" fmla="*/ 62896 w 62895"/>
                  <a:gd name="connsiteY4" fmla="*/ 31450 h 629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62895" h="62900">
                    <a:moveTo>
                      <a:pt x="62896" y="31450"/>
                    </a:moveTo>
                    <a:cubicBezTo>
                      <a:pt x="62896" y="48820"/>
                      <a:pt x="48816" y="62900"/>
                      <a:pt x="31448" y="62900"/>
                    </a:cubicBezTo>
                    <a:cubicBezTo>
                      <a:pt x="14080" y="62900"/>
                      <a:pt x="0" y="48820"/>
                      <a:pt x="0" y="31450"/>
                    </a:cubicBezTo>
                    <a:cubicBezTo>
                      <a:pt x="0" y="14081"/>
                      <a:pt x="14080" y="0"/>
                      <a:pt x="31448" y="0"/>
                    </a:cubicBezTo>
                    <a:cubicBezTo>
                      <a:pt x="48816" y="0"/>
                      <a:pt x="62896" y="14081"/>
                      <a:pt x="62896" y="31450"/>
                    </a:cubicBezTo>
                    <a:close/>
                  </a:path>
                </a:pathLst>
              </a:custGeom>
              <a:solidFill>
                <a:srgbClr val="FFFFFF"/>
              </a:solidFill>
              <a:ln w="5706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33" name="フリーフォーム: 図形 332">
                <a:extLst>
                  <a:ext uri="{FF2B5EF4-FFF2-40B4-BE49-F238E27FC236}">
                    <a16:creationId xmlns:a16="http://schemas.microsoft.com/office/drawing/2014/main" id="{8E2AD469-70A7-9EF7-5165-D754345D8FA0}"/>
                  </a:ext>
                </a:extLst>
              </p:cNvPr>
              <p:cNvSpPr/>
              <p:nvPr/>
            </p:nvSpPr>
            <p:spPr>
              <a:xfrm>
                <a:off x="4179681" y="3002177"/>
                <a:ext cx="62895" cy="62900"/>
              </a:xfrm>
              <a:custGeom>
                <a:avLst/>
                <a:gdLst>
                  <a:gd name="connsiteX0" fmla="*/ 62896 w 62895"/>
                  <a:gd name="connsiteY0" fmla="*/ 31450 h 62900"/>
                  <a:gd name="connsiteX1" fmla="*/ 31448 w 62895"/>
                  <a:gd name="connsiteY1" fmla="*/ 62900 h 62900"/>
                  <a:gd name="connsiteX2" fmla="*/ 0 w 62895"/>
                  <a:gd name="connsiteY2" fmla="*/ 31450 h 62900"/>
                  <a:gd name="connsiteX3" fmla="*/ 31448 w 62895"/>
                  <a:gd name="connsiteY3" fmla="*/ 0 h 62900"/>
                  <a:gd name="connsiteX4" fmla="*/ 62896 w 62895"/>
                  <a:gd name="connsiteY4" fmla="*/ 31450 h 629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62895" h="62900">
                    <a:moveTo>
                      <a:pt x="62896" y="31450"/>
                    </a:moveTo>
                    <a:cubicBezTo>
                      <a:pt x="62896" y="48820"/>
                      <a:pt x="48816" y="62900"/>
                      <a:pt x="31448" y="62900"/>
                    </a:cubicBezTo>
                    <a:cubicBezTo>
                      <a:pt x="14080" y="62900"/>
                      <a:pt x="0" y="48820"/>
                      <a:pt x="0" y="31450"/>
                    </a:cubicBezTo>
                    <a:cubicBezTo>
                      <a:pt x="0" y="14081"/>
                      <a:pt x="14080" y="0"/>
                      <a:pt x="31448" y="0"/>
                    </a:cubicBezTo>
                    <a:cubicBezTo>
                      <a:pt x="48816" y="0"/>
                      <a:pt x="62896" y="14081"/>
                      <a:pt x="62896" y="31450"/>
                    </a:cubicBezTo>
                    <a:close/>
                  </a:path>
                </a:pathLst>
              </a:custGeom>
              <a:solidFill>
                <a:srgbClr val="FFFFFF"/>
              </a:solidFill>
              <a:ln w="5706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34" name="フリーフォーム: 図形 333">
                <a:extLst>
                  <a:ext uri="{FF2B5EF4-FFF2-40B4-BE49-F238E27FC236}">
                    <a16:creationId xmlns:a16="http://schemas.microsoft.com/office/drawing/2014/main" id="{79EE0236-4C91-4217-A74D-2E0AE392AB30}"/>
                  </a:ext>
                </a:extLst>
              </p:cNvPr>
              <p:cNvSpPr/>
              <p:nvPr/>
            </p:nvSpPr>
            <p:spPr>
              <a:xfrm>
                <a:off x="4256054" y="2984205"/>
                <a:ext cx="62895" cy="62900"/>
              </a:xfrm>
              <a:custGeom>
                <a:avLst/>
                <a:gdLst>
                  <a:gd name="connsiteX0" fmla="*/ 62896 w 62895"/>
                  <a:gd name="connsiteY0" fmla="*/ 31450 h 62900"/>
                  <a:gd name="connsiteX1" fmla="*/ 31448 w 62895"/>
                  <a:gd name="connsiteY1" fmla="*/ 62900 h 62900"/>
                  <a:gd name="connsiteX2" fmla="*/ 0 w 62895"/>
                  <a:gd name="connsiteY2" fmla="*/ 31450 h 62900"/>
                  <a:gd name="connsiteX3" fmla="*/ 31448 w 62895"/>
                  <a:gd name="connsiteY3" fmla="*/ 0 h 62900"/>
                  <a:gd name="connsiteX4" fmla="*/ 62896 w 62895"/>
                  <a:gd name="connsiteY4" fmla="*/ 31450 h 629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62895" h="62900">
                    <a:moveTo>
                      <a:pt x="62896" y="31450"/>
                    </a:moveTo>
                    <a:cubicBezTo>
                      <a:pt x="62896" y="48820"/>
                      <a:pt x="48816" y="62900"/>
                      <a:pt x="31448" y="62900"/>
                    </a:cubicBezTo>
                    <a:cubicBezTo>
                      <a:pt x="14080" y="62900"/>
                      <a:pt x="0" y="48820"/>
                      <a:pt x="0" y="31450"/>
                    </a:cubicBezTo>
                    <a:cubicBezTo>
                      <a:pt x="0" y="14081"/>
                      <a:pt x="14080" y="0"/>
                      <a:pt x="31448" y="0"/>
                    </a:cubicBezTo>
                    <a:cubicBezTo>
                      <a:pt x="48816" y="0"/>
                      <a:pt x="62896" y="14081"/>
                      <a:pt x="62896" y="31450"/>
                    </a:cubicBezTo>
                    <a:close/>
                  </a:path>
                </a:pathLst>
              </a:custGeom>
              <a:solidFill>
                <a:srgbClr val="FFFFFF"/>
              </a:solidFill>
              <a:ln w="5706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35" name="フリーフォーム: 図形 334">
                <a:extLst>
                  <a:ext uri="{FF2B5EF4-FFF2-40B4-BE49-F238E27FC236}">
                    <a16:creationId xmlns:a16="http://schemas.microsoft.com/office/drawing/2014/main" id="{490472D6-8B5F-B77C-3F15-7BB5F95BCB32}"/>
                  </a:ext>
                </a:extLst>
              </p:cNvPr>
              <p:cNvSpPr/>
              <p:nvPr/>
            </p:nvSpPr>
            <p:spPr>
              <a:xfrm>
                <a:off x="4215621" y="2930291"/>
                <a:ext cx="62895" cy="62900"/>
              </a:xfrm>
              <a:custGeom>
                <a:avLst/>
                <a:gdLst>
                  <a:gd name="connsiteX0" fmla="*/ 62896 w 62895"/>
                  <a:gd name="connsiteY0" fmla="*/ 31450 h 62900"/>
                  <a:gd name="connsiteX1" fmla="*/ 31448 w 62895"/>
                  <a:gd name="connsiteY1" fmla="*/ 62900 h 62900"/>
                  <a:gd name="connsiteX2" fmla="*/ 0 w 62895"/>
                  <a:gd name="connsiteY2" fmla="*/ 31450 h 62900"/>
                  <a:gd name="connsiteX3" fmla="*/ 31448 w 62895"/>
                  <a:gd name="connsiteY3" fmla="*/ 0 h 62900"/>
                  <a:gd name="connsiteX4" fmla="*/ 62896 w 62895"/>
                  <a:gd name="connsiteY4" fmla="*/ 31450 h 629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62895" h="62900">
                    <a:moveTo>
                      <a:pt x="62896" y="31450"/>
                    </a:moveTo>
                    <a:cubicBezTo>
                      <a:pt x="62896" y="48820"/>
                      <a:pt x="48816" y="62900"/>
                      <a:pt x="31448" y="62900"/>
                    </a:cubicBezTo>
                    <a:cubicBezTo>
                      <a:pt x="14080" y="62900"/>
                      <a:pt x="0" y="48820"/>
                      <a:pt x="0" y="31450"/>
                    </a:cubicBezTo>
                    <a:cubicBezTo>
                      <a:pt x="0" y="14081"/>
                      <a:pt x="14080" y="0"/>
                      <a:pt x="31448" y="0"/>
                    </a:cubicBezTo>
                    <a:cubicBezTo>
                      <a:pt x="48816" y="0"/>
                      <a:pt x="62896" y="14081"/>
                      <a:pt x="62896" y="31450"/>
                    </a:cubicBezTo>
                    <a:close/>
                  </a:path>
                </a:pathLst>
              </a:custGeom>
              <a:solidFill>
                <a:srgbClr val="FFFFFF"/>
              </a:solidFill>
              <a:ln w="5706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36" name="フリーフォーム: 図形 335">
                <a:extLst>
                  <a:ext uri="{FF2B5EF4-FFF2-40B4-BE49-F238E27FC236}">
                    <a16:creationId xmlns:a16="http://schemas.microsoft.com/office/drawing/2014/main" id="{94E98CFC-6E4A-965D-9C5B-E3112BCC8054}"/>
                  </a:ext>
                </a:extLst>
              </p:cNvPr>
              <p:cNvSpPr/>
              <p:nvPr/>
            </p:nvSpPr>
            <p:spPr>
              <a:xfrm>
                <a:off x="4179681" y="2876376"/>
                <a:ext cx="62895" cy="62900"/>
              </a:xfrm>
              <a:custGeom>
                <a:avLst/>
                <a:gdLst>
                  <a:gd name="connsiteX0" fmla="*/ 62896 w 62895"/>
                  <a:gd name="connsiteY0" fmla="*/ 31450 h 62900"/>
                  <a:gd name="connsiteX1" fmla="*/ 31448 w 62895"/>
                  <a:gd name="connsiteY1" fmla="*/ 62900 h 62900"/>
                  <a:gd name="connsiteX2" fmla="*/ 0 w 62895"/>
                  <a:gd name="connsiteY2" fmla="*/ 31450 h 62900"/>
                  <a:gd name="connsiteX3" fmla="*/ 31448 w 62895"/>
                  <a:gd name="connsiteY3" fmla="*/ 0 h 62900"/>
                  <a:gd name="connsiteX4" fmla="*/ 62896 w 62895"/>
                  <a:gd name="connsiteY4" fmla="*/ 31450 h 629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62895" h="62900">
                    <a:moveTo>
                      <a:pt x="62896" y="31450"/>
                    </a:moveTo>
                    <a:cubicBezTo>
                      <a:pt x="62896" y="48820"/>
                      <a:pt x="48816" y="62900"/>
                      <a:pt x="31448" y="62900"/>
                    </a:cubicBezTo>
                    <a:cubicBezTo>
                      <a:pt x="14080" y="62900"/>
                      <a:pt x="0" y="48820"/>
                      <a:pt x="0" y="31450"/>
                    </a:cubicBezTo>
                    <a:cubicBezTo>
                      <a:pt x="0" y="14081"/>
                      <a:pt x="14080" y="0"/>
                      <a:pt x="31448" y="0"/>
                    </a:cubicBezTo>
                    <a:cubicBezTo>
                      <a:pt x="48816" y="0"/>
                      <a:pt x="62896" y="14081"/>
                      <a:pt x="62896" y="31450"/>
                    </a:cubicBezTo>
                    <a:close/>
                  </a:path>
                </a:pathLst>
              </a:custGeom>
              <a:solidFill>
                <a:srgbClr val="FFFFFF"/>
              </a:solidFill>
              <a:ln w="5706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37" name="フリーフォーム: 図形 336">
                <a:extLst>
                  <a:ext uri="{FF2B5EF4-FFF2-40B4-BE49-F238E27FC236}">
                    <a16:creationId xmlns:a16="http://schemas.microsoft.com/office/drawing/2014/main" id="{1AF660C8-A463-99B7-F5D7-42A09F7DDC00}"/>
                  </a:ext>
                </a:extLst>
              </p:cNvPr>
              <p:cNvSpPr/>
              <p:nvPr/>
            </p:nvSpPr>
            <p:spPr>
              <a:xfrm>
                <a:off x="4256054" y="2867391"/>
                <a:ext cx="62895" cy="62900"/>
              </a:xfrm>
              <a:custGeom>
                <a:avLst/>
                <a:gdLst>
                  <a:gd name="connsiteX0" fmla="*/ 62896 w 62895"/>
                  <a:gd name="connsiteY0" fmla="*/ 31450 h 62900"/>
                  <a:gd name="connsiteX1" fmla="*/ 31448 w 62895"/>
                  <a:gd name="connsiteY1" fmla="*/ 62900 h 62900"/>
                  <a:gd name="connsiteX2" fmla="*/ 0 w 62895"/>
                  <a:gd name="connsiteY2" fmla="*/ 31450 h 62900"/>
                  <a:gd name="connsiteX3" fmla="*/ 31448 w 62895"/>
                  <a:gd name="connsiteY3" fmla="*/ 0 h 62900"/>
                  <a:gd name="connsiteX4" fmla="*/ 62896 w 62895"/>
                  <a:gd name="connsiteY4" fmla="*/ 31450 h 629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62895" h="62900">
                    <a:moveTo>
                      <a:pt x="62896" y="31450"/>
                    </a:moveTo>
                    <a:cubicBezTo>
                      <a:pt x="62896" y="48820"/>
                      <a:pt x="48816" y="62900"/>
                      <a:pt x="31448" y="62900"/>
                    </a:cubicBezTo>
                    <a:cubicBezTo>
                      <a:pt x="14080" y="62900"/>
                      <a:pt x="0" y="48820"/>
                      <a:pt x="0" y="31450"/>
                    </a:cubicBezTo>
                    <a:cubicBezTo>
                      <a:pt x="0" y="14081"/>
                      <a:pt x="14080" y="0"/>
                      <a:pt x="31448" y="0"/>
                    </a:cubicBezTo>
                    <a:cubicBezTo>
                      <a:pt x="48816" y="0"/>
                      <a:pt x="62896" y="14081"/>
                      <a:pt x="62896" y="31450"/>
                    </a:cubicBezTo>
                    <a:close/>
                  </a:path>
                </a:pathLst>
              </a:custGeom>
              <a:solidFill>
                <a:srgbClr val="FFFFFF"/>
              </a:solidFill>
              <a:ln w="5706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38" name="フリーフォーム: 図形 337">
                <a:extLst>
                  <a:ext uri="{FF2B5EF4-FFF2-40B4-BE49-F238E27FC236}">
                    <a16:creationId xmlns:a16="http://schemas.microsoft.com/office/drawing/2014/main" id="{301723EF-5F29-4B4C-E55B-83238B5BFEC1}"/>
                  </a:ext>
                </a:extLst>
              </p:cNvPr>
              <p:cNvSpPr/>
              <p:nvPr/>
            </p:nvSpPr>
            <p:spPr>
              <a:xfrm>
                <a:off x="4139248" y="2786519"/>
                <a:ext cx="62895" cy="62900"/>
              </a:xfrm>
              <a:custGeom>
                <a:avLst/>
                <a:gdLst>
                  <a:gd name="connsiteX0" fmla="*/ 62896 w 62895"/>
                  <a:gd name="connsiteY0" fmla="*/ 31450 h 62900"/>
                  <a:gd name="connsiteX1" fmla="*/ 31448 w 62895"/>
                  <a:gd name="connsiteY1" fmla="*/ 62900 h 62900"/>
                  <a:gd name="connsiteX2" fmla="*/ 0 w 62895"/>
                  <a:gd name="connsiteY2" fmla="*/ 31450 h 62900"/>
                  <a:gd name="connsiteX3" fmla="*/ 31448 w 62895"/>
                  <a:gd name="connsiteY3" fmla="*/ 0 h 62900"/>
                  <a:gd name="connsiteX4" fmla="*/ 62896 w 62895"/>
                  <a:gd name="connsiteY4" fmla="*/ 31450 h 629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62895" h="62900">
                    <a:moveTo>
                      <a:pt x="62896" y="31450"/>
                    </a:moveTo>
                    <a:cubicBezTo>
                      <a:pt x="62896" y="48820"/>
                      <a:pt x="48816" y="62900"/>
                      <a:pt x="31448" y="62900"/>
                    </a:cubicBezTo>
                    <a:cubicBezTo>
                      <a:pt x="14080" y="62900"/>
                      <a:pt x="0" y="48820"/>
                      <a:pt x="0" y="31450"/>
                    </a:cubicBezTo>
                    <a:cubicBezTo>
                      <a:pt x="0" y="14081"/>
                      <a:pt x="14080" y="0"/>
                      <a:pt x="31448" y="0"/>
                    </a:cubicBezTo>
                    <a:cubicBezTo>
                      <a:pt x="48816" y="0"/>
                      <a:pt x="62896" y="14081"/>
                      <a:pt x="62896" y="31450"/>
                    </a:cubicBezTo>
                    <a:close/>
                  </a:path>
                </a:pathLst>
              </a:custGeom>
              <a:solidFill>
                <a:srgbClr val="FFFFFF"/>
              </a:solidFill>
              <a:ln w="5706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39" name="フリーフォーム: 図形 338">
                <a:extLst>
                  <a:ext uri="{FF2B5EF4-FFF2-40B4-BE49-F238E27FC236}">
                    <a16:creationId xmlns:a16="http://schemas.microsoft.com/office/drawing/2014/main" id="{DABB3F6C-7806-5801-B351-95C210311425}"/>
                  </a:ext>
                </a:extLst>
              </p:cNvPr>
              <p:cNvSpPr/>
              <p:nvPr/>
            </p:nvSpPr>
            <p:spPr>
              <a:xfrm>
                <a:off x="4215621" y="2764055"/>
                <a:ext cx="62895" cy="62900"/>
              </a:xfrm>
              <a:custGeom>
                <a:avLst/>
                <a:gdLst>
                  <a:gd name="connsiteX0" fmla="*/ 62896 w 62895"/>
                  <a:gd name="connsiteY0" fmla="*/ 31450 h 62900"/>
                  <a:gd name="connsiteX1" fmla="*/ 31448 w 62895"/>
                  <a:gd name="connsiteY1" fmla="*/ 62900 h 62900"/>
                  <a:gd name="connsiteX2" fmla="*/ 0 w 62895"/>
                  <a:gd name="connsiteY2" fmla="*/ 31450 h 62900"/>
                  <a:gd name="connsiteX3" fmla="*/ 31448 w 62895"/>
                  <a:gd name="connsiteY3" fmla="*/ 0 h 62900"/>
                  <a:gd name="connsiteX4" fmla="*/ 62896 w 62895"/>
                  <a:gd name="connsiteY4" fmla="*/ 31450 h 629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62895" h="62900">
                    <a:moveTo>
                      <a:pt x="62896" y="31450"/>
                    </a:moveTo>
                    <a:cubicBezTo>
                      <a:pt x="62896" y="48820"/>
                      <a:pt x="48816" y="62900"/>
                      <a:pt x="31448" y="62900"/>
                    </a:cubicBezTo>
                    <a:cubicBezTo>
                      <a:pt x="14080" y="62900"/>
                      <a:pt x="0" y="48820"/>
                      <a:pt x="0" y="31450"/>
                    </a:cubicBezTo>
                    <a:cubicBezTo>
                      <a:pt x="0" y="14081"/>
                      <a:pt x="14080" y="0"/>
                      <a:pt x="31448" y="0"/>
                    </a:cubicBezTo>
                    <a:cubicBezTo>
                      <a:pt x="48816" y="0"/>
                      <a:pt x="62896" y="14081"/>
                      <a:pt x="62896" y="31450"/>
                    </a:cubicBezTo>
                    <a:close/>
                  </a:path>
                </a:pathLst>
              </a:custGeom>
              <a:solidFill>
                <a:srgbClr val="FFFFFF"/>
              </a:solidFill>
              <a:ln w="5706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40" name="フリーフォーム: 図形 339">
                <a:extLst>
                  <a:ext uri="{FF2B5EF4-FFF2-40B4-BE49-F238E27FC236}">
                    <a16:creationId xmlns:a16="http://schemas.microsoft.com/office/drawing/2014/main" id="{279F4FE9-59FA-4AB4-ED44-D7AE6E406C09}"/>
                  </a:ext>
                </a:extLst>
              </p:cNvPr>
              <p:cNvSpPr/>
              <p:nvPr/>
            </p:nvSpPr>
            <p:spPr>
              <a:xfrm>
                <a:off x="4291995" y="2759562"/>
                <a:ext cx="62895" cy="62900"/>
              </a:xfrm>
              <a:custGeom>
                <a:avLst/>
                <a:gdLst>
                  <a:gd name="connsiteX0" fmla="*/ 62896 w 62895"/>
                  <a:gd name="connsiteY0" fmla="*/ 31450 h 62900"/>
                  <a:gd name="connsiteX1" fmla="*/ 31448 w 62895"/>
                  <a:gd name="connsiteY1" fmla="*/ 62900 h 62900"/>
                  <a:gd name="connsiteX2" fmla="*/ 0 w 62895"/>
                  <a:gd name="connsiteY2" fmla="*/ 31450 h 62900"/>
                  <a:gd name="connsiteX3" fmla="*/ 31448 w 62895"/>
                  <a:gd name="connsiteY3" fmla="*/ 0 h 62900"/>
                  <a:gd name="connsiteX4" fmla="*/ 62896 w 62895"/>
                  <a:gd name="connsiteY4" fmla="*/ 31450 h 629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62895" h="62900">
                    <a:moveTo>
                      <a:pt x="62896" y="31450"/>
                    </a:moveTo>
                    <a:cubicBezTo>
                      <a:pt x="62896" y="48820"/>
                      <a:pt x="48816" y="62900"/>
                      <a:pt x="31448" y="62900"/>
                    </a:cubicBezTo>
                    <a:cubicBezTo>
                      <a:pt x="14080" y="62900"/>
                      <a:pt x="0" y="48820"/>
                      <a:pt x="0" y="31450"/>
                    </a:cubicBezTo>
                    <a:cubicBezTo>
                      <a:pt x="0" y="14081"/>
                      <a:pt x="14080" y="0"/>
                      <a:pt x="31448" y="0"/>
                    </a:cubicBezTo>
                    <a:cubicBezTo>
                      <a:pt x="48816" y="0"/>
                      <a:pt x="62896" y="14081"/>
                      <a:pt x="62896" y="31450"/>
                    </a:cubicBezTo>
                    <a:close/>
                  </a:path>
                </a:pathLst>
              </a:custGeom>
              <a:solidFill>
                <a:srgbClr val="FFFFFF"/>
              </a:solidFill>
              <a:ln w="5706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41" name="フリーフォーム: 図形 340">
                <a:extLst>
                  <a:ext uri="{FF2B5EF4-FFF2-40B4-BE49-F238E27FC236}">
                    <a16:creationId xmlns:a16="http://schemas.microsoft.com/office/drawing/2014/main" id="{5C9D91F6-165A-7261-931E-BE484B42E61B}"/>
                  </a:ext>
                </a:extLst>
              </p:cNvPr>
              <p:cNvSpPr/>
              <p:nvPr/>
            </p:nvSpPr>
            <p:spPr>
              <a:xfrm>
                <a:off x="4215621" y="2674197"/>
                <a:ext cx="62895" cy="62900"/>
              </a:xfrm>
              <a:custGeom>
                <a:avLst/>
                <a:gdLst>
                  <a:gd name="connsiteX0" fmla="*/ 62896 w 62895"/>
                  <a:gd name="connsiteY0" fmla="*/ 31450 h 62900"/>
                  <a:gd name="connsiteX1" fmla="*/ 31448 w 62895"/>
                  <a:gd name="connsiteY1" fmla="*/ 62900 h 62900"/>
                  <a:gd name="connsiteX2" fmla="*/ 0 w 62895"/>
                  <a:gd name="connsiteY2" fmla="*/ 31450 h 62900"/>
                  <a:gd name="connsiteX3" fmla="*/ 31448 w 62895"/>
                  <a:gd name="connsiteY3" fmla="*/ 0 h 62900"/>
                  <a:gd name="connsiteX4" fmla="*/ 62896 w 62895"/>
                  <a:gd name="connsiteY4" fmla="*/ 31450 h 629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62895" h="62900">
                    <a:moveTo>
                      <a:pt x="62896" y="31450"/>
                    </a:moveTo>
                    <a:cubicBezTo>
                      <a:pt x="62896" y="48820"/>
                      <a:pt x="48816" y="62900"/>
                      <a:pt x="31448" y="62900"/>
                    </a:cubicBezTo>
                    <a:cubicBezTo>
                      <a:pt x="14080" y="62900"/>
                      <a:pt x="0" y="48820"/>
                      <a:pt x="0" y="31450"/>
                    </a:cubicBezTo>
                    <a:cubicBezTo>
                      <a:pt x="0" y="14081"/>
                      <a:pt x="14080" y="0"/>
                      <a:pt x="31448" y="0"/>
                    </a:cubicBezTo>
                    <a:cubicBezTo>
                      <a:pt x="48816" y="0"/>
                      <a:pt x="62896" y="14081"/>
                      <a:pt x="62896" y="31450"/>
                    </a:cubicBezTo>
                    <a:close/>
                  </a:path>
                </a:pathLst>
              </a:custGeom>
              <a:solidFill>
                <a:srgbClr val="FFFFFF"/>
              </a:solidFill>
              <a:ln w="5706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42" name="フリーフォーム: 図形 341">
                <a:extLst>
                  <a:ext uri="{FF2B5EF4-FFF2-40B4-BE49-F238E27FC236}">
                    <a16:creationId xmlns:a16="http://schemas.microsoft.com/office/drawing/2014/main" id="{FC9B8264-D002-0E80-DD98-5973FB93D752}"/>
                  </a:ext>
                </a:extLst>
              </p:cNvPr>
              <p:cNvSpPr/>
              <p:nvPr/>
            </p:nvSpPr>
            <p:spPr>
              <a:xfrm>
                <a:off x="4215621" y="2472018"/>
                <a:ext cx="62895" cy="62900"/>
              </a:xfrm>
              <a:custGeom>
                <a:avLst/>
                <a:gdLst>
                  <a:gd name="connsiteX0" fmla="*/ 62896 w 62895"/>
                  <a:gd name="connsiteY0" fmla="*/ 31450 h 62900"/>
                  <a:gd name="connsiteX1" fmla="*/ 31448 w 62895"/>
                  <a:gd name="connsiteY1" fmla="*/ 62900 h 62900"/>
                  <a:gd name="connsiteX2" fmla="*/ 0 w 62895"/>
                  <a:gd name="connsiteY2" fmla="*/ 31450 h 62900"/>
                  <a:gd name="connsiteX3" fmla="*/ 31448 w 62895"/>
                  <a:gd name="connsiteY3" fmla="*/ 0 h 62900"/>
                  <a:gd name="connsiteX4" fmla="*/ 62896 w 62895"/>
                  <a:gd name="connsiteY4" fmla="*/ 31450 h 629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62895" h="62900">
                    <a:moveTo>
                      <a:pt x="62896" y="31450"/>
                    </a:moveTo>
                    <a:cubicBezTo>
                      <a:pt x="62896" y="48820"/>
                      <a:pt x="48816" y="62900"/>
                      <a:pt x="31448" y="62900"/>
                    </a:cubicBezTo>
                    <a:cubicBezTo>
                      <a:pt x="14080" y="62900"/>
                      <a:pt x="0" y="48820"/>
                      <a:pt x="0" y="31450"/>
                    </a:cubicBezTo>
                    <a:cubicBezTo>
                      <a:pt x="0" y="14081"/>
                      <a:pt x="14080" y="0"/>
                      <a:pt x="31448" y="0"/>
                    </a:cubicBezTo>
                    <a:cubicBezTo>
                      <a:pt x="48816" y="0"/>
                      <a:pt x="62896" y="14081"/>
                      <a:pt x="62896" y="31450"/>
                    </a:cubicBezTo>
                    <a:close/>
                  </a:path>
                </a:pathLst>
              </a:custGeom>
              <a:solidFill>
                <a:srgbClr val="FFFFFF"/>
              </a:solidFill>
              <a:ln w="5706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43" name="フリーフォーム: 図形 342">
                <a:extLst>
                  <a:ext uri="{FF2B5EF4-FFF2-40B4-BE49-F238E27FC236}">
                    <a16:creationId xmlns:a16="http://schemas.microsoft.com/office/drawing/2014/main" id="{A47DD4D3-E68C-9809-76B5-CC0C34B50DDA}"/>
                  </a:ext>
                </a:extLst>
              </p:cNvPr>
              <p:cNvSpPr/>
              <p:nvPr/>
            </p:nvSpPr>
            <p:spPr>
              <a:xfrm>
                <a:off x="4179681" y="2391146"/>
                <a:ext cx="62895" cy="62900"/>
              </a:xfrm>
              <a:custGeom>
                <a:avLst/>
                <a:gdLst>
                  <a:gd name="connsiteX0" fmla="*/ 62896 w 62895"/>
                  <a:gd name="connsiteY0" fmla="*/ 31450 h 62900"/>
                  <a:gd name="connsiteX1" fmla="*/ 31448 w 62895"/>
                  <a:gd name="connsiteY1" fmla="*/ 62900 h 62900"/>
                  <a:gd name="connsiteX2" fmla="*/ 0 w 62895"/>
                  <a:gd name="connsiteY2" fmla="*/ 31450 h 62900"/>
                  <a:gd name="connsiteX3" fmla="*/ 31448 w 62895"/>
                  <a:gd name="connsiteY3" fmla="*/ 0 h 62900"/>
                  <a:gd name="connsiteX4" fmla="*/ 62896 w 62895"/>
                  <a:gd name="connsiteY4" fmla="*/ 31450 h 629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62895" h="62900">
                    <a:moveTo>
                      <a:pt x="62896" y="31450"/>
                    </a:moveTo>
                    <a:cubicBezTo>
                      <a:pt x="62896" y="48820"/>
                      <a:pt x="48816" y="62900"/>
                      <a:pt x="31448" y="62900"/>
                    </a:cubicBezTo>
                    <a:cubicBezTo>
                      <a:pt x="14080" y="62900"/>
                      <a:pt x="0" y="48820"/>
                      <a:pt x="0" y="31450"/>
                    </a:cubicBezTo>
                    <a:cubicBezTo>
                      <a:pt x="0" y="14081"/>
                      <a:pt x="14080" y="0"/>
                      <a:pt x="31448" y="0"/>
                    </a:cubicBezTo>
                    <a:cubicBezTo>
                      <a:pt x="48816" y="0"/>
                      <a:pt x="62896" y="14081"/>
                      <a:pt x="62896" y="31450"/>
                    </a:cubicBezTo>
                    <a:close/>
                  </a:path>
                </a:pathLst>
              </a:custGeom>
              <a:solidFill>
                <a:srgbClr val="FFFFFF"/>
              </a:solidFill>
              <a:ln w="5706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44" name="フリーフォーム: 図形 343">
                <a:extLst>
                  <a:ext uri="{FF2B5EF4-FFF2-40B4-BE49-F238E27FC236}">
                    <a16:creationId xmlns:a16="http://schemas.microsoft.com/office/drawing/2014/main" id="{5B8B2105-9472-2866-39C4-AD918F2BD40C}"/>
                  </a:ext>
                </a:extLst>
              </p:cNvPr>
              <p:cNvSpPr/>
              <p:nvPr/>
            </p:nvSpPr>
            <p:spPr>
              <a:xfrm>
                <a:off x="4256054" y="2364189"/>
                <a:ext cx="62895" cy="62900"/>
              </a:xfrm>
              <a:custGeom>
                <a:avLst/>
                <a:gdLst>
                  <a:gd name="connsiteX0" fmla="*/ 62896 w 62895"/>
                  <a:gd name="connsiteY0" fmla="*/ 31450 h 62900"/>
                  <a:gd name="connsiteX1" fmla="*/ 31448 w 62895"/>
                  <a:gd name="connsiteY1" fmla="*/ 62900 h 62900"/>
                  <a:gd name="connsiteX2" fmla="*/ 0 w 62895"/>
                  <a:gd name="connsiteY2" fmla="*/ 31450 h 62900"/>
                  <a:gd name="connsiteX3" fmla="*/ 31448 w 62895"/>
                  <a:gd name="connsiteY3" fmla="*/ 0 h 62900"/>
                  <a:gd name="connsiteX4" fmla="*/ 62896 w 62895"/>
                  <a:gd name="connsiteY4" fmla="*/ 31450 h 629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62895" h="62900">
                    <a:moveTo>
                      <a:pt x="62896" y="31450"/>
                    </a:moveTo>
                    <a:cubicBezTo>
                      <a:pt x="62896" y="48820"/>
                      <a:pt x="48816" y="62900"/>
                      <a:pt x="31448" y="62900"/>
                    </a:cubicBezTo>
                    <a:cubicBezTo>
                      <a:pt x="14080" y="62900"/>
                      <a:pt x="0" y="48820"/>
                      <a:pt x="0" y="31450"/>
                    </a:cubicBezTo>
                    <a:cubicBezTo>
                      <a:pt x="0" y="14081"/>
                      <a:pt x="14080" y="0"/>
                      <a:pt x="31448" y="0"/>
                    </a:cubicBezTo>
                    <a:cubicBezTo>
                      <a:pt x="48816" y="0"/>
                      <a:pt x="62896" y="14081"/>
                      <a:pt x="62896" y="31450"/>
                    </a:cubicBezTo>
                    <a:close/>
                  </a:path>
                </a:pathLst>
              </a:custGeom>
              <a:solidFill>
                <a:srgbClr val="FFFFFF"/>
              </a:solidFill>
              <a:ln w="5706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45" name="フリーフォーム: 図形 344">
                <a:extLst>
                  <a:ext uri="{FF2B5EF4-FFF2-40B4-BE49-F238E27FC236}">
                    <a16:creationId xmlns:a16="http://schemas.microsoft.com/office/drawing/2014/main" id="{1F169074-F8A9-1226-337B-95F069D8610B}"/>
                  </a:ext>
                </a:extLst>
              </p:cNvPr>
              <p:cNvSpPr/>
              <p:nvPr/>
            </p:nvSpPr>
            <p:spPr>
              <a:xfrm>
                <a:off x="4179681" y="2135053"/>
                <a:ext cx="62895" cy="62900"/>
              </a:xfrm>
              <a:custGeom>
                <a:avLst/>
                <a:gdLst>
                  <a:gd name="connsiteX0" fmla="*/ 62896 w 62895"/>
                  <a:gd name="connsiteY0" fmla="*/ 31450 h 62900"/>
                  <a:gd name="connsiteX1" fmla="*/ 31448 w 62895"/>
                  <a:gd name="connsiteY1" fmla="*/ 62900 h 62900"/>
                  <a:gd name="connsiteX2" fmla="*/ 0 w 62895"/>
                  <a:gd name="connsiteY2" fmla="*/ 31450 h 62900"/>
                  <a:gd name="connsiteX3" fmla="*/ 31448 w 62895"/>
                  <a:gd name="connsiteY3" fmla="*/ 0 h 62900"/>
                  <a:gd name="connsiteX4" fmla="*/ 62896 w 62895"/>
                  <a:gd name="connsiteY4" fmla="*/ 31450 h 629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62895" h="62900">
                    <a:moveTo>
                      <a:pt x="62896" y="31450"/>
                    </a:moveTo>
                    <a:cubicBezTo>
                      <a:pt x="62896" y="48820"/>
                      <a:pt x="48816" y="62900"/>
                      <a:pt x="31448" y="62900"/>
                    </a:cubicBezTo>
                    <a:cubicBezTo>
                      <a:pt x="14080" y="62900"/>
                      <a:pt x="0" y="48820"/>
                      <a:pt x="0" y="31450"/>
                    </a:cubicBezTo>
                    <a:cubicBezTo>
                      <a:pt x="0" y="14081"/>
                      <a:pt x="14080" y="0"/>
                      <a:pt x="31448" y="0"/>
                    </a:cubicBezTo>
                    <a:cubicBezTo>
                      <a:pt x="48816" y="0"/>
                      <a:pt x="62896" y="14081"/>
                      <a:pt x="62896" y="31450"/>
                    </a:cubicBezTo>
                    <a:close/>
                  </a:path>
                </a:pathLst>
              </a:custGeom>
              <a:solidFill>
                <a:srgbClr val="FFFFFF"/>
              </a:solidFill>
              <a:ln w="5706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46" name="フリーフォーム: 図形 345">
                <a:extLst>
                  <a:ext uri="{FF2B5EF4-FFF2-40B4-BE49-F238E27FC236}">
                    <a16:creationId xmlns:a16="http://schemas.microsoft.com/office/drawing/2014/main" id="{E0D8481B-470D-643F-7579-34EE6FFB9F0C}"/>
                  </a:ext>
                </a:extLst>
              </p:cNvPr>
              <p:cNvSpPr/>
              <p:nvPr/>
            </p:nvSpPr>
            <p:spPr>
              <a:xfrm>
                <a:off x="4256054" y="2130560"/>
                <a:ext cx="62895" cy="62900"/>
              </a:xfrm>
              <a:custGeom>
                <a:avLst/>
                <a:gdLst>
                  <a:gd name="connsiteX0" fmla="*/ 62896 w 62895"/>
                  <a:gd name="connsiteY0" fmla="*/ 31450 h 62900"/>
                  <a:gd name="connsiteX1" fmla="*/ 31448 w 62895"/>
                  <a:gd name="connsiteY1" fmla="*/ 62900 h 62900"/>
                  <a:gd name="connsiteX2" fmla="*/ 0 w 62895"/>
                  <a:gd name="connsiteY2" fmla="*/ 31450 h 62900"/>
                  <a:gd name="connsiteX3" fmla="*/ 31448 w 62895"/>
                  <a:gd name="connsiteY3" fmla="*/ 0 h 62900"/>
                  <a:gd name="connsiteX4" fmla="*/ 62896 w 62895"/>
                  <a:gd name="connsiteY4" fmla="*/ 31450 h 629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62895" h="62900">
                    <a:moveTo>
                      <a:pt x="62896" y="31450"/>
                    </a:moveTo>
                    <a:cubicBezTo>
                      <a:pt x="62896" y="48820"/>
                      <a:pt x="48816" y="62900"/>
                      <a:pt x="31448" y="62900"/>
                    </a:cubicBezTo>
                    <a:cubicBezTo>
                      <a:pt x="14080" y="62900"/>
                      <a:pt x="0" y="48820"/>
                      <a:pt x="0" y="31450"/>
                    </a:cubicBezTo>
                    <a:cubicBezTo>
                      <a:pt x="0" y="14081"/>
                      <a:pt x="14080" y="0"/>
                      <a:pt x="31448" y="0"/>
                    </a:cubicBezTo>
                    <a:cubicBezTo>
                      <a:pt x="48816" y="0"/>
                      <a:pt x="62896" y="14081"/>
                      <a:pt x="62896" y="31450"/>
                    </a:cubicBezTo>
                    <a:close/>
                  </a:path>
                </a:pathLst>
              </a:custGeom>
              <a:solidFill>
                <a:srgbClr val="FFFFFF"/>
              </a:solidFill>
              <a:ln w="5706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47" name="フリーフォーム: 図形 346">
                <a:extLst>
                  <a:ext uri="{FF2B5EF4-FFF2-40B4-BE49-F238E27FC236}">
                    <a16:creationId xmlns:a16="http://schemas.microsoft.com/office/drawing/2014/main" id="{C25907B4-EEB0-D4AB-D560-35F5593EBA8F}"/>
                  </a:ext>
                </a:extLst>
              </p:cNvPr>
              <p:cNvSpPr/>
              <p:nvPr/>
            </p:nvSpPr>
            <p:spPr>
              <a:xfrm>
                <a:off x="4179681" y="2058674"/>
                <a:ext cx="62895" cy="62900"/>
              </a:xfrm>
              <a:custGeom>
                <a:avLst/>
                <a:gdLst>
                  <a:gd name="connsiteX0" fmla="*/ 62896 w 62895"/>
                  <a:gd name="connsiteY0" fmla="*/ 31450 h 62900"/>
                  <a:gd name="connsiteX1" fmla="*/ 31448 w 62895"/>
                  <a:gd name="connsiteY1" fmla="*/ 62900 h 62900"/>
                  <a:gd name="connsiteX2" fmla="*/ 0 w 62895"/>
                  <a:gd name="connsiteY2" fmla="*/ 31450 h 62900"/>
                  <a:gd name="connsiteX3" fmla="*/ 31448 w 62895"/>
                  <a:gd name="connsiteY3" fmla="*/ 0 h 62900"/>
                  <a:gd name="connsiteX4" fmla="*/ 62896 w 62895"/>
                  <a:gd name="connsiteY4" fmla="*/ 31450 h 629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62895" h="62900">
                    <a:moveTo>
                      <a:pt x="62896" y="31450"/>
                    </a:moveTo>
                    <a:cubicBezTo>
                      <a:pt x="62896" y="48820"/>
                      <a:pt x="48816" y="62900"/>
                      <a:pt x="31448" y="62900"/>
                    </a:cubicBezTo>
                    <a:cubicBezTo>
                      <a:pt x="14080" y="62900"/>
                      <a:pt x="0" y="48820"/>
                      <a:pt x="0" y="31450"/>
                    </a:cubicBezTo>
                    <a:cubicBezTo>
                      <a:pt x="0" y="14081"/>
                      <a:pt x="14080" y="0"/>
                      <a:pt x="31448" y="0"/>
                    </a:cubicBezTo>
                    <a:cubicBezTo>
                      <a:pt x="48816" y="0"/>
                      <a:pt x="62896" y="14081"/>
                      <a:pt x="62896" y="31450"/>
                    </a:cubicBezTo>
                    <a:close/>
                  </a:path>
                </a:pathLst>
              </a:custGeom>
              <a:solidFill>
                <a:srgbClr val="FFFFFF"/>
              </a:solidFill>
              <a:ln w="5706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48" name="フリーフォーム: 図形 347">
                <a:extLst>
                  <a:ext uri="{FF2B5EF4-FFF2-40B4-BE49-F238E27FC236}">
                    <a16:creationId xmlns:a16="http://schemas.microsoft.com/office/drawing/2014/main" id="{B2F755BD-0CFC-8271-E234-3779E4B2952E}"/>
                  </a:ext>
                </a:extLst>
              </p:cNvPr>
              <p:cNvSpPr/>
              <p:nvPr/>
            </p:nvSpPr>
            <p:spPr>
              <a:xfrm>
                <a:off x="4256054" y="2058674"/>
                <a:ext cx="62895" cy="62900"/>
              </a:xfrm>
              <a:custGeom>
                <a:avLst/>
                <a:gdLst>
                  <a:gd name="connsiteX0" fmla="*/ 62896 w 62895"/>
                  <a:gd name="connsiteY0" fmla="*/ 31450 h 62900"/>
                  <a:gd name="connsiteX1" fmla="*/ 31448 w 62895"/>
                  <a:gd name="connsiteY1" fmla="*/ 62900 h 62900"/>
                  <a:gd name="connsiteX2" fmla="*/ 0 w 62895"/>
                  <a:gd name="connsiteY2" fmla="*/ 31450 h 62900"/>
                  <a:gd name="connsiteX3" fmla="*/ 31448 w 62895"/>
                  <a:gd name="connsiteY3" fmla="*/ 0 h 62900"/>
                  <a:gd name="connsiteX4" fmla="*/ 62896 w 62895"/>
                  <a:gd name="connsiteY4" fmla="*/ 31450 h 629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62895" h="62900">
                    <a:moveTo>
                      <a:pt x="62896" y="31450"/>
                    </a:moveTo>
                    <a:cubicBezTo>
                      <a:pt x="62896" y="48820"/>
                      <a:pt x="48816" y="62900"/>
                      <a:pt x="31448" y="62900"/>
                    </a:cubicBezTo>
                    <a:cubicBezTo>
                      <a:pt x="14080" y="62900"/>
                      <a:pt x="0" y="48820"/>
                      <a:pt x="0" y="31450"/>
                    </a:cubicBezTo>
                    <a:cubicBezTo>
                      <a:pt x="0" y="14081"/>
                      <a:pt x="14080" y="0"/>
                      <a:pt x="31448" y="0"/>
                    </a:cubicBezTo>
                    <a:cubicBezTo>
                      <a:pt x="48816" y="0"/>
                      <a:pt x="62896" y="14081"/>
                      <a:pt x="62896" y="31450"/>
                    </a:cubicBezTo>
                    <a:close/>
                  </a:path>
                </a:pathLst>
              </a:custGeom>
              <a:solidFill>
                <a:srgbClr val="FFFFFF"/>
              </a:solidFill>
              <a:ln w="5706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</p:grpSp>
      </p:grpSp>
      <p:cxnSp>
        <p:nvCxnSpPr>
          <p:cNvPr id="197" name="直線コネクタ 196">
            <a:extLst>
              <a:ext uri="{FF2B5EF4-FFF2-40B4-BE49-F238E27FC236}">
                <a16:creationId xmlns:a16="http://schemas.microsoft.com/office/drawing/2014/main" id="{42965DDC-217C-1944-D13F-42A6C8D23FAC}"/>
              </a:ext>
            </a:extLst>
          </p:cNvPr>
          <p:cNvCxnSpPr>
            <a:cxnSpLocks/>
          </p:cNvCxnSpPr>
          <p:nvPr/>
        </p:nvCxnSpPr>
        <p:spPr>
          <a:xfrm>
            <a:off x="979613" y="3708720"/>
            <a:ext cx="4636096" cy="0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96" name="グループ化 395">
            <a:extLst>
              <a:ext uri="{FF2B5EF4-FFF2-40B4-BE49-F238E27FC236}">
                <a16:creationId xmlns:a16="http://schemas.microsoft.com/office/drawing/2014/main" id="{5BAC7CB2-4C64-469A-CE73-BAE1EF6DC836}"/>
              </a:ext>
            </a:extLst>
          </p:cNvPr>
          <p:cNvGrpSpPr/>
          <p:nvPr/>
        </p:nvGrpSpPr>
        <p:grpSpPr>
          <a:xfrm>
            <a:off x="6189195" y="1506326"/>
            <a:ext cx="4993200" cy="3445200"/>
            <a:chOff x="1810988" y="253935"/>
            <a:chExt cx="8940139" cy="6183810"/>
          </a:xfrm>
        </p:grpSpPr>
        <p:grpSp>
          <p:nvGrpSpPr>
            <p:cNvPr id="397" name="グラフィックス 4">
              <a:extLst>
                <a:ext uri="{FF2B5EF4-FFF2-40B4-BE49-F238E27FC236}">
                  <a16:creationId xmlns:a16="http://schemas.microsoft.com/office/drawing/2014/main" id="{8E329469-CD47-A70D-46C0-8ABDC349A775}"/>
                </a:ext>
              </a:extLst>
            </p:cNvPr>
            <p:cNvGrpSpPr/>
            <p:nvPr/>
          </p:nvGrpSpPr>
          <p:grpSpPr>
            <a:xfrm>
              <a:off x="1810988" y="253935"/>
              <a:ext cx="8820067" cy="6183810"/>
              <a:chOff x="6124371" y="1510081"/>
              <a:chExt cx="4834561" cy="3457952"/>
            </a:xfrm>
          </p:grpSpPr>
          <p:grpSp>
            <p:nvGrpSpPr>
              <p:cNvPr id="399" name="グラフィックス 4">
                <a:extLst>
                  <a:ext uri="{FF2B5EF4-FFF2-40B4-BE49-F238E27FC236}">
                    <a16:creationId xmlns:a16="http://schemas.microsoft.com/office/drawing/2014/main" id="{F1065511-78DD-023F-ABE1-1F1F91B368D1}"/>
                  </a:ext>
                </a:extLst>
              </p:cNvPr>
              <p:cNvGrpSpPr/>
              <p:nvPr/>
            </p:nvGrpSpPr>
            <p:grpSpPr>
              <a:xfrm>
                <a:off x="6124371" y="1510081"/>
                <a:ext cx="377026" cy="3457952"/>
                <a:chOff x="6124371" y="1510081"/>
                <a:chExt cx="377026" cy="3457952"/>
              </a:xfrm>
              <a:solidFill>
                <a:srgbClr val="000000"/>
              </a:solidFill>
            </p:grpSpPr>
            <p:sp>
              <p:nvSpPr>
                <p:cNvPr id="488" name="テキスト ボックス 487">
                  <a:extLst>
                    <a:ext uri="{FF2B5EF4-FFF2-40B4-BE49-F238E27FC236}">
                      <a16:creationId xmlns:a16="http://schemas.microsoft.com/office/drawing/2014/main" id="{A2AB62B4-9A30-F639-BE08-0D39BDD46FB2}"/>
                    </a:ext>
                  </a:extLst>
                </p:cNvPr>
                <p:cNvSpPr txBox="1"/>
                <p:nvPr/>
              </p:nvSpPr>
              <p:spPr>
                <a:xfrm>
                  <a:off x="6124371" y="4691034"/>
                  <a:ext cx="37702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l"/>
                  <a:r>
                    <a:rPr lang="ja-JP" altLang="en-US" sz="1200" spc="0" baseline="0">
                      <a:ln/>
                      <a:solidFill>
                        <a:srgbClr val="000000"/>
                      </a:solidFill>
                      <a:latin typeface="Palatino Linotype" panose="02040502050505030304" pitchFamily="18" charset="0"/>
                      <a:cs typeface="Arial"/>
                      <a:sym typeface="Arial"/>
                      <a:rtl val="0"/>
                    </a:rPr>
                    <a:t>0.0</a:t>
                  </a:r>
                </a:p>
              </p:txBody>
            </p:sp>
            <p:sp>
              <p:nvSpPr>
                <p:cNvPr id="489" name="テキスト ボックス 488">
                  <a:extLst>
                    <a:ext uri="{FF2B5EF4-FFF2-40B4-BE49-F238E27FC236}">
                      <a16:creationId xmlns:a16="http://schemas.microsoft.com/office/drawing/2014/main" id="{EA96BC0C-26CC-9214-11B4-FB99C32BBAA9}"/>
                    </a:ext>
                  </a:extLst>
                </p:cNvPr>
                <p:cNvSpPr txBox="1"/>
                <p:nvPr/>
              </p:nvSpPr>
              <p:spPr>
                <a:xfrm>
                  <a:off x="6124371" y="4372040"/>
                  <a:ext cx="37702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l"/>
                  <a:r>
                    <a:rPr lang="ja-JP" altLang="en-US" sz="1200" spc="0" baseline="0">
                      <a:ln/>
                      <a:solidFill>
                        <a:srgbClr val="000000"/>
                      </a:solidFill>
                      <a:latin typeface="Palatino Linotype" panose="02040502050505030304" pitchFamily="18" charset="0"/>
                      <a:cs typeface="Arial"/>
                      <a:sym typeface="Arial"/>
                      <a:rtl val="0"/>
                    </a:rPr>
                    <a:t>0.1</a:t>
                  </a:r>
                </a:p>
              </p:txBody>
            </p:sp>
            <p:sp>
              <p:nvSpPr>
                <p:cNvPr id="490" name="テキスト ボックス 489">
                  <a:extLst>
                    <a:ext uri="{FF2B5EF4-FFF2-40B4-BE49-F238E27FC236}">
                      <a16:creationId xmlns:a16="http://schemas.microsoft.com/office/drawing/2014/main" id="{50F42675-0C78-E449-BF2D-E57A9554BE77}"/>
                    </a:ext>
                  </a:extLst>
                </p:cNvPr>
                <p:cNvSpPr txBox="1"/>
                <p:nvPr/>
              </p:nvSpPr>
              <p:spPr>
                <a:xfrm>
                  <a:off x="6124371" y="4053046"/>
                  <a:ext cx="37702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l"/>
                  <a:r>
                    <a:rPr lang="ja-JP" altLang="en-US" sz="1200" spc="0" baseline="0">
                      <a:ln/>
                      <a:solidFill>
                        <a:srgbClr val="000000"/>
                      </a:solidFill>
                      <a:latin typeface="Palatino Linotype" panose="02040502050505030304" pitchFamily="18" charset="0"/>
                      <a:cs typeface="Arial"/>
                      <a:sym typeface="Arial"/>
                      <a:rtl val="0"/>
                    </a:rPr>
                    <a:t>0.2</a:t>
                  </a:r>
                </a:p>
              </p:txBody>
            </p:sp>
            <p:sp>
              <p:nvSpPr>
                <p:cNvPr id="491" name="テキスト ボックス 490">
                  <a:extLst>
                    <a:ext uri="{FF2B5EF4-FFF2-40B4-BE49-F238E27FC236}">
                      <a16:creationId xmlns:a16="http://schemas.microsoft.com/office/drawing/2014/main" id="{10E7FD57-5C71-56BD-3E85-BB88D35A1226}"/>
                    </a:ext>
                  </a:extLst>
                </p:cNvPr>
                <p:cNvSpPr txBox="1"/>
                <p:nvPr/>
              </p:nvSpPr>
              <p:spPr>
                <a:xfrm>
                  <a:off x="6124371" y="3738545"/>
                  <a:ext cx="37702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l"/>
                  <a:r>
                    <a:rPr lang="ja-JP" altLang="en-US" sz="1200" spc="0" baseline="0">
                      <a:ln/>
                      <a:solidFill>
                        <a:srgbClr val="000000"/>
                      </a:solidFill>
                      <a:latin typeface="Palatino Linotype" panose="02040502050505030304" pitchFamily="18" charset="0"/>
                      <a:cs typeface="Arial"/>
                      <a:sym typeface="Arial"/>
                      <a:rtl val="0"/>
                    </a:rPr>
                    <a:t>0.3</a:t>
                  </a:r>
                </a:p>
              </p:txBody>
            </p:sp>
            <p:sp>
              <p:nvSpPr>
                <p:cNvPr id="492" name="テキスト ボックス 491">
                  <a:extLst>
                    <a:ext uri="{FF2B5EF4-FFF2-40B4-BE49-F238E27FC236}">
                      <a16:creationId xmlns:a16="http://schemas.microsoft.com/office/drawing/2014/main" id="{384C6D85-E866-9BEB-1A32-9C3556865B28}"/>
                    </a:ext>
                  </a:extLst>
                </p:cNvPr>
                <p:cNvSpPr txBox="1"/>
                <p:nvPr/>
              </p:nvSpPr>
              <p:spPr>
                <a:xfrm>
                  <a:off x="6124371" y="3419552"/>
                  <a:ext cx="37702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l"/>
                  <a:r>
                    <a:rPr lang="ja-JP" altLang="en-US" sz="1200" spc="0" baseline="0">
                      <a:ln/>
                      <a:solidFill>
                        <a:srgbClr val="000000"/>
                      </a:solidFill>
                      <a:latin typeface="Palatino Linotype" panose="02040502050505030304" pitchFamily="18" charset="0"/>
                      <a:cs typeface="Arial"/>
                      <a:sym typeface="Arial"/>
                      <a:rtl val="0"/>
                    </a:rPr>
                    <a:t>0.4</a:t>
                  </a:r>
                </a:p>
              </p:txBody>
            </p:sp>
            <p:sp>
              <p:nvSpPr>
                <p:cNvPr id="493" name="テキスト ボックス 492">
                  <a:extLst>
                    <a:ext uri="{FF2B5EF4-FFF2-40B4-BE49-F238E27FC236}">
                      <a16:creationId xmlns:a16="http://schemas.microsoft.com/office/drawing/2014/main" id="{61B11284-9A4E-05B4-3ABD-D64264E3BE05}"/>
                    </a:ext>
                  </a:extLst>
                </p:cNvPr>
                <p:cNvSpPr txBox="1"/>
                <p:nvPr/>
              </p:nvSpPr>
              <p:spPr>
                <a:xfrm>
                  <a:off x="6124371" y="3100558"/>
                  <a:ext cx="37702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l"/>
                  <a:r>
                    <a:rPr lang="ja-JP" altLang="en-US" sz="1200" spc="0" baseline="0">
                      <a:ln/>
                      <a:solidFill>
                        <a:srgbClr val="000000"/>
                      </a:solidFill>
                      <a:latin typeface="Palatino Linotype" panose="02040502050505030304" pitchFamily="18" charset="0"/>
                      <a:cs typeface="Arial"/>
                      <a:sym typeface="Arial"/>
                      <a:rtl val="0"/>
                    </a:rPr>
                    <a:t>0.5</a:t>
                  </a:r>
                </a:p>
              </p:txBody>
            </p:sp>
            <p:sp>
              <p:nvSpPr>
                <p:cNvPr id="494" name="テキスト ボックス 493">
                  <a:extLst>
                    <a:ext uri="{FF2B5EF4-FFF2-40B4-BE49-F238E27FC236}">
                      <a16:creationId xmlns:a16="http://schemas.microsoft.com/office/drawing/2014/main" id="{37050FD2-9CB0-5669-ABA5-6B22B2F2759C}"/>
                    </a:ext>
                  </a:extLst>
                </p:cNvPr>
                <p:cNvSpPr txBox="1"/>
                <p:nvPr/>
              </p:nvSpPr>
              <p:spPr>
                <a:xfrm>
                  <a:off x="6124371" y="2781564"/>
                  <a:ext cx="37702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l"/>
                  <a:r>
                    <a:rPr lang="ja-JP" altLang="en-US" sz="1200" spc="0" baseline="0">
                      <a:ln/>
                      <a:solidFill>
                        <a:srgbClr val="000000"/>
                      </a:solidFill>
                      <a:latin typeface="Palatino Linotype" panose="02040502050505030304" pitchFamily="18" charset="0"/>
                      <a:cs typeface="Arial"/>
                      <a:sym typeface="Arial"/>
                      <a:rtl val="0"/>
                    </a:rPr>
                    <a:t>0.6</a:t>
                  </a:r>
                </a:p>
              </p:txBody>
            </p:sp>
            <p:sp>
              <p:nvSpPr>
                <p:cNvPr id="495" name="テキスト ボックス 494">
                  <a:extLst>
                    <a:ext uri="{FF2B5EF4-FFF2-40B4-BE49-F238E27FC236}">
                      <a16:creationId xmlns:a16="http://schemas.microsoft.com/office/drawing/2014/main" id="{4F8EE85A-6420-0C72-F1C9-4A6002FC7ABC}"/>
                    </a:ext>
                  </a:extLst>
                </p:cNvPr>
                <p:cNvSpPr txBox="1"/>
                <p:nvPr/>
              </p:nvSpPr>
              <p:spPr>
                <a:xfrm>
                  <a:off x="6124371" y="2462570"/>
                  <a:ext cx="37702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l"/>
                  <a:r>
                    <a:rPr lang="ja-JP" altLang="en-US" sz="1200" spc="0" baseline="0">
                      <a:ln/>
                      <a:solidFill>
                        <a:srgbClr val="000000"/>
                      </a:solidFill>
                      <a:latin typeface="Palatino Linotype" panose="02040502050505030304" pitchFamily="18" charset="0"/>
                      <a:cs typeface="Arial"/>
                      <a:sym typeface="Arial"/>
                      <a:rtl val="0"/>
                    </a:rPr>
                    <a:t>0.7</a:t>
                  </a:r>
                </a:p>
              </p:txBody>
            </p:sp>
            <p:sp>
              <p:nvSpPr>
                <p:cNvPr id="496" name="テキスト ボックス 495">
                  <a:extLst>
                    <a:ext uri="{FF2B5EF4-FFF2-40B4-BE49-F238E27FC236}">
                      <a16:creationId xmlns:a16="http://schemas.microsoft.com/office/drawing/2014/main" id="{85E65417-FE6E-DC10-DC8F-8C77214EF97B}"/>
                    </a:ext>
                  </a:extLst>
                </p:cNvPr>
                <p:cNvSpPr txBox="1"/>
                <p:nvPr/>
              </p:nvSpPr>
              <p:spPr>
                <a:xfrm>
                  <a:off x="6124371" y="2148069"/>
                  <a:ext cx="37702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l"/>
                  <a:r>
                    <a:rPr lang="ja-JP" altLang="en-US" sz="1200" spc="0" baseline="0">
                      <a:ln/>
                      <a:solidFill>
                        <a:srgbClr val="000000"/>
                      </a:solidFill>
                      <a:latin typeface="Palatino Linotype" panose="02040502050505030304" pitchFamily="18" charset="0"/>
                      <a:cs typeface="Arial"/>
                      <a:sym typeface="Arial"/>
                      <a:rtl val="0"/>
                    </a:rPr>
                    <a:t>0.8</a:t>
                  </a:r>
                </a:p>
              </p:txBody>
            </p:sp>
            <p:sp>
              <p:nvSpPr>
                <p:cNvPr id="497" name="テキスト ボックス 496">
                  <a:extLst>
                    <a:ext uri="{FF2B5EF4-FFF2-40B4-BE49-F238E27FC236}">
                      <a16:creationId xmlns:a16="http://schemas.microsoft.com/office/drawing/2014/main" id="{A1E9C67E-5B5D-43B5-2B58-BBF908F26FC0}"/>
                    </a:ext>
                  </a:extLst>
                </p:cNvPr>
                <p:cNvSpPr txBox="1"/>
                <p:nvPr/>
              </p:nvSpPr>
              <p:spPr>
                <a:xfrm>
                  <a:off x="6124371" y="1829075"/>
                  <a:ext cx="37702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l"/>
                  <a:r>
                    <a:rPr lang="ja-JP" altLang="en-US" sz="1200" spc="0" baseline="0">
                      <a:ln/>
                      <a:solidFill>
                        <a:srgbClr val="000000"/>
                      </a:solidFill>
                      <a:latin typeface="Palatino Linotype" panose="02040502050505030304" pitchFamily="18" charset="0"/>
                      <a:cs typeface="Arial"/>
                      <a:sym typeface="Arial"/>
                      <a:rtl val="0"/>
                    </a:rPr>
                    <a:t>0.9</a:t>
                  </a:r>
                </a:p>
              </p:txBody>
            </p:sp>
            <p:sp>
              <p:nvSpPr>
                <p:cNvPr id="498" name="テキスト ボックス 497">
                  <a:extLst>
                    <a:ext uri="{FF2B5EF4-FFF2-40B4-BE49-F238E27FC236}">
                      <a16:creationId xmlns:a16="http://schemas.microsoft.com/office/drawing/2014/main" id="{D283CBD5-0482-F61F-5C5F-8E9188A95C2A}"/>
                    </a:ext>
                  </a:extLst>
                </p:cNvPr>
                <p:cNvSpPr txBox="1"/>
                <p:nvPr/>
              </p:nvSpPr>
              <p:spPr>
                <a:xfrm>
                  <a:off x="6124371" y="1510081"/>
                  <a:ext cx="37702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l"/>
                  <a:r>
                    <a:rPr lang="ja-JP" altLang="en-US" sz="1200" spc="0" baseline="0">
                      <a:ln/>
                      <a:solidFill>
                        <a:srgbClr val="000000"/>
                      </a:solidFill>
                      <a:latin typeface="Palatino Linotype" panose="02040502050505030304" pitchFamily="18" charset="0"/>
                      <a:cs typeface="Arial"/>
                      <a:sym typeface="Arial"/>
                      <a:rtl val="0"/>
                    </a:rPr>
                    <a:t>1.0</a:t>
                  </a:r>
                </a:p>
              </p:txBody>
            </p:sp>
          </p:grpSp>
          <p:grpSp>
            <p:nvGrpSpPr>
              <p:cNvPr id="400" name="グラフィックス 4">
                <a:extLst>
                  <a:ext uri="{FF2B5EF4-FFF2-40B4-BE49-F238E27FC236}">
                    <a16:creationId xmlns:a16="http://schemas.microsoft.com/office/drawing/2014/main" id="{028C0A45-613F-5DD6-ECC7-351582CCE643}"/>
                  </a:ext>
                </a:extLst>
              </p:cNvPr>
              <p:cNvGrpSpPr/>
              <p:nvPr/>
            </p:nvGrpSpPr>
            <p:grpSpPr>
              <a:xfrm>
                <a:off x="6628118" y="1663301"/>
                <a:ext cx="4317336" cy="3180952"/>
                <a:chOff x="6628118" y="1663301"/>
                <a:chExt cx="4317336" cy="3180952"/>
              </a:xfrm>
              <a:noFill/>
            </p:grpSpPr>
            <p:sp>
              <p:nvSpPr>
                <p:cNvPr id="477" name="フリーフォーム: 図形 476">
                  <a:extLst>
                    <a:ext uri="{FF2B5EF4-FFF2-40B4-BE49-F238E27FC236}">
                      <a16:creationId xmlns:a16="http://schemas.microsoft.com/office/drawing/2014/main" id="{81EFAD7F-28DC-D700-FE2A-724DF2908734}"/>
                    </a:ext>
                  </a:extLst>
                </p:cNvPr>
                <p:cNvSpPr/>
                <p:nvPr/>
              </p:nvSpPr>
              <p:spPr>
                <a:xfrm>
                  <a:off x="6628118" y="1663301"/>
                  <a:ext cx="4317336" cy="4492"/>
                </a:xfrm>
                <a:custGeom>
                  <a:avLst/>
                  <a:gdLst>
                    <a:gd name="connsiteX0" fmla="*/ 0 w 4317336"/>
                    <a:gd name="connsiteY0" fmla="*/ 0 h 4492"/>
                    <a:gd name="connsiteX1" fmla="*/ 4317337 w 4317336"/>
                    <a:gd name="connsiteY1" fmla="*/ 0 h 4492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4317336" h="4492">
                      <a:moveTo>
                        <a:pt x="0" y="0"/>
                      </a:moveTo>
                      <a:lnTo>
                        <a:pt x="4317337" y="0"/>
                      </a:lnTo>
                    </a:path>
                  </a:pathLst>
                </a:custGeom>
                <a:noFill/>
                <a:ln w="4485" cap="flat">
                  <a:solidFill>
                    <a:srgbClr val="A0A0A0"/>
                  </a:solidFill>
                  <a:custDash>
                    <a:ds d="75000" sp="75000"/>
                  </a:custDash>
                  <a:miter/>
                </a:ln>
              </p:spPr>
              <p:txBody>
                <a:bodyPr rtlCol="0" anchor="ctr"/>
                <a:lstStyle/>
                <a:p>
                  <a:endParaRPr lang="ja-JP" altLang="en-US" sz="1200"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478" name="フリーフォーム: 図形 477">
                  <a:extLst>
                    <a:ext uri="{FF2B5EF4-FFF2-40B4-BE49-F238E27FC236}">
                      <a16:creationId xmlns:a16="http://schemas.microsoft.com/office/drawing/2014/main" id="{1A812496-B64B-373B-937D-DA6D519CF1BB}"/>
                    </a:ext>
                  </a:extLst>
                </p:cNvPr>
                <p:cNvSpPr/>
                <p:nvPr/>
              </p:nvSpPr>
              <p:spPr>
                <a:xfrm>
                  <a:off x="6628118" y="1982295"/>
                  <a:ext cx="4317336" cy="4492"/>
                </a:xfrm>
                <a:custGeom>
                  <a:avLst/>
                  <a:gdLst>
                    <a:gd name="connsiteX0" fmla="*/ 0 w 4317336"/>
                    <a:gd name="connsiteY0" fmla="*/ 0 h 4492"/>
                    <a:gd name="connsiteX1" fmla="*/ 4317337 w 4317336"/>
                    <a:gd name="connsiteY1" fmla="*/ 0 h 4492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4317336" h="4492">
                      <a:moveTo>
                        <a:pt x="0" y="0"/>
                      </a:moveTo>
                      <a:lnTo>
                        <a:pt x="4317337" y="0"/>
                      </a:lnTo>
                    </a:path>
                  </a:pathLst>
                </a:custGeom>
                <a:noFill/>
                <a:ln w="4485" cap="flat">
                  <a:solidFill>
                    <a:srgbClr val="A0A0A0"/>
                  </a:solidFill>
                  <a:custDash>
                    <a:ds d="75000" sp="75000"/>
                  </a:custDash>
                  <a:miter/>
                </a:ln>
              </p:spPr>
              <p:txBody>
                <a:bodyPr rtlCol="0" anchor="ctr"/>
                <a:lstStyle/>
                <a:p>
                  <a:endParaRPr lang="ja-JP" altLang="en-US" sz="1200"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479" name="フリーフォーム: 図形 478">
                  <a:extLst>
                    <a:ext uri="{FF2B5EF4-FFF2-40B4-BE49-F238E27FC236}">
                      <a16:creationId xmlns:a16="http://schemas.microsoft.com/office/drawing/2014/main" id="{0AC92ADC-C892-C69D-500D-78AFC970882A}"/>
                    </a:ext>
                  </a:extLst>
                </p:cNvPr>
                <p:cNvSpPr/>
                <p:nvPr/>
              </p:nvSpPr>
              <p:spPr>
                <a:xfrm>
                  <a:off x="6628118" y="2301289"/>
                  <a:ext cx="4317336" cy="4492"/>
                </a:xfrm>
                <a:custGeom>
                  <a:avLst/>
                  <a:gdLst>
                    <a:gd name="connsiteX0" fmla="*/ 0 w 4317336"/>
                    <a:gd name="connsiteY0" fmla="*/ 0 h 4492"/>
                    <a:gd name="connsiteX1" fmla="*/ 4317337 w 4317336"/>
                    <a:gd name="connsiteY1" fmla="*/ 0 h 4492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4317336" h="4492">
                      <a:moveTo>
                        <a:pt x="0" y="0"/>
                      </a:moveTo>
                      <a:lnTo>
                        <a:pt x="4317337" y="0"/>
                      </a:lnTo>
                    </a:path>
                  </a:pathLst>
                </a:custGeom>
                <a:noFill/>
                <a:ln w="4485" cap="flat">
                  <a:solidFill>
                    <a:srgbClr val="A0A0A0"/>
                  </a:solidFill>
                  <a:custDash>
                    <a:ds d="75000" sp="75000"/>
                  </a:custDash>
                  <a:miter/>
                </a:ln>
              </p:spPr>
              <p:txBody>
                <a:bodyPr rtlCol="0" anchor="ctr"/>
                <a:lstStyle/>
                <a:p>
                  <a:endParaRPr lang="ja-JP" altLang="en-US" sz="1200"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480" name="フリーフォーム: 図形 479">
                  <a:extLst>
                    <a:ext uri="{FF2B5EF4-FFF2-40B4-BE49-F238E27FC236}">
                      <a16:creationId xmlns:a16="http://schemas.microsoft.com/office/drawing/2014/main" id="{61F55BB8-DD45-2DE6-DC1D-95D03EDA5A64}"/>
                    </a:ext>
                  </a:extLst>
                </p:cNvPr>
                <p:cNvSpPr/>
                <p:nvPr/>
              </p:nvSpPr>
              <p:spPr>
                <a:xfrm>
                  <a:off x="6628118" y="2615790"/>
                  <a:ext cx="4317336" cy="4492"/>
                </a:xfrm>
                <a:custGeom>
                  <a:avLst/>
                  <a:gdLst>
                    <a:gd name="connsiteX0" fmla="*/ 0 w 4317336"/>
                    <a:gd name="connsiteY0" fmla="*/ 0 h 4492"/>
                    <a:gd name="connsiteX1" fmla="*/ 4317337 w 4317336"/>
                    <a:gd name="connsiteY1" fmla="*/ 0 h 4492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4317336" h="4492">
                      <a:moveTo>
                        <a:pt x="0" y="0"/>
                      </a:moveTo>
                      <a:lnTo>
                        <a:pt x="4317337" y="0"/>
                      </a:lnTo>
                    </a:path>
                  </a:pathLst>
                </a:custGeom>
                <a:noFill/>
                <a:ln w="4485" cap="flat">
                  <a:solidFill>
                    <a:srgbClr val="A0A0A0"/>
                  </a:solidFill>
                  <a:custDash>
                    <a:ds d="75000" sp="75000"/>
                  </a:custDash>
                  <a:miter/>
                </a:ln>
              </p:spPr>
              <p:txBody>
                <a:bodyPr rtlCol="0" anchor="ctr"/>
                <a:lstStyle/>
                <a:p>
                  <a:endParaRPr lang="ja-JP" altLang="en-US" sz="1200"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481" name="フリーフォーム: 図形 480">
                  <a:extLst>
                    <a:ext uri="{FF2B5EF4-FFF2-40B4-BE49-F238E27FC236}">
                      <a16:creationId xmlns:a16="http://schemas.microsoft.com/office/drawing/2014/main" id="{A8B986A8-7EFF-666A-281E-486815A3AB08}"/>
                    </a:ext>
                  </a:extLst>
                </p:cNvPr>
                <p:cNvSpPr/>
                <p:nvPr/>
              </p:nvSpPr>
              <p:spPr>
                <a:xfrm>
                  <a:off x="6628118" y="2934784"/>
                  <a:ext cx="4317336" cy="4492"/>
                </a:xfrm>
                <a:custGeom>
                  <a:avLst/>
                  <a:gdLst>
                    <a:gd name="connsiteX0" fmla="*/ 0 w 4317336"/>
                    <a:gd name="connsiteY0" fmla="*/ 0 h 4492"/>
                    <a:gd name="connsiteX1" fmla="*/ 4317337 w 4317336"/>
                    <a:gd name="connsiteY1" fmla="*/ 0 h 4492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4317336" h="4492">
                      <a:moveTo>
                        <a:pt x="0" y="0"/>
                      </a:moveTo>
                      <a:lnTo>
                        <a:pt x="4317337" y="0"/>
                      </a:lnTo>
                    </a:path>
                  </a:pathLst>
                </a:custGeom>
                <a:noFill/>
                <a:ln w="4485" cap="flat">
                  <a:solidFill>
                    <a:srgbClr val="A0A0A0"/>
                  </a:solidFill>
                  <a:custDash>
                    <a:ds d="75000" sp="75000"/>
                  </a:custDash>
                  <a:miter/>
                </a:ln>
              </p:spPr>
              <p:txBody>
                <a:bodyPr rtlCol="0" anchor="ctr"/>
                <a:lstStyle/>
                <a:p>
                  <a:endParaRPr lang="ja-JP" altLang="en-US" sz="1200"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482" name="フリーフォーム: 図形 481">
                  <a:extLst>
                    <a:ext uri="{FF2B5EF4-FFF2-40B4-BE49-F238E27FC236}">
                      <a16:creationId xmlns:a16="http://schemas.microsoft.com/office/drawing/2014/main" id="{769FF7A9-A0FD-1486-1192-412A2F34E9E4}"/>
                    </a:ext>
                  </a:extLst>
                </p:cNvPr>
                <p:cNvSpPr/>
                <p:nvPr/>
              </p:nvSpPr>
              <p:spPr>
                <a:xfrm>
                  <a:off x="6628118" y="3253778"/>
                  <a:ext cx="4317336" cy="4492"/>
                </a:xfrm>
                <a:custGeom>
                  <a:avLst/>
                  <a:gdLst>
                    <a:gd name="connsiteX0" fmla="*/ 0 w 4317336"/>
                    <a:gd name="connsiteY0" fmla="*/ 0 h 4492"/>
                    <a:gd name="connsiteX1" fmla="*/ 4317337 w 4317336"/>
                    <a:gd name="connsiteY1" fmla="*/ 0 h 4492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4317336" h="4492">
                      <a:moveTo>
                        <a:pt x="0" y="0"/>
                      </a:moveTo>
                      <a:lnTo>
                        <a:pt x="4317337" y="0"/>
                      </a:lnTo>
                    </a:path>
                  </a:pathLst>
                </a:custGeom>
                <a:noFill/>
                <a:ln w="4485" cap="flat">
                  <a:solidFill>
                    <a:srgbClr val="A0A0A0"/>
                  </a:solidFill>
                  <a:custDash>
                    <a:ds d="75000" sp="75000"/>
                  </a:custDash>
                  <a:miter/>
                </a:ln>
              </p:spPr>
              <p:txBody>
                <a:bodyPr rtlCol="0" anchor="ctr"/>
                <a:lstStyle/>
                <a:p>
                  <a:endParaRPr lang="ja-JP" altLang="en-US" sz="1200"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483" name="フリーフォーム: 図形 482">
                  <a:extLst>
                    <a:ext uri="{FF2B5EF4-FFF2-40B4-BE49-F238E27FC236}">
                      <a16:creationId xmlns:a16="http://schemas.microsoft.com/office/drawing/2014/main" id="{14FB5FD8-DDED-664D-7629-CF75FADF49E1}"/>
                    </a:ext>
                  </a:extLst>
                </p:cNvPr>
                <p:cNvSpPr/>
                <p:nvPr/>
              </p:nvSpPr>
              <p:spPr>
                <a:xfrm>
                  <a:off x="6628118" y="3572771"/>
                  <a:ext cx="4317336" cy="4492"/>
                </a:xfrm>
                <a:custGeom>
                  <a:avLst/>
                  <a:gdLst>
                    <a:gd name="connsiteX0" fmla="*/ 0 w 4317336"/>
                    <a:gd name="connsiteY0" fmla="*/ 0 h 4492"/>
                    <a:gd name="connsiteX1" fmla="*/ 4317337 w 4317336"/>
                    <a:gd name="connsiteY1" fmla="*/ 0 h 4492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4317336" h="4492">
                      <a:moveTo>
                        <a:pt x="0" y="0"/>
                      </a:moveTo>
                      <a:lnTo>
                        <a:pt x="4317337" y="0"/>
                      </a:lnTo>
                    </a:path>
                  </a:pathLst>
                </a:custGeom>
                <a:noFill/>
                <a:ln w="4485" cap="flat">
                  <a:solidFill>
                    <a:srgbClr val="A0A0A0"/>
                  </a:solidFill>
                  <a:custDash>
                    <a:ds d="75000" sp="75000"/>
                  </a:custDash>
                  <a:miter/>
                </a:ln>
              </p:spPr>
              <p:txBody>
                <a:bodyPr rtlCol="0" anchor="ctr"/>
                <a:lstStyle/>
                <a:p>
                  <a:endParaRPr lang="ja-JP" altLang="en-US" sz="1200"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484" name="フリーフォーム: 図形 483">
                  <a:extLst>
                    <a:ext uri="{FF2B5EF4-FFF2-40B4-BE49-F238E27FC236}">
                      <a16:creationId xmlns:a16="http://schemas.microsoft.com/office/drawing/2014/main" id="{B730AE87-4C28-97D3-FAF0-AC6A9553686D}"/>
                    </a:ext>
                  </a:extLst>
                </p:cNvPr>
                <p:cNvSpPr/>
                <p:nvPr/>
              </p:nvSpPr>
              <p:spPr>
                <a:xfrm>
                  <a:off x="6628118" y="3891765"/>
                  <a:ext cx="4317336" cy="4492"/>
                </a:xfrm>
                <a:custGeom>
                  <a:avLst/>
                  <a:gdLst>
                    <a:gd name="connsiteX0" fmla="*/ 0 w 4317336"/>
                    <a:gd name="connsiteY0" fmla="*/ 0 h 4492"/>
                    <a:gd name="connsiteX1" fmla="*/ 4317337 w 4317336"/>
                    <a:gd name="connsiteY1" fmla="*/ 0 h 4492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4317336" h="4492">
                      <a:moveTo>
                        <a:pt x="0" y="0"/>
                      </a:moveTo>
                      <a:lnTo>
                        <a:pt x="4317337" y="0"/>
                      </a:lnTo>
                    </a:path>
                  </a:pathLst>
                </a:custGeom>
                <a:noFill/>
                <a:ln w="4485" cap="flat">
                  <a:solidFill>
                    <a:srgbClr val="A0A0A0"/>
                  </a:solidFill>
                  <a:custDash>
                    <a:ds d="75000" sp="75000"/>
                  </a:custDash>
                  <a:miter/>
                </a:ln>
              </p:spPr>
              <p:txBody>
                <a:bodyPr rtlCol="0" anchor="ctr"/>
                <a:lstStyle/>
                <a:p>
                  <a:endParaRPr lang="ja-JP" altLang="en-US" sz="1200"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485" name="フリーフォーム: 図形 484">
                  <a:extLst>
                    <a:ext uri="{FF2B5EF4-FFF2-40B4-BE49-F238E27FC236}">
                      <a16:creationId xmlns:a16="http://schemas.microsoft.com/office/drawing/2014/main" id="{80148A62-47F3-6534-F699-AE1405457082}"/>
                    </a:ext>
                  </a:extLst>
                </p:cNvPr>
                <p:cNvSpPr/>
                <p:nvPr/>
              </p:nvSpPr>
              <p:spPr>
                <a:xfrm>
                  <a:off x="6628118" y="4206266"/>
                  <a:ext cx="4317336" cy="4492"/>
                </a:xfrm>
                <a:custGeom>
                  <a:avLst/>
                  <a:gdLst>
                    <a:gd name="connsiteX0" fmla="*/ 0 w 4317336"/>
                    <a:gd name="connsiteY0" fmla="*/ 0 h 4492"/>
                    <a:gd name="connsiteX1" fmla="*/ 4317337 w 4317336"/>
                    <a:gd name="connsiteY1" fmla="*/ 0 h 4492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4317336" h="4492">
                      <a:moveTo>
                        <a:pt x="0" y="0"/>
                      </a:moveTo>
                      <a:lnTo>
                        <a:pt x="4317337" y="0"/>
                      </a:lnTo>
                    </a:path>
                  </a:pathLst>
                </a:custGeom>
                <a:noFill/>
                <a:ln w="4485" cap="flat">
                  <a:solidFill>
                    <a:srgbClr val="A0A0A0"/>
                  </a:solidFill>
                  <a:custDash>
                    <a:ds d="75000" sp="75000"/>
                  </a:custDash>
                  <a:miter/>
                </a:ln>
              </p:spPr>
              <p:txBody>
                <a:bodyPr rtlCol="0" anchor="ctr"/>
                <a:lstStyle/>
                <a:p>
                  <a:endParaRPr lang="ja-JP" altLang="en-US" sz="1200"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486" name="フリーフォーム: 図形 485">
                  <a:extLst>
                    <a:ext uri="{FF2B5EF4-FFF2-40B4-BE49-F238E27FC236}">
                      <a16:creationId xmlns:a16="http://schemas.microsoft.com/office/drawing/2014/main" id="{5B117D6C-2AE0-8EC4-00F6-DEDEA5F6B50B}"/>
                    </a:ext>
                  </a:extLst>
                </p:cNvPr>
                <p:cNvSpPr/>
                <p:nvPr/>
              </p:nvSpPr>
              <p:spPr>
                <a:xfrm>
                  <a:off x="6628118" y="4525260"/>
                  <a:ext cx="4317336" cy="4492"/>
                </a:xfrm>
                <a:custGeom>
                  <a:avLst/>
                  <a:gdLst>
                    <a:gd name="connsiteX0" fmla="*/ 0 w 4317336"/>
                    <a:gd name="connsiteY0" fmla="*/ 0 h 4492"/>
                    <a:gd name="connsiteX1" fmla="*/ 4317337 w 4317336"/>
                    <a:gd name="connsiteY1" fmla="*/ 0 h 4492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4317336" h="4492">
                      <a:moveTo>
                        <a:pt x="0" y="0"/>
                      </a:moveTo>
                      <a:lnTo>
                        <a:pt x="4317337" y="0"/>
                      </a:lnTo>
                    </a:path>
                  </a:pathLst>
                </a:custGeom>
                <a:noFill/>
                <a:ln w="4485" cap="flat">
                  <a:solidFill>
                    <a:srgbClr val="A0A0A0"/>
                  </a:solidFill>
                  <a:custDash>
                    <a:ds d="75000" sp="75000"/>
                  </a:custDash>
                  <a:miter/>
                </a:ln>
              </p:spPr>
              <p:txBody>
                <a:bodyPr rtlCol="0" anchor="ctr"/>
                <a:lstStyle/>
                <a:p>
                  <a:endParaRPr lang="ja-JP" altLang="en-US" sz="1200"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487" name="フリーフォーム: 図形 486">
                  <a:extLst>
                    <a:ext uri="{FF2B5EF4-FFF2-40B4-BE49-F238E27FC236}">
                      <a16:creationId xmlns:a16="http://schemas.microsoft.com/office/drawing/2014/main" id="{0E51D8E4-8881-BFD9-78EE-9E8B0105FBA4}"/>
                    </a:ext>
                  </a:extLst>
                </p:cNvPr>
                <p:cNvSpPr/>
                <p:nvPr/>
              </p:nvSpPr>
              <p:spPr>
                <a:xfrm>
                  <a:off x="6628118" y="4844254"/>
                  <a:ext cx="4317336" cy="4492"/>
                </a:xfrm>
                <a:custGeom>
                  <a:avLst/>
                  <a:gdLst>
                    <a:gd name="connsiteX0" fmla="*/ 0 w 4317336"/>
                    <a:gd name="connsiteY0" fmla="*/ 0 h 4492"/>
                    <a:gd name="connsiteX1" fmla="*/ 4317337 w 4317336"/>
                    <a:gd name="connsiteY1" fmla="*/ 0 h 4492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4317336" h="4492">
                      <a:moveTo>
                        <a:pt x="0" y="0"/>
                      </a:moveTo>
                      <a:lnTo>
                        <a:pt x="4317337" y="0"/>
                      </a:lnTo>
                    </a:path>
                  </a:pathLst>
                </a:custGeom>
                <a:noFill/>
                <a:ln w="4485" cap="flat">
                  <a:solidFill>
                    <a:srgbClr val="A0A0A0"/>
                  </a:solidFill>
                  <a:custDash>
                    <a:ds d="75000" sp="75000"/>
                  </a:custDash>
                  <a:miter/>
                </a:ln>
              </p:spPr>
              <p:txBody>
                <a:bodyPr rtlCol="0" anchor="ctr"/>
                <a:lstStyle/>
                <a:p>
                  <a:endParaRPr lang="ja-JP" altLang="en-US" sz="1200">
                    <a:latin typeface="Palatino Linotype" panose="02040502050505030304" pitchFamily="18" charset="0"/>
                  </a:endParaRPr>
                </a:p>
              </p:txBody>
            </p:sp>
          </p:grpSp>
          <p:grpSp>
            <p:nvGrpSpPr>
              <p:cNvPr id="401" name="グラフィックス 4">
                <a:extLst>
                  <a:ext uri="{FF2B5EF4-FFF2-40B4-BE49-F238E27FC236}">
                    <a16:creationId xmlns:a16="http://schemas.microsoft.com/office/drawing/2014/main" id="{1A104A56-E862-3867-7C8A-5FEF83B85BC4}"/>
                  </a:ext>
                </a:extLst>
              </p:cNvPr>
              <p:cNvGrpSpPr/>
              <p:nvPr/>
            </p:nvGrpSpPr>
            <p:grpSpPr>
              <a:xfrm>
                <a:off x="6533775" y="1663301"/>
                <a:ext cx="94343" cy="3180952"/>
                <a:chOff x="6533775" y="1663301"/>
                <a:chExt cx="94343" cy="3180952"/>
              </a:xfrm>
              <a:noFill/>
            </p:grpSpPr>
            <p:sp>
              <p:nvSpPr>
                <p:cNvPr id="466" name="フリーフォーム: 図形 465">
                  <a:extLst>
                    <a:ext uri="{FF2B5EF4-FFF2-40B4-BE49-F238E27FC236}">
                      <a16:creationId xmlns:a16="http://schemas.microsoft.com/office/drawing/2014/main" id="{780E79E6-28EC-A3E1-56CD-B5F0C4C47C52}"/>
                    </a:ext>
                  </a:extLst>
                </p:cNvPr>
                <p:cNvSpPr/>
                <p:nvPr/>
              </p:nvSpPr>
              <p:spPr>
                <a:xfrm>
                  <a:off x="6533775" y="1663301"/>
                  <a:ext cx="94343" cy="4492"/>
                </a:xfrm>
                <a:custGeom>
                  <a:avLst/>
                  <a:gdLst>
                    <a:gd name="connsiteX0" fmla="*/ 0 w 94343"/>
                    <a:gd name="connsiteY0" fmla="*/ 0 h 4492"/>
                    <a:gd name="connsiteX1" fmla="*/ 94343 w 94343"/>
                    <a:gd name="connsiteY1" fmla="*/ 0 h 4492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94343" h="4492">
                      <a:moveTo>
                        <a:pt x="0" y="0"/>
                      </a:moveTo>
                      <a:lnTo>
                        <a:pt x="94343" y="0"/>
                      </a:lnTo>
                    </a:path>
                  </a:pathLst>
                </a:custGeom>
                <a:noFill/>
                <a:ln w="12227" cap="flat">
                  <a:solidFill>
                    <a:srgbClr val="40404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ja-JP" altLang="en-US" sz="1200"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467" name="フリーフォーム: 図形 466">
                  <a:extLst>
                    <a:ext uri="{FF2B5EF4-FFF2-40B4-BE49-F238E27FC236}">
                      <a16:creationId xmlns:a16="http://schemas.microsoft.com/office/drawing/2014/main" id="{38E6D489-F5E8-9964-3C32-E2F730EABB04}"/>
                    </a:ext>
                  </a:extLst>
                </p:cNvPr>
                <p:cNvSpPr/>
                <p:nvPr/>
              </p:nvSpPr>
              <p:spPr>
                <a:xfrm>
                  <a:off x="6533775" y="1982295"/>
                  <a:ext cx="94343" cy="4492"/>
                </a:xfrm>
                <a:custGeom>
                  <a:avLst/>
                  <a:gdLst>
                    <a:gd name="connsiteX0" fmla="*/ 0 w 94343"/>
                    <a:gd name="connsiteY0" fmla="*/ 0 h 4492"/>
                    <a:gd name="connsiteX1" fmla="*/ 94343 w 94343"/>
                    <a:gd name="connsiteY1" fmla="*/ 0 h 4492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94343" h="4492">
                      <a:moveTo>
                        <a:pt x="0" y="0"/>
                      </a:moveTo>
                      <a:lnTo>
                        <a:pt x="94343" y="0"/>
                      </a:lnTo>
                    </a:path>
                  </a:pathLst>
                </a:custGeom>
                <a:noFill/>
                <a:ln w="12227" cap="flat">
                  <a:solidFill>
                    <a:srgbClr val="40404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ja-JP" altLang="en-US" sz="1200"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468" name="フリーフォーム: 図形 467">
                  <a:extLst>
                    <a:ext uri="{FF2B5EF4-FFF2-40B4-BE49-F238E27FC236}">
                      <a16:creationId xmlns:a16="http://schemas.microsoft.com/office/drawing/2014/main" id="{2522026E-29B9-8511-E1FE-B93D9B661AAC}"/>
                    </a:ext>
                  </a:extLst>
                </p:cNvPr>
                <p:cNvSpPr/>
                <p:nvPr/>
              </p:nvSpPr>
              <p:spPr>
                <a:xfrm>
                  <a:off x="6533775" y="2301289"/>
                  <a:ext cx="94343" cy="4492"/>
                </a:xfrm>
                <a:custGeom>
                  <a:avLst/>
                  <a:gdLst>
                    <a:gd name="connsiteX0" fmla="*/ 0 w 94343"/>
                    <a:gd name="connsiteY0" fmla="*/ 0 h 4492"/>
                    <a:gd name="connsiteX1" fmla="*/ 94343 w 94343"/>
                    <a:gd name="connsiteY1" fmla="*/ 0 h 4492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94343" h="4492">
                      <a:moveTo>
                        <a:pt x="0" y="0"/>
                      </a:moveTo>
                      <a:lnTo>
                        <a:pt x="94343" y="0"/>
                      </a:lnTo>
                    </a:path>
                  </a:pathLst>
                </a:custGeom>
                <a:noFill/>
                <a:ln w="12227" cap="flat">
                  <a:solidFill>
                    <a:srgbClr val="40404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ja-JP" altLang="en-US" sz="1200"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469" name="フリーフォーム: 図形 468">
                  <a:extLst>
                    <a:ext uri="{FF2B5EF4-FFF2-40B4-BE49-F238E27FC236}">
                      <a16:creationId xmlns:a16="http://schemas.microsoft.com/office/drawing/2014/main" id="{625092AE-1D26-30D2-5BD5-C00A8A2E7969}"/>
                    </a:ext>
                  </a:extLst>
                </p:cNvPr>
                <p:cNvSpPr/>
                <p:nvPr/>
              </p:nvSpPr>
              <p:spPr>
                <a:xfrm>
                  <a:off x="6533775" y="2615790"/>
                  <a:ext cx="94343" cy="4492"/>
                </a:xfrm>
                <a:custGeom>
                  <a:avLst/>
                  <a:gdLst>
                    <a:gd name="connsiteX0" fmla="*/ 0 w 94343"/>
                    <a:gd name="connsiteY0" fmla="*/ 0 h 4492"/>
                    <a:gd name="connsiteX1" fmla="*/ 94343 w 94343"/>
                    <a:gd name="connsiteY1" fmla="*/ 0 h 4492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94343" h="4492">
                      <a:moveTo>
                        <a:pt x="0" y="0"/>
                      </a:moveTo>
                      <a:lnTo>
                        <a:pt x="94343" y="0"/>
                      </a:lnTo>
                    </a:path>
                  </a:pathLst>
                </a:custGeom>
                <a:noFill/>
                <a:ln w="12227" cap="flat">
                  <a:solidFill>
                    <a:srgbClr val="40404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ja-JP" altLang="en-US" sz="1200"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470" name="フリーフォーム: 図形 469">
                  <a:extLst>
                    <a:ext uri="{FF2B5EF4-FFF2-40B4-BE49-F238E27FC236}">
                      <a16:creationId xmlns:a16="http://schemas.microsoft.com/office/drawing/2014/main" id="{DD259BD8-98F3-1D45-E15A-F07939297DF4}"/>
                    </a:ext>
                  </a:extLst>
                </p:cNvPr>
                <p:cNvSpPr/>
                <p:nvPr/>
              </p:nvSpPr>
              <p:spPr>
                <a:xfrm>
                  <a:off x="6533775" y="2934784"/>
                  <a:ext cx="94343" cy="4492"/>
                </a:xfrm>
                <a:custGeom>
                  <a:avLst/>
                  <a:gdLst>
                    <a:gd name="connsiteX0" fmla="*/ 0 w 94343"/>
                    <a:gd name="connsiteY0" fmla="*/ 0 h 4492"/>
                    <a:gd name="connsiteX1" fmla="*/ 94343 w 94343"/>
                    <a:gd name="connsiteY1" fmla="*/ 0 h 4492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94343" h="4492">
                      <a:moveTo>
                        <a:pt x="0" y="0"/>
                      </a:moveTo>
                      <a:lnTo>
                        <a:pt x="94343" y="0"/>
                      </a:lnTo>
                    </a:path>
                  </a:pathLst>
                </a:custGeom>
                <a:noFill/>
                <a:ln w="12227" cap="flat">
                  <a:solidFill>
                    <a:srgbClr val="40404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ja-JP" altLang="en-US" sz="1200"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471" name="フリーフォーム: 図形 470">
                  <a:extLst>
                    <a:ext uri="{FF2B5EF4-FFF2-40B4-BE49-F238E27FC236}">
                      <a16:creationId xmlns:a16="http://schemas.microsoft.com/office/drawing/2014/main" id="{BFEC088A-9FFF-0723-811C-1D7886D17601}"/>
                    </a:ext>
                  </a:extLst>
                </p:cNvPr>
                <p:cNvSpPr/>
                <p:nvPr/>
              </p:nvSpPr>
              <p:spPr>
                <a:xfrm>
                  <a:off x="6533775" y="3253778"/>
                  <a:ext cx="94343" cy="4492"/>
                </a:xfrm>
                <a:custGeom>
                  <a:avLst/>
                  <a:gdLst>
                    <a:gd name="connsiteX0" fmla="*/ 0 w 94343"/>
                    <a:gd name="connsiteY0" fmla="*/ 0 h 4492"/>
                    <a:gd name="connsiteX1" fmla="*/ 94343 w 94343"/>
                    <a:gd name="connsiteY1" fmla="*/ 0 h 4492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94343" h="4492">
                      <a:moveTo>
                        <a:pt x="0" y="0"/>
                      </a:moveTo>
                      <a:lnTo>
                        <a:pt x="94343" y="0"/>
                      </a:lnTo>
                    </a:path>
                  </a:pathLst>
                </a:custGeom>
                <a:noFill/>
                <a:ln w="12227" cap="flat">
                  <a:solidFill>
                    <a:srgbClr val="40404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ja-JP" altLang="en-US" sz="1200"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472" name="フリーフォーム: 図形 471">
                  <a:extLst>
                    <a:ext uri="{FF2B5EF4-FFF2-40B4-BE49-F238E27FC236}">
                      <a16:creationId xmlns:a16="http://schemas.microsoft.com/office/drawing/2014/main" id="{59EE3983-CF03-8727-194E-A253273F9B3B}"/>
                    </a:ext>
                  </a:extLst>
                </p:cNvPr>
                <p:cNvSpPr/>
                <p:nvPr/>
              </p:nvSpPr>
              <p:spPr>
                <a:xfrm>
                  <a:off x="6533775" y="3572771"/>
                  <a:ext cx="94343" cy="4492"/>
                </a:xfrm>
                <a:custGeom>
                  <a:avLst/>
                  <a:gdLst>
                    <a:gd name="connsiteX0" fmla="*/ 0 w 94343"/>
                    <a:gd name="connsiteY0" fmla="*/ 0 h 4492"/>
                    <a:gd name="connsiteX1" fmla="*/ 94343 w 94343"/>
                    <a:gd name="connsiteY1" fmla="*/ 0 h 4492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94343" h="4492">
                      <a:moveTo>
                        <a:pt x="0" y="0"/>
                      </a:moveTo>
                      <a:lnTo>
                        <a:pt x="94343" y="0"/>
                      </a:lnTo>
                    </a:path>
                  </a:pathLst>
                </a:custGeom>
                <a:noFill/>
                <a:ln w="12227" cap="flat">
                  <a:solidFill>
                    <a:srgbClr val="40404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ja-JP" altLang="en-US" sz="1200"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473" name="フリーフォーム: 図形 472">
                  <a:extLst>
                    <a:ext uri="{FF2B5EF4-FFF2-40B4-BE49-F238E27FC236}">
                      <a16:creationId xmlns:a16="http://schemas.microsoft.com/office/drawing/2014/main" id="{95A46A83-D7C0-0A87-1670-AF11C768447D}"/>
                    </a:ext>
                  </a:extLst>
                </p:cNvPr>
                <p:cNvSpPr/>
                <p:nvPr/>
              </p:nvSpPr>
              <p:spPr>
                <a:xfrm>
                  <a:off x="6533775" y="3891765"/>
                  <a:ext cx="94343" cy="4492"/>
                </a:xfrm>
                <a:custGeom>
                  <a:avLst/>
                  <a:gdLst>
                    <a:gd name="connsiteX0" fmla="*/ 0 w 94343"/>
                    <a:gd name="connsiteY0" fmla="*/ 0 h 4492"/>
                    <a:gd name="connsiteX1" fmla="*/ 94343 w 94343"/>
                    <a:gd name="connsiteY1" fmla="*/ 0 h 4492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94343" h="4492">
                      <a:moveTo>
                        <a:pt x="0" y="0"/>
                      </a:moveTo>
                      <a:lnTo>
                        <a:pt x="94343" y="0"/>
                      </a:lnTo>
                    </a:path>
                  </a:pathLst>
                </a:custGeom>
                <a:noFill/>
                <a:ln w="12227" cap="flat">
                  <a:solidFill>
                    <a:srgbClr val="40404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ja-JP" altLang="en-US" sz="1200"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474" name="フリーフォーム: 図形 473">
                  <a:extLst>
                    <a:ext uri="{FF2B5EF4-FFF2-40B4-BE49-F238E27FC236}">
                      <a16:creationId xmlns:a16="http://schemas.microsoft.com/office/drawing/2014/main" id="{AEC431EC-0DFA-4B21-C33B-8E543220E4CB}"/>
                    </a:ext>
                  </a:extLst>
                </p:cNvPr>
                <p:cNvSpPr/>
                <p:nvPr/>
              </p:nvSpPr>
              <p:spPr>
                <a:xfrm>
                  <a:off x="6533775" y="4206266"/>
                  <a:ext cx="94343" cy="4492"/>
                </a:xfrm>
                <a:custGeom>
                  <a:avLst/>
                  <a:gdLst>
                    <a:gd name="connsiteX0" fmla="*/ 0 w 94343"/>
                    <a:gd name="connsiteY0" fmla="*/ 0 h 4492"/>
                    <a:gd name="connsiteX1" fmla="*/ 94343 w 94343"/>
                    <a:gd name="connsiteY1" fmla="*/ 0 h 4492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94343" h="4492">
                      <a:moveTo>
                        <a:pt x="0" y="0"/>
                      </a:moveTo>
                      <a:lnTo>
                        <a:pt x="94343" y="0"/>
                      </a:lnTo>
                    </a:path>
                  </a:pathLst>
                </a:custGeom>
                <a:noFill/>
                <a:ln w="12227" cap="flat">
                  <a:solidFill>
                    <a:srgbClr val="40404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ja-JP" altLang="en-US" sz="1200"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475" name="フリーフォーム: 図形 474">
                  <a:extLst>
                    <a:ext uri="{FF2B5EF4-FFF2-40B4-BE49-F238E27FC236}">
                      <a16:creationId xmlns:a16="http://schemas.microsoft.com/office/drawing/2014/main" id="{37E04209-1808-E402-EF69-8DB8252371A8}"/>
                    </a:ext>
                  </a:extLst>
                </p:cNvPr>
                <p:cNvSpPr/>
                <p:nvPr/>
              </p:nvSpPr>
              <p:spPr>
                <a:xfrm>
                  <a:off x="6533775" y="4525260"/>
                  <a:ext cx="94343" cy="4492"/>
                </a:xfrm>
                <a:custGeom>
                  <a:avLst/>
                  <a:gdLst>
                    <a:gd name="connsiteX0" fmla="*/ 0 w 94343"/>
                    <a:gd name="connsiteY0" fmla="*/ 0 h 4492"/>
                    <a:gd name="connsiteX1" fmla="*/ 94343 w 94343"/>
                    <a:gd name="connsiteY1" fmla="*/ 0 h 4492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94343" h="4492">
                      <a:moveTo>
                        <a:pt x="0" y="0"/>
                      </a:moveTo>
                      <a:lnTo>
                        <a:pt x="94343" y="0"/>
                      </a:lnTo>
                    </a:path>
                  </a:pathLst>
                </a:custGeom>
                <a:noFill/>
                <a:ln w="12227" cap="flat">
                  <a:solidFill>
                    <a:srgbClr val="40404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ja-JP" altLang="en-US" sz="1200"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476" name="フリーフォーム: 図形 475">
                  <a:extLst>
                    <a:ext uri="{FF2B5EF4-FFF2-40B4-BE49-F238E27FC236}">
                      <a16:creationId xmlns:a16="http://schemas.microsoft.com/office/drawing/2014/main" id="{EB736A28-4E2E-963C-DAF3-595ECFF08A8F}"/>
                    </a:ext>
                  </a:extLst>
                </p:cNvPr>
                <p:cNvSpPr/>
                <p:nvPr/>
              </p:nvSpPr>
              <p:spPr>
                <a:xfrm>
                  <a:off x="6533775" y="4844254"/>
                  <a:ext cx="94343" cy="4492"/>
                </a:xfrm>
                <a:custGeom>
                  <a:avLst/>
                  <a:gdLst>
                    <a:gd name="connsiteX0" fmla="*/ 0 w 94343"/>
                    <a:gd name="connsiteY0" fmla="*/ 0 h 4492"/>
                    <a:gd name="connsiteX1" fmla="*/ 94343 w 94343"/>
                    <a:gd name="connsiteY1" fmla="*/ 0 h 4492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94343" h="4492">
                      <a:moveTo>
                        <a:pt x="0" y="0"/>
                      </a:moveTo>
                      <a:lnTo>
                        <a:pt x="94343" y="0"/>
                      </a:lnTo>
                    </a:path>
                  </a:pathLst>
                </a:custGeom>
                <a:noFill/>
                <a:ln w="12227" cap="flat">
                  <a:solidFill>
                    <a:srgbClr val="40404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ja-JP" altLang="en-US" sz="1200">
                    <a:latin typeface="Palatino Linotype" panose="02040502050505030304" pitchFamily="18" charset="0"/>
                  </a:endParaRPr>
                </a:p>
              </p:txBody>
            </p:sp>
          </p:grpSp>
          <p:grpSp>
            <p:nvGrpSpPr>
              <p:cNvPr id="402" name="グラフィックス 4">
                <a:extLst>
                  <a:ext uri="{FF2B5EF4-FFF2-40B4-BE49-F238E27FC236}">
                    <a16:creationId xmlns:a16="http://schemas.microsoft.com/office/drawing/2014/main" id="{46305CC0-5A7E-D720-D0D1-F51D17DC540B}"/>
                  </a:ext>
                </a:extLst>
              </p:cNvPr>
              <p:cNvGrpSpPr/>
              <p:nvPr/>
            </p:nvGrpSpPr>
            <p:grpSpPr>
              <a:xfrm>
                <a:off x="6533775" y="1820552"/>
                <a:ext cx="49418" cy="2866451"/>
                <a:chOff x="6533775" y="1820552"/>
                <a:chExt cx="49418" cy="2866451"/>
              </a:xfrm>
              <a:noFill/>
            </p:grpSpPr>
            <p:sp>
              <p:nvSpPr>
                <p:cNvPr id="456" name="フリーフォーム: 図形 455">
                  <a:extLst>
                    <a:ext uri="{FF2B5EF4-FFF2-40B4-BE49-F238E27FC236}">
                      <a16:creationId xmlns:a16="http://schemas.microsoft.com/office/drawing/2014/main" id="{65550007-EB65-1EE4-FB12-A7F9B321C86F}"/>
                    </a:ext>
                  </a:extLst>
                </p:cNvPr>
                <p:cNvSpPr/>
                <p:nvPr/>
              </p:nvSpPr>
              <p:spPr>
                <a:xfrm>
                  <a:off x="6533775" y="1820552"/>
                  <a:ext cx="49418" cy="4492"/>
                </a:xfrm>
                <a:custGeom>
                  <a:avLst/>
                  <a:gdLst>
                    <a:gd name="connsiteX0" fmla="*/ 0 w 49418"/>
                    <a:gd name="connsiteY0" fmla="*/ 0 h 4492"/>
                    <a:gd name="connsiteX1" fmla="*/ 49418 w 49418"/>
                    <a:gd name="connsiteY1" fmla="*/ 0 h 4492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49418" h="4492">
                      <a:moveTo>
                        <a:pt x="0" y="0"/>
                      </a:moveTo>
                      <a:lnTo>
                        <a:pt x="49418" y="0"/>
                      </a:lnTo>
                    </a:path>
                  </a:pathLst>
                </a:custGeom>
                <a:noFill/>
                <a:ln w="8151" cap="flat">
                  <a:solidFill>
                    <a:srgbClr val="40404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ja-JP" altLang="en-US" sz="1200"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457" name="フリーフォーム: 図形 456">
                  <a:extLst>
                    <a:ext uri="{FF2B5EF4-FFF2-40B4-BE49-F238E27FC236}">
                      <a16:creationId xmlns:a16="http://schemas.microsoft.com/office/drawing/2014/main" id="{417A1103-2F07-8E8E-401B-50F95AAE99AB}"/>
                    </a:ext>
                  </a:extLst>
                </p:cNvPr>
                <p:cNvSpPr/>
                <p:nvPr/>
              </p:nvSpPr>
              <p:spPr>
                <a:xfrm>
                  <a:off x="6533775" y="2139545"/>
                  <a:ext cx="49418" cy="4492"/>
                </a:xfrm>
                <a:custGeom>
                  <a:avLst/>
                  <a:gdLst>
                    <a:gd name="connsiteX0" fmla="*/ 0 w 49418"/>
                    <a:gd name="connsiteY0" fmla="*/ 0 h 4492"/>
                    <a:gd name="connsiteX1" fmla="*/ 49418 w 49418"/>
                    <a:gd name="connsiteY1" fmla="*/ 0 h 4492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49418" h="4492">
                      <a:moveTo>
                        <a:pt x="0" y="0"/>
                      </a:moveTo>
                      <a:lnTo>
                        <a:pt x="49418" y="0"/>
                      </a:lnTo>
                    </a:path>
                  </a:pathLst>
                </a:custGeom>
                <a:noFill/>
                <a:ln w="8151" cap="flat">
                  <a:solidFill>
                    <a:srgbClr val="40404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ja-JP" altLang="en-US" sz="1200"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458" name="フリーフォーム: 図形 457">
                  <a:extLst>
                    <a:ext uri="{FF2B5EF4-FFF2-40B4-BE49-F238E27FC236}">
                      <a16:creationId xmlns:a16="http://schemas.microsoft.com/office/drawing/2014/main" id="{FE5E0649-8043-9FCB-3719-5DF0D6B9CDE0}"/>
                    </a:ext>
                  </a:extLst>
                </p:cNvPr>
                <p:cNvSpPr/>
                <p:nvPr/>
              </p:nvSpPr>
              <p:spPr>
                <a:xfrm>
                  <a:off x="6533775" y="2458539"/>
                  <a:ext cx="49418" cy="4492"/>
                </a:xfrm>
                <a:custGeom>
                  <a:avLst/>
                  <a:gdLst>
                    <a:gd name="connsiteX0" fmla="*/ 0 w 49418"/>
                    <a:gd name="connsiteY0" fmla="*/ 0 h 4492"/>
                    <a:gd name="connsiteX1" fmla="*/ 49418 w 49418"/>
                    <a:gd name="connsiteY1" fmla="*/ 0 h 4492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49418" h="4492">
                      <a:moveTo>
                        <a:pt x="0" y="0"/>
                      </a:moveTo>
                      <a:lnTo>
                        <a:pt x="49418" y="0"/>
                      </a:lnTo>
                    </a:path>
                  </a:pathLst>
                </a:custGeom>
                <a:noFill/>
                <a:ln w="8151" cap="flat">
                  <a:solidFill>
                    <a:srgbClr val="40404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ja-JP" altLang="en-US" sz="1200"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459" name="フリーフォーム: 図形 458">
                  <a:extLst>
                    <a:ext uri="{FF2B5EF4-FFF2-40B4-BE49-F238E27FC236}">
                      <a16:creationId xmlns:a16="http://schemas.microsoft.com/office/drawing/2014/main" id="{93021FB2-64AB-924B-9F86-873790C3C2E9}"/>
                    </a:ext>
                  </a:extLst>
                </p:cNvPr>
                <p:cNvSpPr/>
                <p:nvPr/>
              </p:nvSpPr>
              <p:spPr>
                <a:xfrm>
                  <a:off x="6533775" y="2777533"/>
                  <a:ext cx="49418" cy="4492"/>
                </a:xfrm>
                <a:custGeom>
                  <a:avLst/>
                  <a:gdLst>
                    <a:gd name="connsiteX0" fmla="*/ 0 w 49418"/>
                    <a:gd name="connsiteY0" fmla="*/ 0 h 4492"/>
                    <a:gd name="connsiteX1" fmla="*/ 49418 w 49418"/>
                    <a:gd name="connsiteY1" fmla="*/ 0 h 4492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49418" h="4492">
                      <a:moveTo>
                        <a:pt x="0" y="0"/>
                      </a:moveTo>
                      <a:lnTo>
                        <a:pt x="49418" y="0"/>
                      </a:lnTo>
                    </a:path>
                  </a:pathLst>
                </a:custGeom>
                <a:noFill/>
                <a:ln w="8151" cap="flat">
                  <a:solidFill>
                    <a:srgbClr val="40404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ja-JP" altLang="en-US" sz="1200"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460" name="フリーフォーム: 図形 459">
                  <a:extLst>
                    <a:ext uri="{FF2B5EF4-FFF2-40B4-BE49-F238E27FC236}">
                      <a16:creationId xmlns:a16="http://schemas.microsoft.com/office/drawing/2014/main" id="{4D61B2C4-9258-878D-2689-51585E3F4BC5}"/>
                    </a:ext>
                  </a:extLst>
                </p:cNvPr>
                <p:cNvSpPr/>
                <p:nvPr/>
              </p:nvSpPr>
              <p:spPr>
                <a:xfrm>
                  <a:off x="6533775" y="3096527"/>
                  <a:ext cx="49418" cy="4492"/>
                </a:xfrm>
                <a:custGeom>
                  <a:avLst/>
                  <a:gdLst>
                    <a:gd name="connsiteX0" fmla="*/ 0 w 49418"/>
                    <a:gd name="connsiteY0" fmla="*/ 0 h 4492"/>
                    <a:gd name="connsiteX1" fmla="*/ 49418 w 49418"/>
                    <a:gd name="connsiteY1" fmla="*/ 0 h 4492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49418" h="4492">
                      <a:moveTo>
                        <a:pt x="0" y="0"/>
                      </a:moveTo>
                      <a:lnTo>
                        <a:pt x="49418" y="0"/>
                      </a:lnTo>
                    </a:path>
                  </a:pathLst>
                </a:custGeom>
                <a:noFill/>
                <a:ln w="8151" cap="flat">
                  <a:solidFill>
                    <a:srgbClr val="40404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ja-JP" altLang="en-US" sz="1200"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461" name="フリーフォーム: 図形 460">
                  <a:extLst>
                    <a:ext uri="{FF2B5EF4-FFF2-40B4-BE49-F238E27FC236}">
                      <a16:creationId xmlns:a16="http://schemas.microsoft.com/office/drawing/2014/main" id="{13364DF0-C653-0FB0-6227-930749CE178C}"/>
                    </a:ext>
                  </a:extLst>
                </p:cNvPr>
                <p:cNvSpPr/>
                <p:nvPr/>
              </p:nvSpPr>
              <p:spPr>
                <a:xfrm>
                  <a:off x="6533775" y="3411028"/>
                  <a:ext cx="49418" cy="4492"/>
                </a:xfrm>
                <a:custGeom>
                  <a:avLst/>
                  <a:gdLst>
                    <a:gd name="connsiteX0" fmla="*/ 0 w 49418"/>
                    <a:gd name="connsiteY0" fmla="*/ 0 h 4492"/>
                    <a:gd name="connsiteX1" fmla="*/ 49418 w 49418"/>
                    <a:gd name="connsiteY1" fmla="*/ 0 h 4492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49418" h="4492">
                      <a:moveTo>
                        <a:pt x="0" y="0"/>
                      </a:moveTo>
                      <a:lnTo>
                        <a:pt x="49418" y="0"/>
                      </a:lnTo>
                    </a:path>
                  </a:pathLst>
                </a:custGeom>
                <a:noFill/>
                <a:ln w="8151" cap="flat">
                  <a:solidFill>
                    <a:srgbClr val="40404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ja-JP" altLang="en-US" sz="1200"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462" name="フリーフォーム: 図形 461">
                  <a:extLst>
                    <a:ext uri="{FF2B5EF4-FFF2-40B4-BE49-F238E27FC236}">
                      <a16:creationId xmlns:a16="http://schemas.microsoft.com/office/drawing/2014/main" id="{E1CB1B91-09A2-832D-9701-E8AF52420757}"/>
                    </a:ext>
                  </a:extLst>
                </p:cNvPr>
                <p:cNvSpPr/>
                <p:nvPr/>
              </p:nvSpPr>
              <p:spPr>
                <a:xfrm>
                  <a:off x="6533775" y="3730022"/>
                  <a:ext cx="49418" cy="4492"/>
                </a:xfrm>
                <a:custGeom>
                  <a:avLst/>
                  <a:gdLst>
                    <a:gd name="connsiteX0" fmla="*/ 0 w 49418"/>
                    <a:gd name="connsiteY0" fmla="*/ 0 h 4492"/>
                    <a:gd name="connsiteX1" fmla="*/ 49418 w 49418"/>
                    <a:gd name="connsiteY1" fmla="*/ 0 h 4492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49418" h="4492">
                      <a:moveTo>
                        <a:pt x="0" y="0"/>
                      </a:moveTo>
                      <a:lnTo>
                        <a:pt x="49418" y="0"/>
                      </a:lnTo>
                    </a:path>
                  </a:pathLst>
                </a:custGeom>
                <a:noFill/>
                <a:ln w="8151" cap="flat">
                  <a:solidFill>
                    <a:srgbClr val="40404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ja-JP" altLang="en-US" sz="1200"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463" name="フリーフォーム: 図形 462">
                  <a:extLst>
                    <a:ext uri="{FF2B5EF4-FFF2-40B4-BE49-F238E27FC236}">
                      <a16:creationId xmlns:a16="http://schemas.microsoft.com/office/drawing/2014/main" id="{5E5EAB88-4F98-B439-7EFA-D1D584F0290C}"/>
                    </a:ext>
                  </a:extLst>
                </p:cNvPr>
                <p:cNvSpPr/>
                <p:nvPr/>
              </p:nvSpPr>
              <p:spPr>
                <a:xfrm>
                  <a:off x="6533775" y="4049016"/>
                  <a:ext cx="49418" cy="4492"/>
                </a:xfrm>
                <a:custGeom>
                  <a:avLst/>
                  <a:gdLst>
                    <a:gd name="connsiteX0" fmla="*/ 0 w 49418"/>
                    <a:gd name="connsiteY0" fmla="*/ 0 h 4492"/>
                    <a:gd name="connsiteX1" fmla="*/ 49418 w 49418"/>
                    <a:gd name="connsiteY1" fmla="*/ 0 h 4492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49418" h="4492">
                      <a:moveTo>
                        <a:pt x="0" y="0"/>
                      </a:moveTo>
                      <a:lnTo>
                        <a:pt x="49418" y="0"/>
                      </a:lnTo>
                    </a:path>
                  </a:pathLst>
                </a:custGeom>
                <a:noFill/>
                <a:ln w="8151" cap="flat">
                  <a:solidFill>
                    <a:srgbClr val="40404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ja-JP" altLang="en-US" sz="1200"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464" name="フリーフォーム: 図形 463">
                  <a:extLst>
                    <a:ext uri="{FF2B5EF4-FFF2-40B4-BE49-F238E27FC236}">
                      <a16:creationId xmlns:a16="http://schemas.microsoft.com/office/drawing/2014/main" id="{910091AD-799F-657E-C021-4B4BF5A3A8AC}"/>
                    </a:ext>
                  </a:extLst>
                </p:cNvPr>
                <p:cNvSpPr/>
                <p:nvPr/>
              </p:nvSpPr>
              <p:spPr>
                <a:xfrm>
                  <a:off x="6533775" y="4368010"/>
                  <a:ext cx="49418" cy="4492"/>
                </a:xfrm>
                <a:custGeom>
                  <a:avLst/>
                  <a:gdLst>
                    <a:gd name="connsiteX0" fmla="*/ 0 w 49418"/>
                    <a:gd name="connsiteY0" fmla="*/ 0 h 4492"/>
                    <a:gd name="connsiteX1" fmla="*/ 49418 w 49418"/>
                    <a:gd name="connsiteY1" fmla="*/ 0 h 4492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49418" h="4492">
                      <a:moveTo>
                        <a:pt x="0" y="0"/>
                      </a:moveTo>
                      <a:lnTo>
                        <a:pt x="49418" y="0"/>
                      </a:lnTo>
                    </a:path>
                  </a:pathLst>
                </a:custGeom>
                <a:noFill/>
                <a:ln w="8151" cap="flat">
                  <a:solidFill>
                    <a:srgbClr val="40404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ja-JP" altLang="en-US" sz="1200"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465" name="フリーフォーム: 図形 464">
                  <a:extLst>
                    <a:ext uri="{FF2B5EF4-FFF2-40B4-BE49-F238E27FC236}">
                      <a16:creationId xmlns:a16="http://schemas.microsoft.com/office/drawing/2014/main" id="{D0A12B4A-4AD3-2398-FB9E-EE9A62EB84AB}"/>
                    </a:ext>
                  </a:extLst>
                </p:cNvPr>
                <p:cNvSpPr/>
                <p:nvPr/>
              </p:nvSpPr>
              <p:spPr>
                <a:xfrm>
                  <a:off x="6533775" y="4687003"/>
                  <a:ext cx="49418" cy="4492"/>
                </a:xfrm>
                <a:custGeom>
                  <a:avLst/>
                  <a:gdLst>
                    <a:gd name="connsiteX0" fmla="*/ 0 w 49418"/>
                    <a:gd name="connsiteY0" fmla="*/ 0 h 4492"/>
                    <a:gd name="connsiteX1" fmla="*/ 49418 w 49418"/>
                    <a:gd name="connsiteY1" fmla="*/ 0 h 4492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49418" h="4492">
                      <a:moveTo>
                        <a:pt x="0" y="0"/>
                      </a:moveTo>
                      <a:lnTo>
                        <a:pt x="49418" y="0"/>
                      </a:lnTo>
                    </a:path>
                  </a:pathLst>
                </a:custGeom>
                <a:noFill/>
                <a:ln w="8151" cap="flat">
                  <a:solidFill>
                    <a:srgbClr val="40404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ja-JP" altLang="en-US" sz="1200">
                    <a:latin typeface="Palatino Linotype" panose="02040502050505030304" pitchFamily="18" charset="0"/>
                  </a:endParaRPr>
                </a:p>
              </p:txBody>
            </p:sp>
          </p:grpSp>
          <p:grpSp>
            <p:nvGrpSpPr>
              <p:cNvPr id="403" name="グラフィックス 4">
                <a:extLst>
                  <a:ext uri="{FF2B5EF4-FFF2-40B4-BE49-F238E27FC236}">
                    <a16:creationId xmlns:a16="http://schemas.microsoft.com/office/drawing/2014/main" id="{B2D1552D-AE7B-CE78-9E14-2D1EE8D6B77E}"/>
                  </a:ext>
                </a:extLst>
              </p:cNvPr>
              <p:cNvGrpSpPr/>
              <p:nvPr/>
            </p:nvGrpSpPr>
            <p:grpSpPr>
              <a:xfrm>
                <a:off x="6524790" y="1564458"/>
                <a:ext cx="4434142" cy="3374146"/>
                <a:chOff x="6524790" y="1564458"/>
                <a:chExt cx="4434142" cy="3374146"/>
              </a:xfrm>
              <a:noFill/>
            </p:grpSpPr>
            <p:sp>
              <p:nvSpPr>
                <p:cNvPr id="454" name="フリーフォーム: 図形 453">
                  <a:extLst>
                    <a:ext uri="{FF2B5EF4-FFF2-40B4-BE49-F238E27FC236}">
                      <a16:creationId xmlns:a16="http://schemas.microsoft.com/office/drawing/2014/main" id="{6FDE16AB-6ED9-0989-92AC-0D1EFD24A92F}"/>
                    </a:ext>
                  </a:extLst>
                </p:cNvPr>
                <p:cNvSpPr/>
                <p:nvPr/>
              </p:nvSpPr>
              <p:spPr>
                <a:xfrm>
                  <a:off x="6533775" y="1564458"/>
                  <a:ext cx="4492" cy="3374146"/>
                </a:xfrm>
                <a:custGeom>
                  <a:avLst/>
                  <a:gdLst>
                    <a:gd name="connsiteX0" fmla="*/ 0 w 4492"/>
                    <a:gd name="connsiteY0" fmla="*/ 0 h 3374146"/>
                    <a:gd name="connsiteX1" fmla="*/ 0 w 4492"/>
                    <a:gd name="connsiteY1" fmla="*/ 3374147 h 3374146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4492" h="3374146">
                      <a:moveTo>
                        <a:pt x="0" y="0"/>
                      </a:moveTo>
                      <a:lnTo>
                        <a:pt x="0" y="3374147"/>
                      </a:lnTo>
                    </a:path>
                  </a:pathLst>
                </a:custGeom>
                <a:noFill/>
                <a:ln w="16302" cap="flat">
                  <a:solidFill>
                    <a:srgbClr val="00000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ja-JP" altLang="en-US" sz="1200"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455" name="フリーフォーム: 図形 454">
                  <a:extLst>
                    <a:ext uri="{FF2B5EF4-FFF2-40B4-BE49-F238E27FC236}">
                      <a16:creationId xmlns:a16="http://schemas.microsoft.com/office/drawing/2014/main" id="{AFF54EFD-3A03-E0EE-6A7D-4D0AF1CD16F6}"/>
                    </a:ext>
                  </a:extLst>
                </p:cNvPr>
                <p:cNvSpPr/>
                <p:nvPr/>
              </p:nvSpPr>
              <p:spPr>
                <a:xfrm>
                  <a:off x="6524790" y="4938604"/>
                  <a:ext cx="4434142" cy="4492"/>
                </a:xfrm>
                <a:custGeom>
                  <a:avLst/>
                  <a:gdLst>
                    <a:gd name="connsiteX0" fmla="*/ 0 w 4434142"/>
                    <a:gd name="connsiteY0" fmla="*/ 0 h 4492"/>
                    <a:gd name="connsiteX1" fmla="*/ 4434143 w 4434142"/>
                    <a:gd name="connsiteY1" fmla="*/ 0 h 4492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4434142" h="4492">
                      <a:moveTo>
                        <a:pt x="0" y="0"/>
                      </a:moveTo>
                      <a:lnTo>
                        <a:pt x="4434143" y="0"/>
                      </a:lnTo>
                    </a:path>
                  </a:pathLst>
                </a:custGeom>
                <a:noFill/>
                <a:ln w="16302" cap="flat">
                  <a:solidFill>
                    <a:srgbClr val="00000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ja-JP" altLang="en-US" sz="1200">
                    <a:latin typeface="Palatino Linotype" panose="02040502050505030304" pitchFamily="18" charset="0"/>
                  </a:endParaRPr>
                </a:p>
              </p:txBody>
            </p:sp>
          </p:grpSp>
          <p:sp>
            <p:nvSpPr>
              <p:cNvPr id="404" name="フリーフォーム: 図形 403">
                <a:extLst>
                  <a:ext uri="{FF2B5EF4-FFF2-40B4-BE49-F238E27FC236}">
                    <a16:creationId xmlns:a16="http://schemas.microsoft.com/office/drawing/2014/main" id="{72A2C8A5-31DA-F50B-0B9B-FB9290F347CA}"/>
                  </a:ext>
                </a:extLst>
              </p:cNvPr>
              <p:cNvSpPr/>
              <p:nvPr/>
            </p:nvSpPr>
            <p:spPr>
              <a:xfrm>
                <a:off x="7836613" y="4853240"/>
                <a:ext cx="4492" cy="85364"/>
              </a:xfrm>
              <a:custGeom>
                <a:avLst/>
                <a:gdLst>
                  <a:gd name="connsiteX0" fmla="*/ 0 w 4492"/>
                  <a:gd name="connsiteY0" fmla="*/ 85365 h 85364"/>
                  <a:gd name="connsiteX1" fmla="*/ 0 w 4492"/>
                  <a:gd name="connsiteY1" fmla="*/ 0 h 8536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4492" h="85364">
                    <a:moveTo>
                      <a:pt x="0" y="85365"/>
                    </a:moveTo>
                    <a:lnTo>
                      <a:pt x="0" y="0"/>
                    </a:lnTo>
                  </a:path>
                </a:pathLst>
              </a:custGeom>
              <a:noFill/>
              <a:ln w="12227" cap="flat">
                <a:solidFill>
                  <a:srgbClr val="40404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405" name="フリーフォーム: 図形 404">
                <a:extLst>
                  <a:ext uri="{FF2B5EF4-FFF2-40B4-BE49-F238E27FC236}">
                    <a16:creationId xmlns:a16="http://schemas.microsoft.com/office/drawing/2014/main" id="{A81E80A8-1BF8-B15B-1C5C-95020C228ECB}"/>
                  </a:ext>
                </a:extLst>
              </p:cNvPr>
              <p:cNvSpPr/>
              <p:nvPr/>
            </p:nvSpPr>
            <p:spPr>
              <a:xfrm>
                <a:off x="9647109" y="4853240"/>
                <a:ext cx="4492" cy="85364"/>
              </a:xfrm>
              <a:custGeom>
                <a:avLst/>
                <a:gdLst>
                  <a:gd name="connsiteX0" fmla="*/ 0 w 4492"/>
                  <a:gd name="connsiteY0" fmla="*/ 85365 h 85364"/>
                  <a:gd name="connsiteX1" fmla="*/ 0 w 4492"/>
                  <a:gd name="connsiteY1" fmla="*/ 0 h 8536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4492" h="85364">
                    <a:moveTo>
                      <a:pt x="0" y="85365"/>
                    </a:moveTo>
                    <a:lnTo>
                      <a:pt x="0" y="0"/>
                    </a:lnTo>
                  </a:path>
                </a:pathLst>
              </a:custGeom>
              <a:noFill/>
              <a:ln w="12227" cap="flat">
                <a:solidFill>
                  <a:srgbClr val="40404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grpSp>
            <p:nvGrpSpPr>
              <p:cNvPr id="406" name="グラフィックス 4">
                <a:extLst>
                  <a:ext uri="{FF2B5EF4-FFF2-40B4-BE49-F238E27FC236}">
                    <a16:creationId xmlns:a16="http://schemas.microsoft.com/office/drawing/2014/main" id="{BB67D48E-F029-02A6-1B84-CD480C8D6E67}"/>
                  </a:ext>
                </a:extLst>
              </p:cNvPr>
              <p:cNvGrpSpPr/>
              <p:nvPr/>
            </p:nvGrpSpPr>
            <p:grpSpPr>
              <a:xfrm>
                <a:off x="7836613" y="1667794"/>
                <a:ext cx="1810495" cy="3171967"/>
                <a:chOff x="7836613" y="1667794"/>
                <a:chExt cx="1810495" cy="3171967"/>
              </a:xfrm>
              <a:noFill/>
            </p:grpSpPr>
            <p:sp>
              <p:nvSpPr>
                <p:cNvPr id="452" name="フリーフォーム: 図形 451">
                  <a:extLst>
                    <a:ext uri="{FF2B5EF4-FFF2-40B4-BE49-F238E27FC236}">
                      <a16:creationId xmlns:a16="http://schemas.microsoft.com/office/drawing/2014/main" id="{BC0F6FAC-52D7-47FA-CD7D-6E1E9CD6A919}"/>
                    </a:ext>
                  </a:extLst>
                </p:cNvPr>
                <p:cNvSpPr/>
                <p:nvPr/>
              </p:nvSpPr>
              <p:spPr>
                <a:xfrm>
                  <a:off x="7836613" y="1667794"/>
                  <a:ext cx="4492" cy="3171967"/>
                </a:xfrm>
                <a:custGeom>
                  <a:avLst/>
                  <a:gdLst>
                    <a:gd name="connsiteX0" fmla="*/ 0 w 4492"/>
                    <a:gd name="connsiteY0" fmla="*/ 3171967 h 3171967"/>
                    <a:gd name="connsiteX1" fmla="*/ 0 w 4492"/>
                    <a:gd name="connsiteY1" fmla="*/ 0 h 3171967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4492" h="3171967">
                      <a:moveTo>
                        <a:pt x="0" y="3171967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w="4485" cap="flat">
                  <a:solidFill>
                    <a:srgbClr val="A0A0A0"/>
                  </a:solidFill>
                  <a:custDash>
                    <a:ds d="75000" sp="75000"/>
                  </a:custDash>
                  <a:miter/>
                </a:ln>
              </p:spPr>
              <p:txBody>
                <a:bodyPr rtlCol="0" anchor="ctr"/>
                <a:lstStyle/>
                <a:p>
                  <a:endParaRPr lang="ja-JP" altLang="en-US" sz="1200"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453" name="フリーフォーム: 図形 452">
                  <a:extLst>
                    <a:ext uri="{FF2B5EF4-FFF2-40B4-BE49-F238E27FC236}">
                      <a16:creationId xmlns:a16="http://schemas.microsoft.com/office/drawing/2014/main" id="{B61AE7F1-7383-3D64-DB88-A48F8607832B}"/>
                    </a:ext>
                  </a:extLst>
                </p:cNvPr>
                <p:cNvSpPr/>
                <p:nvPr/>
              </p:nvSpPr>
              <p:spPr>
                <a:xfrm>
                  <a:off x="9647109" y="1667794"/>
                  <a:ext cx="4492" cy="3171967"/>
                </a:xfrm>
                <a:custGeom>
                  <a:avLst/>
                  <a:gdLst>
                    <a:gd name="connsiteX0" fmla="*/ 0 w 4492"/>
                    <a:gd name="connsiteY0" fmla="*/ 3171967 h 3171967"/>
                    <a:gd name="connsiteX1" fmla="*/ 0 w 4492"/>
                    <a:gd name="connsiteY1" fmla="*/ 0 h 3171967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4492" h="3171967">
                      <a:moveTo>
                        <a:pt x="0" y="3171967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w="4485" cap="flat">
                  <a:solidFill>
                    <a:srgbClr val="A0A0A0"/>
                  </a:solidFill>
                  <a:custDash>
                    <a:ds d="75000" sp="75000"/>
                  </a:custDash>
                  <a:miter/>
                </a:ln>
              </p:spPr>
              <p:txBody>
                <a:bodyPr rtlCol="0" anchor="ctr"/>
                <a:lstStyle/>
                <a:p>
                  <a:endParaRPr lang="ja-JP" altLang="en-US" sz="1200">
                    <a:latin typeface="Palatino Linotype" panose="02040502050505030304" pitchFamily="18" charset="0"/>
                  </a:endParaRPr>
                </a:p>
              </p:txBody>
            </p:sp>
          </p:grpSp>
          <p:grpSp>
            <p:nvGrpSpPr>
              <p:cNvPr id="407" name="グラフィックス 4">
                <a:extLst>
                  <a:ext uri="{FF2B5EF4-FFF2-40B4-BE49-F238E27FC236}">
                    <a16:creationId xmlns:a16="http://schemas.microsoft.com/office/drawing/2014/main" id="{E5AD2A2C-A630-0832-728F-44ECF2D17C9D}"/>
                  </a:ext>
                </a:extLst>
              </p:cNvPr>
              <p:cNvGrpSpPr/>
              <p:nvPr/>
            </p:nvGrpSpPr>
            <p:grpSpPr>
              <a:xfrm>
                <a:off x="7692852" y="1771130"/>
                <a:ext cx="2026138" cy="3086602"/>
                <a:chOff x="7692852" y="1771130"/>
                <a:chExt cx="2026138" cy="3086602"/>
              </a:xfrm>
              <a:solidFill>
                <a:srgbClr val="FFFFFF"/>
              </a:solidFill>
            </p:grpSpPr>
            <p:sp>
              <p:nvSpPr>
                <p:cNvPr id="408" name="フリーフォーム: 図形 407">
                  <a:extLst>
                    <a:ext uri="{FF2B5EF4-FFF2-40B4-BE49-F238E27FC236}">
                      <a16:creationId xmlns:a16="http://schemas.microsoft.com/office/drawing/2014/main" id="{000EE14F-16B5-7D36-E4A8-0A5460A7B21C}"/>
                    </a:ext>
                  </a:extLst>
                </p:cNvPr>
                <p:cNvSpPr/>
                <p:nvPr/>
              </p:nvSpPr>
              <p:spPr>
                <a:xfrm>
                  <a:off x="7728792" y="4794832"/>
                  <a:ext cx="62895" cy="62900"/>
                </a:xfrm>
                <a:custGeom>
                  <a:avLst/>
                  <a:gdLst>
                    <a:gd name="connsiteX0" fmla="*/ 62896 w 62895"/>
                    <a:gd name="connsiteY0" fmla="*/ 31450 h 62900"/>
                    <a:gd name="connsiteX1" fmla="*/ 31448 w 62895"/>
                    <a:gd name="connsiteY1" fmla="*/ 62900 h 62900"/>
                    <a:gd name="connsiteX2" fmla="*/ 0 w 62895"/>
                    <a:gd name="connsiteY2" fmla="*/ 31450 h 62900"/>
                    <a:gd name="connsiteX3" fmla="*/ 31448 w 62895"/>
                    <a:gd name="connsiteY3" fmla="*/ 0 h 62900"/>
                    <a:gd name="connsiteX4" fmla="*/ 62896 w 62895"/>
                    <a:gd name="connsiteY4" fmla="*/ 31450 h 629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62895" h="62900">
                      <a:moveTo>
                        <a:pt x="62896" y="31450"/>
                      </a:moveTo>
                      <a:cubicBezTo>
                        <a:pt x="62896" y="48819"/>
                        <a:pt x="48816" y="62900"/>
                        <a:pt x="31448" y="62900"/>
                      </a:cubicBezTo>
                      <a:cubicBezTo>
                        <a:pt x="14080" y="62900"/>
                        <a:pt x="0" y="48819"/>
                        <a:pt x="0" y="31450"/>
                      </a:cubicBezTo>
                      <a:cubicBezTo>
                        <a:pt x="0" y="14081"/>
                        <a:pt x="14080" y="0"/>
                        <a:pt x="31448" y="0"/>
                      </a:cubicBezTo>
                      <a:cubicBezTo>
                        <a:pt x="48816" y="0"/>
                        <a:pt x="62896" y="14081"/>
                        <a:pt x="62896" y="31450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 w="5706" cap="flat">
                  <a:solidFill>
                    <a:srgbClr val="FF670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ja-JP" altLang="en-US" sz="1200"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409" name="フリーフォーム: 図形 408">
                  <a:extLst>
                    <a:ext uri="{FF2B5EF4-FFF2-40B4-BE49-F238E27FC236}">
                      <a16:creationId xmlns:a16="http://schemas.microsoft.com/office/drawing/2014/main" id="{0425FF56-C1EF-2C52-7731-7D4BD2627F4A}"/>
                    </a:ext>
                  </a:extLst>
                </p:cNvPr>
                <p:cNvSpPr/>
                <p:nvPr/>
              </p:nvSpPr>
              <p:spPr>
                <a:xfrm>
                  <a:off x="7805165" y="4767875"/>
                  <a:ext cx="62895" cy="62900"/>
                </a:xfrm>
                <a:custGeom>
                  <a:avLst/>
                  <a:gdLst>
                    <a:gd name="connsiteX0" fmla="*/ 62896 w 62895"/>
                    <a:gd name="connsiteY0" fmla="*/ 31450 h 62900"/>
                    <a:gd name="connsiteX1" fmla="*/ 31448 w 62895"/>
                    <a:gd name="connsiteY1" fmla="*/ 62900 h 62900"/>
                    <a:gd name="connsiteX2" fmla="*/ 0 w 62895"/>
                    <a:gd name="connsiteY2" fmla="*/ 31450 h 62900"/>
                    <a:gd name="connsiteX3" fmla="*/ 31448 w 62895"/>
                    <a:gd name="connsiteY3" fmla="*/ 0 h 62900"/>
                    <a:gd name="connsiteX4" fmla="*/ 62896 w 62895"/>
                    <a:gd name="connsiteY4" fmla="*/ 31450 h 629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62895" h="62900">
                      <a:moveTo>
                        <a:pt x="62896" y="31450"/>
                      </a:moveTo>
                      <a:cubicBezTo>
                        <a:pt x="62896" y="48819"/>
                        <a:pt x="48816" y="62900"/>
                        <a:pt x="31448" y="62900"/>
                      </a:cubicBezTo>
                      <a:cubicBezTo>
                        <a:pt x="14080" y="62900"/>
                        <a:pt x="0" y="48819"/>
                        <a:pt x="0" y="31450"/>
                      </a:cubicBezTo>
                      <a:cubicBezTo>
                        <a:pt x="0" y="14081"/>
                        <a:pt x="14080" y="0"/>
                        <a:pt x="31448" y="0"/>
                      </a:cubicBezTo>
                      <a:cubicBezTo>
                        <a:pt x="48816" y="0"/>
                        <a:pt x="62896" y="14081"/>
                        <a:pt x="62896" y="31450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 w="5706" cap="flat">
                  <a:solidFill>
                    <a:srgbClr val="FF670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ja-JP" altLang="en-US" sz="1200"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410" name="フリーフォーム: 図形 409">
                  <a:extLst>
                    <a:ext uri="{FF2B5EF4-FFF2-40B4-BE49-F238E27FC236}">
                      <a16:creationId xmlns:a16="http://schemas.microsoft.com/office/drawing/2014/main" id="{0D04FECF-E132-349F-B65B-61F719B8B659}"/>
                    </a:ext>
                  </a:extLst>
                </p:cNvPr>
                <p:cNvSpPr/>
                <p:nvPr/>
              </p:nvSpPr>
              <p:spPr>
                <a:xfrm>
                  <a:off x="7881539" y="4754397"/>
                  <a:ext cx="62895" cy="62900"/>
                </a:xfrm>
                <a:custGeom>
                  <a:avLst/>
                  <a:gdLst>
                    <a:gd name="connsiteX0" fmla="*/ 62896 w 62895"/>
                    <a:gd name="connsiteY0" fmla="*/ 31450 h 62900"/>
                    <a:gd name="connsiteX1" fmla="*/ 31448 w 62895"/>
                    <a:gd name="connsiteY1" fmla="*/ 62900 h 62900"/>
                    <a:gd name="connsiteX2" fmla="*/ 0 w 62895"/>
                    <a:gd name="connsiteY2" fmla="*/ 31450 h 62900"/>
                    <a:gd name="connsiteX3" fmla="*/ 31448 w 62895"/>
                    <a:gd name="connsiteY3" fmla="*/ 0 h 62900"/>
                    <a:gd name="connsiteX4" fmla="*/ 62896 w 62895"/>
                    <a:gd name="connsiteY4" fmla="*/ 31450 h 629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62895" h="62900">
                      <a:moveTo>
                        <a:pt x="62896" y="31450"/>
                      </a:moveTo>
                      <a:cubicBezTo>
                        <a:pt x="62896" y="48819"/>
                        <a:pt x="48816" y="62900"/>
                        <a:pt x="31448" y="62900"/>
                      </a:cubicBezTo>
                      <a:cubicBezTo>
                        <a:pt x="14080" y="62900"/>
                        <a:pt x="0" y="48819"/>
                        <a:pt x="0" y="31450"/>
                      </a:cubicBezTo>
                      <a:cubicBezTo>
                        <a:pt x="0" y="14081"/>
                        <a:pt x="14080" y="0"/>
                        <a:pt x="31448" y="0"/>
                      </a:cubicBezTo>
                      <a:cubicBezTo>
                        <a:pt x="48816" y="0"/>
                        <a:pt x="62896" y="14081"/>
                        <a:pt x="62896" y="31450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 w="5706" cap="flat">
                  <a:solidFill>
                    <a:srgbClr val="FF670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ja-JP" altLang="en-US" sz="1200"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411" name="フリーフォーム: 図形 410">
                  <a:extLst>
                    <a:ext uri="{FF2B5EF4-FFF2-40B4-BE49-F238E27FC236}">
                      <a16:creationId xmlns:a16="http://schemas.microsoft.com/office/drawing/2014/main" id="{49892FD0-BED1-513D-26E3-F2F9548CB5BD}"/>
                    </a:ext>
                  </a:extLst>
                </p:cNvPr>
                <p:cNvSpPr/>
                <p:nvPr/>
              </p:nvSpPr>
              <p:spPr>
                <a:xfrm>
                  <a:off x="7692852" y="4704975"/>
                  <a:ext cx="62895" cy="62900"/>
                </a:xfrm>
                <a:custGeom>
                  <a:avLst/>
                  <a:gdLst>
                    <a:gd name="connsiteX0" fmla="*/ 62896 w 62895"/>
                    <a:gd name="connsiteY0" fmla="*/ 31450 h 62900"/>
                    <a:gd name="connsiteX1" fmla="*/ 31448 w 62895"/>
                    <a:gd name="connsiteY1" fmla="*/ 62900 h 62900"/>
                    <a:gd name="connsiteX2" fmla="*/ 0 w 62895"/>
                    <a:gd name="connsiteY2" fmla="*/ 31450 h 62900"/>
                    <a:gd name="connsiteX3" fmla="*/ 31448 w 62895"/>
                    <a:gd name="connsiteY3" fmla="*/ 0 h 62900"/>
                    <a:gd name="connsiteX4" fmla="*/ 62896 w 62895"/>
                    <a:gd name="connsiteY4" fmla="*/ 31450 h 629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62895" h="62900">
                      <a:moveTo>
                        <a:pt x="62896" y="31450"/>
                      </a:moveTo>
                      <a:cubicBezTo>
                        <a:pt x="62896" y="48819"/>
                        <a:pt x="48816" y="62900"/>
                        <a:pt x="31448" y="62900"/>
                      </a:cubicBezTo>
                      <a:cubicBezTo>
                        <a:pt x="14080" y="62900"/>
                        <a:pt x="0" y="48819"/>
                        <a:pt x="0" y="31450"/>
                      </a:cubicBezTo>
                      <a:cubicBezTo>
                        <a:pt x="0" y="14081"/>
                        <a:pt x="14080" y="0"/>
                        <a:pt x="31448" y="0"/>
                      </a:cubicBezTo>
                      <a:cubicBezTo>
                        <a:pt x="48816" y="0"/>
                        <a:pt x="62896" y="14081"/>
                        <a:pt x="62896" y="31450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 w="5706" cap="flat">
                  <a:solidFill>
                    <a:srgbClr val="FF670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ja-JP" altLang="en-US" sz="1200"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412" name="フリーフォーム: 図形 411">
                  <a:extLst>
                    <a:ext uri="{FF2B5EF4-FFF2-40B4-BE49-F238E27FC236}">
                      <a16:creationId xmlns:a16="http://schemas.microsoft.com/office/drawing/2014/main" id="{37BFF769-2379-61C1-FAAB-45342973B3E8}"/>
                    </a:ext>
                  </a:extLst>
                </p:cNvPr>
                <p:cNvSpPr/>
                <p:nvPr/>
              </p:nvSpPr>
              <p:spPr>
                <a:xfrm>
                  <a:off x="7769225" y="4691496"/>
                  <a:ext cx="62895" cy="62900"/>
                </a:xfrm>
                <a:custGeom>
                  <a:avLst/>
                  <a:gdLst>
                    <a:gd name="connsiteX0" fmla="*/ 62896 w 62895"/>
                    <a:gd name="connsiteY0" fmla="*/ 31450 h 62900"/>
                    <a:gd name="connsiteX1" fmla="*/ 31448 w 62895"/>
                    <a:gd name="connsiteY1" fmla="*/ 62900 h 62900"/>
                    <a:gd name="connsiteX2" fmla="*/ 0 w 62895"/>
                    <a:gd name="connsiteY2" fmla="*/ 31450 h 62900"/>
                    <a:gd name="connsiteX3" fmla="*/ 31448 w 62895"/>
                    <a:gd name="connsiteY3" fmla="*/ 0 h 62900"/>
                    <a:gd name="connsiteX4" fmla="*/ 62896 w 62895"/>
                    <a:gd name="connsiteY4" fmla="*/ 31450 h 629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62895" h="62900">
                      <a:moveTo>
                        <a:pt x="62896" y="31450"/>
                      </a:moveTo>
                      <a:cubicBezTo>
                        <a:pt x="62896" y="48819"/>
                        <a:pt x="48816" y="62900"/>
                        <a:pt x="31448" y="62900"/>
                      </a:cubicBezTo>
                      <a:cubicBezTo>
                        <a:pt x="14080" y="62900"/>
                        <a:pt x="0" y="48819"/>
                        <a:pt x="0" y="31450"/>
                      </a:cubicBezTo>
                      <a:cubicBezTo>
                        <a:pt x="0" y="14081"/>
                        <a:pt x="14080" y="0"/>
                        <a:pt x="31448" y="0"/>
                      </a:cubicBezTo>
                      <a:cubicBezTo>
                        <a:pt x="48816" y="0"/>
                        <a:pt x="62896" y="14081"/>
                        <a:pt x="62896" y="31450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 w="5706" cap="flat">
                  <a:solidFill>
                    <a:srgbClr val="FF670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ja-JP" altLang="en-US" sz="1200"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413" name="フリーフォーム: 図形 412">
                  <a:extLst>
                    <a:ext uri="{FF2B5EF4-FFF2-40B4-BE49-F238E27FC236}">
                      <a16:creationId xmlns:a16="http://schemas.microsoft.com/office/drawing/2014/main" id="{A4ED8AAA-CA9D-61A6-7208-08A0BDA6591F}"/>
                    </a:ext>
                  </a:extLst>
                </p:cNvPr>
                <p:cNvSpPr/>
                <p:nvPr/>
              </p:nvSpPr>
              <p:spPr>
                <a:xfrm>
                  <a:off x="7845598" y="4678018"/>
                  <a:ext cx="62895" cy="62900"/>
                </a:xfrm>
                <a:custGeom>
                  <a:avLst/>
                  <a:gdLst>
                    <a:gd name="connsiteX0" fmla="*/ 62896 w 62895"/>
                    <a:gd name="connsiteY0" fmla="*/ 31450 h 62900"/>
                    <a:gd name="connsiteX1" fmla="*/ 31448 w 62895"/>
                    <a:gd name="connsiteY1" fmla="*/ 62900 h 62900"/>
                    <a:gd name="connsiteX2" fmla="*/ 0 w 62895"/>
                    <a:gd name="connsiteY2" fmla="*/ 31450 h 62900"/>
                    <a:gd name="connsiteX3" fmla="*/ 31448 w 62895"/>
                    <a:gd name="connsiteY3" fmla="*/ 0 h 62900"/>
                    <a:gd name="connsiteX4" fmla="*/ 62896 w 62895"/>
                    <a:gd name="connsiteY4" fmla="*/ 31450 h 629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62895" h="62900">
                      <a:moveTo>
                        <a:pt x="62896" y="31450"/>
                      </a:moveTo>
                      <a:cubicBezTo>
                        <a:pt x="62896" y="48819"/>
                        <a:pt x="48816" y="62900"/>
                        <a:pt x="31448" y="62900"/>
                      </a:cubicBezTo>
                      <a:cubicBezTo>
                        <a:pt x="14080" y="62900"/>
                        <a:pt x="0" y="48819"/>
                        <a:pt x="0" y="31450"/>
                      </a:cubicBezTo>
                      <a:cubicBezTo>
                        <a:pt x="0" y="14081"/>
                        <a:pt x="14080" y="0"/>
                        <a:pt x="31448" y="0"/>
                      </a:cubicBezTo>
                      <a:cubicBezTo>
                        <a:pt x="48816" y="0"/>
                        <a:pt x="62896" y="14081"/>
                        <a:pt x="62896" y="31450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 w="5706" cap="flat">
                  <a:solidFill>
                    <a:srgbClr val="FF670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ja-JP" altLang="en-US" sz="1200"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414" name="フリーフォーム: 図形 413">
                  <a:extLst>
                    <a:ext uri="{FF2B5EF4-FFF2-40B4-BE49-F238E27FC236}">
                      <a16:creationId xmlns:a16="http://schemas.microsoft.com/office/drawing/2014/main" id="{55427D23-29EE-7C3A-000E-ADAEFFCEEBDA}"/>
                    </a:ext>
                  </a:extLst>
                </p:cNvPr>
                <p:cNvSpPr/>
                <p:nvPr/>
              </p:nvSpPr>
              <p:spPr>
                <a:xfrm>
                  <a:off x="7921972" y="4669032"/>
                  <a:ext cx="62895" cy="62900"/>
                </a:xfrm>
                <a:custGeom>
                  <a:avLst/>
                  <a:gdLst>
                    <a:gd name="connsiteX0" fmla="*/ 62896 w 62895"/>
                    <a:gd name="connsiteY0" fmla="*/ 31450 h 62900"/>
                    <a:gd name="connsiteX1" fmla="*/ 31448 w 62895"/>
                    <a:gd name="connsiteY1" fmla="*/ 62900 h 62900"/>
                    <a:gd name="connsiteX2" fmla="*/ 0 w 62895"/>
                    <a:gd name="connsiteY2" fmla="*/ 31450 h 62900"/>
                    <a:gd name="connsiteX3" fmla="*/ 31448 w 62895"/>
                    <a:gd name="connsiteY3" fmla="*/ 0 h 62900"/>
                    <a:gd name="connsiteX4" fmla="*/ 62896 w 62895"/>
                    <a:gd name="connsiteY4" fmla="*/ 31450 h 629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62895" h="62900">
                      <a:moveTo>
                        <a:pt x="62896" y="31450"/>
                      </a:moveTo>
                      <a:cubicBezTo>
                        <a:pt x="62896" y="48819"/>
                        <a:pt x="48816" y="62900"/>
                        <a:pt x="31448" y="62900"/>
                      </a:cubicBezTo>
                      <a:cubicBezTo>
                        <a:pt x="14080" y="62900"/>
                        <a:pt x="0" y="48819"/>
                        <a:pt x="0" y="31450"/>
                      </a:cubicBezTo>
                      <a:cubicBezTo>
                        <a:pt x="0" y="14081"/>
                        <a:pt x="14080" y="0"/>
                        <a:pt x="31448" y="0"/>
                      </a:cubicBezTo>
                      <a:cubicBezTo>
                        <a:pt x="48816" y="0"/>
                        <a:pt x="62896" y="14081"/>
                        <a:pt x="62896" y="31450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 w="5706" cap="flat">
                  <a:solidFill>
                    <a:srgbClr val="FF670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ja-JP" altLang="en-US" sz="1200"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415" name="フリーフォーム: 図形 414">
                  <a:extLst>
                    <a:ext uri="{FF2B5EF4-FFF2-40B4-BE49-F238E27FC236}">
                      <a16:creationId xmlns:a16="http://schemas.microsoft.com/office/drawing/2014/main" id="{5D872C1D-B6F5-DABB-4504-5CD95F9B5102}"/>
                    </a:ext>
                  </a:extLst>
                </p:cNvPr>
                <p:cNvSpPr/>
                <p:nvPr/>
              </p:nvSpPr>
              <p:spPr>
                <a:xfrm>
                  <a:off x="7728792" y="4646568"/>
                  <a:ext cx="62895" cy="62900"/>
                </a:xfrm>
                <a:custGeom>
                  <a:avLst/>
                  <a:gdLst>
                    <a:gd name="connsiteX0" fmla="*/ 62896 w 62895"/>
                    <a:gd name="connsiteY0" fmla="*/ 31450 h 62900"/>
                    <a:gd name="connsiteX1" fmla="*/ 31448 w 62895"/>
                    <a:gd name="connsiteY1" fmla="*/ 62900 h 62900"/>
                    <a:gd name="connsiteX2" fmla="*/ 0 w 62895"/>
                    <a:gd name="connsiteY2" fmla="*/ 31450 h 62900"/>
                    <a:gd name="connsiteX3" fmla="*/ 31448 w 62895"/>
                    <a:gd name="connsiteY3" fmla="*/ 0 h 62900"/>
                    <a:gd name="connsiteX4" fmla="*/ 62896 w 62895"/>
                    <a:gd name="connsiteY4" fmla="*/ 31450 h 629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62895" h="62900">
                      <a:moveTo>
                        <a:pt x="62896" y="31450"/>
                      </a:moveTo>
                      <a:cubicBezTo>
                        <a:pt x="62896" y="48819"/>
                        <a:pt x="48816" y="62900"/>
                        <a:pt x="31448" y="62900"/>
                      </a:cubicBezTo>
                      <a:cubicBezTo>
                        <a:pt x="14080" y="62900"/>
                        <a:pt x="0" y="48819"/>
                        <a:pt x="0" y="31450"/>
                      </a:cubicBezTo>
                      <a:cubicBezTo>
                        <a:pt x="0" y="14081"/>
                        <a:pt x="14080" y="0"/>
                        <a:pt x="31448" y="0"/>
                      </a:cubicBezTo>
                      <a:cubicBezTo>
                        <a:pt x="48816" y="0"/>
                        <a:pt x="62896" y="14081"/>
                        <a:pt x="62896" y="31450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 w="5706" cap="flat">
                  <a:solidFill>
                    <a:srgbClr val="FF670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ja-JP" altLang="en-US" sz="1200"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416" name="フリーフォーム: 図形 415">
                  <a:extLst>
                    <a:ext uri="{FF2B5EF4-FFF2-40B4-BE49-F238E27FC236}">
                      <a16:creationId xmlns:a16="http://schemas.microsoft.com/office/drawing/2014/main" id="{2EECAD26-D8FA-4561-3496-D07788B861CE}"/>
                    </a:ext>
                  </a:extLst>
                </p:cNvPr>
                <p:cNvSpPr/>
                <p:nvPr/>
              </p:nvSpPr>
              <p:spPr>
                <a:xfrm>
                  <a:off x="7805165" y="4642075"/>
                  <a:ext cx="62895" cy="62900"/>
                </a:xfrm>
                <a:custGeom>
                  <a:avLst/>
                  <a:gdLst>
                    <a:gd name="connsiteX0" fmla="*/ 62896 w 62895"/>
                    <a:gd name="connsiteY0" fmla="*/ 31450 h 62900"/>
                    <a:gd name="connsiteX1" fmla="*/ 31448 w 62895"/>
                    <a:gd name="connsiteY1" fmla="*/ 62900 h 62900"/>
                    <a:gd name="connsiteX2" fmla="*/ 0 w 62895"/>
                    <a:gd name="connsiteY2" fmla="*/ 31450 h 62900"/>
                    <a:gd name="connsiteX3" fmla="*/ 31448 w 62895"/>
                    <a:gd name="connsiteY3" fmla="*/ 0 h 62900"/>
                    <a:gd name="connsiteX4" fmla="*/ 62896 w 62895"/>
                    <a:gd name="connsiteY4" fmla="*/ 31450 h 629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62895" h="62900">
                      <a:moveTo>
                        <a:pt x="62896" y="31450"/>
                      </a:moveTo>
                      <a:cubicBezTo>
                        <a:pt x="62896" y="48819"/>
                        <a:pt x="48816" y="62900"/>
                        <a:pt x="31448" y="62900"/>
                      </a:cubicBezTo>
                      <a:cubicBezTo>
                        <a:pt x="14080" y="62900"/>
                        <a:pt x="0" y="48819"/>
                        <a:pt x="0" y="31450"/>
                      </a:cubicBezTo>
                      <a:cubicBezTo>
                        <a:pt x="0" y="14081"/>
                        <a:pt x="14080" y="0"/>
                        <a:pt x="31448" y="0"/>
                      </a:cubicBezTo>
                      <a:cubicBezTo>
                        <a:pt x="48816" y="0"/>
                        <a:pt x="62896" y="14081"/>
                        <a:pt x="62896" y="31450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 w="5706" cap="flat">
                  <a:solidFill>
                    <a:srgbClr val="FF670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ja-JP" altLang="en-US" sz="1200"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417" name="フリーフォーム: 図形 416">
                  <a:extLst>
                    <a:ext uri="{FF2B5EF4-FFF2-40B4-BE49-F238E27FC236}">
                      <a16:creationId xmlns:a16="http://schemas.microsoft.com/office/drawing/2014/main" id="{910DD322-2970-AE05-FD83-0EFF513DC5EA}"/>
                    </a:ext>
                  </a:extLst>
                </p:cNvPr>
                <p:cNvSpPr/>
                <p:nvPr/>
              </p:nvSpPr>
              <p:spPr>
                <a:xfrm>
                  <a:off x="7881539" y="4624103"/>
                  <a:ext cx="62895" cy="62900"/>
                </a:xfrm>
                <a:custGeom>
                  <a:avLst/>
                  <a:gdLst>
                    <a:gd name="connsiteX0" fmla="*/ 62896 w 62895"/>
                    <a:gd name="connsiteY0" fmla="*/ 31450 h 62900"/>
                    <a:gd name="connsiteX1" fmla="*/ 31448 w 62895"/>
                    <a:gd name="connsiteY1" fmla="*/ 62900 h 62900"/>
                    <a:gd name="connsiteX2" fmla="*/ 0 w 62895"/>
                    <a:gd name="connsiteY2" fmla="*/ 31450 h 62900"/>
                    <a:gd name="connsiteX3" fmla="*/ 31448 w 62895"/>
                    <a:gd name="connsiteY3" fmla="*/ 0 h 62900"/>
                    <a:gd name="connsiteX4" fmla="*/ 62896 w 62895"/>
                    <a:gd name="connsiteY4" fmla="*/ 31450 h 629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62895" h="62900">
                      <a:moveTo>
                        <a:pt x="62896" y="31450"/>
                      </a:moveTo>
                      <a:cubicBezTo>
                        <a:pt x="62896" y="48819"/>
                        <a:pt x="48816" y="62900"/>
                        <a:pt x="31448" y="62900"/>
                      </a:cubicBezTo>
                      <a:cubicBezTo>
                        <a:pt x="14080" y="62900"/>
                        <a:pt x="0" y="48819"/>
                        <a:pt x="0" y="31450"/>
                      </a:cubicBezTo>
                      <a:cubicBezTo>
                        <a:pt x="0" y="14081"/>
                        <a:pt x="14080" y="0"/>
                        <a:pt x="31448" y="0"/>
                      </a:cubicBezTo>
                      <a:cubicBezTo>
                        <a:pt x="48816" y="0"/>
                        <a:pt x="62896" y="14081"/>
                        <a:pt x="62896" y="31450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 w="5706" cap="flat">
                  <a:solidFill>
                    <a:srgbClr val="FF670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ja-JP" altLang="en-US" sz="1200"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418" name="フリーフォーム: 図形 417">
                  <a:extLst>
                    <a:ext uri="{FF2B5EF4-FFF2-40B4-BE49-F238E27FC236}">
                      <a16:creationId xmlns:a16="http://schemas.microsoft.com/office/drawing/2014/main" id="{8B7680DA-B545-7343-8EB7-6EE54B3D7F18}"/>
                    </a:ext>
                  </a:extLst>
                </p:cNvPr>
                <p:cNvSpPr/>
                <p:nvPr/>
              </p:nvSpPr>
              <p:spPr>
                <a:xfrm>
                  <a:off x="7805165" y="4592653"/>
                  <a:ext cx="62895" cy="62900"/>
                </a:xfrm>
                <a:custGeom>
                  <a:avLst/>
                  <a:gdLst>
                    <a:gd name="connsiteX0" fmla="*/ 62896 w 62895"/>
                    <a:gd name="connsiteY0" fmla="*/ 31450 h 62900"/>
                    <a:gd name="connsiteX1" fmla="*/ 31448 w 62895"/>
                    <a:gd name="connsiteY1" fmla="*/ 62900 h 62900"/>
                    <a:gd name="connsiteX2" fmla="*/ 0 w 62895"/>
                    <a:gd name="connsiteY2" fmla="*/ 31450 h 62900"/>
                    <a:gd name="connsiteX3" fmla="*/ 31448 w 62895"/>
                    <a:gd name="connsiteY3" fmla="*/ 0 h 62900"/>
                    <a:gd name="connsiteX4" fmla="*/ 62896 w 62895"/>
                    <a:gd name="connsiteY4" fmla="*/ 31450 h 629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62895" h="62900">
                      <a:moveTo>
                        <a:pt x="62896" y="31450"/>
                      </a:moveTo>
                      <a:cubicBezTo>
                        <a:pt x="62896" y="48819"/>
                        <a:pt x="48816" y="62900"/>
                        <a:pt x="31448" y="62900"/>
                      </a:cubicBezTo>
                      <a:cubicBezTo>
                        <a:pt x="14080" y="62900"/>
                        <a:pt x="0" y="48819"/>
                        <a:pt x="0" y="31450"/>
                      </a:cubicBezTo>
                      <a:cubicBezTo>
                        <a:pt x="0" y="14081"/>
                        <a:pt x="14080" y="0"/>
                        <a:pt x="31448" y="0"/>
                      </a:cubicBezTo>
                      <a:cubicBezTo>
                        <a:pt x="48816" y="0"/>
                        <a:pt x="62896" y="14081"/>
                        <a:pt x="62896" y="31450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 w="5706" cap="flat">
                  <a:solidFill>
                    <a:srgbClr val="FF670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ja-JP" altLang="en-US" sz="1200"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419" name="フリーフォーム: 図形 418">
                  <a:extLst>
                    <a:ext uri="{FF2B5EF4-FFF2-40B4-BE49-F238E27FC236}">
                      <a16:creationId xmlns:a16="http://schemas.microsoft.com/office/drawing/2014/main" id="{CB192CCE-C2BF-639F-BD72-3CD3E3E7DE02}"/>
                    </a:ext>
                  </a:extLst>
                </p:cNvPr>
                <p:cNvSpPr/>
                <p:nvPr/>
              </p:nvSpPr>
              <p:spPr>
                <a:xfrm>
                  <a:off x="7805165" y="4475839"/>
                  <a:ext cx="62895" cy="62900"/>
                </a:xfrm>
                <a:custGeom>
                  <a:avLst/>
                  <a:gdLst>
                    <a:gd name="connsiteX0" fmla="*/ 62896 w 62895"/>
                    <a:gd name="connsiteY0" fmla="*/ 31450 h 62900"/>
                    <a:gd name="connsiteX1" fmla="*/ 31448 w 62895"/>
                    <a:gd name="connsiteY1" fmla="*/ 62900 h 62900"/>
                    <a:gd name="connsiteX2" fmla="*/ 0 w 62895"/>
                    <a:gd name="connsiteY2" fmla="*/ 31450 h 62900"/>
                    <a:gd name="connsiteX3" fmla="*/ 31448 w 62895"/>
                    <a:gd name="connsiteY3" fmla="*/ 0 h 62900"/>
                    <a:gd name="connsiteX4" fmla="*/ 62896 w 62895"/>
                    <a:gd name="connsiteY4" fmla="*/ 31450 h 629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62895" h="62900">
                      <a:moveTo>
                        <a:pt x="62896" y="31450"/>
                      </a:moveTo>
                      <a:cubicBezTo>
                        <a:pt x="62896" y="48819"/>
                        <a:pt x="48816" y="62900"/>
                        <a:pt x="31448" y="62900"/>
                      </a:cubicBezTo>
                      <a:cubicBezTo>
                        <a:pt x="14080" y="62900"/>
                        <a:pt x="0" y="48819"/>
                        <a:pt x="0" y="31450"/>
                      </a:cubicBezTo>
                      <a:cubicBezTo>
                        <a:pt x="0" y="14081"/>
                        <a:pt x="14080" y="0"/>
                        <a:pt x="31448" y="0"/>
                      </a:cubicBezTo>
                      <a:cubicBezTo>
                        <a:pt x="48816" y="0"/>
                        <a:pt x="62896" y="14081"/>
                        <a:pt x="62896" y="31450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 w="5706" cap="flat">
                  <a:solidFill>
                    <a:srgbClr val="FF670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ja-JP" altLang="en-US" sz="1200"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420" name="フリーフォーム: 図形 419">
                  <a:extLst>
                    <a:ext uri="{FF2B5EF4-FFF2-40B4-BE49-F238E27FC236}">
                      <a16:creationId xmlns:a16="http://schemas.microsoft.com/office/drawing/2014/main" id="{0F62BA0B-936E-3EB6-DF5F-8A22B2CFC467}"/>
                    </a:ext>
                  </a:extLst>
                </p:cNvPr>
                <p:cNvSpPr/>
                <p:nvPr/>
              </p:nvSpPr>
              <p:spPr>
                <a:xfrm>
                  <a:off x="7805165" y="4412938"/>
                  <a:ext cx="62895" cy="62900"/>
                </a:xfrm>
                <a:custGeom>
                  <a:avLst/>
                  <a:gdLst>
                    <a:gd name="connsiteX0" fmla="*/ 62896 w 62895"/>
                    <a:gd name="connsiteY0" fmla="*/ 31450 h 62900"/>
                    <a:gd name="connsiteX1" fmla="*/ 31448 w 62895"/>
                    <a:gd name="connsiteY1" fmla="*/ 62900 h 62900"/>
                    <a:gd name="connsiteX2" fmla="*/ 0 w 62895"/>
                    <a:gd name="connsiteY2" fmla="*/ 31450 h 62900"/>
                    <a:gd name="connsiteX3" fmla="*/ 31448 w 62895"/>
                    <a:gd name="connsiteY3" fmla="*/ 0 h 62900"/>
                    <a:gd name="connsiteX4" fmla="*/ 62896 w 62895"/>
                    <a:gd name="connsiteY4" fmla="*/ 31450 h 629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62895" h="62900">
                      <a:moveTo>
                        <a:pt x="62896" y="31450"/>
                      </a:moveTo>
                      <a:cubicBezTo>
                        <a:pt x="62896" y="48819"/>
                        <a:pt x="48816" y="62900"/>
                        <a:pt x="31448" y="62900"/>
                      </a:cubicBezTo>
                      <a:cubicBezTo>
                        <a:pt x="14080" y="62900"/>
                        <a:pt x="0" y="48819"/>
                        <a:pt x="0" y="31450"/>
                      </a:cubicBezTo>
                      <a:cubicBezTo>
                        <a:pt x="0" y="14081"/>
                        <a:pt x="14080" y="0"/>
                        <a:pt x="31448" y="0"/>
                      </a:cubicBezTo>
                      <a:cubicBezTo>
                        <a:pt x="48816" y="0"/>
                        <a:pt x="62896" y="14081"/>
                        <a:pt x="62896" y="31450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 w="5706" cap="flat">
                  <a:solidFill>
                    <a:srgbClr val="FF670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ja-JP" altLang="en-US" sz="1200"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421" name="フリーフォーム: 図形 420">
                  <a:extLst>
                    <a:ext uri="{FF2B5EF4-FFF2-40B4-BE49-F238E27FC236}">
                      <a16:creationId xmlns:a16="http://schemas.microsoft.com/office/drawing/2014/main" id="{FDCE8DD6-4CE8-FB73-5934-4E893D182E99}"/>
                    </a:ext>
                  </a:extLst>
                </p:cNvPr>
                <p:cNvSpPr/>
                <p:nvPr/>
              </p:nvSpPr>
              <p:spPr>
                <a:xfrm>
                  <a:off x="7805165" y="4359024"/>
                  <a:ext cx="62895" cy="62900"/>
                </a:xfrm>
                <a:custGeom>
                  <a:avLst/>
                  <a:gdLst>
                    <a:gd name="connsiteX0" fmla="*/ 62896 w 62895"/>
                    <a:gd name="connsiteY0" fmla="*/ 31450 h 62900"/>
                    <a:gd name="connsiteX1" fmla="*/ 31448 w 62895"/>
                    <a:gd name="connsiteY1" fmla="*/ 62900 h 62900"/>
                    <a:gd name="connsiteX2" fmla="*/ 0 w 62895"/>
                    <a:gd name="connsiteY2" fmla="*/ 31450 h 62900"/>
                    <a:gd name="connsiteX3" fmla="*/ 31448 w 62895"/>
                    <a:gd name="connsiteY3" fmla="*/ 0 h 62900"/>
                    <a:gd name="connsiteX4" fmla="*/ 62896 w 62895"/>
                    <a:gd name="connsiteY4" fmla="*/ 31450 h 629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62895" h="62900">
                      <a:moveTo>
                        <a:pt x="62896" y="31450"/>
                      </a:moveTo>
                      <a:cubicBezTo>
                        <a:pt x="62896" y="48819"/>
                        <a:pt x="48816" y="62900"/>
                        <a:pt x="31448" y="62900"/>
                      </a:cubicBezTo>
                      <a:cubicBezTo>
                        <a:pt x="14080" y="62900"/>
                        <a:pt x="0" y="48819"/>
                        <a:pt x="0" y="31450"/>
                      </a:cubicBezTo>
                      <a:cubicBezTo>
                        <a:pt x="0" y="14081"/>
                        <a:pt x="14080" y="0"/>
                        <a:pt x="31448" y="0"/>
                      </a:cubicBezTo>
                      <a:cubicBezTo>
                        <a:pt x="48816" y="0"/>
                        <a:pt x="62896" y="14081"/>
                        <a:pt x="62896" y="31450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 w="5706" cap="flat">
                  <a:solidFill>
                    <a:srgbClr val="FF670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ja-JP" altLang="en-US" sz="1200"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422" name="フリーフォーム: 図形 421">
                  <a:extLst>
                    <a:ext uri="{FF2B5EF4-FFF2-40B4-BE49-F238E27FC236}">
                      <a16:creationId xmlns:a16="http://schemas.microsoft.com/office/drawing/2014/main" id="{AA34932B-BAC3-F6C0-080B-7AD9B7338FCD}"/>
                    </a:ext>
                  </a:extLst>
                </p:cNvPr>
                <p:cNvSpPr/>
                <p:nvPr/>
              </p:nvSpPr>
              <p:spPr>
                <a:xfrm>
                  <a:off x="7805165" y="4264674"/>
                  <a:ext cx="62895" cy="62900"/>
                </a:xfrm>
                <a:custGeom>
                  <a:avLst/>
                  <a:gdLst>
                    <a:gd name="connsiteX0" fmla="*/ 62896 w 62895"/>
                    <a:gd name="connsiteY0" fmla="*/ 31450 h 62900"/>
                    <a:gd name="connsiteX1" fmla="*/ 31448 w 62895"/>
                    <a:gd name="connsiteY1" fmla="*/ 62900 h 62900"/>
                    <a:gd name="connsiteX2" fmla="*/ 0 w 62895"/>
                    <a:gd name="connsiteY2" fmla="*/ 31450 h 62900"/>
                    <a:gd name="connsiteX3" fmla="*/ 31448 w 62895"/>
                    <a:gd name="connsiteY3" fmla="*/ 0 h 62900"/>
                    <a:gd name="connsiteX4" fmla="*/ 62896 w 62895"/>
                    <a:gd name="connsiteY4" fmla="*/ 31450 h 629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62895" h="62900">
                      <a:moveTo>
                        <a:pt x="62896" y="31450"/>
                      </a:moveTo>
                      <a:cubicBezTo>
                        <a:pt x="62896" y="48819"/>
                        <a:pt x="48816" y="62900"/>
                        <a:pt x="31448" y="62900"/>
                      </a:cubicBezTo>
                      <a:cubicBezTo>
                        <a:pt x="14080" y="62900"/>
                        <a:pt x="0" y="48819"/>
                        <a:pt x="0" y="31450"/>
                      </a:cubicBezTo>
                      <a:cubicBezTo>
                        <a:pt x="0" y="14081"/>
                        <a:pt x="14080" y="0"/>
                        <a:pt x="31448" y="0"/>
                      </a:cubicBezTo>
                      <a:cubicBezTo>
                        <a:pt x="48816" y="0"/>
                        <a:pt x="62896" y="14081"/>
                        <a:pt x="62896" y="31450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 w="5706" cap="flat">
                  <a:solidFill>
                    <a:srgbClr val="FF670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ja-JP" altLang="en-US" sz="1200"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423" name="フリーフォーム: 図形 422">
                  <a:extLst>
                    <a:ext uri="{FF2B5EF4-FFF2-40B4-BE49-F238E27FC236}">
                      <a16:creationId xmlns:a16="http://schemas.microsoft.com/office/drawing/2014/main" id="{06645DEA-3D11-B9B3-0D36-90D1C4461B1D}"/>
                    </a:ext>
                  </a:extLst>
                </p:cNvPr>
                <p:cNvSpPr/>
                <p:nvPr/>
              </p:nvSpPr>
              <p:spPr>
                <a:xfrm>
                  <a:off x="7769225" y="4219745"/>
                  <a:ext cx="62895" cy="62900"/>
                </a:xfrm>
                <a:custGeom>
                  <a:avLst/>
                  <a:gdLst>
                    <a:gd name="connsiteX0" fmla="*/ 62896 w 62895"/>
                    <a:gd name="connsiteY0" fmla="*/ 31450 h 62900"/>
                    <a:gd name="connsiteX1" fmla="*/ 31448 w 62895"/>
                    <a:gd name="connsiteY1" fmla="*/ 62900 h 62900"/>
                    <a:gd name="connsiteX2" fmla="*/ 0 w 62895"/>
                    <a:gd name="connsiteY2" fmla="*/ 31450 h 62900"/>
                    <a:gd name="connsiteX3" fmla="*/ 31448 w 62895"/>
                    <a:gd name="connsiteY3" fmla="*/ 0 h 62900"/>
                    <a:gd name="connsiteX4" fmla="*/ 62896 w 62895"/>
                    <a:gd name="connsiteY4" fmla="*/ 31450 h 629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62895" h="62900">
                      <a:moveTo>
                        <a:pt x="62896" y="31450"/>
                      </a:moveTo>
                      <a:cubicBezTo>
                        <a:pt x="62896" y="48819"/>
                        <a:pt x="48816" y="62900"/>
                        <a:pt x="31448" y="62900"/>
                      </a:cubicBezTo>
                      <a:cubicBezTo>
                        <a:pt x="14080" y="62900"/>
                        <a:pt x="0" y="48819"/>
                        <a:pt x="0" y="31450"/>
                      </a:cubicBezTo>
                      <a:cubicBezTo>
                        <a:pt x="0" y="14081"/>
                        <a:pt x="14080" y="0"/>
                        <a:pt x="31448" y="0"/>
                      </a:cubicBezTo>
                      <a:cubicBezTo>
                        <a:pt x="48816" y="0"/>
                        <a:pt x="62896" y="14081"/>
                        <a:pt x="62896" y="31450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 w="5706" cap="flat">
                  <a:solidFill>
                    <a:srgbClr val="FF670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ja-JP" altLang="en-US" sz="1200"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424" name="フリーフォーム: 図形 423">
                  <a:extLst>
                    <a:ext uri="{FF2B5EF4-FFF2-40B4-BE49-F238E27FC236}">
                      <a16:creationId xmlns:a16="http://schemas.microsoft.com/office/drawing/2014/main" id="{DF11BC0C-7029-8FBF-476A-F9A6D51CA27B}"/>
                    </a:ext>
                  </a:extLst>
                </p:cNvPr>
                <p:cNvSpPr/>
                <p:nvPr/>
              </p:nvSpPr>
              <p:spPr>
                <a:xfrm>
                  <a:off x="7845598" y="4215252"/>
                  <a:ext cx="62895" cy="62900"/>
                </a:xfrm>
                <a:custGeom>
                  <a:avLst/>
                  <a:gdLst>
                    <a:gd name="connsiteX0" fmla="*/ 62896 w 62895"/>
                    <a:gd name="connsiteY0" fmla="*/ 31450 h 62900"/>
                    <a:gd name="connsiteX1" fmla="*/ 31448 w 62895"/>
                    <a:gd name="connsiteY1" fmla="*/ 62900 h 62900"/>
                    <a:gd name="connsiteX2" fmla="*/ 0 w 62895"/>
                    <a:gd name="connsiteY2" fmla="*/ 31450 h 62900"/>
                    <a:gd name="connsiteX3" fmla="*/ 31448 w 62895"/>
                    <a:gd name="connsiteY3" fmla="*/ 0 h 62900"/>
                    <a:gd name="connsiteX4" fmla="*/ 62896 w 62895"/>
                    <a:gd name="connsiteY4" fmla="*/ 31450 h 629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62895" h="62900">
                      <a:moveTo>
                        <a:pt x="62896" y="31450"/>
                      </a:moveTo>
                      <a:cubicBezTo>
                        <a:pt x="62896" y="48819"/>
                        <a:pt x="48816" y="62900"/>
                        <a:pt x="31448" y="62900"/>
                      </a:cubicBezTo>
                      <a:cubicBezTo>
                        <a:pt x="14080" y="62900"/>
                        <a:pt x="0" y="48819"/>
                        <a:pt x="0" y="31450"/>
                      </a:cubicBezTo>
                      <a:cubicBezTo>
                        <a:pt x="0" y="14081"/>
                        <a:pt x="14080" y="0"/>
                        <a:pt x="31448" y="0"/>
                      </a:cubicBezTo>
                      <a:cubicBezTo>
                        <a:pt x="48816" y="0"/>
                        <a:pt x="62896" y="14081"/>
                        <a:pt x="62896" y="31450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 w="5706" cap="flat">
                  <a:solidFill>
                    <a:srgbClr val="FF670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ja-JP" altLang="en-US" sz="1200"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425" name="フリーフォーム: 図形 424">
                  <a:extLst>
                    <a:ext uri="{FF2B5EF4-FFF2-40B4-BE49-F238E27FC236}">
                      <a16:creationId xmlns:a16="http://schemas.microsoft.com/office/drawing/2014/main" id="{32A9B481-2AB8-6EFF-65D2-2D12C814F6A0}"/>
                    </a:ext>
                  </a:extLst>
                </p:cNvPr>
                <p:cNvSpPr/>
                <p:nvPr/>
              </p:nvSpPr>
              <p:spPr>
                <a:xfrm>
                  <a:off x="7805165" y="4165830"/>
                  <a:ext cx="62895" cy="62900"/>
                </a:xfrm>
                <a:custGeom>
                  <a:avLst/>
                  <a:gdLst>
                    <a:gd name="connsiteX0" fmla="*/ 62896 w 62895"/>
                    <a:gd name="connsiteY0" fmla="*/ 31450 h 62900"/>
                    <a:gd name="connsiteX1" fmla="*/ 31448 w 62895"/>
                    <a:gd name="connsiteY1" fmla="*/ 62900 h 62900"/>
                    <a:gd name="connsiteX2" fmla="*/ 0 w 62895"/>
                    <a:gd name="connsiteY2" fmla="*/ 31450 h 62900"/>
                    <a:gd name="connsiteX3" fmla="*/ 31448 w 62895"/>
                    <a:gd name="connsiteY3" fmla="*/ 0 h 62900"/>
                    <a:gd name="connsiteX4" fmla="*/ 62896 w 62895"/>
                    <a:gd name="connsiteY4" fmla="*/ 31450 h 629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62895" h="62900">
                      <a:moveTo>
                        <a:pt x="62896" y="31450"/>
                      </a:moveTo>
                      <a:cubicBezTo>
                        <a:pt x="62896" y="48819"/>
                        <a:pt x="48816" y="62900"/>
                        <a:pt x="31448" y="62900"/>
                      </a:cubicBezTo>
                      <a:cubicBezTo>
                        <a:pt x="14080" y="62900"/>
                        <a:pt x="0" y="48819"/>
                        <a:pt x="0" y="31450"/>
                      </a:cubicBezTo>
                      <a:cubicBezTo>
                        <a:pt x="0" y="14081"/>
                        <a:pt x="14080" y="0"/>
                        <a:pt x="31448" y="0"/>
                      </a:cubicBezTo>
                      <a:cubicBezTo>
                        <a:pt x="48816" y="0"/>
                        <a:pt x="62896" y="14081"/>
                        <a:pt x="62896" y="31450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 w="5706" cap="flat">
                  <a:solidFill>
                    <a:srgbClr val="FF670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ja-JP" altLang="en-US" sz="1200"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426" name="フリーフォーム: 図形 425">
                  <a:extLst>
                    <a:ext uri="{FF2B5EF4-FFF2-40B4-BE49-F238E27FC236}">
                      <a16:creationId xmlns:a16="http://schemas.microsoft.com/office/drawing/2014/main" id="{B10AA2D4-DC1C-8168-88B8-A7076504FCC1}"/>
                    </a:ext>
                  </a:extLst>
                </p:cNvPr>
                <p:cNvSpPr/>
                <p:nvPr/>
              </p:nvSpPr>
              <p:spPr>
                <a:xfrm>
                  <a:off x="7769225" y="4058001"/>
                  <a:ext cx="62895" cy="62900"/>
                </a:xfrm>
                <a:custGeom>
                  <a:avLst/>
                  <a:gdLst>
                    <a:gd name="connsiteX0" fmla="*/ 62896 w 62895"/>
                    <a:gd name="connsiteY0" fmla="*/ 31450 h 62900"/>
                    <a:gd name="connsiteX1" fmla="*/ 31448 w 62895"/>
                    <a:gd name="connsiteY1" fmla="*/ 62900 h 62900"/>
                    <a:gd name="connsiteX2" fmla="*/ 0 w 62895"/>
                    <a:gd name="connsiteY2" fmla="*/ 31450 h 62900"/>
                    <a:gd name="connsiteX3" fmla="*/ 31448 w 62895"/>
                    <a:gd name="connsiteY3" fmla="*/ 0 h 62900"/>
                    <a:gd name="connsiteX4" fmla="*/ 62896 w 62895"/>
                    <a:gd name="connsiteY4" fmla="*/ 31450 h 629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62895" h="62900">
                      <a:moveTo>
                        <a:pt x="62896" y="31450"/>
                      </a:moveTo>
                      <a:cubicBezTo>
                        <a:pt x="62896" y="48819"/>
                        <a:pt x="48816" y="62900"/>
                        <a:pt x="31448" y="62900"/>
                      </a:cubicBezTo>
                      <a:cubicBezTo>
                        <a:pt x="14080" y="62900"/>
                        <a:pt x="0" y="48819"/>
                        <a:pt x="0" y="31450"/>
                      </a:cubicBezTo>
                      <a:cubicBezTo>
                        <a:pt x="0" y="14081"/>
                        <a:pt x="14080" y="0"/>
                        <a:pt x="31448" y="0"/>
                      </a:cubicBezTo>
                      <a:cubicBezTo>
                        <a:pt x="48816" y="0"/>
                        <a:pt x="62896" y="14081"/>
                        <a:pt x="62896" y="31450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 w="5706" cap="flat">
                  <a:solidFill>
                    <a:srgbClr val="FF670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ja-JP" altLang="en-US" sz="1200"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427" name="フリーフォーム: 図形 426">
                  <a:extLst>
                    <a:ext uri="{FF2B5EF4-FFF2-40B4-BE49-F238E27FC236}">
                      <a16:creationId xmlns:a16="http://schemas.microsoft.com/office/drawing/2014/main" id="{F8782263-003F-99EB-4023-4F92D5C108C9}"/>
                    </a:ext>
                  </a:extLst>
                </p:cNvPr>
                <p:cNvSpPr/>
                <p:nvPr/>
              </p:nvSpPr>
              <p:spPr>
                <a:xfrm>
                  <a:off x="7845598" y="4049016"/>
                  <a:ext cx="62895" cy="62900"/>
                </a:xfrm>
                <a:custGeom>
                  <a:avLst/>
                  <a:gdLst>
                    <a:gd name="connsiteX0" fmla="*/ 62896 w 62895"/>
                    <a:gd name="connsiteY0" fmla="*/ 31450 h 62900"/>
                    <a:gd name="connsiteX1" fmla="*/ 31448 w 62895"/>
                    <a:gd name="connsiteY1" fmla="*/ 62900 h 62900"/>
                    <a:gd name="connsiteX2" fmla="*/ 0 w 62895"/>
                    <a:gd name="connsiteY2" fmla="*/ 31450 h 62900"/>
                    <a:gd name="connsiteX3" fmla="*/ 31448 w 62895"/>
                    <a:gd name="connsiteY3" fmla="*/ 0 h 62900"/>
                    <a:gd name="connsiteX4" fmla="*/ 62896 w 62895"/>
                    <a:gd name="connsiteY4" fmla="*/ 31450 h 629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62895" h="62900">
                      <a:moveTo>
                        <a:pt x="62896" y="31450"/>
                      </a:moveTo>
                      <a:cubicBezTo>
                        <a:pt x="62896" y="48819"/>
                        <a:pt x="48816" y="62900"/>
                        <a:pt x="31448" y="62900"/>
                      </a:cubicBezTo>
                      <a:cubicBezTo>
                        <a:pt x="14080" y="62900"/>
                        <a:pt x="0" y="48819"/>
                        <a:pt x="0" y="31450"/>
                      </a:cubicBezTo>
                      <a:cubicBezTo>
                        <a:pt x="0" y="14081"/>
                        <a:pt x="14080" y="0"/>
                        <a:pt x="31448" y="0"/>
                      </a:cubicBezTo>
                      <a:cubicBezTo>
                        <a:pt x="48816" y="0"/>
                        <a:pt x="62896" y="14081"/>
                        <a:pt x="62896" y="31450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 w="5706" cap="flat">
                  <a:solidFill>
                    <a:srgbClr val="FF670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ja-JP" altLang="en-US" sz="1200"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428" name="フリーフォーム: 図形 427">
                  <a:extLst>
                    <a:ext uri="{FF2B5EF4-FFF2-40B4-BE49-F238E27FC236}">
                      <a16:creationId xmlns:a16="http://schemas.microsoft.com/office/drawing/2014/main" id="{39E84E70-972D-E4F8-8D1B-80C3E7E4F638}"/>
                    </a:ext>
                  </a:extLst>
                </p:cNvPr>
                <p:cNvSpPr/>
                <p:nvPr/>
              </p:nvSpPr>
              <p:spPr>
                <a:xfrm>
                  <a:off x="7805165" y="3977130"/>
                  <a:ext cx="62895" cy="62900"/>
                </a:xfrm>
                <a:custGeom>
                  <a:avLst/>
                  <a:gdLst>
                    <a:gd name="connsiteX0" fmla="*/ 62896 w 62895"/>
                    <a:gd name="connsiteY0" fmla="*/ 31450 h 62900"/>
                    <a:gd name="connsiteX1" fmla="*/ 31448 w 62895"/>
                    <a:gd name="connsiteY1" fmla="*/ 62900 h 62900"/>
                    <a:gd name="connsiteX2" fmla="*/ 0 w 62895"/>
                    <a:gd name="connsiteY2" fmla="*/ 31450 h 62900"/>
                    <a:gd name="connsiteX3" fmla="*/ 31448 w 62895"/>
                    <a:gd name="connsiteY3" fmla="*/ 0 h 62900"/>
                    <a:gd name="connsiteX4" fmla="*/ 62896 w 62895"/>
                    <a:gd name="connsiteY4" fmla="*/ 31450 h 629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62895" h="62900">
                      <a:moveTo>
                        <a:pt x="62896" y="31450"/>
                      </a:moveTo>
                      <a:cubicBezTo>
                        <a:pt x="62896" y="48819"/>
                        <a:pt x="48816" y="62900"/>
                        <a:pt x="31448" y="62900"/>
                      </a:cubicBezTo>
                      <a:cubicBezTo>
                        <a:pt x="14080" y="62900"/>
                        <a:pt x="0" y="48819"/>
                        <a:pt x="0" y="31450"/>
                      </a:cubicBezTo>
                      <a:cubicBezTo>
                        <a:pt x="0" y="14081"/>
                        <a:pt x="14080" y="0"/>
                        <a:pt x="31448" y="0"/>
                      </a:cubicBezTo>
                      <a:cubicBezTo>
                        <a:pt x="48816" y="0"/>
                        <a:pt x="62896" y="14081"/>
                        <a:pt x="62896" y="31450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 w="5706" cap="flat">
                  <a:solidFill>
                    <a:srgbClr val="FF670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ja-JP" altLang="en-US" sz="1200"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429" name="フリーフォーム: 図形 428">
                  <a:extLst>
                    <a:ext uri="{FF2B5EF4-FFF2-40B4-BE49-F238E27FC236}">
                      <a16:creationId xmlns:a16="http://schemas.microsoft.com/office/drawing/2014/main" id="{2B7FC4ED-EC39-51D0-AF8C-78A483C7A860}"/>
                    </a:ext>
                  </a:extLst>
                </p:cNvPr>
                <p:cNvSpPr/>
                <p:nvPr/>
              </p:nvSpPr>
              <p:spPr>
                <a:xfrm>
                  <a:off x="7728792" y="3900751"/>
                  <a:ext cx="62895" cy="62900"/>
                </a:xfrm>
                <a:custGeom>
                  <a:avLst/>
                  <a:gdLst>
                    <a:gd name="connsiteX0" fmla="*/ 62896 w 62895"/>
                    <a:gd name="connsiteY0" fmla="*/ 31450 h 62900"/>
                    <a:gd name="connsiteX1" fmla="*/ 31448 w 62895"/>
                    <a:gd name="connsiteY1" fmla="*/ 62900 h 62900"/>
                    <a:gd name="connsiteX2" fmla="*/ 0 w 62895"/>
                    <a:gd name="connsiteY2" fmla="*/ 31450 h 62900"/>
                    <a:gd name="connsiteX3" fmla="*/ 31448 w 62895"/>
                    <a:gd name="connsiteY3" fmla="*/ 0 h 62900"/>
                    <a:gd name="connsiteX4" fmla="*/ 62896 w 62895"/>
                    <a:gd name="connsiteY4" fmla="*/ 31450 h 629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62895" h="62900">
                      <a:moveTo>
                        <a:pt x="62896" y="31450"/>
                      </a:moveTo>
                      <a:cubicBezTo>
                        <a:pt x="62896" y="48819"/>
                        <a:pt x="48816" y="62900"/>
                        <a:pt x="31448" y="62900"/>
                      </a:cubicBezTo>
                      <a:cubicBezTo>
                        <a:pt x="14080" y="62900"/>
                        <a:pt x="0" y="48819"/>
                        <a:pt x="0" y="31450"/>
                      </a:cubicBezTo>
                      <a:cubicBezTo>
                        <a:pt x="0" y="14081"/>
                        <a:pt x="14080" y="0"/>
                        <a:pt x="31448" y="0"/>
                      </a:cubicBezTo>
                      <a:cubicBezTo>
                        <a:pt x="48816" y="0"/>
                        <a:pt x="62896" y="14081"/>
                        <a:pt x="62896" y="31450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 w="5706" cap="flat">
                  <a:solidFill>
                    <a:srgbClr val="FF670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ja-JP" altLang="en-US" sz="1200"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430" name="フリーフォーム: 図形 429">
                  <a:extLst>
                    <a:ext uri="{FF2B5EF4-FFF2-40B4-BE49-F238E27FC236}">
                      <a16:creationId xmlns:a16="http://schemas.microsoft.com/office/drawing/2014/main" id="{7AD31416-1A9C-7C08-4240-BABB4BCBDB1D}"/>
                    </a:ext>
                  </a:extLst>
                </p:cNvPr>
                <p:cNvSpPr/>
                <p:nvPr/>
              </p:nvSpPr>
              <p:spPr>
                <a:xfrm>
                  <a:off x="7805165" y="3896258"/>
                  <a:ext cx="62895" cy="62900"/>
                </a:xfrm>
                <a:custGeom>
                  <a:avLst/>
                  <a:gdLst>
                    <a:gd name="connsiteX0" fmla="*/ 62896 w 62895"/>
                    <a:gd name="connsiteY0" fmla="*/ 31450 h 62900"/>
                    <a:gd name="connsiteX1" fmla="*/ 31448 w 62895"/>
                    <a:gd name="connsiteY1" fmla="*/ 62900 h 62900"/>
                    <a:gd name="connsiteX2" fmla="*/ 0 w 62895"/>
                    <a:gd name="connsiteY2" fmla="*/ 31450 h 62900"/>
                    <a:gd name="connsiteX3" fmla="*/ 31448 w 62895"/>
                    <a:gd name="connsiteY3" fmla="*/ 0 h 62900"/>
                    <a:gd name="connsiteX4" fmla="*/ 62896 w 62895"/>
                    <a:gd name="connsiteY4" fmla="*/ 31450 h 629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62895" h="62900">
                      <a:moveTo>
                        <a:pt x="62896" y="31450"/>
                      </a:moveTo>
                      <a:cubicBezTo>
                        <a:pt x="62896" y="48819"/>
                        <a:pt x="48816" y="62900"/>
                        <a:pt x="31448" y="62900"/>
                      </a:cubicBezTo>
                      <a:cubicBezTo>
                        <a:pt x="14080" y="62900"/>
                        <a:pt x="0" y="48819"/>
                        <a:pt x="0" y="31450"/>
                      </a:cubicBezTo>
                      <a:cubicBezTo>
                        <a:pt x="0" y="14081"/>
                        <a:pt x="14080" y="0"/>
                        <a:pt x="31448" y="0"/>
                      </a:cubicBezTo>
                      <a:cubicBezTo>
                        <a:pt x="48816" y="0"/>
                        <a:pt x="62896" y="14081"/>
                        <a:pt x="62896" y="31450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 w="5706" cap="flat">
                  <a:solidFill>
                    <a:srgbClr val="FF670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ja-JP" altLang="en-US" sz="1200"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431" name="フリーフォーム: 図形 430">
                  <a:extLst>
                    <a:ext uri="{FF2B5EF4-FFF2-40B4-BE49-F238E27FC236}">
                      <a16:creationId xmlns:a16="http://schemas.microsoft.com/office/drawing/2014/main" id="{D5819166-5C56-17A2-7DED-AA3ACB42E4BA}"/>
                    </a:ext>
                  </a:extLst>
                </p:cNvPr>
                <p:cNvSpPr/>
                <p:nvPr/>
              </p:nvSpPr>
              <p:spPr>
                <a:xfrm>
                  <a:off x="7881539" y="3860315"/>
                  <a:ext cx="62895" cy="62900"/>
                </a:xfrm>
                <a:custGeom>
                  <a:avLst/>
                  <a:gdLst>
                    <a:gd name="connsiteX0" fmla="*/ 62896 w 62895"/>
                    <a:gd name="connsiteY0" fmla="*/ 31450 h 62900"/>
                    <a:gd name="connsiteX1" fmla="*/ 31448 w 62895"/>
                    <a:gd name="connsiteY1" fmla="*/ 62900 h 62900"/>
                    <a:gd name="connsiteX2" fmla="*/ 0 w 62895"/>
                    <a:gd name="connsiteY2" fmla="*/ 31450 h 62900"/>
                    <a:gd name="connsiteX3" fmla="*/ 31448 w 62895"/>
                    <a:gd name="connsiteY3" fmla="*/ 0 h 62900"/>
                    <a:gd name="connsiteX4" fmla="*/ 62896 w 62895"/>
                    <a:gd name="connsiteY4" fmla="*/ 31450 h 629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62895" h="62900">
                      <a:moveTo>
                        <a:pt x="62896" y="31450"/>
                      </a:moveTo>
                      <a:cubicBezTo>
                        <a:pt x="62896" y="48819"/>
                        <a:pt x="48816" y="62900"/>
                        <a:pt x="31448" y="62900"/>
                      </a:cubicBezTo>
                      <a:cubicBezTo>
                        <a:pt x="14080" y="62900"/>
                        <a:pt x="0" y="48819"/>
                        <a:pt x="0" y="31450"/>
                      </a:cubicBezTo>
                      <a:cubicBezTo>
                        <a:pt x="0" y="14081"/>
                        <a:pt x="14080" y="0"/>
                        <a:pt x="31448" y="0"/>
                      </a:cubicBezTo>
                      <a:cubicBezTo>
                        <a:pt x="48816" y="0"/>
                        <a:pt x="62896" y="14081"/>
                        <a:pt x="62896" y="31450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 w="5706" cap="flat">
                  <a:solidFill>
                    <a:srgbClr val="FF670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ja-JP" altLang="en-US" sz="1200"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432" name="フリーフォーム: 図形 431">
                  <a:extLst>
                    <a:ext uri="{FF2B5EF4-FFF2-40B4-BE49-F238E27FC236}">
                      <a16:creationId xmlns:a16="http://schemas.microsoft.com/office/drawing/2014/main" id="{E4B7255A-2FD6-BDDA-05CD-3630E2193684}"/>
                    </a:ext>
                  </a:extLst>
                </p:cNvPr>
                <p:cNvSpPr/>
                <p:nvPr/>
              </p:nvSpPr>
              <p:spPr>
                <a:xfrm>
                  <a:off x="7805165" y="3837851"/>
                  <a:ext cx="62895" cy="62900"/>
                </a:xfrm>
                <a:custGeom>
                  <a:avLst/>
                  <a:gdLst>
                    <a:gd name="connsiteX0" fmla="*/ 62896 w 62895"/>
                    <a:gd name="connsiteY0" fmla="*/ 31450 h 62900"/>
                    <a:gd name="connsiteX1" fmla="*/ 31448 w 62895"/>
                    <a:gd name="connsiteY1" fmla="*/ 62900 h 62900"/>
                    <a:gd name="connsiteX2" fmla="*/ 0 w 62895"/>
                    <a:gd name="connsiteY2" fmla="*/ 31450 h 62900"/>
                    <a:gd name="connsiteX3" fmla="*/ 31448 w 62895"/>
                    <a:gd name="connsiteY3" fmla="*/ 0 h 62900"/>
                    <a:gd name="connsiteX4" fmla="*/ 62896 w 62895"/>
                    <a:gd name="connsiteY4" fmla="*/ 31450 h 629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62895" h="62900">
                      <a:moveTo>
                        <a:pt x="62896" y="31450"/>
                      </a:moveTo>
                      <a:cubicBezTo>
                        <a:pt x="62896" y="48819"/>
                        <a:pt x="48816" y="62900"/>
                        <a:pt x="31448" y="62900"/>
                      </a:cubicBezTo>
                      <a:cubicBezTo>
                        <a:pt x="14080" y="62900"/>
                        <a:pt x="0" y="48819"/>
                        <a:pt x="0" y="31450"/>
                      </a:cubicBezTo>
                      <a:cubicBezTo>
                        <a:pt x="0" y="14081"/>
                        <a:pt x="14080" y="0"/>
                        <a:pt x="31448" y="0"/>
                      </a:cubicBezTo>
                      <a:cubicBezTo>
                        <a:pt x="48816" y="0"/>
                        <a:pt x="62896" y="14081"/>
                        <a:pt x="62896" y="31450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 w="5706" cap="flat">
                  <a:solidFill>
                    <a:srgbClr val="FF670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ja-JP" altLang="en-US" sz="1200"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433" name="フリーフォーム: 図形 432">
                  <a:extLst>
                    <a:ext uri="{FF2B5EF4-FFF2-40B4-BE49-F238E27FC236}">
                      <a16:creationId xmlns:a16="http://schemas.microsoft.com/office/drawing/2014/main" id="{372A05DC-1DED-1713-68F9-40E05F651146}"/>
                    </a:ext>
                  </a:extLst>
                </p:cNvPr>
                <p:cNvSpPr/>
                <p:nvPr/>
              </p:nvSpPr>
              <p:spPr>
                <a:xfrm>
                  <a:off x="7805165" y="3756979"/>
                  <a:ext cx="62895" cy="62900"/>
                </a:xfrm>
                <a:custGeom>
                  <a:avLst/>
                  <a:gdLst>
                    <a:gd name="connsiteX0" fmla="*/ 62896 w 62895"/>
                    <a:gd name="connsiteY0" fmla="*/ 31450 h 62900"/>
                    <a:gd name="connsiteX1" fmla="*/ 31448 w 62895"/>
                    <a:gd name="connsiteY1" fmla="*/ 62900 h 62900"/>
                    <a:gd name="connsiteX2" fmla="*/ 0 w 62895"/>
                    <a:gd name="connsiteY2" fmla="*/ 31450 h 62900"/>
                    <a:gd name="connsiteX3" fmla="*/ 31448 w 62895"/>
                    <a:gd name="connsiteY3" fmla="*/ 0 h 62900"/>
                    <a:gd name="connsiteX4" fmla="*/ 62896 w 62895"/>
                    <a:gd name="connsiteY4" fmla="*/ 31450 h 629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62895" h="62900">
                      <a:moveTo>
                        <a:pt x="62896" y="31450"/>
                      </a:moveTo>
                      <a:cubicBezTo>
                        <a:pt x="62896" y="48819"/>
                        <a:pt x="48816" y="62900"/>
                        <a:pt x="31448" y="62900"/>
                      </a:cubicBezTo>
                      <a:cubicBezTo>
                        <a:pt x="14080" y="62900"/>
                        <a:pt x="0" y="48819"/>
                        <a:pt x="0" y="31450"/>
                      </a:cubicBezTo>
                      <a:cubicBezTo>
                        <a:pt x="0" y="14081"/>
                        <a:pt x="14080" y="0"/>
                        <a:pt x="31448" y="0"/>
                      </a:cubicBezTo>
                      <a:cubicBezTo>
                        <a:pt x="48816" y="0"/>
                        <a:pt x="62896" y="14081"/>
                        <a:pt x="62896" y="31450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 w="5706" cap="flat">
                  <a:solidFill>
                    <a:srgbClr val="FF670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ja-JP" altLang="en-US" sz="1200"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434" name="フリーフォーム: 図形 433">
                  <a:extLst>
                    <a:ext uri="{FF2B5EF4-FFF2-40B4-BE49-F238E27FC236}">
                      <a16:creationId xmlns:a16="http://schemas.microsoft.com/office/drawing/2014/main" id="{0E582A32-238D-27D5-9471-C3EABDC00D75}"/>
                    </a:ext>
                  </a:extLst>
                </p:cNvPr>
                <p:cNvSpPr/>
                <p:nvPr/>
              </p:nvSpPr>
              <p:spPr>
                <a:xfrm>
                  <a:off x="7805165" y="3460450"/>
                  <a:ext cx="62895" cy="62900"/>
                </a:xfrm>
                <a:custGeom>
                  <a:avLst/>
                  <a:gdLst>
                    <a:gd name="connsiteX0" fmla="*/ 62896 w 62895"/>
                    <a:gd name="connsiteY0" fmla="*/ 31450 h 62900"/>
                    <a:gd name="connsiteX1" fmla="*/ 31448 w 62895"/>
                    <a:gd name="connsiteY1" fmla="*/ 62900 h 62900"/>
                    <a:gd name="connsiteX2" fmla="*/ 0 w 62895"/>
                    <a:gd name="connsiteY2" fmla="*/ 31450 h 62900"/>
                    <a:gd name="connsiteX3" fmla="*/ 31448 w 62895"/>
                    <a:gd name="connsiteY3" fmla="*/ 0 h 62900"/>
                    <a:gd name="connsiteX4" fmla="*/ 62896 w 62895"/>
                    <a:gd name="connsiteY4" fmla="*/ 31450 h 629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62895" h="62900">
                      <a:moveTo>
                        <a:pt x="62896" y="31450"/>
                      </a:moveTo>
                      <a:cubicBezTo>
                        <a:pt x="62896" y="48820"/>
                        <a:pt x="48816" y="62900"/>
                        <a:pt x="31448" y="62900"/>
                      </a:cubicBezTo>
                      <a:cubicBezTo>
                        <a:pt x="14080" y="62900"/>
                        <a:pt x="0" y="48820"/>
                        <a:pt x="0" y="31450"/>
                      </a:cubicBezTo>
                      <a:cubicBezTo>
                        <a:pt x="0" y="14081"/>
                        <a:pt x="14080" y="0"/>
                        <a:pt x="31448" y="0"/>
                      </a:cubicBezTo>
                      <a:cubicBezTo>
                        <a:pt x="48816" y="0"/>
                        <a:pt x="62896" y="14081"/>
                        <a:pt x="62896" y="31450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 w="5706" cap="flat">
                  <a:solidFill>
                    <a:srgbClr val="FF670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ja-JP" altLang="en-US" sz="1200"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435" name="フリーフォーム: 図形 434">
                  <a:extLst>
                    <a:ext uri="{FF2B5EF4-FFF2-40B4-BE49-F238E27FC236}">
                      <a16:creationId xmlns:a16="http://schemas.microsoft.com/office/drawing/2014/main" id="{B56D2C0E-B54E-A830-84B7-68D31807429F}"/>
                    </a:ext>
                  </a:extLst>
                </p:cNvPr>
                <p:cNvSpPr/>
                <p:nvPr/>
              </p:nvSpPr>
              <p:spPr>
                <a:xfrm>
                  <a:off x="7805165" y="3150441"/>
                  <a:ext cx="62895" cy="62900"/>
                </a:xfrm>
                <a:custGeom>
                  <a:avLst/>
                  <a:gdLst>
                    <a:gd name="connsiteX0" fmla="*/ 62896 w 62895"/>
                    <a:gd name="connsiteY0" fmla="*/ 31450 h 62900"/>
                    <a:gd name="connsiteX1" fmla="*/ 31448 w 62895"/>
                    <a:gd name="connsiteY1" fmla="*/ 62900 h 62900"/>
                    <a:gd name="connsiteX2" fmla="*/ 0 w 62895"/>
                    <a:gd name="connsiteY2" fmla="*/ 31450 h 62900"/>
                    <a:gd name="connsiteX3" fmla="*/ 31448 w 62895"/>
                    <a:gd name="connsiteY3" fmla="*/ 0 h 62900"/>
                    <a:gd name="connsiteX4" fmla="*/ 62896 w 62895"/>
                    <a:gd name="connsiteY4" fmla="*/ 31450 h 629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62895" h="62900">
                      <a:moveTo>
                        <a:pt x="62896" y="31450"/>
                      </a:moveTo>
                      <a:cubicBezTo>
                        <a:pt x="62896" y="48820"/>
                        <a:pt x="48816" y="62900"/>
                        <a:pt x="31448" y="62900"/>
                      </a:cubicBezTo>
                      <a:cubicBezTo>
                        <a:pt x="14080" y="62900"/>
                        <a:pt x="0" y="48820"/>
                        <a:pt x="0" y="31450"/>
                      </a:cubicBezTo>
                      <a:cubicBezTo>
                        <a:pt x="0" y="14081"/>
                        <a:pt x="14080" y="0"/>
                        <a:pt x="31448" y="0"/>
                      </a:cubicBezTo>
                      <a:cubicBezTo>
                        <a:pt x="48816" y="0"/>
                        <a:pt x="62896" y="14081"/>
                        <a:pt x="62896" y="31450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 w="5706" cap="flat">
                  <a:solidFill>
                    <a:srgbClr val="FF670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ja-JP" altLang="en-US" sz="1200"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436" name="フリーフォーム: 図形 435">
                  <a:extLst>
                    <a:ext uri="{FF2B5EF4-FFF2-40B4-BE49-F238E27FC236}">
                      <a16:creationId xmlns:a16="http://schemas.microsoft.com/office/drawing/2014/main" id="{8CA1EBF0-8A21-EEAC-43D6-2CF08F150B8B}"/>
                    </a:ext>
                  </a:extLst>
                </p:cNvPr>
                <p:cNvSpPr/>
                <p:nvPr/>
              </p:nvSpPr>
              <p:spPr>
                <a:xfrm>
                  <a:off x="7805165" y="2925798"/>
                  <a:ext cx="62895" cy="62900"/>
                </a:xfrm>
                <a:custGeom>
                  <a:avLst/>
                  <a:gdLst>
                    <a:gd name="connsiteX0" fmla="*/ 62896 w 62895"/>
                    <a:gd name="connsiteY0" fmla="*/ 31450 h 62900"/>
                    <a:gd name="connsiteX1" fmla="*/ 31448 w 62895"/>
                    <a:gd name="connsiteY1" fmla="*/ 62900 h 62900"/>
                    <a:gd name="connsiteX2" fmla="*/ 0 w 62895"/>
                    <a:gd name="connsiteY2" fmla="*/ 31450 h 62900"/>
                    <a:gd name="connsiteX3" fmla="*/ 31448 w 62895"/>
                    <a:gd name="connsiteY3" fmla="*/ 0 h 62900"/>
                    <a:gd name="connsiteX4" fmla="*/ 62896 w 62895"/>
                    <a:gd name="connsiteY4" fmla="*/ 31450 h 629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62895" h="62900">
                      <a:moveTo>
                        <a:pt x="62896" y="31450"/>
                      </a:moveTo>
                      <a:cubicBezTo>
                        <a:pt x="62896" y="48820"/>
                        <a:pt x="48816" y="62900"/>
                        <a:pt x="31448" y="62900"/>
                      </a:cubicBezTo>
                      <a:cubicBezTo>
                        <a:pt x="14080" y="62900"/>
                        <a:pt x="0" y="48820"/>
                        <a:pt x="0" y="31450"/>
                      </a:cubicBezTo>
                      <a:cubicBezTo>
                        <a:pt x="0" y="14081"/>
                        <a:pt x="14080" y="0"/>
                        <a:pt x="31448" y="0"/>
                      </a:cubicBezTo>
                      <a:cubicBezTo>
                        <a:pt x="48816" y="0"/>
                        <a:pt x="62896" y="14081"/>
                        <a:pt x="62896" y="31450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 w="5706" cap="flat">
                  <a:solidFill>
                    <a:srgbClr val="FF670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ja-JP" altLang="en-US" sz="1200"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437" name="フリーフォーム: 図形 436">
                  <a:extLst>
                    <a:ext uri="{FF2B5EF4-FFF2-40B4-BE49-F238E27FC236}">
                      <a16:creationId xmlns:a16="http://schemas.microsoft.com/office/drawing/2014/main" id="{ACF22CC8-0C98-4F67-7EE8-398AF0606D4A}"/>
                    </a:ext>
                  </a:extLst>
                </p:cNvPr>
                <p:cNvSpPr/>
                <p:nvPr/>
              </p:nvSpPr>
              <p:spPr>
                <a:xfrm>
                  <a:off x="9615661" y="3887272"/>
                  <a:ext cx="62895" cy="62900"/>
                </a:xfrm>
                <a:custGeom>
                  <a:avLst/>
                  <a:gdLst>
                    <a:gd name="connsiteX0" fmla="*/ 62896 w 62895"/>
                    <a:gd name="connsiteY0" fmla="*/ 31450 h 62900"/>
                    <a:gd name="connsiteX1" fmla="*/ 31448 w 62895"/>
                    <a:gd name="connsiteY1" fmla="*/ 62900 h 62900"/>
                    <a:gd name="connsiteX2" fmla="*/ 0 w 62895"/>
                    <a:gd name="connsiteY2" fmla="*/ 31450 h 62900"/>
                    <a:gd name="connsiteX3" fmla="*/ 31448 w 62895"/>
                    <a:gd name="connsiteY3" fmla="*/ 0 h 62900"/>
                    <a:gd name="connsiteX4" fmla="*/ 62896 w 62895"/>
                    <a:gd name="connsiteY4" fmla="*/ 31450 h 629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62895" h="62900">
                      <a:moveTo>
                        <a:pt x="62896" y="31450"/>
                      </a:moveTo>
                      <a:cubicBezTo>
                        <a:pt x="62896" y="48819"/>
                        <a:pt x="48816" y="62900"/>
                        <a:pt x="31448" y="62900"/>
                      </a:cubicBezTo>
                      <a:cubicBezTo>
                        <a:pt x="14080" y="62900"/>
                        <a:pt x="0" y="48819"/>
                        <a:pt x="0" y="31450"/>
                      </a:cubicBezTo>
                      <a:cubicBezTo>
                        <a:pt x="0" y="14081"/>
                        <a:pt x="14080" y="0"/>
                        <a:pt x="31448" y="0"/>
                      </a:cubicBezTo>
                      <a:cubicBezTo>
                        <a:pt x="48816" y="0"/>
                        <a:pt x="62896" y="14081"/>
                        <a:pt x="62896" y="31450"/>
                      </a:cubicBezTo>
                      <a:close/>
                    </a:path>
                  </a:pathLst>
                </a:custGeom>
                <a:solidFill>
                  <a:schemeClr val="accent2"/>
                </a:solidFill>
                <a:ln w="5706" cap="flat">
                  <a:solidFill>
                    <a:srgbClr val="FF670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ja-JP" altLang="en-US" sz="1200"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438" name="フリーフォーム: 図形 437">
                  <a:extLst>
                    <a:ext uri="{FF2B5EF4-FFF2-40B4-BE49-F238E27FC236}">
                      <a16:creationId xmlns:a16="http://schemas.microsoft.com/office/drawing/2014/main" id="{C2CEACF9-600B-AF1C-BAF4-017166FF9FF7}"/>
                    </a:ext>
                  </a:extLst>
                </p:cNvPr>
                <p:cNvSpPr/>
                <p:nvPr/>
              </p:nvSpPr>
              <p:spPr>
                <a:xfrm>
                  <a:off x="9579721" y="3613207"/>
                  <a:ext cx="62895" cy="62900"/>
                </a:xfrm>
                <a:custGeom>
                  <a:avLst/>
                  <a:gdLst>
                    <a:gd name="connsiteX0" fmla="*/ 62896 w 62895"/>
                    <a:gd name="connsiteY0" fmla="*/ 31450 h 62900"/>
                    <a:gd name="connsiteX1" fmla="*/ 31448 w 62895"/>
                    <a:gd name="connsiteY1" fmla="*/ 62900 h 62900"/>
                    <a:gd name="connsiteX2" fmla="*/ 0 w 62895"/>
                    <a:gd name="connsiteY2" fmla="*/ 31450 h 62900"/>
                    <a:gd name="connsiteX3" fmla="*/ 31448 w 62895"/>
                    <a:gd name="connsiteY3" fmla="*/ 0 h 62900"/>
                    <a:gd name="connsiteX4" fmla="*/ 62896 w 62895"/>
                    <a:gd name="connsiteY4" fmla="*/ 31450 h 629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62895" h="62900">
                      <a:moveTo>
                        <a:pt x="62896" y="31450"/>
                      </a:moveTo>
                      <a:cubicBezTo>
                        <a:pt x="62896" y="48820"/>
                        <a:pt x="48816" y="62900"/>
                        <a:pt x="31448" y="62900"/>
                      </a:cubicBezTo>
                      <a:cubicBezTo>
                        <a:pt x="14080" y="62900"/>
                        <a:pt x="0" y="48820"/>
                        <a:pt x="0" y="31450"/>
                      </a:cubicBezTo>
                      <a:cubicBezTo>
                        <a:pt x="0" y="14081"/>
                        <a:pt x="14080" y="0"/>
                        <a:pt x="31448" y="0"/>
                      </a:cubicBezTo>
                      <a:cubicBezTo>
                        <a:pt x="48816" y="0"/>
                        <a:pt x="62896" y="14081"/>
                        <a:pt x="62896" y="31450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 w="5706" cap="flat">
                  <a:solidFill>
                    <a:srgbClr val="FF670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ja-JP" altLang="en-US" sz="1200"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439" name="フリーフォーム: 図形 438">
                  <a:extLst>
                    <a:ext uri="{FF2B5EF4-FFF2-40B4-BE49-F238E27FC236}">
                      <a16:creationId xmlns:a16="http://schemas.microsoft.com/office/drawing/2014/main" id="{0DFA9B36-3BAF-6423-6B87-28751E412A6D}"/>
                    </a:ext>
                  </a:extLst>
                </p:cNvPr>
                <p:cNvSpPr/>
                <p:nvPr/>
              </p:nvSpPr>
              <p:spPr>
                <a:xfrm>
                  <a:off x="9656094" y="3572771"/>
                  <a:ext cx="62895" cy="62900"/>
                </a:xfrm>
                <a:custGeom>
                  <a:avLst/>
                  <a:gdLst>
                    <a:gd name="connsiteX0" fmla="*/ 62896 w 62895"/>
                    <a:gd name="connsiteY0" fmla="*/ 31450 h 62900"/>
                    <a:gd name="connsiteX1" fmla="*/ 31448 w 62895"/>
                    <a:gd name="connsiteY1" fmla="*/ 62900 h 62900"/>
                    <a:gd name="connsiteX2" fmla="*/ 0 w 62895"/>
                    <a:gd name="connsiteY2" fmla="*/ 31450 h 62900"/>
                    <a:gd name="connsiteX3" fmla="*/ 31448 w 62895"/>
                    <a:gd name="connsiteY3" fmla="*/ 0 h 62900"/>
                    <a:gd name="connsiteX4" fmla="*/ 62896 w 62895"/>
                    <a:gd name="connsiteY4" fmla="*/ 31450 h 629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62895" h="62900">
                      <a:moveTo>
                        <a:pt x="62896" y="31450"/>
                      </a:moveTo>
                      <a:cubicBezTo>
                        <a:pt x="62896" y="48820"/>
                        <a:pt x="48816" y="62900"/>
                        <a:pt x="31448" y="62900"/>
                      </a:cubicBezTo>
                      <a:cubicBezTo>
                        <a:pt x="14080" y="62900"/>
                        <a:pt x="0" y="48820"/>
                        <a:pt x="0" y="31450"/>
                      </a:cubicBezTo>
                      <a:cubicBezTo>
                        <a:pt x="0" y="14081"/>
                        <a:pt x="14080" y="0"/>
                        <a:pt x="31448" y="0"/>
                      </a:cubicBezTo>
                      <a:cubicBezTo>
                        <a:pt x="48816" y="0"/>
                        <a:pt x="62896" y="14081"/>
                        <a:pt x="62896" y="31450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 w="5706" cap="flat">
                  <a:solidFill>
                    <a:srgbClr val="FF670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ja-JP" altLang="en-US" sz="1200"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440" name="フリーフォーム: 図形 439">
                  <a:extLst>
                    <a:ext uri="{FF2B5EF4-FFF2-40B4-BE49-F238E27FC236}">
                      <a16:creationId xmlns:a16="http://schemas.microsoft.com/office/drawing/2014/main" id="{2ADDB7DD-0BAB-DCF4-0F2D-F9C11B78A605}"/>
                    </a:ext>
                  </a:extLst>
                </p:cNvPr>
                <p:cNvSpPr/>
                <p:nvPr/>
              </p:nvSpPr>
              <p:spPr>
                <a:xfrm>
                  <a:off x="9579721" y="3568279"/>
                  <a:ext cx="62895" cy="62900"/>
                </a:xfrm>
                <a:custGeom>
                  <a:avLst/>
                  <a:gdLst>
                    <a:gd name="connsiteX0" fmla="*/ 62896 w 62895"/>
                    <a:gd name="connsiteY0" fmla="*/ 31450 h 62900"/>
                    <a:gd name="connsiteX1" fmla="*/ 31448 w 62895"/>
                    <a:gd name="connsiteY1" fmla="*/ 62900 h 62900"/>
                    <a:gd name="connsiteX2" fmla="*/ 0 w 62895"/>
                    <a:gd name="connsiteY2" fmla="*/ 31450 h 62900"/>
                    <a:gd name="connsiteX3" fmla="*/ 31448 w 62895"/>
                    <a:gd name="connsiteY3" fmla="*/ 0 h 62900"/>
                    <a:gd name="connsiteX4" fmla="*/ 62896 w 62895"/>
                    <a:gd name="connsiteY4" fmla="*/ 31450 h 629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62895" h="62900">
                      <a:moveTo>
                        <a:pt x="62896" y="31450"/>
                      </a:moveTo>
                      <a:cubicBezTo>
                        <a:pt x="62896" y="48820"/>
                        <a:pt x="48816" y="62900"/>
                        <a:pt x="31448" y="62900"/>
                      </a:cubicBezTo>
                      <a:cubicBezTo>
                        <a:pt x="14080" y="62900"/>
                        <a:pt x="0" y="48820"/>
                        <a:pt x="0" y="31450"/>
                      </a:cubicBezTo>
                      <a:cubicBezTo>
                        <a:pt x="0" y="14081"/>
                        <a:pt x="14080" y="0"/>
                        <a:pt x="31448" y="0"/>
                      </a:cubicBezTo>
                      <a:cubicBezTo>
                        <a:pt x="48816" y="0"/>
                        <a:pt x="62896" y="14081"/>
                        <a:pt x="62896" y="31450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 w="5706" cap="flat">
                  <a:solidFill>
                    <a:srgbClr val="FF670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ja-JP" altLang="en-US" sz="1200"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441" name="フリーフォーム: 図形 440">
                  <a:extLst>
                    <a:ext uri="{FF2B5EF4-FFF2-40B4-BE49-F238E27FC236}">
                      <a16:creationId xmlns:a16="http://schemas.microsoft.com/office/drawing/2014/main" id="{1B0FF6C4-B9CA-3015-5127-5CFA912BDBE5}"/>
                    </a:ext>
                  </a:extLst>
                </p:cNvPr>
                <p:cNvSpPr/>
                <p:nvPr/>
              </p:nvSpPr>
              <p:spPr>
                <a:xfrm>
                  <a:off x="9656094" y="3536828"/>
                  <a:ext cx="62895" cy="62900"/>
                </a:xfrm>
                <a:custGeom>
                  <a:avLst/>
                  <a:gdLst>
                    <a:gd name="connsiteX0" fmla="*/ 62896 w 62895"/>
                    <a:gd name="connsiteY0" fmla="*/ 31450 h 62900"/>
                    <a:gd name="connsiteX1" fmla="*/ 31448 w 62895"/>
                    <a:gd name="connsiteY1" fmla="*/ 62900 h 62900"/>
                    <a:gd name="connsiteX2" fmla="*/ 0 w 62895"/>
                    <a:gd name="connsiteY2" fmla="*/ 31450 h 62900"/>
                    <a:gd name="connsiteX3" fmla="*/ 31448 w 62895"/>
                    <a:gd name="connsiteY3" fmla="*/ 0 h 62900"/>
                    <a:gd name="connsiteX4" fmla="*/ 62896 w 62895"/>
                    <a:gd name="connsiteY4" fmla="*/ 31450 h 629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62895" h="62900">
                      <a:moveTo>
                        <a:pt x="62896" y="31450"/>
                      </a:moveTo>
                      <a:cubicBezTo>
                        <a:pt x="62896" y="48820"/>
                        <a:pt x="48816" y="62900"/>
                        <a:pt x="31448" y="62900"/>
                      </a:cubicBezTo>
                      <a:cubicBezTo>
                        <a:pt x="14080" y="62900"/>
                        <a:pt x="0" y="48820"/>
                        <a:pt x="0" y="31450"/>
                      </a:cubicBezTo>
                      <a:cubicBezTo>
                        <a:pt x="0" y="14081"/>
                        <a:pt x="14080" y="0"/>
                        <a:pt x="31448" y="0"/>
                      </a:cubicBezTo>
                      <a:cubicBezTo>
                        <a:pt x="48816" y="0"/>
                        <a:pt x="62896" y="14081"/>
                        <a:pt x="62896" y="31450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 w="5706" cap="flat">
                  <a:solidFill>
                    <a:srgbClr val="FF670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ja-JP" altLang="en-US" sz="1200"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442" name="フリーフォーム: 図形 441">
                  <a:extLst>
                    <a:ext uri="{FF2B5EF4-FFF2-40B4-BE49-F238E27FC236}">
                      <a16:creationId xmlns:a16="http://schemas.microsoft.com/office/drawing/2014/main" id="{85DE2A20-5C73-CCB0-7961-6AA8D6F41F25}"/>
                    </a:ext>
                  </a:extLst>
                </p:cNvPr>
                <p:cNvSpPr/>
                <p:nvPr/>
              </p:nvSpPr>
              <p:spPr>
                <a:xfrm>
                  <a:off x="9615661" y="3509871"/>
                  <a:ext cx="62895" cy="62900"/>
                </a:xfrm>
                <a:custGeom>
                  <a:avLst/>
                  <a:gdLst>
                    <a:gd name="connsiteX0" fmla="*/ 62896 w 62895"/>
                    <a:gd name="connsiteY0" fmla="*/ 31450 h 62900"/>
                    <a:gd name="connsiteX1" fmla="*/ 31448 w 62895"/>
                    <a:gd name="connsiteY1" fmla="*/ 62900 h 62900"/>
                    <a:gd name="connsiteX2" fmla="*/ 0 w 62895"/>
                    <a:gd name="connsiteY2" fmla="*/ 31450 h 62900"/>
                    <a:gd name="connsiteX3" fmla="*/ 31448 w 62895"/>
                    <a:gd name="connsiteY3" fmla="*/ 0 h 62900"/>
                    <a:gd name="connsiteX4" fmla="*/ 62896 w 62895"/>
                    <a:gd name="connsiteY4" fmla="*/ 31450 h 629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62895" h="62900">
                      <a:moveTo>
                        <a:pt x="62896" y="31450"/>
                      </a:moveTo>
                      <a:cubicBezTo>
                        <a:pt x="62896" y="48820"/>
                        <a:pt x="48816" y="62900"/>
                        <a:pt x="31448" y="62900"/>
                      </a:cubicBezTo>
                      <a:cubicBezTo>
                        <a:pt x="14080" y="62900"/>
                        <a:pt x="0" y="48820"/>
                        <a:pt x="0" y="31450"/>
                      </a:cubicBezTo>
                      <a:cubicBezTo>
                        <a:pt x="0" y="14081"/>
                        <a:pt x="14080" y="0"/>
                        <a:pt x="31448" y="0"/>
                      </a:cubicBezTo>
                      <a:cubicBezTo>
                        <a:pt x="48816" y="0"/>
                        <a:pt x="62896" y="14081"/>
                        <a:pt x="62896" y="31450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 w="5706" cap="flat">
                  <a:solidFill>
                    <a:srgbClr val="FF670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ja-JP" altLang="en-US" sz="1200"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443" name="フリーフォーム: 図形 442">
                  <a:extLst>
                    <a:ext uri="{FF2B5EF4-FFF2-40B4-BE49-F238E27FC236}">
                      <a16:creationId xmlns:a16="http://schemas.microsoft.com/office/drawing/2014/main" id="{528AFB0D-4AAC-8072-64A5-110F142498A2}"/>
                    </a:ext>
                  </a:extLst>
                </p:cNvPr>
                <p:cNvSpPr/>
                <p:nvPr/>
              </p:nvSpPr>
              <p:spPr>
                <a:xfrm>
                  <a:off x="9579721" y="3186384"/>
                  <a:ext cx="62895" cy="62900"/>
                </a:xfrm>
                <a:custGeom>
                  <a:avLst/>
                  <a:gdLst>
                    <a:gd name="connsiteX0" fmla="*/ 62896 w 62895"/>
                    <a:gd name="connsiteY0" fmla="*/ 31450 h 62900"/>
                    <a:gd name="connsiteX1" fmla="*/ 31448 w 62895"/>
                    <a:gd name="connsiteY1" fmla="*/ 62900 h 62900"/>
                    <a:gd name="connsiteX2" fmla="*/ 0 w 62895"/>
                    <a:gd name="connsiteY2" fmla="*/ 31450 h 62900"/>
                    <a:gd name="connsiteX3" fmla="*/ 31448 w 62895"/>
                    <a:gd name="connsiteY3" fmla="*/ 0 h 62900"/>
                    <a:gd name="connsiteX4" fmla="*/ 62896 w 62895"/>
                    <a:gd name="connsiteY4" fmla="*/ 31450 h 629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62895" h="62900">
                      <a:moveTo>
                        <a:pt x="62896" y="31450"/>
                      </a:moveTo>
                      <a:cubicBezTo>
                        <a:pt x="62896" y="48820"/>
                        <a:pt x="48816" y="62900"/>
                        <a:pt x="31448" y="62900"/>
                      </a:cubicBezTo>
                      <a:cubicBezTo>
                        <a:pt x="14080" y="62900"/>
                        <a:pt x="0" y="48820"/>
                        <a:pt x="0" y="31450"/>
                      </a:cubicBezTo>
                      <a:cubicBezTo>
                        <a:pt x="0" y="14081"/>
                        <a:pt x="14080" y="0"/>
                        <a:pt x="31448" y="0"/>
                      </a:cubicBezTo>
                      <a:cubicBezTo>
                        <a:pt x="48816" y="0"/>
                        <a:pt x="62896" y="14081"/>
                        <a:pt x="62896" y="31450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 w="5706" cap="flat">
                  <a:solidFill>
                    <a:srgbClr val="FF670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ja-JP" altLang="en-US" sz="1200"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444" name="フリーフォーム: 図形 443">
                  <a:extLst>
                    <a:ext uri="{FF2B5EF4-FFF2-40B4-BE49-F238E27FC236}">
                      <a16:creationId xmlns:a16="http://schemas.microsoft.com/office/drawing/2014/main" id="{C501B588-0DF6-16DC-ABCB-06A2EA1255E0}"/>
                    </a:ext>
                  </a:extLst>
                </p:cNvPr>
                <p:cNvSpPr/>
                <p:nvPr/>
              </p:nvSpPr>
              <p:spPr>
                <a:xfrm>
                  <a:off x="9656094" y="3181892"/>
                  <a:ext cx="62895" cy="62900"/>
                </a:xfrm>
                <a:custGeom>
                  <a:avLst/>
                  <a:gdLst>
                    <a:gd name="connsiteX0" fmla="*/ 62896 w 62895"/>
                    <a:gd name="connsiteY0" fmla="*/ 31450 h 62900"/>
                    <a:gd name="connsiteX1" fmla="*/ 31448 w 62895"/>
                    <a:gd name="connsiteY1" fmla="*/ 62900 h 62900"/>
                    <a:gd name="connsiteX2" fmla="*/ 0 w 62895"/>
                    <a:gd name="connsiteY2" fmla="*/ 31450 h 62900"/>
                    <a:gd name="connsiteX3" fmla="*/ 31448 w 62895"/>
                    <a:gd name="connsiteY3" fmla="*/ 0 h 62900"/>
                    <a:gd name="connsiteX4" fmla="*/ 62896 w 62895"/>
                    <a:gd name="connsiteY4" fmla="*/ 31450 h 629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62895" h="62900">
                      <a:moveTo>
                        <a:pt x="62896" y="31450"/>
                      </a:moveTo>
                      <a:cubicBezTo>
                        <a:pt x="62896" y="48820"/>
                        <a:pt x="48816" y="62900"/>
                        <a:pt x="31448" y="62900"/>
                      </a:cubicBezTo>
                      <a:cubicBezTo>
                        <a:pt x="14080" y="62900"/>
                        <a:pt x="0" y="48820"/>
                        <a:pt x="0" y="31450"/>
                      </a:cubicBezTo>
                      <a:cubicBezTo>
                        <a:pt x="0" y="14081"/>
                        <a:pt x="14080" y="0"/>
                        <a:pt x="31448" y="0"/>
                      </a:cubicBezTo>
                      <a:cubicBezTo>
                        <a:pt x="48816" y="0"/>
                        <a:pt x="62896" y="14081"/>
                        <a:pt x="62896" y="31450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 w="5706" cap="flat">
                  <a:solidFill>
                    <a:srgbClr val="FF670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ja-JP" altLang="en-US" sz="1200"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445" name="フリーフォーム: 図形 444">
                  <a:extLst>
                    <a:ext uri="{FF2B5EF4-FFF2-40B4-BE49-F238E27FC236}">
                      <a16:creationId xmlns:a16="http://schemas.microsoft.com/office/drawing/2014/main" id="{D02CCACB-833A-9BE8-B031-9FF2F8C0E2C9}"/>
                    </a:ext>
                  </a:extLst>
                </p:cNvPr>
                <p:cNvSpPr/>
                <p:nvPr/>
              </p:nvSpPr>
              <p:spPr>
                <a:xfrm>
                  <a:off x="9615661" y="2970727"/>
                  <a:ext cx="62895" cy="62900"/>
                </a:xfrm>
                <a:custGeom>
                  <a:avLst/>
                  <a:gdLst>
                    <a:gd name="connsiteX0" fmla="*/ 62896 w 62895"/>
                    <a:gd name="connsiteY0" fmla="*/ 31450 h 62900"/>
                    <a:gd name="connsiteX1" fmla="*/ 31448 w 62895"/>
                    <a:gd name="connsiteY1" fmla="*/ 62900 h 62900"/>
                    <a:gd name="connsiteX2" fmla="*/ 0 w 62895"/>
                    <a:gd name="connsiteY2" fmla="*/ 31450 h 62900"/>
                    <a:gd name="connsiteX3" fmla="*/ 31448 w 62895"/>
                    <a:gd name="connsiteY3" fmla="*/ 0 h 62900"/>
                    <a:gd name="connsiteX4" fmla="*/ 62896 w 62895"/>
                    <a:gd name="connsiteY4" fmla="*/ 31450 h 629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62895" h="62900">
                      <a:moveTo>
                        <a:pt x="62896" y="31450"/>
                      </a:moveTo>
                      <a:cubicBezTo>
                        <a:pt x="62896" y="48820"/>
                        <a:pt x="48816" y="62900"/>
                        <a:pt x="31448" y="62900"/>
                      </a:cubicBezTo>
                      <a:cubicBezTo>
                        <a:pt x="14080" y="62900"/>
                        <a:pt x="0" y="48820"/>
                        <a:pt x="0" y="31450"/>
                      </a:cubicBezTo>
                      <a:cubicBezTo>
                        <a:pt x="0" y="14081"/>
                        <a:pt x="14080" y="0"/>
                        <a:pt x="31448" y="0"/>
                      </a:cubicBezTo>
                      <a:cubicBezTo>
                        <a:pt x="48816" y="0"/>
                        <a:pt x="62896" y="14081"/>
                        <a:pt x="62896" y="31450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 w="5706" cap="flat">
                  <a:solidFill>
                    <a:srgbClr val="FF670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ja-JP" altLang="en-US" sz="1200"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446" name="フリーフォーム: 図形 445">
                  <a:extLst>
                    <a:ext uri="{FF2B5EF4-FFF2-40B4-BE49-F238E27FC236}">
                      <a16:creationId xmlns:a16="http://schemas.microsoft.com/office/drawing/2014/main" id="{10700641-240A-85F9-15D5-D57CBB75B735}"/>
                    </a:ext>
                  </a:extLst>
                </p:cNvPr>
                <p:cNvSpPr/>
                <p:nvPr/>
              </p:nvSpPr>
              <p:spPr>
                <a:xfrm>
                  <a:off x="9579721" y="2669704"/>
                  <a:ext cx="62895" cy="62900"/>
                </a:xfrm>
                <a:custGeom>
                  <a:avLst/>
                  <a:gdLst>
                    <a:gd name="connsiteX0" fmla="*/ 62896 w 62895"/>
                    <a:gd name="connsiteY0" fmla="*/ 31450 h 62900"/>
                    <a:gd name="connsiteX1" fmla="*/ 31448 w 62895"/>
                    <a:gd name="connsiteY1" fmla="*/ 62900 h 62900"/>
                    <a:gd name="connsiteX2" fmla="*/ 0 w 62895"/>
                    <a:gd name="connsiteY2" fmla="*/ 31450 h 62900"/>
                    <a:gd name="connsiteX3" fmla="*/ 31448 w 62895"/>
                    <a:gd name="connsiteY3" fmla="*/ 0 h 62900"/>
                    <a:gd name="connsiteX4" fmla="*/ 62896 w 62895"/>
                    <a:gd name="connsiteY4" fmla="*/ 31450 h 629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62895" h="62900">
                      <a:moveTo>
                        <a:pt x="62896" y="31450"/>
                      </a:moveTo>
                      <a:cubicBezTo>
                        <a:pt x="62896" y="48820"/>
                        <a:pt x="48816" y="62900"/>
                        <a:pt x="31448" y="62900"/>
                      </a:cubicBezTo>
                      <a:cubicBezTo>
                        <a:pt x="14080" y="62900"/>
                        <a:pt x="0" y="48820"/>
                        <a:pt x="0" y="31450"/>
                      </a:cubicBezTo>
                      <a:cubicBezTo>
                        <a:pt x="0" y="14081"/>
                        <a:pt x="14080" y="0"/>
                        <a:pt x="31448" y="0"/>
                      </a:cubicBezTo>
                      <a:cubicBezTo>
                        <a:pt x="48816" y="0"/>
                        <a:pt x="62896" y="14081"/>
                        <a:pt x="62896" y="31450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 w="5706" cap="flat">
                  <a:solidFill>
                    <a:srgbClr val="FF670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ja-JP" altLang="en-US" sz="1200"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447" name="フリーフォーム: 図形 446">
                  <a:extLst>
                    <a:ext uri="{FF2B5EF4-FFF2-40B4-BE49-F238E27FC236}">
                      <a16:creationId xmlns:a16="http://schemas.microsoft.com/office/drawing/2014/main" id="{C27082A8-89B9-C42C-AA75-E1A34DF7E40F}"/>
                    </a:ext>
                  </a:extLst>
                </p:cNvPr>
                <p:cNvSpPr/>
                <p:nvPr/>
              </p:nvSpPr>
              <p:spPr>
                <a:xfrm>
                  <a:off x="9656094" y="2651733"/>
                  <a:ext cx="62895" cy="62900"/>
                </a:xfrm>
                <a:custGeom>
                  <a:avLst/>
                  <a:gdLst>
                    <a:gd name="connsiteX0" fmla="*/ 62896 w 62895"/>
                    <a:gd name="connsiteY0" fmla="*/ 31450 h 62900"/>
                    <a:gd name="connsiteX1" fmla="*/ 31448 w 62895"/>
                    <a:gd name="connsiteY1" fmla="*/ 62900 h 62900"/>
                    <a:gd name="connsiteX2" fmla="*/ 0 w 62895"/>
                    <a:gd name="connsiteY2" fmla="*/ 31450 h 62900"/>
                    <a:gd name="connsiteX3" fmla="*/ 31448 w 62895"/>
                    <a:gd name="connsiteY3" fmla="*/ 0 h 62900"/>
                    <a:gd name="connsiteX4" fmla="*/ 62896 w 62895"/>
                    <a:gd name="connsiteY4" fmla="*/ 31450 h 629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62895" h="62900">
                      <a:moveTo>
                        <a:pt x="62896" y="31450"/>
                      </a:moveTo>
                      <a:cubicBezTo>
                        <a:pt x="62896" y="48820"/>
                        <a:pt x="48816" y="62900"/>
                        <a:pt x="31448" y="62900"/>
                      </a:cubicBezTo>
                      <a:cubicBezTo>
                        <a:pt x="14080" y="62900"/>
                        <a:pt x="0" y="48820"/>
                        <a:pt x="0" y="31450"/>
                      </a:cubicBezTo>
                      <a:cubicBezTo>
                        <a:pt x="0" y="14081"/>
                        <a:pt x="14080" y="0"/>
                        <a:pt x="31448" y="0"/>
                      </a:cubicBezTo>
                      <a:cubicBezTo>
                        <a:pt x="48816" y="0"/>
                        <a:pt x="62896" y="14081"/>
                        <a:pt x="62896" y="31450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 w="5706" cap="flat">
                  <a:solidFill>
                    <a:srgbClr val="FF670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ja-JP" altLang="en-US" sz="1200"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448" name="フリーフォーム: 図形 447">
                  <a:extLst>
                    <a:ext uri="{FF2B5EF4-FFF2-40B4-BE49-F238E27FC236}">
                      <a16:creationId xmlns:a16="http://schemas.microsoft.com/office/drawing/2014/main" id="{F88BD38F-D10F-0879-43CF-5BE3CA4745E9}"/>
                    </a:ext>
                  </a:extLst>
                </p:cNvPr>
                <p:cNvSpPr/>
                <p:nvPr/>
              </p:nvSpPr>
              <p:spPr>
                <a:xfrm>
                  <a:off x="9615661" y="2557382"/>
                  <a:ext cx="62895" cy="62900"/>
                </a:xfrm>
                <a:custGeom>
                  <a:avLst/>
                  <a:gdLst>
                    <a:gd name="connsiteX0" fmla="*/ 62896 w 62895"/>
                    <a:gd name="connsiteY0" fmla="*/ 31450 h 62900"/>
                    <a:gd name="connsiteX1" fmla="*/ 31448 w 62895"/>
                    <a:gd name="connsiteY1" fmla="*/ 62900 h 62900"/>
                    <a:gd name="connsiteX2" fmla="*/ 0 w 62895"/>
                    <a:gd name="connsiteY2" fmla="*/ 31450 h 62900"/>
                    <a:gd name="connsiteX3" fmla="*/ 31448 w 62895"/>
                    <a:gd name="connsiteY3" fmla="*/ 0 h 62900"/>
                    <a:gd name="connsiteX4" fmla="*/ 62896 w 62895"/>
                    <a:gd name="connsiteY4" fmla="*/ 31450 h 629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62895" h="62900">
                      <a:moveTo>
                        <a:pt x="62896" y="31450"/>
                      </a:moveTo>
                      <a:cubicBezTo>
                        <a:pt x="62896" y="48820"/>
                        <a:pt x="48816" y="62900"/>
                        <a:pt x="31448" y="62900"/>
                      </a:cubicBezTo>
                      <a:cubicBezTo>
                        <a:pt x="14080" y="62900"/>
                        <a:pt x="0" y="48820"/>
                        <a:pt x="0" y="31450"/>
                      </a:cubicBezTo>
                      <a:cubicBezTo>
                        <a:pt x="0" y="14081"/>
                        <a:pt x="14080" y="0"/>
                        <a:pt x="31448" y="0"/>
                      </a:cubicBezTo>
                      <a:cubicBezTo>
                        <a:pt x="48816" y="0"/>
                        <a:pt x="62896" y="14081"/>
                        <a:pt x="62896" y="31450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 w="5706" cap="flat">
                  <a:solidFill>
                    <a:srgbClr val="FF670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ja-JP" altLang="en-US" sz="1200"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449" name="フリーフォーム: 図形 448">
                  <a:extLst>
                    <a:ext uri="{FF2B5EF4-FFF2-40B4-BE49-F238E27FC236}">
                      <a16:creationId xmlns:a16="http://schemas.microsoft.com/office/drawing/2014/main" id="{8AF9186B-575F-D7D3-CCC4-5975AF3317E6}"/>
                    </a:ext>
                  </a:extLst>
                </p:cNvPr>
                <p:cNvSpPr/>
                <p:nvPr/>
              </p:nvSpPr>
              <p:spPr>
                <a:xfrm>
                  <a:off x="9615661" y="2323753"/>
                  <a:ext cx="62895" cy="62900"/>
                </a:xfrm>
                <a:custGeom>
                  <a:avLst/>
                  <a:gdLst>
                    <a:gd name="connsiteX0" fmla="*/ 62896 w 62895"/>
                    <a:gd name="connsiteY0" fmla="*/ 31450 h 62900"/>
                    <a:gd name="connsiteX1" fmla="*/ 31448 w 62895"/>
                    <a:gd name="connsiteY1" fmla="*/ 62900 h 62900"/>
                    <a:gd name="connsiteX2" fmla="*/ 0 w 62895"/>
                    <a:gd name="connsiteY2" fmla="*/ 31450 h 62900"/>
                    <a:gd name="connsiteX3" fmla="*/ 31448 w 62895"/>
                    <a:gd name="connsiteY3" fmla="*/ 0 h 62900"/>
                    <a:gd name="connsiteX4" fmla="*/ 62896 w 62895"/>
                    <a:gd name="connsiteY4" fmla="*/ 31450 h 629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62895" h="62900">
                      <a:moveTo>
                        <a:pt x="62896" y="31450"/>
                      </a:moveTo>
                      <a:cubicBezTo>
                        <a:pt x="62896" y="48820"/>
                        <a:pt x="48816" y="62900"/>
                        <a:pt x="31448" y="62900"/>
                      </a:cubicBezTo>
                      <a:cubicBezTo>
                        <a:pt x="14080" y="62900"/>
                        <a:pt x="0" y="48820"/>
                        <a:pt x="0" y="31450"/>
                      </a:cubicBezTo>
                      <a:cubicBezTo>
                        <a:pt x="0" y="14081"/>
                        <a:pt x="14080" y="0"/>
                        <a:pt x="31448" y="0"/>
                      </a:cubicBezTo>
                      <a:cubicBezTo>
                        <a:pt x="48816" y="0"/>
                        <a:pt x="62896" y="14081"/>
                        <a:pt x="62896" y="31450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 w="5706" cap="flat">
                  <a:solidFill>
                    <a:srgbClr val="FF670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ja-JP" altLang="en-US" sz="1200"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450" name="フリーフォーム: 図形 449">
                  <a:extLst>
                    <a:ext uri="{FF2B5EF4-FFF2-40B4-BE49-F238E27FC236}">
                      <a16:creationId xmlns:a16="http://schemas.microsoft.com/office/drawing/2014/main" id="{430BEDE2-01F6-5FB6-C137-38EE635FEC51}"/>
                    </a:ext>
                  </a:extLst>
                </p:cNvPr>
                <p:cNvSpPr/>
                <p:nvPr/>
              </p:nvSpPr>
              <p:spPr>
                <a:xfrm>
                  <a:off x="9615661" y="2081138"/>
                  <a:ext cx="62895" cy="62900"/>
                </a:xfrm>
                <a:custGeom>
                  <a:avLst/>
                  <a:gdLst>
                    <a:gd name="connsiteX0" fmla="*/ 62896 w 62895"/>
                    <a:gd name="connsiteY0" fmla="*/ 31450 h 62900"/>
                    <a:gd name="connsiteX1" fmla="*/ 31448 w 62895"/>
                    <a:gd name="connsiteY1" fmla="*/ 62900 h 62900"/>
                    <a:gd name="connsiteX2" fmla="*/ 0 w 62895"/>
                    <a:gd name="connsiteY2" fmla="*/ 31450 h 62900"/>
                    <a:gd name="connsiteX3" fmla="*/ 31448 w 62895"/>
                    <a:gd name="connsiteY3" fmla="*/ 0 h 62900"/>
                    <a:gd name="connsiteX4" fmla="*/ 62896 w 62895"/>
                    <a:gd name="connsiteY4" fmla="*/ 31450 h 629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62895" h="62900">
                      <a:moveTo>
                        <a:pt x="62896" y="31450"/>
                      </a:moveTo>
                      <a:cubicBezTo>
                        <a:pt x="62896" y="48820"/>
                        <a:pt x="48816" y="62900"/>
                        <a:pt x="31448" y="62900"/>
                      </a:cubicBezTo>
                      <a:cubicBezTo>
                        <a:pt x="14080" y="62900"/>
                        <a:pt x="0" y="48820"/>
                        <a:pt x="0" y="31450"/>
                      </a:cubicBezTo>
                      <a:cubicBezTo>
                        <a:pt x="0" y="14081"/>
                        <a:pt x="14080" y="0"/>
                        <a:pt x="31448" y="0"/>
                      </a:cubicBezTo>
                      <a:cubicBezTo>
                        <a:pt x="48816" y="0"/>
                        <a:pt x="62896" y="14081"/>
                        <a:pt x="62896" y="31450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 w="5706" cap="flat">
                  <a:solidFill>
                    <a:srgbClr val="FF670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ja-JP" altLang="en-US" sz="1200"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451" name="フリーフォーム: 図形 450">
                  <a:extLst>
                    <a:ext uri="{FF2B5EF4-FFF2-40B4-BE49-F238E27FC236}">
                      <a16:creationId xmlns:a16="http://schemas.microsoft.com/office/drawing/2014/main" id="{F05EC40F-070E-B274-68BF-596CAAAD21C1}"/>
                    </a:ext>
                  </a:extLst>
                </p:cNvPr>
                <p:cNvSpPr/>
                <p:nvPr/>
              </p:nvSpPr>
              <p:spPr>
                <a:xfrm>
                  <a:off x="9615661" y="1771130"/>
                  <a:ext cx="62895" cy="62900"/>
                </a:xfrm>
                <a:custGeom>
                  <a:avLst/>
                  <a:gdLst>
                    <a:gd name="connsiteX0" fmla="*/ 62896 w 62895"/>
                    <a:gd name="connsiteY0" fmla="*/ 31450 h 62900"/>
                    <a:gd name="connsiteX1" fmla="*/ 31448 w 62895"/>
                    <a:gd name="connsiteY1" fmla="*/ 62900 h 62900"/>
                    <a:gd name="connsiteX2" fmla="*/ 0 w 62895"/>
                    <a:gd name="connsiteY2" fmla="*/ 31450 h 62900"/>
                    <a:gd name="connsiteX3" fmla="*/ 31448 w 62895"/>
                    <a:gd name="connsiteY3" fmla="*/ 0 h 62900"/>
                    <a:gd name="connsiteX4" fmla="*/ 62896 w 62895"/>
                    <a:gd name="connsiteY4" fmla="*/ 31450 h 629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62895" h="62900">
                      <a:moveTo>
                        <a:pt x="62896" y="31450"/>
                      </a:moveTo>
                      <a:cubicBezTo>
                        <a:pt x="62896" y="48819"/>
                        <a:pt x="48816" y="62900"/>
                        <a:pt x="31448" y="62900"/>
                      </a:cubicBezTo>
                      <a:cubicBezTo>
                        <a:pt x="14080" y="62900"/>
                        <a:pt x="0" y="48819"/>
                        <a:pt x="0" y="31450"/>
                      </a:cubicBezTo>
                      <a:cubicBezTo>
                        <a:pt x="0" y="14081"/>
                        <a:pt x="14080" y="0"/>
                        <a:pt x="31448" y="0"/>
                      </a:cubicBezTo>
                      <a:cubicBezTo>
                        <a:pt x="48816" y="0"/>
                        <a:pt x="62896" y="14081"/>
                        <a:pt x="62896" y="31450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 w="5706" cap="flat">
                  <a:solidFill>
                    <a:srgbClr val="FF670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ja-JP" altLang="en-US" sz="1200">
                    <a:latin typeface="Palatino Linotype" panose="02040502050505030304" pitchFamily="18" charset="0"/>
                  </a:endParaRPr>
                </a:p>
              </p:txBody>
            </p:sp>
          </p:grpSp>
        </p:grpSp>
        <p:cxnSp>
          <p:nvCxnSpPr>
            <p:cNvPr id="398" name="直線コネクタ 397">
              <a:extLst>
                <a:ext uri="{FF2B5EF4-FFF2-40B4-BE49-F238E27FC236}">
                  <a16:creationId xmlns:a16="http://schemas.microsoft.com/office/drawing/2014/main" id="{0024C2EA-BA8F-D352-802E-BC5C10548F3D}"/>
                </a:ext>
              </a:extLst>
            </p:cNvPr>
            <p:cNvCxnSpPr/>
            <p:nvPr/>
          </p:nvCxnSpPr>
          <p:spPr>
            <a:xfrm>
              <a:off x="2558472" y="4158258"/>
              <a:ext cx="8192655" cy="0"/>
            </a:xfrm>
            <a:prstGeom prst="line">
              <a:avLst/>
            </a:prstGeom>
            <a:ln w="1905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00" name="テキスト ボックス 499">
            <a:extLst>
              <a:ext uri="{FF2B5EF4-FFF2-40B4-BE49-F238E27FC236}">
                <a16:creationId xmlns:a16="http://schemas.microsoft.com/office/drawing/2014/main" id="{84F0DADF-D65A-3A00-C165-9E031F605730}"/>
              </a:ext>
            </a:extLst>
          </p:cNvPr>
          <p:cNvSpPr txBox="1"/>
          <p:nvPr/>
        </p:nvSpPr>
        <p:spPr>
          <a:xfrm>
            <a:off x="5551057" y="3565234"/>
            <a:ext cx="6003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solidFill>
                  <a:schemeClr val="accent1"/>
                </a:solidFill>
                <a:latin typeface="Palatino Linotype" panose="02040502050505030304" pitchFamily="18" charset="0"/>
              </a:rPr>
              <a:t>0.357</a:t>
            </a:r>
            <a:endParaRPr kumimoji="1" lang="ja-JP" altLang="en-US" sz="1400" b="1" dirty="0">
              <a:solidFill>
                <a:schemeClr val="accent1"/>
              </a:solidFill>
              <a:latin typeface="Palatino Linotype" panose="02040502050505030304" pitchFamily="18" charset="0"/>
            </a:endParaRPr>
          </a:p>
        </p:txBody>
      </p:sp>
      <p:sp>
        <p:nvSpPr>
          <p:cNvPr id="501" name="テキスト ボックス 500">
            <a:extLst>
              <a:ext uri="{FF2B5EF4-FFF2-40B4-BE49-F238E27FC236}">
                <a16:creationId xmlns:a16="http://schemas.microsoft.com/office/drawing/2014/main" id="{34951651-1DC2-1C2A-1FE6-87112917001F}"/>
              </a:ext>
            </a:extLst>
          </p:cNvPr>
          <p:cNvSpPr txBox="1"/>
          <p:nvPr/>
        </p:nvSpPr>
        <p:spPr>
          <a:xfrm>
            <a:off x="11182395" y="3527661"/>
            <a:ext cx="6003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solidFill>
                  <a:schemeClr val="accent1"/>
                </a:solidFill>
                <a:latin typeface="Palatino Linotype" panose="02040502050505030304" pitchFamily="18" charset="0"/>
              </a:rPr>
              <a:t>0.357</a:t>
            </a:r>
            <a:endParaRPr kumimoji="1" lang="ja-JP" altLang="en-US" sz="1400" b="1" dirty="0">
              <a:solidFill>
                <a:schemeClr val="accent1"/>
              </a:solidFill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661027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6</TotalTime>
  <Words>98</Words>
  <Application>Microsoft Office PowerPoint</Application>
  <PresentationFormat>ワイド画面</PresentationFormat>
  <Paragraphs>36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Palatino Linotype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さや香 味原</dc:creator>
  <cp:lastModifiedBy>さや香 味原</cp:lastModifiedBy>
  <cp:revision>8</cp:revision>
  <cp:lastPrinted>2025-07-29T01:05:07Z</cp:lastPrinted>
  <dcterms:created xsi:type="dcterms:W3CDTF">2025-07-27T07:02:16Z</dcterms:created>
  <dcterms:modified xsi:type="dcterms:W3CDTF">2025-07-29T06:39:54Z</dcterms:modified>
</cp:coreProperties>
</file>